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1" d="100"/>
          <a:sy n="111" d="100"/>
        </p:scale>
        <p:origin x="45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endParaRPr lang="en-US"/>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a:p>
        </p:txBody>
      </p:sp>
      <p:sp>
        <p:nvSpPr>
          <p:cNvPr id="4" name="날짜 개체 틀 3"/>
          <p:cNvSpPr>
            <a:spLocks noGrp="1"/>
          </p:cNvSpPr>
          <p:nvPr>
            <p:ph type="dt" sz="half" idx="10"/>
          </p:nvPr>
        </p:nvSpPr>
        <p:spPr/>
        <p:txBody>
          <a:bodyPr/>
          <a:lstStyle/>
          <a:p>
            <a:fld id="{00BF43D3-B96D-401C-8AF4-AF16618C3F67}" type="datetimeFigureOut">
              <a:rPr lang="en-US" smtClean="0"/>
              <a:t>9/25/2024</a:t>
            </a:fld>
            <a:endParaRPr lang="en-US"/>
          </a:p>
        </p:txBody>
      </p:sp>
      <p:sp>
        <p:nvSpPr>
          <p:cNvPr id="5" name="바닥글 개체 틀 4"/>
          <p:cNvSpPr>
            <a:spLocks noGrp="1"/>
          </p:cNvSpPr>
          <p:nvPr>
            <p:ph type="ftr" sz="quarter" idx="11"/>
          </p:nvPr>
        </p:nvSpPr>
        <p:spPr/>
        <p:txBody>
          <a:bodyPr/>
          <a:lstStyle/>
          <a:p>
            <a:endParaRPr lang="en-US"/>
          </a:p>
        </p:txBody>
      </p:sp>
      <p:sp>
        <p:nvSpPr>
          <p:cNvPr id="6" name="슬라이드 번호 개체 틀 5"/>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33348928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endParaRPr lang="en-US"/>
          </a:p>
        </p:txBody>
      </p:sp>
      <p:sp>
        <p:nvSpPr>
          <p:cNvPr id="3" name="세로 텍스트 개체 틀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날짜 개체 틀 3"/>
          <p:cNvSpPr>
            <a:spLocks noGrp="1"/>
          </p:cNvSpPr>
          <p:nvPr>
            <p:ph type="dt" sz="half" idx="10"/>
          </p:nvPr>
        </p:nvSpPr>
        <p:spPr/>
        <p:txBody>
          <a:bodyPr/>
          <a:lstStyle/>
          <a:p>
            <a:fld id="{00BF43D3-B96D-401C-8AF4-AF16618C3F67}" type="datetimeFigureOut">
              <a:rPr lang="en-US" smtClean="0"/>
              <a:t>9/25/2024</a:t>
            </a:fld>
            <a:endParaRPr lang="en-US"/>
          </a:p>
        </p:txBody>
      </p:sp>
      <p:sp>
        <p:nvSpPr>
          <p:cNvPr id="5" name="바닥글 개체 틀 4"/>
          <p:cNvSpPr>
            <a:spLocks noGrp="1"/>
          </p:cNvSpPr>
          <p:nvPr>
            <p:ph type="ftr" sz="quarter" idx="11"/>
          </p:nvPr>
        </p:nvSpPr>
        <p:spPr/>
        <p:txBody>
          <a:bodyPr/>
          <a:lstStyle/>
          <a:p>
            <a:endParaRPr lang="en-US"/>
          </a:p>
        </p:txBody>
      </p:sp>
      <p:sp>
        <p:nvSpPr>
          <p:cNvPr id="6" name="슬라이드 번호 개체 틀 5"/>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4736799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a:t>마스터 제목 스타일 편집</a:t>
            </a:r>
            <a:endParaRPr lang="en-US"/>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날짜 개체 틀 3"/>
          <p:cNvSpPr>
            <a:spLocks noGrp="1"/>
          </p:cNvSpPr>
          <p:nvPr>
            <p:ph type="dt" sz="half" idx="10"/>
          </p:nvPr>
        </p:nvSpPr>
        <p:spPr/>
        <p:txBody>
          <a:bodyPr/>
          <a:lstStyle/>
          <a:p>
            <a:fld id="{00BF43D3-B96D-401C-8AF4-AF16618C3F67}" type="datetimeFigureOut">
              <a:rPr lang="en-US" smtClean="0"/>
              <a:t>9/25/2024</a:t>
            </a:fld>
            <a:endParaRPr lang="en-US"/>
          </a:p>
        </p:txBody>
      </p:sp>
      <p:sp>
        <p:nvSpPr>
          <p:cNvPr id="5" name="바닥글 개체 틀 4"/>
          <p:cNvSpPr>
            <a:spLocks noGrp="1"/>
          </p:cNvSpPr>
          <p:nvPr>
            <p:ph type="ftr" sz="quarter" idx="11"/>
          </p:nvPr>
        </p:nvSpPr>
        <p:spPr/>
        <p:txBody>
          <a:bodyPr/>
          <a:lstStyle/>
          <a:p>
            <a:endParaRPr lang="en-US"/>
          </a:p>
        </p:txBody>
      </p:sp>
      <p:sp>
        <p:nvSpPr>
          <p:cNvPr id="6" name="슬라이드 번호 개체 틀 5"/>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35215733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endParaRPr lang="en-US"/>
          </a:p>
        </p:txBody>
      </p:sp>
      <p:sp>
        <p:nvSpPr>
          <p:cNvPr id="3" name="내용 개체 틀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날짜 개체 틀 3"/>
          <p:cNvSpPr>
            <a:spLocks noGrp="1"/>
          </p:cNvSpPr>
          <p:nvPr>
            <p:ph type="dt" sz="half" idx="10"/>
          </p:nvPr>
        </p:nvSpPr>
        <p:spPr/>
        <p:txBody>
          <a:bodyPr/>
          <a:lstStyle/>
          <a:p>
            <a:fld id="{00BF43D3-B96D-401C-8AF4-AF16618C3F67}" type="datetimeFigureOut">
              <a:rPr lang="en-US" smtClean="0"/>
              <a:t>9/25/2024</a:t>
            </a:fld>
            <a:endParaRPr lang="en-US"/>
          </a:p>
        </p:txBody>
      </p:sp>
      <p:sp>
        <p:nvSpPr>
          <p:cNvPr id="5" name="바닥글 개체 틀 4"/>
          <p:cNvSpPr>
            <a:spLocks noGrp="1"/>
          </p:cNvSpPr>
          <p:nvPr>
            <p:ph type="ftr" sz="quarter" idx="11"/>
          </p:nvPr>
        </p:nvSpPr>
        <p:spPr/>
        <p:txBody>
          <a:bodyPr/>
          <a:lstStyle/>
          <a:p>
            <a:endParaRPr lang="en-US"/>
          </a:p>
        </p:txBody>
      </p:sp>
      <p:sp>
        <p:nvSpPr>
          <p:cNvPr id="6" name="슬라이드 번호 개체 틀 5"/>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15446260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endParaRPr lang="en-US"/>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p:cNvSpPr>
            <a:spLocks noGrp="1"/>
          </p:cNvSpPr>
          <p:nvPr>
            <p:ph type="dt" sz="half" idx="10"/>
          </p:nvPr>
        </p:nvSpPr>
        <p:spPr/>
        <p:txBody>
          <a:bodyPr/>
          <a:lstStyle/>
          <a:p>
            <a:fld id="{00BF43D3-B96D-401C-8AF4-AF16618C3F67}" type="datetimeFigureOut">
              <a:rPr lang="en-US" smtClean="0"/>
              <a:t>9/25/2024</a:t>
            </a:fld>
            <a:endParaRPr lang="en-US"/>
          </a:p>
        </p:txBody>
      </p:sp>
      <p:sp>
        <p:nvSpPr>
          <p:cNvPr id="5" name="바닥글 개체 틀 4"/>
          <p:cNvSpPr>
            <a:spLocks noGrp="1"/>
          </p:cNvSpPr>
          <p:nvPr>
            <p:ph type="ftr" sz="quarter" idx="11"/>
          </p:nvPr>
        </p:nvSpPr>
        <p:spPr/>
        <p:txBody>
          <a:bodyPr/>
          <a:lstStyle/>
          <a:p>
            <a:endParaRPr lang="en-US"/>
          </a:p>
        </p:txBody>
      </p:sp>
      <p:sp>
        <p:nvSpPr>
          <p:cNvPr id="6" name="슬라이드 번호 개체 틀 5"/>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25744838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endParaRPr lang="en-US"/>
          </a:p>
        </p:txBody>
      </p:sp>
      <p:sp>
        <p:nvSpPr>
          <p:cNvPr id="3" name="내용 개체 틀 2"/>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내용 개체 틀 3"/>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5" name="날짜 개체 틀 4"/>
          <p:cNvSpPr>
            <a:spLocks noGrp="1"/>
          </p:cNvSpPr>
          <p:nvPr>
            <p:ph type="dt" sz="half" idx="10"/>
          </p:nvPr>
        </p:nvSpPr>
        <p:spPr/>
        <p:txBody>
          <a:bodyPr/>
          <a:lstStyle/>
          <a:p>
            <a:fld id="{00BF43D3-B96D-401C-8AF4-AF16618C3F67}" type="datetimeFigureOut">
              <a:rPr lang="en-US" smtClean="0"/>
              <a:t>9/25/2024</a:t>
            </a:fld>
            <a:endParaRPr lang="en-US"/>
          </a:p>
        </p:txBody>
      </p:sp>
      <p:sp>
        <p:nvSpPr>
          <p:cNvPr id="6" name="바닥글 개체 틀 5"/>
          <p:cNvSpPr>
            <a:spLocks noGrp="1"/>
          </p:cNvSpPr>
          <p:nvPr>
            <p:ph type="ftr" sz="quarter" idx="11"/>
          </p:nvPr>
        </p:nvSpPr>
        <p:spPr/>
        <p:txBody>
          <a:bodyPr/>
          <a:lstStyle/>
          <a:p>
            <a:endParaRPr lang="en-US"/>
          </a:p>
        </p:txBody>
      </p:sp>
      <p:sp>
        <p:nvSpPr>
          <p:cNvPr id="7" name="슬라이드 번호 개체 틀 6"/>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9442386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a:t>마스터 제목 스타일 편집</a:t>
            </a:r>
            <a:endParaRPr lang="en-US"/>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7" name="날짜 개체 틀 6"/>
          <p:cNvSpPr>
            <a:spLocks noGrp="1"/>
          </p:cNvSpPr>
          <p:nvPr>
            <p:ph type="dt" sz="half" idx="10"/>
          </p:nvPr>
        </p:nvSpPr>
        <p:spPr/>
        <p:txBody>
          <a:bodyPr/>
          <a:lstStyle/>
          <a:p>
            <a:fld id="{00BF43D3-B96D-401C-8AF4-AF16618C3F67}" type="datetimeFigureOut">
              <a:rPr lang="en-US" smtClean="0"/>
              <a:t>9/25/2024</a:t>
            </a:fld>
            <a:endParaRPr lang="en-US"/>
          </a:p>
        </p:txBody>
      </p:sp>
      <p:sp>
        <p:nvSpPr>
          <p:cNvPr id="8" name="바닥글 개체 틀 7"/>
          <p:cNvSpPr>
            <a:spLocks noGrp="1"/>
          </p:cNvSpPr>
          <p:nvPr>
            <p:ph type="ftr" sz="quarter" idx="11"/>
          </p:nvPr>
        </p:nvSpPr>
        <p:spPr/>
        <p:txBody>
          <a:bodyPr/>
          <a:lstStyle/>
          <a:p>
            <a:endParaRPr lang="en-US"/>
          </a:p>
        </p:txBody>
      </p:sp>
      <p:sp>
        <p:nvSpPr>
          <p:cNvPr id="9" name="슬라이드 번호 개체 틀 8"/>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39661309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endParaRPr lang="en-US"/>
          </a:p>
        </p:txBody>
      </p:sp>
      <p:sp>
        <p:nvSpPr>
          <p:cNvPr id="3" name="날짜 개체 틀 2"/>
          <p:cNvSpPr>
            <a:spLocks noGrp="1"/>
          </p:cNvSpPr>
          <p:nvPr>
            <p:ph type="dt" sz="half" idx="10"/>
          </p:nvPr>
        </p:nvSpPr>
        <p:spPr/>
        <p:txBody>
          <a:bodyPr/>
          <a:lstStyle/>
          <a:p>
            <a:fld id="{00BF43D3-B96D-401C-8AF4-AF16618C3F67}" type="datetimeFigureOut">
              <a:rPr lang="en-US" smtClean="0"/>
              <a:t>9/25/2024</a:t>
            </a:fld>
            <a:endParaRPr lang="en-US"/>
          </a:p>
        </p:txBody>
      </p:sp>
      <p:sp>
        <p:nvSpPr>
          <p:cNvPr id="4" name="바닥글 개체 틀 3"/>
          <p:cNvSpPr>
            <a:spLocks noGrp="1"/>
          </p:cNvSpPr>
          <p:nvPr>
            <p:ph type="ftr" sz="quarter" idx="11"/>
          </p:nvPr>
        </p:nvSpPr>
        <p:spPr/>
        <p:txBody>
          <a:bodyPr/>
          <a:lstStyle/>
          <a:p>
            <a:endParaRPr lang="en-US"/>
          </a:p>
        </p:txBody>
      </p:sp>
      <p:sp>
        <p:nvSpPr>
          <p:cNvPr id="5" name="슬라이드 번호 개체 틀 4"/>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42238149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00BF43D3-B96D-401C-8AF4-AF16618C3F67}" type="datetimeFigureOut">
              <a:rPr lang="en-US" smtClean="0"/>
              <a:t>9/25/2024</a:t>
            </a:fld>
            <a:endParaRPr lang="en-US"/>
          </a:p>
        </p:txBody>
      </p:sp>
      <p:sp>
        <p:nvSpPr>
          <p:cNvPr id="3" name="바닥글 개체 틀 2"/>
          <p:cNvSpPr>
            <a:spLocks noGrp="1"/>
          </p:cNvSpPr>
          <p:nvPr>
            <p:ph type="ftr" sz="quarter" idx="11"/>
          </p:nvPr>
        </p:nvSpPr>
        <p:spPr/>
        <p:txBody>
          <a:bodyPr/>
          <a:lstStyle/>
          <a:p>
            <a:endParaRPr lang="en-US"/>
          </a:p>
        </p:txBody>
      </p:sp>
      <p:sp>
        <p:nvSpPr>
          <p:cNvPr id="4" name="슬라이드 번호 개체 틀 3"/>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21429939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endParaRPr lang="en-US"/>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00BF43D3-B96D-401C-8AF4-AF16618C3F67}" type="datetimeFigureOut">
              <a:rPr lang="en-US" smtClean="0"/>
              <a:t>9/25/2024</a:t>
            </a:fld>
            <a:endParaRPr lang="en-US"/>
          </a:p>
        </p:txBody>
      </p:sp>
      <p:sp>
        <p:nvSpPr>
          <p:cNvPr id="6" name="바닥글 개체 틀 5"/>
          <p:cNvSpPr>
            <a:spLocks noGrp="1"/>
          </p:cNvSpPr>
          <p:nvPr>
            <p:ph type="ftr" sz="quarter" idx="11"/>
          </p:nvPr>
        </p:nvSpPr>
        <p:spPr/>
        <p:txBody>
          <a:bodyPr/>
          <a:lstStyle/>
          <a:p>
            <a:endParaRPr lang="en-US"/>
          </a:p>
        </p:txBody>
      </p:sp>
      <p:sp>
        <p:nvSpPr>
          <p:cNvPr id="7" name="슬라이드 번호 개체 틀 6"/>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27627762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endParaRPr lang="en-US"/>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00BF43D3-B96D-401C-8AF4-AF16618C3F67}" type="datetimeFigureOut">
              <a:rPr lang="en-US" smtClean="0"/>
              <a:t>9/25/2024</a:t>
            </a:fld>
            <a:endParaRPr lang="en-US"/>
          </a:p>
        </p:txBody>
      </p:sp>
      <p:sp>
        <p:nvSpPr>
          <p:cNvPr id="6" name="바닥글 개체 틀 5"/>
          <p:cNvSpPr>
            <a:spLocks noGrp="1"/>
          </p:cNvSpPr>
          <p:nvPr>
            <p:ph type="ftr" sz="quarter" idx="11"/>
          </p:nvPr>
        </p:nvSpPr>
        <p:spPr/>
        <p:txBody>
          <a:bodyPr/>
          <a:lstStyle/>
          <a:p>
            <a:endParaRPr lang="en-US"/>
          </a:p>
        </p:txBody>
      </p:sp>
      <p:sp>
        <p:nvSpPr>
          <p:cNvPr id="7" name="슬라이드 번호 개체 틀 6"/>
          <p:cNvSpPr>
            <a:spLocks noGrp="1"/>
          </p:cNvSpPr>
          <p:nvPr>
            <p:ph type="sldNum" sz="quarter" idx="12"/>
          </p:nvPr>
        </p:nvSpPr>
        <p:spPr/>
        <p:txBody>
          <a:bodyPr/>
          <a:lstStyle/>
          <a:p>
            <a:fld id="{8C2A47D9-A950-4DF8-8ADF-346CF517A75A}" type="slidenum">
              <a:rPr lang="en-US" smtClean="0"/>
              <a:t>‹#›</a:t>
            </a:fld>
            <a:endParaRPr lang="en-US"/>
          </a:p>
        </p:txBody>
      </p:sp>
    </p:spTree>
    <p:extLst>
      <p:ext uri="{BB962C8B-B14F-4D97-AF65-F5344CB8AC3E}">
        <p14:creationId xmlns:p14="http://schemas.microsoft.com/office/powerpoint/2010/main" val="41257869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endParaRPr lang="en-US"/>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0BF43D3-B96D-401C-8AF4-AF16618C3F67}" type="datetimeFigureOut">
              <a:rPr lang="en-US" smtClean="0"/>
              <a:t>9/25/2024</a:t>
            </a:fld>
            <a:endParaRPr 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2A47D9-A950-4DF8-8ADF-346CF517A75A}" type="slidenum">
              <a:rPr lang="en-US" smtClean="0"/>
              <a:t>‹#›</a:t>
            </a:fld>
            <a:endParaRPr lang="en-US"/>
          </a:p>
        </p:txBody>
      </p:sp>
    </p:spTree>
    <p:extLst>
      <p:ext uri="{BB962C8B-B14F-4D97-AF65-F5344CB8AC3E}">
        <p14:creationId xmlns:p14="http://schemas.microsoft.com/office/powerpoint/2010/main" val="9974512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1" name="Group 4">
            <a:extLst>
              <a:ext uri="{FF2B5EF4-FFF2-40B4-BE49-F238E27FC236}">
                <a16:creationId xmlns:a16="http://schemas.microsoft.com/office/drawing/2014/main" id="{A83E6A19-026D-8A9F-533F-1FE0E6E2B76D}"/>
              </a:ext>
            </a:extLst>
          </p:cNvPr>
          <p:cNvGrpSpPr>
            <a:grpSpLocks noChangeAspect="1"/>
          </p:cNvGrpSpPr>
          <p:nvPr/>
        </p:nvGrpSpPr>
        <p:grpSpPr bwMode="auto">
          <a:xfrm>
            <a:off x="1704678" y="452523"/>
            <a:ext cx="7267284" cy="2193758"/>
            <a:chOff x="386" y="151"/>
            <a:chExt cx="6819" cy="2156"/>
          </a:xfrm>
        </p:grpSpPr>
        <p:sp>
          <p:nvSpPr>
            <p:cNvPr id="212" name="AutoShape 3">
              <a:extLst>
                <a:ext uri="{FF2B5EF4-FFF2-40B4-BE49-F238E27FC236}">
                  <a16:creationId xmlns:a16="http://schemas.microsoft.com/office/drawing/2014/main" id="{637E2038-A412-1298-6DCF-5CF843250750}"/>
                </a:ext>
              </a:extLst>
            </p:cNvPr>
            <p:cNvSpPr>
              <a:spLocks noChangeAspect="1" noChangeArrowheads="1" noTextEdit="1"/>
            </p:cNvSpPr>
            <p:nvPr/>
          </p:nvSpPr>
          <p:spPr bwMode="auto">
            <a:xfrm>
              <a:off x="386" y="151"/>
              <a:ext cx="6752" cy="2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81213" tIns="40607" rIns="81213" bIns="40607" numCol="1" anchor="t" anchorCtr="0" compatLnSpc="1">
              <a:prstTxWarp prst="textNoShape">
                <a:avLst/>
              </a:prstTxWarp>
            </a:bodyPr>
            <a:lstStyle/>
            <a:p>
              <a:endParaRPr lang="en-US" sz="2000"/>
            </a:p>
          </p:txBody>
        </p:sp>
        <p:grpSp>
          <p:nvGrpSpPr>
            <p:cNvPr id="213" name="Group 205">
              <a:extLst>
                <a:ext uri="{FF2B5EF4-FFF2-40B4-BE49-F238E27FC236}">
                  <a16:creationId xmlns:a16="http://schemas.microsoft.com/office/drawing/2014/main" id="{0047F8BF-DD88-B676-5FC2-4E401B50AB63}"/>
                </a:ext>
              </a:extLst>
            </p:cNvPr>
            <p:cNvGrpSpPr>
              <a:grpSpLocks/>
            </p:cNvGrpSpPr>
            <p:nvPr/>
          </p:nvGrpSpPr>
          <p:grpSpPr bwMode="auto">
            <a:xfrm>
              <a:off x="394" y="189"/>
              <a:ext cx="6811" cy="2118"/>
              <a:chOff x="394" y="189"/>
              <a:chExt cx="6811" cy="2118"/>
            </a:xfrm>
          </p:grpSpPr>
          <p:sp>
            <p:nvSpPr>
              <p:cNvPr id="216" name="Line 5">
                <a:extLst>
                  <a:ext uri="{FF2B5EF4-FFF2-40B4-BE49-F238E27FC236}">
                    <a16:creationId xmlns:a16="http://schemas.microsoft.com/office/drawing/2014/main" id="{10CDE957-E1FB-6890-A5AF-5D12F1ACB9E3}"/>
                  </a:ext>
                </a:extLst>
              </p:cNvPr>
              <p:cNvSpPr>
                <a:spLocks noChangeShapeType="1"/>
              </p:cNvSpPr>
              <p:nvPr/>
            </p:nvSpPr>
            <p:spPr bwMode="auto">
              <a:xfrm>
                <a:off x="555" y="2193"/>
                <a:ext cx="6524"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17" name="Line 6">
                <a:extLst>
                  <a:ext uri="{FF2B5EF4-FFF2-40B4-BE49-F238E27FC236}">
                    <a16:creationId xmlns:a16="http://schemas.microsoft.com/office/drawing/2014/main" id="{91D5D6FD-BA11-DC1F-F181-EAE88D0D0BAC}"/>
                  </a:ext>
                </a:extLst>
              </p:cNvPr>
              <p:cNvSpPr>
                <a:spLocks noChangeShapeType="1"/>
              </p:cNvSpPr>
              <p:nvPr/>
            </p:nvSpPr>
            <p:spPr bwMode="auto">
              <a:xfrm>
                <a:off x="555"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18" name="Rectangle 7">
                <a:extLst>
                  <a:ext uri="{FF2B5EF4-FFF2-40B4-BE49-F238E27FC236}">
                    <a16:creationId xmlns:a16="http://schemas.microsoft.com/office/drawing/2014/main" id="{9DBB81E7-052E-B990-6C12-A09CDCF6AD8F}"/>
                  </a:ext>
                </a:extLst>
              </p:cNvPr>
              <p:cNvSpPr>
                <a:spLocks noChangeArrowheads="1"/>
              </p:cNvSpPr>
              <p:nvPr/>
            </p:nvSpPr>
            <p:spPr bwMode="auto">
              <a:xfrm>
                <a:off x="509"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0.01</a:t>
                </a:r>
                <a:endParaRPr lang="en-US" altLang="en-US" b="1"/>
              </a:p>
            </p:txBody>
          </p:sp>
          <p:sp>
            <p:nvSpPr>
              <p:cNvPr id="219" name="Line 8">
                <a:extLst>
                  <a:ext uri="{FF2B5EF4-FFF2-40B4-BE49-F238E27FC236}">
                    <a16:creationId xmlns:a16="http://schemas.microsoft.com/office/drawing/2014/main" id="{21941E24-659D-B2EF-2A2D-B23D11B5F5FF}"/>
                  </a:ext>
                </a:extLst>
              </p:cNvPr>
              <p:cNvSpPr>
                <a:spLocks noChangeShapeType="1"/>
              </p:cNvSpPr>
              <p:nvPr/>
            </p:nvSpPr>
            <p:spPr bwMode="auto">
              <a:xfrm>
                <a:off x="61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0" name="Line 9">
                <a:extLst>
                  <a:ext uri="{FF2B5EF4-FFF2-40B4-BE49-F238E27FC236}">
                    <a16:creationId xmlns:a16="http://schemas.microsoft.com/office/drawing/2014/main" id="{34A04C62-EDD9-9B14-872D-56ECB5B0650C}"/>
                  </a:ext>
                </a:extLst>
              </p:cNvPr>
              <p:cNvSpPr>
                <a:spLocks noChangeShapeType="1"/>
              </p:cNvSpPr>
              <p:nvPr/>
            </p:nvSpPr>
            <p:spPr bwMode="auto">
              <a:xfrm>
                <a:off x="68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1" name="Line 10">
                <a:extLst>
                  <a:ext uri="{FF2B5EF4-FFF2-40B4-BE49-F238E27FC236}">
                    <a16:creationId xmlns:a16="http://schemas.microsoft.com/office/drawing/2014/main" id="{703027B9-98D5-8315-B25B-D69642336677}"/>
                  </a:ext>
                </a:extLst>
              </p:cNvPr>
              <p:cNvSpPr>
                <a:spLocks noChangeShapeType="1"/>
              </p:cNvSpPr>
              <p:nvPr/>
            </p:nvSpPr>
            <p:spPr bwMode="auto">
              <a:xfrm>
                <a:off x="74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2" name="Line 11">
                <a:extLst>
                  <a:ext uri="{FF2B5EF4-FFF2-40B4-BE49-F238E27FC236}">
                    <a16:creationId xmlns:a16="http://schemas.microsoft.com/office/drawing/2014/main" id="{A4050711-4F7B-19D0-4EB5-9D543ADBB0AE}"/>
                  </a:ext>
                </a:extLst>
              </p:cNvPr>
              <p:cNvSpPr>
                <a:spLocks noChangeShapeType="1"/>
              </p:cNvSpPr>
              <p:nvPr/>
            </p:nvSpPr>
            <p:spPr bwMode="auto">
              <a:xfrm>
                <a:off x="81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3" name="Line 12">
                <a:extLst>
                  <a:ext uri="{FF2B5EF4-FFF2-40B4-BE49-F238E27FC236}">
                    <a16:creationId xmlns:a16="http://schemas.microsoft.com/office/drawing/2014/main" id="{AEB9AE7D-4559-58F7-FDBE-3BE00685772C}"/>
                  </a:ext>
                </a:extLst>
              </p:cNvPr>
              <p:cNvSpPr>
                <a:spLocks noChangeShapeType="1"/>
              </p:cNvSpPr>
              <p:nvPr/>
            </p:nvSpPr>
            <p:spPr bwMode="auto">
              <a:xfrm>
                <a:off x="880"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4" name="Rectangle 13">
                <a:extLst>
                  <a:ext uri="{FF2B5EF4-FFF2-40B4-BE49-F238E27FC236}">
                    <a16:creationId xmlns:a16="http://schemas.microsoft.com/office/drawing/2014/main" id="{9C3601E1-944C-5392-B027-6418038B7AA2}"/>
                  </a:ext>
                </a:extLst>
              </p:cNvPr>
              <p:cNvSpPr>
                <a:spLocks noChangeArrowheads="1"/>
              </p:cNvSpPr>
              <p:nvPr/>
            </p:nvSpPr>
            <p:spPr bwMode="auto">
              <a:xfrm>
                <a:off x="834"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a:t>
                </a:r>
                <a:endParaRPr lang="en-US" altLang="en-US" b="1"/>
              </a:p>
            </p:txBody>
          </p:sp>
          <p:sp>
            <p:nvSpPr>
              <p:cNvPr id="225" name="Line 14">
                <a:extLst>
                  <a:ext uri="{FF2B5EF4-FFF2-40B4-BE49-F238E27FC236}">
                    <a16:creationId xmlns:a16="http://schemas.microsoft.com/office/drawing/2014/main" id="{2C2B4CC1-DA71-F9CD-4FF3-31EFEF070B58}"/>
                  </a:ext>
                </a:extLst>
              </p:cNvPr>
              <p:cNvSpPr>
                <a:spLocks noChangeShapeType="1"/>
              </p:cNvSpPr>
              <p:nvPr/>
            </p:nvSpPr>
            <p:spPr bwMode="auto">
              <a:xfrm>
                <a:off x="94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6" name="Line 15">
                <a:extLst>
                  <a:ext uri="{FF2B5EF4-FFF2-40B4-BE49-F238E27FC236}">
                    <a16:creationId xmlns:a16="http://schemas.microsoft.com/office/drawing/2014/main" id="{946E6BA8-64F2-8C87-B0B6-87BB8F11DA5D}"/>
                  </a:ext>
                </a:extLst>
              </p:cNvPr>
              <p:cNvSpPr>
                <a:spLocks noChangeShapeType="1"/>
              </p:cNvSpPr>
              <p:nvPr/>
            </p:nvSpPr>
            <p:spPr bwMode="auto">
              <a:xfrm>
                <a:off x="101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7" name="Line 16">
                <a:extLst>
                  <a:ext uri="{FF2B5EF4-FFF2-40B4-BE49-F238E27FC236}">
                    <a16:creationId xmlns:a16="http://schemas.microsoft.com/office/drawing/2014/main" id="{68028DD9-21E3-115A-A5F4-F963F290E751}"/>
                  </a:ext>
                </a:extLst>
              </p:cNvPr>
              <p:cNvSpPr>
                <a:spLocks noChangeShapeType="1"/>
              </p:cNvSpPr>
              <p:nvPr/>
            </p:nvSpPr>
            <p:spPr bwMode="auto">
              <a:xfrm>
                <a:off x="107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8" name="Line 17">
                <a:extLst>
                  <a:ext uri="{FF2B5EF4-FFF2-40B4-BE49-F238E27FC236}">
                    <a16:creationId xmlns:a16="http://schemas.microsoft.com/office/drawing/2014/main" id="{C0C87FE4-F603-93E2-C6B4-3F24B90DB7FC}"/>
                  </a:ext>
                </a:extLst>
              </p:cNvPr>
              <p:cNvSpPr>
                <a:spLocks noChangeShapeType="1"/>
              </p:cNvSpPr>
              <p:nvPr/>
            </p:nvSpPr>
            <p:spPr bwMode="auto">
              <a:xfrm>
                <a:off x="114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29" name="Line 18">
                <a:extLst>
                  <a:ext uri="{FF2B5EF4-FFF2-40B4-BE49-F238E27FC236}">
                    <a16:creationId xmlns:a16="http://schemas.microsoft.com/office/drawing/2014/main" id="{62E794CE-FCB0-7E39-01A9-92F4E85E45EF}"/>
                  </a:ext>
                </a:extLst>
              </p:cNvPr>
              <p:cNvSpPr>
                <a:spLocks noChangeShapeType="1"/>
              </p:cNvSpPr>
              <p:nvPr/>
            </p:nvSpPr>
            <p:spPr bwMode="auto">
              <a:xfrm>
                <a:off x="1206"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0" name="Rectangle 19">
                <a:extLst>
                  <a:ext uri="{FF2B5EF4-FFF2-40B4-BE49-F238E27FC236}">
                    <a16:creationId xmlns:a16="http://schemas.microsoft.com/office/drawing/2014/main" id="{B61B80C0-1457-0C7B-1F2D-9674B3BA7332}"/>
                  </a:ext>
                </a:extLst>
              </p:cNvPr>
              <p:cNvSpPr>
                <a:spLocks noChangeArrowheads="1"/>
              </p:cNvSpPr>
              <p:nvPr/>
            </p:nvSpPr>
            <p:spPr bwMode="auto">
              <a:xfrm>
                <a:off x="1159"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a:t>
                </a:r>
                <a:endParaRPr lang="en-US" altLang="en-US" b="1"/>
              </a:p>
            </p:txBody>
          </p:sp>
          <p:sp>
            <p:nvSpPr>
              <p:cNvPr id="231" name="Line 20">
                <a:extLst>
                  <a:ext uri="{FF2B5EF4-FFF2-40B4-BE49-F238E27FC236}">
                    <a16:creationId xmlns:a16="http://schemas.microsoft.com/office/drawing/2014/main" id="{689D1AB0-8923-A0FE-66CB-67130EA943F7}"/>
                  </a:ext>
                </a:extLst>
              </p:cNvPr>
              <p:cNvSpPr>
                <a:spLocks noChangeShapeType="1"/>
              </p:cNvSpPr>
              <p:nvPr/>
            </p:nvSpPr>
            <p:spPr bwMode="auto">
              <a:xfrm>
                <a:off x="127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2" name="Line 21">
                <a:extLst>
                  <a:ext uri="{FF2B5EF4-FFF2-40B4-BE49-F238E27FC236}">
                    <a16:creationId xmlns:a16="http://schemas.microsoft.com/office/drawing/2014/main" id="{972AEEB1-467B-C552-D7EF-065C7F1E23B0}"/>
                  </a:ext>
                </a:extLst>
              </p:cNvPr>
              <p:cNvSpPr>
                <a:spLocks noChangeShapeType="1"/>
              </p:cNvSpPr>
              <p:nvPr/>
            </p:nvSpPr>
            <p:spPr bwMode="auto">
              <a:xfrm>
                <a:off x="133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3" name="Line 22">
                <a:extLst>
                  <a:ext uri="{FF2B5EF4-FFF2-40B4-BE49-F238E27FC236}">
                    <a16:creationId xmlns:a16="http://schemas.microsoft.com/office/drawing/2014/main" id="{1E2EFB97-8F79-E05B-BB8F-4664318D5EE3}"/>
                  </a:ext>
                </a:extLst>
              </p:cNvPr>
              <p:cNvSpPr>
                <a:spLocks noChangeShapeType="1"/>
              </p:cNvSpPr>
              <p:nvPr/>
            </p:nvSpPr>
            <p:spPr bwMode="auto">
              <a:xfrm>
                <a:off x="140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4" name="Line 23">
                <a:extLst>
                  <a:ext uri="{FF2B5EF4-FFF2-40B4-BE49-F238E27FC236}">
                    <a16:creationId xmlns:a16="http://schemas.microsoft.com/office/drawing/2014/main" id="{A93A3DF7-C70A-D014-EDDC-1362ABC9FE3F}"/>
                  </a:ext>
                </a:extLst>
              </p:cNvPr>
              <p:cNvSpPr>
                <a:spLocks noChangeShapeType="1"/>
              </p:cNvSpPr>
              <p:nvPr/>
            </p:nvSpPr>
            <p:spPr bwMode="auto">
              <a:xfrm>
                <a:off x="146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5" name="Line 24">
                <a:extLst>
                  <a:ext uri="{FF2B5EF4-FFF2-40B4-BE49-F238E27FC236}">
                    <a16:creationId xmlns:a16="http://schemas.microsoft.com/office/drawing/2014/main" id="{CDA31404-C02D-EE0D-6B20-F3685F9F9F6B}"/>
                  </a:ext>
                </a:extLst>
              </p:cNvPr>
              <p:cNvSpPr>
                <a:spLocks noChangeShapeType="1"/>
              </p:cNvSpPr>
              <p:nvPr/>
            </p:nvSpPr>
            <p:spPr bwMode="auto">
              <a:xfrm>
                <a:off x="1532"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6" name="Rectangle 25">
                <a:extLst>
                  <a:ext uri="{FF2B5EF4-FFF2-40B4-BE49-F238E27FC236}">
                    <a16:creationId xmlns:a16="http://schemas.microsoft.com/office/drawing/2014/main" id="{2B6216BF-A348-0E8D-852A-9A9D9CC6810C}"/>
                  </a:ext>
                </a:extLst>
              </p:cNvPr>
              <p:cNvSpPr>
                <a:spLocks noChangeArrowheads="1"/>
              </p:cNvSpPr>
              <p:nvPr/>
            </p:nvSpPr>
            <p:spPr bwMode="auto">
              <a:xfrm>
                <a:off x="1485"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3.75</a:t>
                </a:r>
                <a:endParaRPr lang="en-US" altLang="en-US" b="1"/>
              </a:p>
            </p:txBody>
          </p:sp>
          <p:sp>
            <p:nvSpPr>
              <p:cNvPr id="237" name="Line 26">
                <a:extLst>
                  <a:ext uri="{FF2B5EF4-FFF2-40B4-BE49-F238E27FC236}">
                    <a16:creationId xmlns:a16="http://schemas.microsoft.com/office/drawing/2014/main" id="{ACC14DED-195D-E704-EA14-E9000FEB3066}"/>
                  </a:ext>
                </a:extLst>
              </p:cNvPr>
              <p:cNvSpPr>
                <a:spLocks noChangeShapeType="1"/>
              </p:cNvSpPr>
              <p:nvPr/>
            </p:nvSpPr>
            <p:spPr bwMode="auto">
              <a:xfrm>
                <a:off x="159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8" name="Line 27">
                <a:extLst>
                  <a:ext uri="{FF2B5EF4-FFF2-40B4-BE49-F238E27FC236}">
                    <a16:creationId xmlns:a16="http://schemas.microsoft.com/office/drawing/2014/main" id="{F7A6D6DB-008B-83BC-75CC-CE1585E7AFDB}"/>
                  </a:ext>
                </a:extLst>
              </p:cNvPr>
              <p:cNvSpPr>
                <a:spLocks noChangeShapeType="1"/>
              </p:cNvSpPr>
              <p:nvPr/>
            </p:nvSpPr>
            <p:spPr bwMode="auto">
              <a:xfrm>
                <a:off x="166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39" name="Line 28">
                <a:extLst>
                  <a:ext uri="{FF2B5EF4-FFF2-40B4-BE49-F238E27FC236}">
                    <a16:creationId xmlns:a16="http://schemas.microsoft.com/office/drawing/2014/main" id="{97B90134-0F16-AF6C-BA22-D76CAFAE2CF8}"/>
                  </a:ext>
                </a:extLst>
              </p:cNvPr>
              <p:cNvSpPr>
                <a:spLocks noChangeShapeType="1"/>
              </p:cNvSpPr>
              <p:nvPr/>
            </p:nvSpPr>
            <p:spPr bwMode="auto">
              <a:xfrm>
                <a:off x="1728"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0" name="Line 29">
                <a:extLst>
                  <a:ext uri="{FF2B5EF4-FFF2-40B4-BE49-F238E27FC236}">
                    <a16:creationId xmlns:a16="http://schemas.microsoft.com/office/drawing/2014/main" id="{56BC23C3-E036-3E8F-21A4-170AE5D3473F}"/>
                  </a:ext>
                </a:extLst>
              </p:cNvPr>
              <p:cNvSpPr>
                <a:spLocks noChangeShapeType="1"/>
              </p:cNvSpPr>
              <p:nvPr/>
            </p:nvSpPr>
            <p:spPr bwMode="auto">
              <a:xfrm>
                <a:off x="179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1" name="Line 30">
                <a:extLst>
                  <a:ext uri="{FF2B5EF4-FFF2-40B4-BE49-F238E27FC236}">
                    <a16:creationId xmlns:a16="http://schemas.microsoft.com/office/drawing/2014/main" id="{20C70966-A0D9-40A9-B5FE-E7A72A5FED6D}"/>
                  </a:ext>
                </a:extLst>
              </p:cNvPr>
              <p:cNvSpPr>
                <a:spLocks noChangeShapeType="1"/>
              </p:cNvSpPr>
              <p:nvPr/>
            </p:nvSpPr>
            <p:spPr bwMode="auto">
              <a:xfrm>
                <a:off x="1858"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2" name="Rectangle 31">
                <a:extLst>
                  <a:ext uri="{FF2B5EF4-FFF2-40B4-BE49-F238E27FC236}">
                    <a16:creationId xmlns:a16="http://schemas.microsoft.com/office/drawing/2014/main" id="{03875B4E-C3C0-A4DB-D460-6ED1937C2070}"/>
                  </a:ext>
                </a:extLst>
              </p:cNvPr>
              <p:cNvSpPr>
                <a:spLocks noChangeArrowheads="1"/>
              </p:cNvSpPr>
              <p:nvPr/>
            </p:nvSpPr>
            <p:spPr bwMode="auto">
              <a:xfrm>
                <a:off x="1810"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5.00</a:t>
                </a:r>
                <a:endParaRPr lang="en-US" altLang="en-US" b="1"/>
              </a:p>
            </p:txBody>
          </p:sp>
          <p:sp>
            <p:nvSpPr>
              <p:cNvPr id="243" name="Line 32">
                <a:extLst>
                  <a:ext uri="{FF2B5EF4-FFF2-40B4-BE49-F238E27FC236}">
                    <a16:creationId xmlns:a16="http://schemas.microsoft.com/office/drawing/2014/main" id="{A0127F85-963F-F292-0D56-60CF8C3D6B11}"/>
                  </a:ext>
                </a:extLst>
              </p:cNvPr>
              <p:cNvSpPr>
                <a:spLocks noChangeShapeType="1"/>
              </p:cNvSpPr>
              <p:nvPr/>
            </p:nvSpPr>
            <p:spPr bwMode="auto">
              <a:xfrm>
                <a:off x="192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4" name="Line 33">
                <a:extLst>
                  <a:ext uri="{FF2B5EF4-FFF2-40B4-BE49-F238E27FC236}">
                    <a16:creationId xmlns:a16="http://schemas.microsoft.com/office/drawing/2014/main" id="{B7ED5C56-9999-92BF-9C0F-1D2EE414D071}"/>
                  </a:ext>
                </a:extLst>
              </p:cNvPr>
              <p:cNvSpPr>
                <a:spLocks noChangeShapeType="1"/>
              </p:cNvSpPr>
              <p:nvPr/>
            </p:nvSpPr>
            <p:spPr bwMode="auto">
              <a:xfrm>
                <a:off x="198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5" name="Line 34">
                <a:extLst>
                  <a:ext uri="{FF2B5EF4-FFF2-40B4-BE49-F238E27FC236}">
                    <a16:creationId xmlns:a16="http://schemas.microsoft.com/office/drawing/2014/main" id="{A021C78B-2EB7-C00A-58F3-06355A4E2B5E}"/>
                  </a:ext>
                </a:extLst>
              </p:cNvPr>
              <p:cNvSpPr>
                <a:spLocks noChangeShapeType="1"/>
              </p:cNvSpPr>
              <p:nvPr/>
            </p:nvSpPr>
            <p:spPr bwMode="auto">
              <a:xfrm>
                <a:off x="205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6" name="Line 35">
                <a:extLst>
                  <a:ext uri="{FF2B5EF4-FFF2-40B4-BE49-F238E27FC236}">
                    <a16:creationId xmlns:a16="http://schemas.microsoft.com/office/drawing/2014/main" id="{3B16BBC7-096F-343B-509C-AA971CCDD342}"/>
                  </a:ext>
                </a:extLst>
              </p:cNvPr>
              <p:cNvSpPr>
                <a:spLocks noChangeShapeType="1"/>
              </p:cNvSpPr>
              <p:nvPr/>
            </p:nvSpPr>
            <p:spPr bwMode="auto">
              <a:xfrm>
                <a:off x="211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7" name="Line 36">
                <a:extLst>
                  <a:ext uri="{FF2B5EF4-FFF2-40B4-BE49-F238E27FC236}">
                    <a16:creationId xmlns:a16="http://schemas.microsoft.com/office/drawing/2014/main" id="{81FFC6CE-74EF-303E-CBAC-C21F8875AD29}"/>
                  </a:ext>
                </a:extLst>
              </p:cNvPr>
              <p:cNvSpPr>
                <a:spLocks noChangeShapeType="1"/>
              </p:cNvSpPr>
              <p:nvPr/>
            </p:nvSpPr>
            <p:spPr bwMode="auto">
              <a:xfrm>
                <a:off x="2184"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48" name="Rectangle 37">
                <a:extLst>
                  <a:ext uri="{FF2B5EF4-FFF2-40B4-BE49-F238E27FC236}">
                    <a16:creationId xmlns:a16="http://schemas.microsoft.com/office/drawing/2014/main" id="{8CED9CCC-B3AF-7CF9-7152-1BE16D8460C0}"/>
                  </a:ext>
                </a:extLst>
              </p:cNvPr>
              <p:cNvSpPr>
                <a:spLocks noChangeArrowheads="1"/>
              </p:cNvSpPr>
              <p:nvPr/>
            </p:nvSpPr>
            <p:spPr bwMode="auto">
              <a:xfrm>
                <a:off x="2135"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6.25</a:t>
                </a:r>
                <a:endParaRPr lang="en-US" altLang="en-US" b="1"/>
              </a:p>
            </p:txBody>
          </p:sp>
          <p:sp>
            <p:nvSpPr>
              <p:cNvPr id="249" name="Line 38">
                <a:extLst>
                  <a:ext uri="{FF2B5EF4-FFF2-40B4-BE49-F238E27FC236}">
                    <a16:creationId xmlns:a16="http://schemas.microsoft.com/office/drawing/2014/main" id="{1582E28F-0156-8A0B-65E2-1BB3098AA718}"/>
                  </a:ext>
                </a:extLst>
              </p:cNvPr>
              <p:cNvSpPr>
                <a:spLocks noChangeShapeType="1"/>
              </p:cNvSpPr>
              <p:nvPr/>
            </p:nvSpPr>
            <p:spPr bwMode="auto">
              <a:xfrm>
                <a:off x="225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0" name="Line 39">
                <a:extLst>
                  <a:ext uri="{FF2B5EF4-FFF2-40B4-BE49-F238E27FC236}">
                    <a16:creationId xmlns:a16="http://schemas.microsoft.com/office/drawing/2014/main" id="{BF600E81-33BC-7E7A-8946-65919FCF114E}"/>
                  </a:ext>
                </a:extLst>
              </p:cNvPr>
              <p:cNvSpPr>
                <a:spLocks noChangeShapeType="1"/>
              </p:cNvSpPr>
              <p:nvPr/>
            </p:nvSpPr>
            <p:spPr bwMode="auto">
              <a:xfrm>
                <a:off x="231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1" name="Line 40">
                <a:extLst>
                  <a:ext uri="{FF2B5EF4-FFF2-40B4-BE49-F238E27FC236}">
                    <a16:creationId xmlns:a16="http://schemas.microsoft.com/office/drawing/2014/main" id="{A1A7FEFB-62B1-C35F-2534-02017765661D}"/>
                  </a:ext>
                </a:extLst>
              </p:cNvPr>
              <p:cNvSpPr>
                <a:spLocks noChangeShapeType="1"/>
              </p:cNvSpPr>
              <p:nvPr/>
            </p:nvSpPr>
            <p:spPr bwMode="auto">
              <a:xfrm>
                <a:off x="238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2" name="Line 41">
                <a:extLst>
                  <a:ext uri="{FF2B5EF4-FFF2-40B4-BE49-F238E27FC236}">
                    <a16:creationId xmlns:a16="http://schemas.microsoft.com/office/drawing/2014/main" id="{66B717B5-4D0F-5F4A-C95E-0B2A9EC48666}"/>
                  </a:ext>
                </a:extLst>
              </p:cNvPr>
              <p:cNvSpPr>
                <a:spLocks noChangeShapeType="1"/>
              </p:cNvSpPr>
              <p:nvPr/>
            </p:nvSpPr>
            <p:spPr bwMode="auto">
              <a:xfrm>
                <a:off x="244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3" name="Line 42">
                <a:extLst>
                  <a:ext uri="{FF2B5EF4-FFF2-40B4-BE49-F238E27FC236}">
                    <a16:creationId xmlns:a16="http://schemas.microsoft.com/office/drawing/2014/main" id="{FFD68D1C-68FA-1185-EF1D-457D58476651}"/>
                  </a:ext>
                </a:extLst>
              </p:cNvPr>
              <p:cNvSpPr>
                <a:spLocks noChangeShapeType="1"/>
              </p:cNvSpPr>
              <p:nvPr/>
            </p:nvSpPr>
            <p:spPr bwMode="auto">
              <a:xfrm>
                <a:off x="2511"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4" name="Rectangle 43">
                <a:extLst>
                  <a:ext uri="{FF2B5EF4-FFF2-40B4-BE49-F238E27FC236}">
                    <a16:creationId xmlns:a16="http://schemas.microsoft.com/office/drawing/2014/main" id="{B39521A1-4EA1-76D1-A148-A2B3A16F1662}"/>
                  </a:ext>
                </a:extLst>
              </p:cNvPr>
              <p:cNvSpPr>
                <a:spLocks noChangeArrowheads="1"/>
              </p:cNvSpPr>
              <p:nvPr/>
            </p:nvSpPr>
            <p:spPr bwMode="auto">
              <a:xfrm>
                <a:off x="2465"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7.50</a:t>
                </a:r>
                <a:endParaRPr lang="en-US" altLang="en-US" b="1"/>
              </a:p>
            </p:txBody>
          </p:sp>
          <p:sp>
            <p:nvSpPr>
              <p:cNvPr id="255" name="Line 44">
                <a:extLst>
                  <a:ext uri="{FF2B5EF4-FFF2-40B4-BE49-F238E27FC236}">
                    <a16:creationId xmlns:a16="http://schemas.microsoft.com/office/drawing/2014/main" id="{4724988E-65AE-5F64-DDF5-2277E09C234F}"/>
                  </a:ext>
                </a:extLst>
              </p:cNvPr>
              <p:cNvSpPr>
                <a:spLocks noChangeShapeType="1"/>
              </p:cNvSpPr>
              <p:nvPr/>
            </p:nvSpPr>
            <p:spPr bwMode="auto">
              <a:xfrm>
                <a:off x="257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6" name="Line 45">
                <a:extLst>
                  <a:ext uri="{FF2B5EF4-FFF2-40B4-BE49-F238E27FC236}">
                    <a16:creationId xmlns:a16="http://schemas.microsoft.com/office/drawing/2014/main" id="{5EC0A554-01A4-3497-8CE2-11A06639CDD8}"/>
                  </a:ext>
                </a:extLst>
              </p:cNvPr>
              <p:cNvSpPr>
                <a:spLocks noChangeShapeType="1"/>
              </p:cNvSpPr>
              <p:nvPr/>
            </p:nvSpPr>
            <p:spPr bwMode="auto">
              <a:xfrm>
                <a:off x="264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7" name="Line 46">
                <a:extLst>
                  <a:ext uri="{FF2B5EF4-FFF2-40B4-BE49-F238E27FC236}">
                    <a16:creationId xmlns:a16="http://schemas.microsoft.com/office/drawing/2014/main" id="{D3B4ADB1-D7F6-85DD-F501-7B19B78FABC4}"/>
                  </a:ext>
                </a:extLst>
              </p:cNvPr>
              <p:cNvSpPr>
                <a:spLocks noChangeShapeType="1"/>
              </p:cNvSpPr>
              <p:nvPr/>
            </p:nvSpPr>
            <p:spPr bwMode="auto">
              <a:xfrm>
                <a:off x="270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8" name="Line 47">
                <a:extLst>
                  <a:ext uri="{FF2B5EF4-FFF2-40B4-BE49-F238E27FC236}">
                    <a16:creationId xmlns:a16="http://schemas.microsoft.com/office/drawing/2014/main" id="{F75077BB-61AB-7FA3-B7F2-9AC2FF7F4B28}"/>
                  </a:ext>
                </a:extLst>
              </p:cNvPr>
              <p:cNvSpPr>
                <a:spLocks noChangeShapeType="1"/>
              </p:cNvSpPr>
              <p:nvPr/>
            </p:nvSpPr>
            <p:spPr bwMode="auto">
              <a:xfrm>
                <a:off x="277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59" name="Line 48">
                <a:extLst>
                  <a:ext uri="{FF2B5EF4-FFF2-40B4-BE49-F238E27FC236}">
                    <a16:creationId xmlns:a16="http://schemas.microsoft.com/office/drawing/2014/main" id="{9AA35785-48CF-1D8D-4EA6-A4B324B8DD86}"/>
                  </a:ext>
                </a:extLst>
              </p:cNvPr>
              <p:cNvSpPr>
                <a:spLocks noChangeShapeType="1"/>
              </p:cNvSpPr>
              <p:nvPr/>
            </p:nvSpPr>
            <p:spPr bwMode="auto">
              <a:xfrm>
                <a:off x="2837"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0" name="Rectangle 49">
                <a:extLst>
                  <a:ext uri="{FF2B5EF4-FFF2-40B4-BE49-F238E27FC236}">
                    <a16:creationId xmlns:a16="http://schemas.microsoft.com/office/drawing/2014/main" id="{C82BBCA4-40F0-2767-D7B4-72A2A0701DC8}"/>
                  </a:ext>
                </a:extLst>
              </p:cNvPr>
              <p:cNvSpPr>
                <a:spLocks noChangeArrowheads="1"/>
              </p:cNvSpPr>
              <p:nvPr/>
            </p:nvSpPr>
            <p:spPr bwMode="auto">
              <a:xfrm>
                <a:off x="2790" y="221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8.75</a:t>
                </a:r>
                <a:endParaRPr lang="en-US" altLang="en-US" b="1"/>
              </a:p>
            </p:txBody>
          </p:sp>
          <p:sp>
            <p:nvSpPr>
              <p:cNvPr id="261" name="Line 50">
                <a:extLst>
                  <a:ext uri="{FF2B5EF4-FFF2-40B4-BE49-F238E27FC236}">
                    <a16:creationId xmlns:a16="http://schemas.microsoft.com/office/drawing/2014/main" id="{A992A890-15EE-8B29-20EA-453B90BC18E4}"/>
                  </a:ext>
                </a:extLst>
              </p:cNvPr>
              <p:cNvSpPr>
                <a:spLocks noChangeShapeType="1"/>
              </p:cNvSpPr>
              <p:nvPr/>
            </p:nvSpPr>
            <p:spPr bwMode="auto">
              <a:xfrm>
                <a:off x="290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2" name="Line 51">
                <a:extLst>
                  <a:ext uri="{FF2B5EF4-FFF2-40B4-BE49-F238E27FC236}">
                    <a16:creationId xmlns:a16="http://schemas.microsoft.com/office/drawing/2014/main" id="{37FD58F9-4087-A3CF-27E0-DA3F25E0AE84}"/>
                  </a:ext>
                </a:extLst>
              </p:cNvPr>
              <p:cNvSpPr>
                <a:spLocks noChangeShapeType="1"/>
              </p:cNvSpPr>
              <p:nvPr/>
            </p:nvSpPr>
            <p:spPr bwMode="auto">
              <a:xfrm>
                <a:off x="296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3" name="Line 52">
                <a:extLst>
                  <a:ext uri="{FF2B5EF4-FFF2-40B4-BE49-F238E27FC236}">
                    <a16:creationId xmlns:a16="http://schemas.microsoft.com/office/drawing/2014/main" id="{F29C7ACA-C1F8-A85D-A6C9-553A7E294B8F}"/>
                  </a:ext>
                </a:extLst>
              </p:cNvPr>
              <p:cNvSpPr>
                <a:spLocks noChangeShapeType="1"/>
              </p:cNvSpPr>
              <p:nvPr/>
            </p:nvSpPr>
            <p:spPr bwMode="auto">
              <a:xfrm>
                <a:off x="303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4" name="Line 53">
                <a:extLst>
                  <a:ext uri="{FF2B5EF4-FFF2-40B4-BE49-F238E27FC236}">
                    <a16:creationId xmlns:a16="http://schemas.microsoft.com/office/drawing/2014/main" id="{3EA99A42-F5B7-6E58-7E0E-A3CBB2E6B7D0}"/>
                  </a:ext>
                </a:extLst>
              </p:cNvPr>
              <p:cNvSpPr>
                <a:spLocks noChangeShapeType="1"/>
              </p:cNvSpPr>
              <p:nvPr/>
            </p:nvSpPr>
            <p:spPr bwMode="auto">
              <a:xfrm>
                <a:off x="3098"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5" name="Line 54">
                <a:extLst>
                  <a:ext uri="{FF2B5EF4-FFF2-40B4-BE49-F238E27FC236}">
                    <a16:creationId xmlns:a16="http://schemas.microsoft.com/office/drawing/2014/main" id="{AF66EAE2-4E39-A76A-E723-71194CAB1775}"/>
                  </a:ext>
                </a:extLst>
              </p:cNvPr>
              <p:cNvSpPr>
                <a:spLocks noChangeShapeType="1"/>
              </p:cNvSpPr>
              <p:nvPr/>
            </p:nvSpPr>
            <p:spPr bwMode="auto">
              <a:xfrm>
                <a:off x="3163"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6" name="Rectangle 55">
                <a:extLst>
                  <a:ext uri="{FF2B5EF4-FFF2-40B4-BE49-F238E27FC236}">
                    <a16:creationId xmlns:a16="http://schemas.microsoft.com/office/drawing/2014/main" id="{B79DF861-39D0-93DD-6C2C-680A9765B214}"/>
                  </a:ext>
                </a:extLst>
              </p:cNvPr>
              <p:cNvSpPr>
                <a:spLocks noChangeArrowheads="1"/>
              </p:cNvSpPr>
              <p:nvPr/>
            </p:nvSpPr>
            <p:spPr bwMode="auto">
              <a:xfrm>
                <a:off x="3103"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0.00</a:t>
                </a:r>
                <a:endParaRPr lang="en-US" altLang="en-US" b="1"/>
              </a:p>
            </p:txBody>
          </p:sp>
          <p:sp>
            <p:nvSpPr>
              <p:cNvPr id="267" name="Line 56">
                <a:extLst>
                  <a:ext uri="{FF2B5EF4-FFF2-40B4-BE49-F238E27FC236}">
                    <a16:creationId xmlns:a16="http://schemas.microsoft.com/office/drawing/2014/main" id="{891FE558-9FD3-3CCF-A720-890551859C47}"/>
                  </a:ext>
                </a:extLst>
              </p:cNvPr>
              <p:cNvSpPr>
                <a:spLocks noChangeShapeType="1"/>
              </p:cNvSpPr>
              <p:nvPr/>
            </p:nvSpPr>
            <p:spPr bwMode="auto">
              <a:xfrm>
                <a:off x="3228"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8" name="Line 57">
                <a:extLst>
                  <a:ext uri="{FF2B5EF4-FFF2-40B4-BE49-F238E27FC236}">
                    <a16:creationId xmlns:a16="http://schemas.microsoft.com/office/drawing/2014/main" id="{3049F713-8F49-4F27-5A0F-33278EDE447C}"/>
                  </a:ext>
                </a:extLst>
              </p:cNvPr>
              <p:cNvSpPr>
                <a:spLocks noChangeShapeType="1"/>
              </p:cNvSpPr>
              <p:nvPr/>
            </p:nvSpPr>
            <p:spPr bwMode="auto">
              <a:xfrm>
                <a:off x="329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69" name="Line 58">
                <a:extLst>
                  <a:ext uri="{FF2B5EF4-FFF2-40B4-BE49-F238E27FC236}">
                    <a16:creationId xmlns:a16="http://schemas.microsoft.com/office/drawing/2014/main" id="{E4C2137E-E926-4A04-2B81-454F607FEDF2}"/>
                  </a:ext>
                </a:extLst>
              </p:cNvPr>
              <p:cNvSpPr>
                <a:spLocks noChangeShapeType="1"/>
              </p:cNvSpPr>
              <p:nvPr/>
            </p:nvSpPr>
            <p:spPr bwMode="auto">
              <a:xfrm>
                <a:off x="335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0" name="Line 59">
                <a:extLst>
                  <a:ext uri="{FF2B5EF4-FFF2-40B4-BE49-F238E27FC236}">
                    <a16:creationId xmlns:a16="http://schemas.microsoft.com/office/drawing/2014/main" id="{4175DE14-55A2-B51E-35A8-618B886B4C5D}"/>
                  </a:ext>
                </a:extLst>
              </p:cNvPr>
              <p:cNvSpPr>
                <a:spLocks noChangeShapeType="1"/>
              </p:cNvSpPr>
              <p:nvPr/>
            </p:nvSpPr>
            <p:spPr bwMode="auto">
              <a:xfrm>
                <a:off x="342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1" name="Line 60">
                <a:extLst>
                  <a:ext uri="{FF2B5EF4-FFF2-40B4-BE49-F238E27FC236}">
                    <a16:creationId xmlns:a16="http://schemas.microsoft.com/office/drawing/2014/main" id="{18F4C7FD-E96A-BFF2-2205-EEE9A9F7DEE1}"/>
                  </a:ext>
                </a:extLst>
              </p:cNvPr>
              <p:cNvSpPr>
                <a:spLocks noChangeShapeType="1"/>
              </p:cNvSpPr>
              <p:nvPr/>
            </p:nvSpPr>
            <p:spPr bwMode="auto">
              <a:xfrm>
                <a:off x="3489"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2" name="Rectangle 61">
                <a:extLst>
                  <a:ext uri="{FF2B5EF4-FFF2-40B4-BE49-F238E27FC236}">
                    <a16:creationId xmlns:a16="http://schemas.microsoft.com/office/drawing/2014/main" id="{1F8242A5-488F-4FEF-D215-9DFBCF02367F}"/>
                  </a:ext>
                </a:extLst>
              </p:cNvPr>
              <p:cNvSpPr>
                <a:spLocks noChangeArrowheads="1"/>
              </p:cNvSpPr>
              <p:nvPr/>
            </p:nvSpPr>
            <p:spPr bwMode="auto">
              <a:xfrm>
                <a:off x="3428"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1.25</a:t>
                </a:r>
                <a:endParaRPr lang="en-US" altLang="en-US" b="1"/>
              </a:p>
            </p:txBody>
          </p:sp>
          <p:sp>
            <p:nvSpPr>
              <p:cNvPr id="273" name="Line 62">
                <a:extLst>
                  <a:ext uri="{FF2B5EF4-FFF2-40B4-BE49-F238E27FC236}">
                    <a16:creationId xmlns:a16="http://schemas.microsoft.com/office/drawing/2014/main" id="{EC81997B-E7CA-D884-E9E2-A3D8FEE24163}"/>
                  </a:ext>
                </a:extLst>
              </p:cNvPr>
              <p:cNvSpPr>
                <a:spLocks noChangeShapeType="1"/>
              </p:cNvSpPr>
              <p:nvPr/>
            </p:nvSpPr>
            <p:spPr bwMode="auto">
              <a:xfrm>
                <a:off x="355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4" name="Line 63">
                <a:extLst>
                  <a:ext uri="{FF2B5EF4-FFF2-40B4-BE49-F238E27FC236}">
                    <a16:creationId xmlns:a16="http://schemas.microsoft.com/office/drawing/2014/main" id="{488978E3-EC68-89C4-2145-2AC9F978901E}"/>
                  </a:ext>
                </a:extLst>
              </p:cNvPr>
              <p:cNvSpPr>
                <a:spLocks noChangeShapeType="1"/>
              </p:cNvSpPr>
              <p:nvPr/>
            </p:nvSpPr>
            <p:spPr bwMode="auto">
              <a:xfrm>
                <a:off x="362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5" name="Line 64">
                <a:extLst>
                  <a:ext uri="{FF2B5EF4-FFF2-40B4-BE49-F238E27FC236}">
                    <a16:creationId xmlns:a16="http://schemas.microsoft.com/office/drawing/2014/main" id="{36317847-6A5F-5857-21D5-0D06E31D5FFD}"/>
                  </a:ext>
                </a:extLst>
              </p:cNvPr>
              <p:cNvSpPr>
                <a:spLocks noChangeShapeType="1"/>
              </p:cNvSpPr>
              <p:nvPr/>
            </p:nvSpPr>
            <p:spPr bwMode="auto">
              <a:xfrm>
                <a:off x="368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6" name="Line 65">
                <a:extLst>
                  <a:ext uri="{FF2B5EF4-FFF2-40B4-BE49-F238E27FC236}">
                    <a16:creationId xmlns:a16="http://schemas.microsoft.com/office/drawing/2014/main" id="{CA7DF46C-C01A-0B66-3F1E-AB981503DF16}"/>
                  </a:ext>
                </a:extLst>
              </p:cNvPr>
              <p:cNvSpPr>
                <a:spLocks noChangeShapeType="1"/>
              </p:cNvSpPr>
              <p:nvPr/>
            </p:nvSpPr>
            <p:spPr bwMode="auto">
              <a:xfrm>
                <a:off x="375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7" name="Line 66">
                <a:extLst>
                  <a:ext uri="{FF2B5EF4-FFF2-40B4-BE49-F238E27FC236}">
                    <a16:creationId xmlns:a16="http://schemas.microsoft.com/office/drawing/2014/main" id="{3D790C48-0785-CB66-B319-3CEB8F5D3C45}"/>
                  </a:ext>
                </a:extLst>
              </p:cNvPr>
              <p:cNvSpPr>
                <a:spLocks noChangeShapeType="1"/>
              </p:cNvSpPr>
              <p:nvPr/>
            </p:nvSpPr>
            <p:spPr bwMode="auto">
              <a:xfrm>
                <a:off x="3815"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78" name="Rectangle 67">
                <a:extLst>
                  <a:ext uri="{FF2B5EF4-FFF2-40B4-BE49-F238E27FC236}">
                    <a16:creationId xmlns:a16="http://schemas.microsoft.com/office/drawing/2014/main" id="{8EDD479D-DE9F-ED84-B74F-BA4EBD0DE060}"/>
                  </a:ext>
                </a:extLst>
              </p:cNvPr>
              <p:cNvSpPr>
                <a:spLocks noChangeArrowheads="1"/>
              </p:cNvSpPr>
              <p:nvPr/>
            </p:nvSpPr>
            <p:spPr bwMode="auto">
              <a:xfrm>
                <a:off x="3754"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0</a:t>
                </a:r>
                <a:endParaRPr lang="en-US" altLang="en-US" b="1"/>
              </a:p>
            </p:txBody>
          </p:sp>
          <p:sp>
            <p:nvSpPr>
              <p:cNvPr id="279" name="Line 68">
                <a:extLst>
                  <a:ext uri="{FF2B5EF4-FFF2-40B4-BE49-F238E27FC236}">
                    <a16:creationId xmlns:a16="http://schemas.microsoft.com/office/drawing/2014/main" id="{C0806FDF-2DFB-1148-DC2C-36B0FD8F267D}"/>
                  </a:ext>
                </a:extLst>
              </p:cNvPr>
              <p:cNvSpPr>
                <a:spLocks noChangeShapeType="1"/>
              </p:cNvSpPr>
              <p:nvPr/>
            </p:nvSpPr>
            <p:spPr bwMode="auto">
              <a:xfrm>
                <a:off x="388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0" name="Line 69">
                <a:extLst>
                  <a:ext uri="{FF2B5EF4-FFF2-40B4-BE49-F238E27FC236}">
                    <a16:creationId xmlns:a16="http://schemas.microsoft.com/office/drawing/2014/main" id="{56EEBA85-C897-F1D5-ADE3-EC0D4B54DC19}"/>
                  </a:ext>
                </a:extLst>
              </p:cNvPr>
              <p:cNvSpPr>
                <a:spLocks noChangeShapeType="1"/>
              </p:cNvSpPr>
              <p:nvPr/>
            </p:nvSpPr>
            <p:spPr bwMode="auto">
              <a:xfrm>
                <a:off x="394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1" name="Line 70">
                <a:extLst>
                  <a:ext uri="{FF2B5EF4-FFF2-40B4-BE49-F238E27FC236}">
                    <a16:creationId xmlns:a16="http://schemas.microsoft.com/office/drawing/2014/main" id="{24E4464C-DE98-E14D-353C-40299E4AB7D0}"/>
                  </a:ext>
                </a:extLst>
              </p:cNvPr>
              <p:cNvSpPr>
                <a:spLocks noChangeShapeType="1"/>
              </p:cNvSpPr>
              <p:nvPr/>
            </p:nvSpPr>
            <p:spPr bwMode="auto">
              <a:xfrm>
                <a:off x="401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2" name="Line 71">
                <a:extLst>
                  <a:ext uri="{FF2B5EF4-FFF2-40B4-BE49-F238E27FC236}">
                    <a16:creationId xmlns:a16="http://schemas.microsoft.com/office/drawing/2014/main" id="{D50D5365-D855-DEDF-1DC1-584169464345}"/>
                  </a:ext>
                </a:extLst>
              </p:cNvPr>
              <p:cNvSpPr>
                <a:spLocks noChangeShapeType="1"/>
              </p:cNvSpPr>
              <p:nvPr/>
            </p:nvSpPr>
            <p:spPr bwMode="auto">
              <a:xfrm>
                <a:off x="407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3" name="Line 72">
                <a:extLst>
                  <a:ext uri="{FF2B5EF4-FFF2-40B4-BE49-F238E27FC236}">
                    <a16:creationId xmlns:a16="http://schemas.microsoft.com/office/drawing/2014/main" id="{3CF147AC-4D4A-7668-0F48-F28CE485D085}"/>
                  </a:ext>
                </a:extLst>
              </p:cNvPr>
              <p:cNvSpPr>
                <a:spLocks noChangeShapeType="1"/>
              </p:cNvSpPr>
              <p:nvPr/>
            </p:nvSpPr>
            <p:spPr bwMode="auto">
              <a:xfrm>
                <a:off x="4142"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4" name="Rectangle 73">
                <a:extLst>
                  <a:ext uri="{FF2B5EF4-FFF2-40B4-BE49-F238E27FC236}">
                    <a16:creationId xmlns:a16="http://schemas.microsoft.com/office/drawing/2014/main" id="{4B14B653-1827-008E-0789-7E916F03273D}"/>
                  </a:ext>
                </a:extLst>
              </p:cNvPr>
              <p:cNvSpPr>
                <a:spLocks noChangeArrowheads="1"/>
              </p:cNvSpPr>
              <p:nvPr/>
            </p:nvSpPr>
            <p:spPr bwMode="auto">
              <a:xfrm>
                <a:off x="4083"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3.75</a:t>
                </a:r>
                <a:endParaRPr lang="en-US" altLang="en-US" b="1"/>
              </a:p>
            </p:txBody>
          </p:sp>
          <p:sp>
            <p:nvSpPr>
              <p:cNvPr id="285" name="Line 74">
                <a:extLst>
                  <a:ext uri="{FF2B5EF4-FFF2-40B4-BE49-F238E27FC236}">
                    <a16:creationId xmlns:a16="http://schemas.microsoft.com/office/drawing/2014/main" id="{077F9088-2FD0-550B-FAD8-F258DB6EFB16}"/>
                  </a:ext>
                </a:extLst>
              </p:cNvPr>
              <p:cNvSpPr>
                <a:spLocks noChangeShapeType="1"/>
              </p:cNvSpPr>
              <p:nvPr/>
            </p:nvSpPr>
            <p:spPr bwMode="auto">
              <a:xfrm>
                <a:off x="420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6" name="Line 75">
                <a:extLst>
                  <a:ext uri="{FF2B5EF4-FFF2-40B4-BE49-F238E27FC236}">
                    <a16:creationId xmlns:a16="http://schemas.microsoft.com/office/drawing/2014/main" id="{9C8E650D-AE57-A3E7-66F1-90766F680C34}"/>
                  </a:ext>
                </a:extLst>
              </p:cNvPr>
              <p:cNvSpPr>
                <a:spLocks noChangeShapeType="1"/>
              </p:cNvSpPr>
              <p:nvPr/>
            </p:nvSpPr>
            <p:spPr bwMode="auto">
              <a:xfrm>
                <a:off x="427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7" name="Line 76">
                <a:extLst>
                  <a:ext uri="{FF2B5EF4-FFF2-40B4-BE49-F238E27FC236}">
                    <a16:creationId xmlns:a16="http://schemas.microsoft.com/office/drawing/2014/main" id="{8817B0D7-CD9B-8AD6-EC6D-D76FE1734C85}"/>
                  </a:ext>
                </a:extLst>
              </p:cNvPr>
              <p:cNvSpPr>
                <a:spLocks noChangeShapeType="1"/>
              </p:cNvSpPr>
              <p:nvPr/>
            </p:nvSpPr>
            <p:spPr bwMode="auto">
              <a:xfrm>
                <a:off x="433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8" name="Line 77">
                <a:extLst>
                  <a:ext uri="{FF2B5EF4-FFF2-40B4-BE49-F238E27FC236}">
                    <a16:creationId xmlns:a16="http://schemas.microsoft.com/office/drawing/2014/main" id="{31608DFD-DAF2-8D42-F424-9793BD5A65FA}"/>
                  </a:ext>
                </a:extLst>
              </p:cNvPr>
              <p:cNvSpPr>
                <a:spLocks noChangeShapeType="1"/>
              </p:cNvSpPr>
              <p:nvPr/>
            </p:nvSpPr>
            <p:spPr bwMode="auto">
              <a:xfrm>
                <a:off x="440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89" name="Line 78">
                <a:extLst>
                  <a:ext uri="{FF2B5EF4-FFF2-40B4-BE49-F238E27FC236}">
                    <a16:creationId xmlns:a16="http://schemas.microsoft.com/office/drawing/2014/main" id="{6E6B3777-3AA1-E368-A7EB-D77D8F9BF970}"/>
                  </a:ext>
                </a:extLst>
              </p:cNvPr>
              <p:cNvSpPr>
                <a:spLocks noChangeShapeType="1"/>
              </p:cNvSpPr>
              <p:nvPr/>
            </p:nvSpPr>
            <p:spPr bwMode="auto">
              <a:xfrm>
                <a:off x="4468"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0" name="Rectangle 79">
                <a:extLst>
                  <a:ext uri="{FF2B5EF4-FFF2-40B4-BE49-F238E27FC236}">
                    <a16:creationId xmlns:a16="http://schemas.microsoft.com/office/drawing/2014/main" id="{82000E74-2E43-F0C9-FE79-901EBE035720}"/>
                  </a:ext>
                </a:extLst>
              </p:cNvPr>
              <p:cNvSpPr>
                <a:spLocks noChangeArrowheads="1"/>
              </p:cNvSpPr>
              <p:nvPr/>
            </p:nvSpPr>
            <p:spPr bwMode="auto">
              <a:xfrm>
                <a:off x="4409"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5.00</a:t>
                </a:r>
                <a:endParaRPr lang="en-US" altLang="en-US" b="1"/>
              </a:p>
            </p:txBody>
          </p:sp>
          <p:sp>
            <p:nvSpPr>
              <p:cNvPr id="291" name="Line 80">
                <a:extLst>
                  <a:ext uri="{FF2B5EF4-FFF2-40B4-BE49-F238E27FC236}">
                    <a16:creationId xmlns:a16="http://schemas.microsoft.com/office/drawing/2014/main" id="{A7B316C2-4FE4-F003-F231-2DD36B7DB873}"/>
                  </a:ext>
                </a:extLst>
              </p:cNvPr>
              <p:cNvSpPr>
                <a:spLocks noChangeShapeType="1"/>
              </p:cNvSpPr>
              <p:nvPr/>
            </p:nvSpPr>
            <p:spPr bwMode="auto">
              <a:xfrm>
                <a:off x="453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2" name="Line 81">
                <a:extLst>
                  <a:ext uri="{FF2B5EF4-FFF2-40B4-BE49-F238E27FC236}">
                    <a16:creationId xmlns:a16="http://schemas.microsoft.com/office/drawing/2014/main" id="{859840D4-51D9-00F5-5D2D-AE6E3725A833}"/>
                  </a:ext>
                </a:extLst>
              </p:cNvPr>
              <p:cNvSpPr>
                <a:spLocks noChangeShapeType="1"/>
              </p:cNvSpPr>
              <p:nvPr/>
            </p:nvSpPr>
            <p:spPr bwMode="auto">
              <a:xfrm>
                <a:off x="4598"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3" name="Line 82">
                <a:extLst>
                  <a:ext uri="{FF2B5EF4-FFF2-40B4-BE49-F238E27FC236}">
                    <a16:creationId xmlns:a16="http://schemas.microsoft.com/office/drawing/2014/main" id="{E813EA74-5624-052A-BAB1-B7B6EE0CB5CF}"/>
                  </a:ext>
                </a:extLst>
              </p:cNvPr>
              <p:cNvSpPr>
                <a:spLocks noChangeShapeType="1"/>
              </p:cNvSpPr>
              <p:nvPr/>
            </p:nvSpPr>
            <p:spPr bwMode="auto">
              <a:xfrm>
                <a:off x="466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4" name="Line 83">
                <a:extLst>
                  <a:ext uri="{FF2B5EF4-FFF2-40B4-BE49-F238E27FC236}">
                    <a16:creationId xmlns:a16="http://schemas.microsoft.com/office/drawing/2014/main" id="{127EF47A-C62D-3D4B-8ECE-EC2A9EF022F9}"/>
                  </a:ext>
                </a:extLst>
              </p:cNvPr>
              <p:cNvSpPr>
                <a:spLocks noChangeShapeType="1"/>
              </p:cNvSpPr>
              <p:nvPr/>
            </p:nvSpPr>
            <p:spPr bwMode="auto">
              <a:xfrm>
                <a:off x="472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5" name="Line 84">
                <a:extLst>
                  <a:ext uri="{FF2B5EF4-FFF2-40B4-BE49-F238E27FC236}">
                    <a16:creationId xmlns:a16="http://schemas.microsoft.com/office/drawing/2014/main" id="{2D0C7838-AAF4-8505-DCBA-7DEA1D46C528}"/>
                  </a:ext>
                </a:extLst>
              </p:cNvPr>
              <p:cNvSpPr>
                <a:spLocks noChangeShapeType="1"/>
              </p:cNvSpPr>
              <p:nvPr/>
            </p:nvSpPr>
            <p:spPr bwMode="auto">
              <a:xfrm>
                <a:off x="4794"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6" name="Rectangle 85">
                <a:extLst>
                  <a:ext uri="{FF2B5EF4-FFF2-40B4-BE49-F238E27FC236}">
                    <a16:creationId xmlns:a16="http://schemas.microsoft.com/office/drawing/2014/main" id="{54295BAD-485A-2288-F851-CEBAC53027D0}"/>
                  </a:ext>
                </a:extLst>
              </p:cNvPr>
              <p:cNvSpPr>
                <a:spLocks noChangeArrowheads="1"/>
              </p:cNvSpPr>
              <p:nvPr/>
            </p:nvSpPr>
            <p:spPr bwMode="auto">
              <a:xfrm>
                <a:off x="4734"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6.25</a:t>
                </a:r>
                <a:endParaRPr lang="en-US" altLang="en-US" b="1"/>
              </a:p>
            </p:txBody>
          </p:sp>
          <p:sp>
            <p:nvSpPr>
              <p:cNvPr id="297" name="Line 86">
                <a:extLst>
                  <a:ext uri="{FF2B5EF4-FFF2-40B4-BE49-F238E27FC236}">
                    <a16:creationId xmlns:a16="http://schemas.microsoft.com/office/drawing/2014/main" id="{17C6C564-489C-1E69-6014-443320BDD03B}"/>
                  </a:ext>
                </a:extLst>
              </p:cNvPr>
              <p:cNvSpPr>
                <a:spLocks noChangeShapeType="1"/>
              </p:cNvSpPr>
              <p:nvPr/>
            </p:nvSpPr>
            <p:spPr bwMode="auto">
              <a:xfrm>
                <a:off x="485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8" name="Line 87">
                <a:extLst>
                  <a:ext uri="{FF2B5EF4-FFF2-40B4-BE49-F238E27FC236}">
                    <a16:creationId xmlns:a16="http://schemas.microsoft.com/office/drawing/2014/main" id="{BF9E9884-98C7-3133-AFA7-1411A7B244B8}"/>
                  </a:ext>
                </a:extLst>
              </p:cNvPr>
              <p:cNvSpPr>
                <a:spLocks noChangeShapeType="1"/>
              </p:cNvSpPr>
              <p:nvPr/>
            </p:nvSpPr>
            <p:spPr bwMode="auto">
              <a:xfrm>
                <a:off x="492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299" name="Line 88">
                <a:extLst>
                  <a:ext uri="{FF2B5EF4-FFF2-40B4-BE49-F238E27FC236}">
                    <a16:creationId xmlns:a16="http://schemas.microsoft.com/office/drawing/2014/main" id="{DD35DF18-AB3E-5F3C-1443-B05574C3106A}"/>
                  </a:ext>
                </a:extLst>
              </p:cNvPr>
              <p:cNvSpPr>
                <a:spLocks noChangeShapeType="1"/>
              </p:cNvSpPr>
              <p:nvPr/>
            </p:nvSpPr>
            <p:spPr bwMode="auto">
              <a:xfrm>
                <a:off x="498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0" name="Line 89">
                <a:extLst>
                  <a:ext uri="{FF2B5EF4-FFF2-40B4-BE49-F238E27FC236}">
                    <a16:creationId xmlns:a16="http://schemas.microsoft.com/office/drawing/2014/main" id="{C9FF81D4-E256-0F41-7EFB-1D2F104BB207}"/>
                  </a:ext>
                </a:extLst>
              </p:cNvPr>
              <p:cNvSpPr>
                <a:spLocks noChangeShapeType="1"/>
              </p:cNvSpPr>
              <p:nvPr/>
            </p:nvSpPr>
            <p:spPr bwMode="auto">
              <a:xfrm>
                <a:off x="505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1" name="Line 90">
                <a:extLst>
                  <a:ext uri="{FF2B5EF4-FFF2-40B4-BE49-F238E27FC236}">
                    <a16:creationId xmlns:a16="http://schemas.microsoft.com/office/drawing/2014/main" id="{FA0B51E9-DBBE-BE17-943B-9DB9FAA5B5C2}"/>
                  </a:ext>
                </a:extLst>
              </p:cNvPr>
              <p:cNvSpPr>
                <a:spLocks noChangeShapeType="1"/>
              </p:cNvSpPr>
              <p:nvPr/>
            </p:nvSpPr>
            <p:spPr bwMode="auto">
              <a:xfrm>
                <a:off x="5120"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2" name="Rectangle 91">
                <a:extLst>
                  <a:ext uri="{FF2B5EF4-FFF2-40B4-BE49-F238E27FC236}">
                    <a16:creationId xmlns:a16="http://schemas.microsoft.com/office/drawing/2014/main" id="{46318037-AA63-A98D-B5BA-0E247710D68B}"/>
                  </a:ext>
                </a:extLst>
              </p:cNvPr>
              <p:cNvSpPr>
                <a:spLocks noChangeArrowheads="1"/>
              </p:cNvSpPr>
              <p:nvPr/>
            </p:nvSpPr>
            <p:spPr bwMode="auto">
              <a:xfrm>
                <a:off x="5059"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7.50</a:t>
                </a:r>
                <a:endParaRPr lang="en-US" altLang="en-US" b="1"/>
              </a:p>
            </p:txBody>
          </p:sp>
          <p:sp>
            <p:nvSpPr>
              <p:cNvPr id="303" name="Line 92">
                <a:extLst>
                  <a:ext uri="{FF2B5EF4-FFF2-40B4-BE49-F238E27FC236}">
                    <a16:creationId xmlns:a16="http://schemas.microsoft.com/office/drawing/2014/main" id="{286A3305-19B1-597B-97CA-D508CDF6F4D2}"/>
                  </a:ext>
                </a:extLst>
              </p:cNvPr>
              <p:cNvSpPr>
                <a:spLocks noChangeShapeType="1"/>
              </p:cNvSpPr>
              <p:nvPr/>
            </p:nvSpPr>
            <p:spPr bwMode="auto">
              <a:xfrm>
                <a:off x="518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4" name="Line 93">
                <a:extLst>
                  <a:ext uri="{FF2B5EF4-FFF2-40B4-BE49-F238E27FC236}">
                    <a16:creationId xmlns:a16="http://schemas.microsoft.com/office/drawing/2014/main" id="{A12394E8-C2D8-681D-6E56-1CBA42221B16}"/>
                  </a:ext>
                </a:extLst>
              </p:cNvPr>
              <p:cNvSpPr>
                <a:spLocks noChangeShapeType="1"/>
              </p:cNvSpPr>
              <p:nvPr/>
            </p:nvSpPr>
            <p:spPr bwMode="auto">
              <a:xfrm>
                <a:off x="525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5" name="Line 94">
                <a:extLst>
                  <a:ext uri="{FF2B5EF4-FFF2-40B4-BE49-F238E27FC236}">
                    <a16:creationId xmlns:a16="http://schemas.microsoft.com/office/drawing/2014/main" id="{4E38B663-C0EF-CF2B-78ED-D4AB7808E2CD}"/>
                  </a:ext>
                </a:extLst>
              </p:cNvPr>
              <p:cNvSpPr>
                <a:spLocks noChangeShapeType="1"/>
              </p:cNvSpPr>
              <p:nvPr/>
            </p:nvSpPr>
            <p:spPr bwMode="auto">
              <a:xfrm>
                <a:off x="531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6" name="Line 95">
                <a:extLst>
                  <a:ext uri="{FF2B5EF4-FFF2-40B4-BE49-F238E27FC236}">
                    <a16:creationId xmlns:a16="http://schemas.microsoft.com/office/drawing/2014/main" id="{10D126D2-3F54-E5E5-41D4-11516A6BE049}"/>
                  </a:ext>
                </a:extLst>
              </p:cNvPr>
              <p:cNvSpPr>
                <a:spLocks noChangeShapeType="1"/>
              </p:cNvSpPr>
              <p:nvPr/>
            </p:nvSpPr>
            <p:spPr bwMode="auto">
              <a:xfrm>
                <a:off x="538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7" name="Line 96">
                <a:extLst>
                  <a:ext uri="{FF2B5EF4-FFF2-40B4-BE49-F238E27FC236}">
                    <a16:creationId xmlns:a16="http://schemas.microsoft.com/office/drawing/2014/main" id="{89E69568-B8CD-415E-6B14-1718AFC69531}"/>
                  </a:ext>
                </a:extLst>
              </p:cNvPr>
              <p:cNvSpPr>
                <a:spLocks noChangeShapeType="1"/>
              </p:cNvSpPr>
              <p:nvPr/>
            </p:nvSpPr>
            <p:spPr bwMode="auto">
              <a:xfrm>
                <a:off x="5446"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08" name="Rectangle 97">
                <a:extLst>
                  <a:ext uri="{FF2B5EF4-FFF2-40B4-BE49-F238E27FC236}">
                    <a16:creationId xmlns:a16="http://schemas.microsoft.com/office/drawing/2014/main" id="{597D9C02-51EE-38B3-AF31-6F96F468A9F2}"/>
                  </a:ext>
                </a:extLst>
              </p:cNvPr>
              <p:cNvSpPr>
                <a:spLocks noChangeArrowheads="1"/>
              </p:cNvSpPr>
              <p:nvPr/>
            </p:nvSpPr>
            <p:spPr bwMode="auto">
              <a:xfrm>
                <a:off x="5385"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dirty="0">
                    <a:solidFill>
                      <a:srgbClr val="000000"/>
                    </a:solidFill>
                  </a:rPr>
                  <a:t>18.75</a:t>
                </a:r>
                <a:endParaRPr lang="en-US" altLang="en-US" b="1" dirty="0"/>
              </a:p>
            </p:txBody>
          </p:sp>
          <p:sp>
            <p:nvSpPr>
              <p:cNvPr id="309" name="Line 98">
                <a:extLst>
                  <a:ext uri="{FF2B5EF4-FFF2-40B4-BE49-F238E27FC236}">
                    <a16:creationId xmlns:a16="http://schemas.microsoft.com/office/drawing/2014/main" id="{54605A7D-D1E6-78A2-99D1-8C124445BC1F}"/>
                  </a:ext>
                </a:extLst>
              </p:cNvPr>
              <p:cNvSpPr>
                <a:spLocks noChangeShapeType="1"/>
              </p:cNvSpPr>
              <p:nvPr/>
            </p:nvSpPr>
            <p:spPr bwMode="auto">
              <a:xfrm>
                <a:off x="551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0" name="Line 99">
                <a:extLst>
                  <a:ext uri="{FF2B5EF4-FFF2-40B4-BE49-F238E27FC236}">
                    <a16:creationId xmlns:a16="http://schemas.microsoft.com/office/drawing/2014/main" id="{63BE9680-A646-693D-5892-45EA89A5C7C8}"/>
                  </a:ext>
                </a:extLst>
              </p:cNvPr>
              <p:cNvSpPr>
                <a:spLocks noChangeShapeType="1"/>
              </p:cNvSpPr>
              <p:nvPr/>
            </p:nvSpPr>
            <p:spPr bwMode="auto">
              <a:xfrm>
                <a:off x="557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1" name="Line 100">
                <a:extLst>
                  <a:ext uri="{FF2B5EF4-FFF2-40B4-BE49-F238E27FC236}">
                    <a16:creationId xmlns:a16="http://schemas.microsoft.com/office/drawing/2014/main" id="{563F3974-01F9-33F5-FE39-CF6A640C0727}"/>
                  </a:ext>
                </a:extLst>
              </p:cNvPr>
              <p:cNvSpPr>
                <a:spLocks noChangeShapeType="1"/>
              </p:cNvSpPr>
              <p:nvPr/>
            </p:nvSpPr>
            <p:spPr bwMode="auto">
              <a:xfrm>
                <a:off x="564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2" name="Line 101">
                <a:extLst>
                  <a:ext uri="{FF2B5EF4-FFF2-40B4-BE49-F238E27FC236}">
                    <a16:creationId xmlns:a16="http://schemas.microsoft.com/office/drawing/2014/main" id="{3D14786C-1C9D-DB5B-5FCA-966C5D811214}"/>
                  </a:ext>
                </a:extLst>
              </p:cNvPr>
              <p:cNvSpPr>
                <a:spLocks noChangeShapeType="1"/>
              </p:cNvSpPr>
              <p:nvPr/>
            </p:nvSpPr>
            <p:spPr bwMode="auto">
              <a:xfrm>
                <a:off x="570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3" name="Line 102">
                <a:extLst>
                  <a:ext uri="{FF2B5EF4-FFF2-40B4-BE49-F238E27FC236}">
                    <a16:creationId xmlns:a16="http://schemas.microsoft.com/office/drawing/2014/main" id="{088EDB6D-FA2A-2ACE-7E11-510F476DE1D5}"/>
                  </a:ext>
                </a:extLst>
              </p:cNvPr>
              <p:cNvSpPr>
                <a:spLocks noChangeShapeType="1"/>
              </p:cNvSpPr>
              <p:nvPr/>
            </p:nvSpPr>
            <p:spPr bwMode="auto">
              <a:xfrm>
                <a:off x="5772"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4" name="Rectangle 103">
                <a:extLst>
                  <a:ext uri="{FF2B5EF4-FFF2-40B4-BE49-F238E27FC236}">
                    <a16:creationId xmlns:a16="http://schemas.microsoft.com/office/drawing/2014/main" id="{77EFF4F7-DE3B-38FA-F779-ED7BA4AE135B}"/>
                  </a:ext>
                </a:extLst>
              </p:cNvPr>
              <p:cNvSpPr>
                <a:spLocks noChangeArrowheads="1"/>
              </p:cNvSpPr>
              <p:nvPr/>
            </p:nvSpPr>
            <p:spPr bwMode="auto">
              <a:xfrm>
                <a:off x="5710"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0.00</a:t>
                </a:r>
                <a:endParaRPr lang="en-US" altLang="en-US" b="1"/>
              </a:p>
            </p:txBody>
          </p:sp>
          <p:sp>
            <p:nvSpPr>
              <p:cNvPr id="315" name="Line 104">
                <a:extLst>
                  <a:ext uri="{FF2B5EF4-FFF2-40B4-BE49-F238E27FC236}">
                    <a16:creationId xmlns:a16="http://schemas.microsoft.com/office/drawing/2014/main" id="{9C7E9CB0-ED7D-3D35-B4C5-A3FD419F7ADE}"/>
                  </a:ext>
                </a:extLst>
              </p:cNvPr>
              <p:cNvSpPr>
                <a:spLocks noChangeShapeType="1"/>
              </p:cNvSpPr>
              <p:nvPr/>
            </p:nvSpPr>
            <p:spPr bwMode="auto">
              <a:xfrm>
                <a:off x="583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6" name="Line 105">
                <a:extLst>
                  <a:ext uri="{FF2B5EF4-FFF2-40B4-BE49-F238E27FC236}">
                    <a16:creationId xmlns:a16="http://schemas.microsoft.com/office/drawing/2014/main" id="{52FD2D91-8D93-669F-C484-4D7E9376BBDC}"/>
                  </a:ext>
                </a:extLst>
              </p:cNvPr>
              <p:cNvSpPr>
                <a:spLocks noChangeShapeType="1"/>
              </p:cNvSpPr>
              <p:nvPr/>
            </p:nvSpPr>
            <p:spPr bwMode="auto">
              <a:xfrm>
                <a:off x="590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7" name="Line 106">
                <a:extLst>
                  <a:ext uri="{FF2B5EF4-FFF2-40B4-BE49-F238E27FC236}">
                    <a16:creationId xmlns:a16="http://schemas.microsoft.com/office/drawing/2014/main" id="{4298D857-3071-E228-A730-D015A0CF77DC}"/>
                  </a:ext>
                </a:extLst>
              </p:cNvPr>
              <p:cNvSpPr>
                <a:spLocks noChangeShapeType="1"/>
              </p:cNvSpPr>
              <p:nvPr/>
            </p:nvSpPr>
            <p:spPr bwMode="auto">
              <a:xfrm>
                <a:off x="5968"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8" name="Line 107">
                <a:extLst>
                  <a:ext uri="{FF2B5EF4-FFF2-40B4-BE49-F238E27FC236}">
                    <a16:creationId xmlns:a16="http://schemas.microsoft.com/office/drawing/2014/main" id="{00302F63-BA29-6D55-BB4C-78FD971A5842}"/>
                  </a:ext>
                </a:extLst>
              </p:cNvPr>
              <p:cNvSpPr>
                <a:spLocks noChangeShapeType="1"/>
              </p:cNvSpPr>
              <p:nvPr/>
            </p:nvSpPr>
            <p:spPr bwMode="auto">
              <a:xfrm>
                <a:off x="6033"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19" name="Line 108">
                <a:extLst>
                  <a:ext uri="{FF2B5EF4-FFF2-40B4-BE49-F238E27FC236}">
                    <a16:creationId xmlns:a16="http://schemas.microsoft.com/office/drawing/2014/main" id="{EBFDC248-7D3E-D6CC-B60A-0CF4C5F6A9ED}"/>
                  </a:ext>
                </a:extLst>
              </p:cNvPr>
              <p:cNvSpPr>
                <a:spLocks noChangeShapeType="1"/>
              </p:cNvSpPr>
              <p:nvPr/>
            </p:nvSpPr>
            <p:spPr bwMode="auto">
              <a:xfrm>
                <a:off x="6098"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0" name="Rectangle 109">
                <a:extLst>
                  <a:ext uri="{FF2B5EF4-FFF2-40B4-BE49-F238E27FC236}">
                    <a16:creationId xmlns:a16="http://schemas.microsoft.com/office/drawing/2014/main" id="{492A1F8B-A67E-8C5B-F77E-02F61DA8C78B}"/>
                  </a:ext>
                </a:extLst>
              </p:cNvPr>
              <p:cNvSpPr>
                <a:spLocks noChangeArrowheads="1"/>
              </p:cNvSpPr>
              <p:nvPr/>
            </p:nvSpPr>
            <p:spPr bwMode="auto">
              <a:xfrm>
                <a:off x="6039"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1.25</a:t>
                </a:r>
                <a:endParaRPr lang="en-US" altLang="en-US" b="1"/>
              </a:p>
            </p:txBody>
          </p:sp>
          <p:sp>
            <p:nvSpPr>
              <p:cNvPr id="321" name="Line 110">
                <a:extLst>
                  <a:ext uri="{FF2B5EF4-FFF2-40B4-BE49-F238E27FC236}">
                    <a16:creationId xmlns:a16="http://schemas.microsoft.com/office/drawing/2014/main" id="{5A4DE36C-577B-1A7E-919F-2BB4C8321D6A}"/>
                  </a:ext>
                </a:extLst>
              </p:cNvPr>
              <p:cNvSpPr>
                <a:spLocks noChangeShapeType="1"/>
              </p:cNvSpPr>
              <p:nvPr/>
            </p:nvSpPr>
            <p:spPr bwMode="auto">
              <a:xfrm>
                <a:off x="616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2" name="Line 111">
                <a:extLst>
                  <a:ext uri="{FF2B5EF4-FFF2-40B4-BE49-F238E27FC236}">
                    <a16:creationId xmlns:a16="http://schemas.microsoft.com/office/drawing/2014/main" id="{283803EE-4AC8-7AB0-8EA6-303647633F96}"/>
                  </a:ext>
                </a:extLst>
              </p:cNvPr>
              <p:cNvSpPr>
                <a:spLocks noChangeShapeType="1"/>
              </p:cNvSpPr>
              <p:nvPr/>
            </p:nvSpPr>
            <p:spPr bwMode="auto">
              <a:xfrm>
                <a:off x="6229"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3" name="Line 112">
                <a:extLst>
                  <a:ext uri="{FF2B5EF4-FFF2-40B4-BE49-F238E27FC236}">
                    <a16:creationId xmlns:a16="http://schemas.microsoft.com/office/drawing/2014/main" id="{6BDD6102-64F1-D051-5071-6E5A21D6ABB1}"/>
                  </a:ext>
                </a:extLst>
              </p:cNvPr>
              <p:cNvSpPr>
                <a:spLocks noChangeShapeType="1"/>
              </p:cNvSpPr>
              <p:nvPr/>
            </p:nvSpPr>
            <p:spPr bwMode="auto">
              <a:xfrm>
                <a:off x="6294"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4" name="Line 113">
                <a:extLst>
                  <a:ext uri="{FF2B5EF4-FFF2-40B4-BE49-F238E27FC236}">
                    <a16:creationId xmlns:a16="http://schemas.microsoft.com/office/drawing/2014/main" id="{EC6AF61D-93EF-CD8A-7421-A49AC8E06DD5}"/>
                  </a:ext>
                </a:extLst>
              </p:cNvPr>
              <p:cNvSpPr>
                <a:spLocks noChangeShapeType="1"/>
              </p:cNvSpPr>
              <p:nvPr/>
            </p:nvSpPr>
            <p:spPr bwMode="auto">
              <a:xfrm>
                <a:off x="636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5" name="Line 114">
                <a:extLst>
                  <a:ext uri="{FF2B5EF4-FFF2-40B4-BE49-F238E27FC236}">
                    <a16:creationId xmlns:a16="http://schemas.microsoft.com/office/drawing/2014/main" id="{53725E15-A6DC-902C-F59B-E7342C6C3091}"/>
                  </a:ext>
                </a:extLst>
              </p:cNvPr>
              <p:cNvSpPr>
                <a:spLocks noChangeShapeType="1"/>
              </p:cNvSpPr>
              <p:nvPr/>
            </p:nvSpPr>
            <p:spPr bwMode="auto">
              <a:xfrm>
                <a:off x="6425"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6" name="Rectangle 115">
                <a:extLst>
                  <a:ext uri="{FF2B5EF4-FFF2-40B4-BE49-F238E27FC236}">
                    <a16:creationId xmlns:a16="http://schemas.microsoft.com/office/drawing/2014/main" id="{5E1EE42A-CA4B-DE7D-53C4-1356E4B94F8D}"/>
                  </a:ext>
                </a:extLst>
              </p:cNvPr>
              <p:cNvSpPr>
                <a:spLocks noChangeArrowheads="1"/>
              </p:cNvSpPr>
              <p:nvPr/>
            </p:nvSpPr>
            <p:spPr bwMode="auto">
              <a:xfrm>
                <a:off x="6365"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2.50</a:t>
                </a:r>
                <a:endParaRPr lang="en-US" altLang="en-US" b="1"/>
              </a:p>
            </p:txBody>
          </p:sp>
          <p:sp>
            <p:nvSpPr>
              <p:cNvPr id="327" name="Line 116">
                <a:extLst>
                  <a:ext uri="{FF2B5EF4-FFF2-40B4-BE49-F238E27FC236}">
                    <a16:creationId xmlns:a16="http://schemas.microsoft.com/office/drawing/2014/main" id="{828D538E-15DF-E44E-71C6-96EA0F19579A}"/>
                  </a:ext>
                </a:extLst>
              </p:cNvPr>
              <p:cNvSpPr>
                <a:spLocks noChangeShapeType="1"/>
              </p:cNvSpPr>
              <p:nvPr/>
            </p:nvSpPr>
            <p:spPr bwMode="auto">
              <a:xfrm>
                <a:off x="649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8" name="Line 117">
                <a:extLst>
                  <a:ext uri="{FF2B5EF4-FFF2-40B4-BE49-F238E27FC236}">
                    <a16:creationId xmlns:a16="http://schemas.microsoft.com/office/drawing/2014/main" id="{5CF14DB3-0719-7124-5A1E-7A695BA1B60D}"/>
                  </a:ext>
                </a:extLst>
              </p:cNvPr>
              <p:cNvSpPr>
                <a:spLocks noChangeShapeType="1"/>
              </p:cNvSpPr>
              <p:nvPr/>
            </p:nvSpPr>
            <p:spPr bwMode="auto">
              <a:xfrm>
                <a:off x="6555"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29" name="Line 118">
                <a:extLst>
                  <a:ext uri="{FF2B5EF4-FFF2-40B4-BE49-F238E27FC236}">
                    <a16:creationId xmlns:a16="http://schemas.microsoft.com/office/drawing/2014/main" id="{BAE13382-7244-3E77-24CF-B603C901F330}"/>
                  </a:ext>
                </a:extLst>
              </p:cNvPr>
              <p:cNvSpPr>
                <a:spLocks noChangeShapeType="1"/>
              </p:cNvSpPr>
              <p:nvPr/>
            </p:nvSpPr>
            <p:spPr bwMode="auto">
              <a:xfrm>
                <a:off x="6620"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0" name="Line 119">
                <a:extLst>
                  <a:ext uri="{FF2B5EF4-FFF2-40B4-BE49-F238E27FC236}">
                    <a16:creationId xmlns:a16="http://schemas.microsoft.com/office/drawing/2014/main" id="{D0F570A8-ED53-66C0-0E6D-BDE6FF268381}"/>
                  </a:ext>
                </a:extLst>
              </p:cNvPr>
              <p:cNvSpPr>
                <a:spLocks noChangeShapeType="1"/>
              </p:cNvSpPr>
              <p:nvPr/>
            </p:nvSpPr>
            <p:spPr bwMode="auto">
              <a:xfrm>
                <a:off x="668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1" name="Line 120">
                <a:extLst>
                  <a:ext uri="{FF2B5EF4-FFF2-40B4-BE49-F238E27FC236}">
                    <a16:creationId xmlns:a16="http://schemas.microsoft.com/office/drawing/2014/main" id="{5D874ED1-7389-F1F6-EF7F-B76673E13EDA}"/>
                  </a:ext>
                </a:extLst>
              </p:cNvPr>
              <p:cNvSpPr>
                <a:spLocks noChangeShapeType="1"/>
              </p:cNvSpPr>
              <p:nvPr/>
            </p:nvSpPr>
            <p:spPr bwMode="auto">
              <a:xfrm>
                <a:off x="6751"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2" name="Rectangle 121">
                <a:extLst>
                  <a:ext uri="{FF2B5EF4-FFF2-40B4-BE49-F238E27FC236}">
                    <a16:creationId xmlns:a16="http://schemas.microsoft.com/office/drawing/2014/main" id="{B7B17B90-827B-AAF5-8617-24F8FAFE067D}"/>
                  </a:ext>
                </a:extLst>
              </p:cNvPr>
              <p:cNvSpPr>
                <a:spLocks noChangeArrowheads="1"/>
              </p:cNvSpPr>
              <p:nvPr/>
            </p:nvSpPr>
            <p:spPr bwMode="auto">
              <a:xfrm>
                <a:off x="6690"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3.75</a:t>
                </a:r>
                <a:endParaRPr lang="en-US" altLang="en-US" b="1"/>
              </a:p>
            </p:txBody>
          </p:sp>
          <p:sp>
            <p:nvSpPr>
              <p:cNvPr id="333" name="Line 122">
                <a:extLst>
                  <a:ext uri="{FF2B5EF4-FFF2-40B4-BE49-F238E27FC236}">
                    <a16:creationId xmlns:a16="http://schemas.microsoft.com/office/drawing/2014/main" id="{900DF14B-C5B5-EA4A-DCA7-53EC7E8B5D29}"/>
                  </a:ext>
                </a:extLst>
              </p:cNvPr>
              <p:cNvSpPr>
                <a:spLocks noChangeShapeType="1"/>
              </p:cNvSpPr>
              <p:nvPr/>
            </p:nvSpPr>
            <p:spPr bwMode="auto">
              <a:xfrm>
                <a:off x="6816"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4" name="Line 123">
                <a:extLst>
                  <a:ext uri="{FF2B5EF4-FFF2-40B4-BE49-F238E27FC236}">
                    <a16:creationId xmlns:a16="http://schemas.microsoft.com/office/drawing/2014/main" id="{4DB72A56-CA3E-9F11-B5F6-FFE9AFDDE812}"/>
                  </a:ext>
                </a:extLst>
              </p:cNvPr>
              <p:cNvSpPr>
                <a:spLocks noChangeShapeType="1"/>
              </p:cNvSpPr>
              <p:nvPr/>
            </p:nvSpPr>
            <p:spPr bwMode="auto">
              <a:xfrm>
                <a:off x="6881"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5" name="Line 124">
                <a:extLst>
                  <a:ext uri="{FF2B5EF4-FFF2-40B4-BE49-F238E27FC236}">
                    <a16:creationId xmlns:a16="http://schemas.microsoft.com/office/drawing/2014/main" id="{456676B1-E02B-391F-3EB1-D4AB98D0D07F}"/>
                  </a:ext>
                </a:extLst>
              </p:cNvPr>
              <p:cNvSpPr>
                <a:spLocks noChangeShapeType="1"/>
              </p:cNvSpPr>
              <p:nvPr/>
            </p:nvSpPr>
            <p:spPr bwMode="auto">
              <a:xfrm>
                <a:off x="6947"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6" name="Line 125">
                <a:extLst>
                  <a:ext uri="{FF2B5EF4-FFF2-40B4-BE49-F238E27FC236}">
                    <a16:creationId xmlns:a16="http://schemas.microsoft.com/office/drawing/2014/main" id="{0257D0B3-AF56-FBA4-E44F-5D03D84C9EBA}"/>
                  </a:ext>
                </a:extLst>
              </p:cNvPr>
              <p:cNvSpPr>
                <a:spLocks noChangeShapeType="1"/>
              </p:cNvSpPr>
              <p:nvPr/>
            </p:nvSpPr>
            <p:spPr bwMode="auto">
              <a:xfrm>
                <a:off x="7012" y="2193"/>
                <a:ext cx="0" cy="12"/>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7" name="Line 126">
                <a:extLst>
                  <a:ext uri="{FF2B5EF4-FFF2-40B4-BE49-F238E27FC236}">
                    <a16:creationId xmlns:a16="http://schemas.microsoft.com/office/drawing/2014/main" id="{D1FD6F14-5A71-E7C9-4C32-AE9BCF0B2371}"/>
                  </a:ext>
                </a:extLst>
              </p:cNvPr>
              <p:cNvSpPr>
                <a:spLocks noChangeShapeType="1"/>
              </p:cNvSpPr>
              <p:nvPr/>
            </p:nvSpPr>
            <p:spPr bwMode="auto">
              <a:xfrm>
                <a:off x="7077"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8" name="Line 127">
                <a:extLst>
                  <a:ext uri="{FF2B5EF4-FFF2-40B4-BE49-F238E27FC236}">
                    <a16:creationId xmlns:a16="http://schemas.microsoft.com/office/drawing/2014/main" id="{FAF89F56-B36D-F7DB-0503-398F3EE614B6}"/>
                  </a:ext>
                </a:extLst>
              </p:cNvPr>
              <p:cNvSpPr>
                <a:spLocks noChangeShapeType="1"/>
              </p:cNvSpPr>
              <p:nvPr/>
            </p:nvSpPr>
            <p:spPr bwMode="auto">
              <a:xfrm>
                <a:off x="7079" y="2193"/>
                <a:ext cx="0" cy="2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39" name="Rectangle 128">
                <a:extLst>
                  <a:ext uri="{FF2B5EF4-FFF2-40B4-BE49-F238E27FC236}">
                    <a16:creationId xmlns:a16="http://schemas.microsoft.com/office/drawing/2014/main" id="{C2CCADCB-E439-AF90-C747-E0D6714DFDD6}"/>
                  </a:ext>
                </a:extLst>
              </p:cNvPr>
              <p:cNvSpPr>
                <a:spLocks noChangeArrowheads="1"/>
              </p:cNvSpPr>
              <p:nvPr/>
            </p:nvSpPr>
            <p:spPr bwMode="auto">
              <a:xfrm>
                <a:off x="7020" y="2214"/>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1</a:t>
                </a:r>
                <a:endParaRPr lang="en-US" altLang="en-US" b="1"/>
              </a:p>
            </p:txBody>
          </p:sp>
          <p:sp>
            <p:nvSpPr>
              <p:cNvPr id="340" name="Line 129">
                <a:extLst>
                  <a:ext uri="{FF2B5EF4-FFF2-40B4-BE49-F238E27FC236}">
                    <a16:creationId xmlns:a16="http://schemas.microsoft.com/office/drawing/2014/main" id="{DE4B72A7-4708-793B-EEDE-41C9D0BC5DAD}"/>
                  </a:ext>
                </a:extLst>
              </p:cNvPr>
              <p:cNvSpPr>
                <a:spLocks noChangeShapeType="1"/>
              </p:cNvSpPr>
              <p:nvPr/>
            </p:nvSpPr>
            <p:spPr bwMode="auto">
              <a:xfrm>
                <a:off x="539" y="217"/>
                <a:ext cx="0" cy="196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1" name="Line 130">
                <a:extLst>
                  <a:ext uri="{FF2B5EF4-FFF2-40B4-BE49-F238E27FC236}">
                    <a16:creationId xmlns:a16="http://schemas.microsoft.com/office/drawing/2014/main" id="{FC7B51BB-8B2F-E61C-7C49-92DC8FEE086E}"/>
                  </a:ext>
                </a:extLst>
              </p:cNvPr>
              <p:cNvSpPr>
                <a:spLocks noChangeShapeType="1"/>
              </p:cNvSpPr>
              <p:nvPr/>
            </p:nvSpPr>
            <p:spPr bwMode="auto">
              <a:xfrm flipH="1">
                <a:off x="519" y="217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2" name="Line 132">
                <a:extLst>
                  <a:ext uri="{FF2B5EF4-FFF2-40B4-BE49-F238E27FC236}">
                    <a16:creationId xmlns:a16="http://schemas.microsoft.com/office/drawing/2014/main" id="{679000BA-DA70-594F-55C0-BC54DCDBE866}"/>
                  </a:ext>
                </a:extLst>
              </p:cNvPr>
              <p:cNvSpPr>
                <a:spLocks noChangeShapeType="1"/>
              </p:cNvSpPr>
              <p:nvPr/>
            </p:nvSpPr>
            <p:spPr bwMode="auto">
              <a:xfrm flipH="1">
                <a:off x="527" y="214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3" name="Line 133">
                <a:extLst>
                  <a:ext uri="{FF2B5EF4-FFF2-40B4-BE49-F238E27FC236}">
                    <a16:creationId xmlns:a16="http://schemas.microsoft.com/office/drawing/2014/main" id="{849C0F47-C9C0-C883-7B35-DF51CDE60AD7}"/>
                  </a:ext>
                </a:extLst>
              </p:cNvPr>
              <p:cNvSpPr>
                <a:spLocks noChangeShapeType="1"/>
              </p:cNvSpPr>
              <p:nvPr/>
            </p:nvSpPr>
            <p:spPr bwMode="auto">
              <a:xfrm flipH="1">
                <a:off x="527" y="210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4" name="Line 134">
                <a:extLst>
                  <a:ext uri="{FF2B5EF4-FFF2-40B4-BE49-F238E27FC236}">
                    <a16:creationId xmlns:a16="http://schemas.microsoft.com/office/drawing/2014/main" id="{6ADE46B7-E083-5FDA-DE7E-EBC0B102D5E3}"/>
                  </a:ext>
                </a:extLst>
              </p:cNvPr>
              <p:cNvSpPr>
                <a:spLocks noChangeShapeType="1"/>
              </p:cNvSpPr>
              <p:nvPr/>
            </p:nvSpPr>
            <p:spPr bwMode="auto">
              <a:xfrm flipH="1">
                <a:off x="519" y="207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5" name="Line 136">
                <a:extLst>
                  <a:ext uri="{FF2B5EF4-FFF2-40B4-BE49-F238E27FC236}">
                    <a16:creationId xmlns:a16="http://schemas.microsoft.com/office/drawing/2014/main" id="{4EC4C75F-B05C-82B6-2075-C15AB064DD9F}"/>
                  </a:ext>
                </a:extLst>
              </p:cNvPr>
              <p:cNvSpPr>
                <a:spLocks noChangeShapeType="1"/>
              </p:cNvSpPr>
              <p:nvPr/>
            </p:nvSpPr>
            <p:spPr bwMode="auto">
              <a:xfrm flipH="1">
                <a:off x="527" y="203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6" name="Line 137">
                <a:extLst>
                  <a:ext uri="{FF2B5EF4-FFF2-40B4-BE49-F238E27FC236}">
                    <a16:creationId xmlns:a16="http://schemas.microsoft.com/office/drawing/2014/main" id="{FFEF61B6-5932-C6F2-0E88-77E35A48412E}"/>
                  </a:ext>
                </a:extLst>
              </p:cNvPr>
              <p:cNvSpPr>
                <a:spLocks noChangeShapeType="1"/>
              </p:cNvSpPr>
              <p:nvPr/>
            </p:nvSpPr>
            <p:spPr bwMode="auto">
              <a:xfrm flipH="1">
                <a:off x="527" y="200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7" name="Line 138">
                <a:extLst>
                  <a:ext uri="{FF2B5EF4-FFF2-40B4-BE49-F238E27FC236}">
                    <a16:creationId xmlns:a16="http://schemas.microsoft.com/office/drawing/2014/main" id="{91315202-6BB9-492E-15F7-54974A2D9B9A}"/>
                  </a:ext>
                </a:extLst>
              </p:cNvPr>
              <p:cNvSpPr>
                <a:spLocks noChangeShapeType="1"/>
              </p:cNvSpPr>
              <p:nvPr/>
            </p:nvSpPr>
            <p:spPr bwMode="auto">
              <a:xfrm flipH="1">
                <a:off x="527" y="196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8" name="Line 139">
                <a:extLst>
                  <a:ext uri="{FF2B5EF4-FFF2-40B4-BE49-F238E27FC236}">
                    <a16:creationId xmlns:a16="http://schemas.microsoft.com/office/drawing/2014/main" id="{A06007C3-813D-2C6F-00A9-79A55AF7EF77}"/>
                  </a:ext>
                </a:extLst>
              </p:cNvPr>
              <p:cNvSpPr>
                <a:spLocks noChangeShapeType="1"/>
              </p:cNvSpPr>
              <p:nvPr/>
            </p:nvSpPr>
            <p:spPr bwMode="auto">
              <a:xfrm flipH="1">
                <a:off x="527" y="193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49" name="Line 140">
                <a:extLst>
                  <a:ext uri="{FF2B5EF4-FFF2-40B4-BE49-F238E27FC236}">
                    <a16:creationId xmlns:a16="http://schemas.microsoft.com/office/drawing/2014/main" id="{6005E147-755E-A4B8-FDB4-CB0375E25302}"/>
                  </a:ext>
                </a:extLst>
              </p:cNvPr>
              <p:cNvSpPr>
                <a:spLocks noChangeShapeType="1"/>
              </p:cNvSpPr>
              <p:nvPr/>
            </p:nvSpPr>
            <p:spPr bwMode="auto">
              <a:xfrm flipH="1">
                <a:off x="519" y="189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0" name="Rectangle 141">
                <a:extLst>
                  <a:ext uri="{FF2B5EF4-FFF2-40B4-BE49-F238E27FC236}">
                    <a16:creationId xmlns:a16="http://schemas.microsoft.com/office/drawing/2014/main" id="{9896C297-2E18-EF7E-8605-149D9D72237A}"/>
                  </a:ext>
                </a:extLst>
              </p:cNvPr>
              <p:cNvSpPr>
                <a:spLocks noChangeArrowheads="1"/>
              </p:cNvSpPr>
              <p:nvPr/>
            </p:nvSpPr>
            <p:spPr bwMode="auto">
              <a:xfrm>
                <a:off x="445" y="1871"/>
                <a:ext cx="103"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0.0</a:t>
                </a:r>
                <a:endParaRPr lang="en-US" altLang="en-US" b="1"/>
              </a:p>
            </p:txBody>
          </p:sp>
          <p:sp>
            <p:nvSpPr>
              <p:cNvPr id="351" name="Line 142">
                <a:extLst>
                  <a:ext uri="{FF2B5EF4-FFF2-40B4-BE49-F238E27FC236}">
                    <a16:creationId xmlns:a16="http://schemas.microsoft.com/office/drawing/2014/main" id="{C0B3AC28-B1CD-B3A2-08E9-AAEAA04DC1FD}"/>
                  </a:ext>
                </a:extLst>
              </p:cNvPr>
              <p:cNvSpPr>
                <a:spLocks noChangeShapeType="1"/>
              </p:cNvSpPr>
              <p:nvPr/>
            </p:nvSpPr>
            <p:spPr bwMode="auto">
              <a:xfrm flipH="1">
                <a:off x="527" y="186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2" name="Line 143">
                <a:extLst>
                  <a:ext uri="{FF2B5EF4-FFF2-40B4-BE49-F238E27FC236}">
                    <a16:creationId xmlns:a16="http://schemas.microsoft.com/office/drawing/2014/main" id="{63CD39AA-9F43-697B-A0D4-640955984545}"/>
                  </a:ext>
                </a:extLst>
              </p:cNvPr>
              <p:cNvSpPr>
                <a:spLocks noChangeShapeType="1"/>
              </p:cNvSpPr>
              <p:nvPr/>
            </p:nvSpPr>
            <p:spPr bwMode="auto">
              <a:xfrm flipH="1">
                <a:off x="527" y="182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3" name="Line 144">
                <a:extLst>
                  <a:ext uri="{FF2B5EF4-FFF2-40B4-BE49-F238E27FC236}">
                    <a16:creationId xmlns:a16="http://schemas.microsoft.com/office/drawing/2014/main" id="{FBEE88C4-C964-3C16-4C5A-87DD6FC6F5FD}"/>
                  </a:ext>
                </a:extLst>
              </p:cNvPr>
              <p:cNvSpPr>
                <a:spLocks noChangeShapeType="1"/>
              </p:cNvSpPr>
              <p:nvPr/>
            </p:nvSpPr>
            <p:spPr bwMode="auto">
              <a:xfrm flipH="1">
                <a:off x="527" y="179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4" name="Line 145">
                <a:extLst>
                  <a:ext uri="{FF2B5EF4-FFF2-40B4-BE49-F238E27FC236}">
                    <a16:creationId xmlns:a16="http://schemas.microsoft.com/office/drawing/2014/main" id="{60D0AF2B-FFA4-E2F0-80E0-D321E0E7B89B}"/>
                  </a:ext>
                </a:extLst>
              </p:cNvPr>
              <p:cNvSpPr>
                <a:spLocks noChangeShapeType="1"/>
              </p:cNvSpPr>
              <p:nvPr/>
            </p:nvSpPr>
            <p:spPr bwMode="auto">
              <a:xfrm flipH="1">
                <a:off x="527" y="175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5" name="Line 146">
                <a:extLst>
                  <a:ext uri="{FF2B5EF4-FFF2-40B4-BE49-F238E27FC236}">
                    <a16:creationId xmlns:a16="http://schemas.microsoft.com/office/drawing/2014/main" id="{3A05EA2E-19AC-5FE2-8305-D80F7A83B60C}"/>
                  </a:ext>
                </a:extLst>
              </p:cNvPr>
              <p:cNvSpPr>
                <a:spLocks noChangeShapeType="1"/>
              </p:cNvSpPr>
              <p:nvPr/>
            </p:nvSpPr>
            <p:spPr bwMode="auto">
              <a:xfrm flipH="1">
                <a:off x="519" y="172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6" name="Rectangle 147">
                <a:extLst>
                  <a:ext uri="{FF2B5EF4-FFF2-40B4-BE49-F238E27FC236}">
                    <a16:creationId xmlns:a16="http://schemas.microsoft.com/office/drawing/2014/main" id="{7D563959-6071-9B9C-A6AA-8664B98EBA80}"/>
                  </a:ext>
                </a:extLst>
              </p:cNvPr>
              <p:cNvSpPr>
                <a:spLocks noChangeArrowheads="1"/>
              </p:cNvSpPr>
              <p:nvPr/>
            </p:nvSpPr>
            <p:spPr bwMode="auto">
              <a:xfrm>
                <a:off x="420" y="1693"/>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a:t>
                </a:r>
                <a:endParaRPr lang="en-US" altLang="en-US" b="1"/>
              </a:p>
            </p:txBody>
          </p:sp>
          <p:sp>
            <p:nvSpPr>
              <p:cNvPr id="357" name="Line 148">
                <a:extLst>
                  <a:ext uri="{FF2B5EF4-FFF2-40B4-BE49-F238E27FC236}">
                    <a16:creationId xmlns:a16="http://schemas.microsoft.com/office/drawing/2014/main" id="{B8D32E55-AE56-3726-162D-EB92C3316675}"/>
                  </a:ext>
                </a:extLst>
              </p:cNvPr>
              <p:cNvSpPr>
                <a:spLocks noChangeShapeType="1"/>
              </p:cNvSpPr>
              <p:nvPr/>
            </p:nvSpPr>
            <p:spPr bwMode="auto">
              <a:xfrm flipH="1">
                <a:off x="527" y="168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8" name="Line 149">
                <a:extLst>
                  <a:ext uri="{FF2B5EF4-FFF2-40B4-BE49-F238E27FC236}">
                    <a16:creationId xmlns:a16="http://schemas.microsoft.com/office/drawing/2014/main" id="{F33883BF-F6D9-A560-FD26-0DDE01ABE710}"/>
                  </a:ext>
                </a:extLst>
              </p:cNvPr>
              <p:cNvSpPr>
                <a:spLocks noChangeShapeType="1"/>
              </p:cNvSpPr>
              <p:nvPr/>
            </p:nvSpPr>
            <p:spPr bwMode="auto">
              <a:xfrm flipH="1">
                <a:off x="527" y="165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59" name="Line 150">
                <a:extLst>
                  <a:ext uri="{FF2B5EF4-FFF2-40B4-BE49-F238E27FC236}">
                    <a16:creationId xmlns:a16="http://schemas.microsoft.com/office/drawing/2014/main" id="{0629C940-8AEB-83B4-C0AD-4D2DC63894A5}"/>
                  </a:ext>
                </a:extLst>
              </p:cNvPr>
              <p:cNvSpPr>
                <a:spLocks noChangeShapeType="1"/>
              </p:cNvSpPr>
              <p:nvPr/>
            </p:nvSpPr>
            <p:spPr bwMode="auto">
              <a:xfrm flipH="1">
                <a:off x="527" y="161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0" name="Line 151">
                <a:extLst>
                  <a:ext uri="{FF2B5EF4-FFF2-40B4-BE49-F238E27FC236}">
                    <a16:creationId xmlns:a16="http://schemas.microsoft.com/office/drawing/2014/main" id="{557BA49E-7ADB-033D-4645-42CA45CC1B79}"/>
                  </a:ext>
                </a:extLst>
              </p:cNvPr>
              <p:cNvSpPr>
                <a:spLocks noChangeShapeType="1"/>
              </p:cNvSpPr>
              <p:nvPr/>
            </p:nvSpPr>
            <p:spPr bwMode="auto">
              <a:xfrm flipH="1">
                <a:off x="527" y="158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1" name="Line 152">
                <a:extLst>
                  <a:ext uri="{FF2B5EF4-FFF2-40B4-BE49-F238E27FC236}">
                    <a16:creationId xmlns:a16="http://schemas.microsoft.com/office/drawing/2014/main" id="{9FCC7957-E337-7D83-BB38-033205157F9B}"/>
                  </a:ext>
                </a:extLst>
              </p:cNvPr>
              <p:cNvSpPr>
                <a:spLocks noChangeShapeType="1"/>
              </p:cNvSpPr>
              <p:nvPr/>
            </p:nvSpPr>
            <p:spPr bwMode="auto">
              <a:xfrm flipH="1">
                <a:off x="519" y="154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2" name="Rectangle 153">
                <a:extLst>
                  <a:ext uri="{FF2B5EF4-FFF2-40B4-BE49-F238E27FC236}">
                    <a16:creationId xmlns:a16="http://schemas.microsoft.com/office/drawing/2014/main" id="{DBC63504-EF6F-91D5-22A8-E67D36B6EDF5}"/>
                  </a:ext>
                </a:extLst>
              </p:cNvPr>
              <p:cNvSpPr>
                <a:spLocks noChangeArrowheads="1"/>
              </p:cNvSpPr>
              <p:nvPr/>
            </p:nvSpPr>
            <p:spPr bwMode="auto">
              <a:xfrm>
                <a:off x="420" y="1519"/>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a:t>
                </a:r>
                <a:endParaRPr lang="en-US" altLang="en-US" b="1"/>
              </a:p>
            </p:txBody>
          </p:sp>
          <p:sp>
            <p:nvSpPr>
              <p:cNvPr id="363" name="Line 154">
                <a:extLst>
                  <a:ext uri="{FF2B5EF4-FFF2-40B4-BE49-F238E27FC236}">
                    <a16:creationId xmlns:a16="http://schemas.microsoft.com/office/drawing/2014/main" id="{3354DCFE-0E93-338F-502B-F578D92395D9}"/>
                  </a:ext>
                </a:extLst>
              </p:cNvPr>
              <p:cNvSpPr>
                <a:spLocks noChangeShapeType="1"/>
              </p:cNvSpPr>
              <p:nvPr/>
            </p:nvSpPr>
            <p:spPr bwMode="auto">
              <a:xfrm flipH="1">
                <a:off x="527" y="151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4" name="Line 155">
                <a:extLst>
                  <a:ext uri="{FF2B5EF4-FFF2-40B4-BE49-F238E27FC236}">
                    <a16:creationId xmlns:a16="http://schemas.microsoft.com/office/drawing/2014/main" id="{EC3AEBFC-A967-21C9-3BAE-D76CD2302D88}"/>
                  </a:ext>
                </a:extLst>
              </p:cNvPr>
              <p:cNvSpPr>
                <a:spLocks noChangeShapeType="1"/>
              </p:cNvSpPr>
              <p:nvPr/>
            </p:nvSpPr>
            <p:spPr bwMode="auto">
              <a:xfrm flipH="1">
                <a:off x="527" y="147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5" name="Line 156">
                <a:extLst>
                  <a:ext uri="{FF2B5EF4-FFF2-40B4-BE49-F238E27FC236}">
                    <a16:creationId xmlns:a16="http://schemas.microsoft.com/office/drawing/2014/main" id="{8AE424C8-B16F-7721-4FF8-D4D774C49C85}"/>
                  </a:ext>
                </a:extLst>
              </p:cNvPr>
              <p:cNvSpPr>
                <a:spLocks noChangeShapeType="1"/>
              </p:cNvSpPr>
              <p:nvPr/>
            </p:nvSpPr>
            <p:spPr bwMode="auto">
              <a:xfrm flipH="1">
                <a:off x="527" y="144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6" name="Line 157">
                <a:extLst>
                  <a:ext uri="{FF2B5EF4-FFF2-40B4-BE49-F238E27FC236}">
                    <a16:creationId xmlns:a16="http://schemas.microsoft.com/office/drawing/2014/main" id="{EFE4E496-5CBC-C1B7-9870-95CF26735A8D}"/>
                  </a:ext>
                </a:extLst>
              </p:cNvPr>
              <p:cNvSpPr>
                <a:spLocks noChangeShapeType="1"/>
              </p:cNvSpPr>
              <p:nvPr/>
            </p:nvSpPr>
            <p:spPr bwMode="auto">
              <a:xfrm flipH="1">
                <a:off x="527" y="140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7" name="Line 158">
                <a:extLst>
                  <a:ext uri="{FF2B5EF4-FFF2-40B4-BE49-F238E27FC236}">
                    <a16:creationId xmlns:a16="http://schemas.microsoft.com/office/drawing/2014/main" id="{9CACEDF6-8F6C-D2D4-A293-02A6557A2064}"/>
                  </a:ext>
                </a:extLst>
              </p:cNvPr>
              <p:cNvSpPr>
                <a:spLocks noChangeShapeType="1"/>
              </p:cNvSpPr>
              <p:nvPr/>
            </p:nvSpPr>
            <p:spPr bwMode="auto">
              <a:xfrm flipH="1">
                <a:off x="519" y="137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68" name="Rectangle 159">
                <a:extLst>
                  <a:ext uri="{FF2B5EF4-FFF2-40B4-BE49-F238E27FC236}">
                    <a16:creationId xmlns:a16="http://schemas.microsoft.com/office/drawing/2014/main" id="{C56DA0CA-DEF4-7682-05CF-18C2DC8C07CA}"/>
                  </a:ext>
                </a:extLst>
              </p:cNvPr>
              <p:cNvSpPr>
                <a:spLocks noChangeArrowheads="1"/>
              </p:cNvSpPr>
              <p:nvPr/>
            </p:nvSpPr>
            <p:spPr bwMode="auto">
              <a:xfrm>
                <a:off x="420" y="1345"/>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37.5</a:t>
                </a:r>
                <a:endParaRPr lang="en-US" altLang="en-US" b="1"/>
              </a:p>
            </p:txBody>
          </p:sp>
          <p:sp>
            <p:nvSpPr>
              <p:cNvPr id="369" name="Line 160">
                <a:extLst>
                  <a:ext uri="{FF2B5EF4-FFF2-40B4-BE49-F238E27FC236}">
                    <a16:creationId xmlns:a16="http://schemas.microsoft.com/office/drawing/2014/main" id="{26A63E0C-4657-E9D4-7890-70B61FB5C83F}"/>
                  </a:ext>
                </a:extLst>
              </p:cNvPr>
              <p:cNvSpPr>
                <a:spLocks noChangeShapeType="1"/>
              </p:cNvSpPr>
              <p:nvPr/>
            </p:nvSpPr>
            <p:spPr bwMode="auto">
              <a:xfrm flipH="1">
                <a:off x="527" y="133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0" name="Line 161">
                <a:extLst>
                  <a:ext uri="{FF2B5EF4-FFF2-40B4-BE49-F238E27FC236}">
                    <a16:creationId xmlns:a16="http://schemas.microsoft.com/office/drawing/2014/main" id="{2D492255-6ABA-6AB9-1AFF-0C9548733E8E}"/>
                  </a:ext>
                </a:extLst>
              </p:cNvPr>
              <p:cNvSpPr>
                <a:spLocks noChangeShapeType="1"/>
              </p:cNvSpPr>
              <p:nvPr/>
            </p:nvSpPr>
            <p:spPr bwMode="auto">
              <a:xfrm flipH="1">
                <a:off x="527" y="130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1" name="Line 162">
                <a:extLst>
                  <a:ext uri="{FF2B5EF4-FFF2-40B4-BE49-F238E27FC236}">
                    <a16:creationId xmlns:a16="http://schemas.microsoft.com/office/drawing/2014/main" id="{C8A3B42F-D6FC-C716-4D2D-1B28AC75DCDF}"/>
                  </a:ext>
                </a:extLst>
              </p:cNvPr>
              <p:cNvSpPr>
                <a:spLocks noChangeShapeType="1"/>
              </p:cNvSpPr>
              <p:nvPr/>
            </p:nvSpPr>
            <p:spPr bwMode="auto">
              <a:xfrm flipH="1">
                <a:off x="527" y="126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2" name="Line 163">
                <a:extLst>
                  <a:ext uri="{FF2B5EF4-FFF2-40B4-BE49-F238E27FC236}">
                    <a16:creationId xmlns:a16="http://schemas.microsoft.com/office/drawing/2014/main" id="{9C71A578-1784-93B8-1A04-467FFFAC38E4}"/>
                  </a:ext>
                </a:extLst>
              </p:cNvPr>
              <p:cNvSpPr>
                <a:spLocks noChangeShapeType="1"/>
              </p:cNvSpPr>
              <p:nvPr/>
            </p:nvSpPr>
            <p:spPr bwMode="auto">
              <a:xfrm flipH="1">
                <a:off x="527" y="123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3" name="Line 164">
                <a:extLst>
                  <a:ext uri="{FF2B5EF4-FFF2-40B4-BE49-F238E27FC236}">
                    <a16:creationId xmlns:a16="http://schemas.microsoft.com/office/drawing/2014/main" id="{E525FB0B-A6B9-C8B3-18E2-6FA3091BE6A6}"/>
                  </a:ext>
                </a:extLst>
              </p:cNvPr>
              <p:cNvSpPr>
                <a:spLocks noChangeShapeType="1"/>
              </p:cNvSpPr>
              <p:nvPr/>
            </p:nvSpPr>
            <p:spPr bwMode="auto">
              <a:xfrm flipH="1">
                <a:off x="519" y="119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4" name="Rectangle 165">
                <a:extLst>
                  <a:ext uri="{FF2B5EF4-FFF2-40B4-BE49-F238E27FC236}">
                    <a16:creationId xmlns:a16="http://schemas.microsoft.com/office/drawing/2014/main" id="{0A2EECE6-15B7-3BEB-8F3B-9C9E42DF5008}"/>
                  </a:ext>
                </a:extLst>
              </p:cNvPr>
              <p:cNvSpPr>
                <a:spLocks noChangeArrowheads="1"/>
              </p:cNvSpPr>
              <p:nvPr/>
            </p:nvSpPr>
            <p:spPr bwMode="auto">
              <a:xfrm>
                <a:off x="420" y="1168"/>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50.0</a:t>
                </a:r>
                <a:endParaRPr lang="en-US" altLang="en-US" b="1"/>
              </a:p>
            </p:txBody>
          </p:sp>
          <p:sp>
            <p:nvSpPr>
              <p:cNvPr id="375" name="Line 166">
                <a:extLst>
                  <a:ext uri="{FF2B5EF4-FFF2-40B4-BE49-F238E27FC236}">
                    <a16:creationId xmlns:a16="http://schemas.microsoft.com/office/drawing/2014/main" id="{76852426-A092-4D4B-D633-EEF26E9C5018}"/>
                  </a:ext>
                </a:extLst>
              </p:cNvPr>
              <p:cNvSpPr>
                <a:spLocks noChangeShapeType="1"/>
              </p:cNvSpPr>
              <p:nvPr/>
            </p:nvSpPr>
            <p:spPr bwMode="auto">
              <a:xfrm flipH="1">
                <a:off x="527" y="116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6" name="Line 167">
                <a:extLst>
                  <a:ext uri="{FF2B5EF4-FFF2-40B4-BE49-F238E27FC236}">
                    <a16:creationId xmlns:a16="http://schemas.microsoft.com/office/drawing/2014/main" id="{0DEF266A-B0E6-AABD-EDA2-71EDBCA1A10F}"/>
                  </a:ext>
                </a:extLst>
              </p:cNvPr>
              <p:cNvSpPr>
                <a:spLocks noChangeShapeType="1"/>
              </p:cNvSpPr>
              <p:nvPr/>
            </p:nvSpPr>
            <p:spPr bwMode="auto">
              <a:xfrm flipH="1">
                <a:off x="527" y="112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7" name="Line 168">
                <a:extLst>
                  <a:ext uri="{FF2B5EF4-FFF2-40B4-BE49-F238E27FC236}">
                    <a16:creationId xmlns:a16="http://schemas.microsoft.com/office/drawing/2014/main" id="{56FF10A3-91EE-0F05-E50E-6907EFFB84ED}"/>
                  </a:ext>
                </a:extLst>
              </p:cNvPr>
              <p:cNvSpPr>
                <a:spLocks noChangeShapeType="1"/>
              </p:cNvSpPr>
              <p:nvPr/>
            </p:nvSpPr>
            <p:spPr bwMode="auto">
              <a:xfrm flipH="1">
                <a:off x="527" y="109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8" name="Line 169">
                <a:extLst>
                  <a:ext uri="{FF2B5EF4-FFF2-40B4-BE49-F238E27FC236}">
                    <a16:creationId xmlns:a16="http://schemas.microsoft.com/office/drawing/2014/main" id="{2872E8D7-39D2-DBDC-4BD0-84B4B7155EA3}"/>
                  </a:ext>
                </a:extLst>
              </p:cNvPr>
              <p:cNvSpPr>
                <a:spLocks noChangeShapeType="1"/>
              </p:cNvSpPr>
              <p:nvPr/>
            </p:nvSpPr>
            <p:spPr bwMode="auto">
              <a:xfrm flipH="1">
                <a:off x="527" y="105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79" name="Line 170">
                <a:extLst>
                  <a:ext uri="{FF2B5EF4-FFF2-40B4-BE49-F238E27FC236}">
                    <a16:creationId xmlns:a16="http://schemas.microsoft.com/office/drawing/2014/main" id="{9FEF8318-09F5-3D03-CB0F-D6F22D7EAFA4}"/>
                  </a:ext>
                </a:extLst>
              </p:cNvPr>
              <p:cNvSpPr>
                <a:spLocks noChangeShapeType="1"/>
              </p:cNvSpPr>
              <p:nvPr/>
            </p:nvSpPr>
            <p:spPr bwMode="auto">
              <a:xfrm flipH="1">
                <a:off x="519" y="102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0" name="Rectangle 171">
                <a:extLst>
                  <a:ext uri="{FF2B5EF4-FFF2-40B4-BE49-F238E27FC236}">
                    <a16:creationId xmlns:a16="http://schemas.microsoft.com/office/drawing/2014/main" id="{DD2B79F9-C186-6158-39AD-5EAA78D59F61}"/>
                  </a:ext>
                </a:extLst>
              </p:cNvPr>
              <p:cNvSpPr>
                <a:spLocks noChangeArrowheads="1"/>
              </p:cNvSpPr>
              <p:nvPr/>
            </p:nvSpPr>
            <p:spPr bwMode="auto">
              <a:xfrm>
                <a:off x="420" y="994"/>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dirty="0">
                    <a:solidFill>
                      <a:srgbClr val="000000"/>
                    </a:solidFill>
                  </a:rPr>
                  <a:t>62.5</a:t>
                </a:r>
                <a:endParaRPr lang="en-US" altLang="en-US" b="1" dirty="0"/>
              </a:p>
            </p:txBody>
          </p:sp>
          <p:sp>
            <p:nvSpPr>
              <p:cNvPr id="381" name="Line 172">
                <a:extLst>
                  <a:ext uri="{FF2B5EF4-FFF2-40B4-BE49-F238E27FC236}">
                    <a16:creationId xmlns:a16="http://schemas.microsoft.com/office/drawing/2014/main" id="{9BE97B4C-6742-6F58-CB5C-FF5114A97288}"/>
                  </a:ext>
                </a:extLst>
              </p:cNvPr>
              <p:cNvSpPr>
                <a:spLocks noChangeShapeType="1"/>
              </p:cNvSpPr>
              <p:nvPr/>
            </p:nvSpPr>
            <p:spPr bwMode="auto">
              <a:xfrm flipH="1">
                <a:off x="527" y="98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2" name="Line 173">
                <a:extLst>
                  <a:ext uri="{FF2B5EF4-FFF2-40B4-BE49-F238E27FC236}">
                    <a16:creationId xmlns:a16="http://schemas.microsoft.com/office/drawing/2014/main" id="{BFD95C2A-0A5F-374F-92D2-142BE1AF8FBA}"/>
                  </a:ext>
                </a:extLst>
              </p:cNvPr>
              <p:cNvSpPr>
                <a:spLocks noChangeShapeType="1"/>
              </p:cNvSpPr>
              <p:nvPr/>
            </p:nvSpPr>
            <p:spPr bwMode="auto">
              <a:xfrm flipH="1">
                <a:off x="527" y="95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3" name="Line 174">
                <a:extLst>
                  <a:ext uri="{FF2B5EF4-FFF2-40B4-BE49-F238E27FC236}">
                    <a16:creationId xmlns:a16="http://schemas.microsoft.com/office/drawing/2014/main" id="{1B66FDAE-82F1-1E5A-E29A-2159F3B1B5F2}"/>
                  </a:ext>
                </a:extLst>
              </p:cNvPr>
              <p:cNvSpPr>
                <a:spLocks noChangeShapeType="1"/>
              </p:cNvSpPr>
              <p:nvPr/>
            </p:nvSpPr>
            <p:spPr bwMode="auto">
              <a:xfrm flipH="1">
                <a:off x="527" y="91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4" name="Line 175">
                <a:extLst>
                  <a:ext uri="{FF2B5EF4-FFF2-40B4-BE49-F238E27FC236}">
                    <a16:creationId xmlns:a16="http://schemas.microsoft.com/office/drawing/2014/main" id="{89DF861A-F8DE-E955-DA2D-4E68100DFE25}"/>
                  </a:ext>
                </a:extLst>
              </p:cNvPr>
              <p:cNvSpPr>
                <a:spLocks noChangeShapeType="1"/>
              </p:cNvSpPr>
              <p:nvPr/>
            </p:nvSpPr>
            <p:spPr bwMode="auto">
              <a:xfrm flipH="1">
                <a:off x="527" y="88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5" name="Line 176">
                <a:extLst>
                  <a:ext uri="{FF2B5EF4-FFF2-40B4-BE49-F238E27FC236}">
                    <a16:creationId xmlns:a16="http://schemas.microsoft.com/office/drawing/2014/main" id="{B1E45B57-1A7A-3509-6FA3-F639C7010777}"/>
                  </a:ext>
                </a:extLst>
              </p:cNvPr>
              <p:cNvSpPr>
                <a:spLocks noChangeShapeType="1"/>
              </p:cNvSpPr>
              <p:nvPr/>
            </p:nvSpPr>
            <p:spPr bwMode="auto">
              <a:xfrm flipH="1">
                <a:off x="519" y="84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6" name="Rectangle 177">
                <a:extLst>
                  <a:ext uri="{FF2B5EF4-FFF2-40B4-BE49-F238E27FC236}">
                    <a16:creationId xmlns:a16="http://schemas.microsoft.com/office/drawing/2014/main" id="{B2997C7B-1790-5E94-9396-8087F35F3C2B}"/>
                  </a:ext>
                </a:extLst>
              </p:cNvPr>
              <p:cNvSpPr>
                <a:spLocks noChangeArrowheads="1"/>
              </p:cNvSpPr>
              <p:nvPr/>
            </p:nvSpPr>
            <p:spPr bwMode="auto">
              <a:xfrm>
                <a:off x="420" y="820"/>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75.0</a:t>
                </a:r>
                <a:endParaRPr lang="en-US" altLang="en-US" b="1"/>
              </a:p>
            </p:txBody>
          </p:sp>
          <p:sp>
            <p:nvSpPr>
              <p:cNvPr id="387" name="Line 178">
                <a:extLst>
                  <a:ext uri="{FF2B5EF4-FFF2-40B4-BE49-F238E27FC236}">
                    <a16:creationId xmlns:a16="http://schemas.microsoft.com/office/drawing/2014/main" id="{8D62EF30-3C01-2348-8AD3-B08136F473A9}"/>
                  </a:ext>
                </a:extLst>
              </p:cNvPr>
              <p:cNvSpPr>
                <a:spLocks noChangeShapeType="1"/>
              </p:cNvSpPr>
              <p:nvPr/>
            </p:nvSpPr>
            <p:spPr bwMode="auto">
              <a:xfrm flipH="1">
                <a:off x="527" y="81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8" name="Line 179">
                <a:extLst>
                  <a:ext uri="{FF2B5EF4-FFF2-40B4-BE49-F238E27FC236}">
                    <a16:creationId xmlns:a16="http://schemas.microsoft.com/office/drawing/2014/main" id="{92796DFE-C9AB-70F3-0A99-8AB736938C31}"/>
                  </a:ext>
                </a:extLst>
              </p:cNvPr>
              <p:cNvSpPr>
                <a:spLocks noChangeShapeType="1"/>
              </p:cNvSpPr>
              <p:nvPr/>
            </p:nvSpPr>
            <p:spPr bwMode="auto">
              <a:xfrm flipH="1">
                <a:off x="527" y="77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89" name="Line 180">
                <a:extLst>
                  <a:ext uri="{FF2B5EF4-FFF2-40B4-BE49-F238E27FC236}">
                    <a16:creationId xmlns:a16="http://schemas.microsoft.com/office/drawing/2014/main" id="{C627061C-FA65-614D-048A-D1A4E5BF2FF1}"/>
                  </a:ext>
                </a:extLst>
              </p:cNvPr>
              <p:cNvSpPr>
                <a:spLocks noChangeShapeType="1"/>
              </p:cNvSpPr>
              <p:nvPr/>
            </p:nvSpPr>
            <p:spPr bwMode="auto">
              <a:xfrm flipH="1">
                <a:off x="527" y="74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0" name="Line 181">
                <a:extLst>
                  <a:ext uri="{FF2B5EF4-FFF2-40B4-BE49-F238E27FC236}">
                    <a16:creationId xmlns:a16="http://schemas.microsoft.com/office/drawing/2014/main" id="{B7569FC4-DA79-B242-1492-F52631CC7BD1}"/>
                  </a:ext>
                </a:extLst>
              </p:cNvPr>
              <p:cNvSpPr>
                <a:spLocks noChangeShapeType="1"/>
              </p:cNvSpPr>
              <p:nvPr/>
            </p:nvSpPr>
            <p:spPr bwMode="auto">
              <a:xfrm flipH="1">
                <a:off x="527" y="70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1" name="Line 182">
                <a:extLst>
                  <a:ext uri="{FF2B5EF4-FFF2-40B4-BE49-F238E27FC236}">
                    <a16:creationId xmlns:a16="http://schemas.microsoft.com/office/drawing/2014/main" id="{62EFFF17-C83E-B8A5-ED76-A415145F5CB5}"/>
                  </a:ext>
                </a:extLst>
              </p:cNvPr>
              <p:cNvSpPr>
                <a:spLocks noChangeShapeType="1"/>
              </p:cNvSpPr>
              <p:nvPr/>
            </p:nvSpPr>
            <p:spPr bwMode="auto">
              <a:xfrm flipH="1">
                <a:off x="519" y="67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2" name="Rectangle 183">
                <a:extLst>
                  <a:ext uri="{FF2B5EF4-FFF2-40B4-BE49-F238E27FC236}">
                    <a16:creationId xmlns:a16="http://schemas.microsoft.com/office/drawing/2014/main" id="{0AB8538C-2B92-3CD3-B17B-5E9B46944469}"/>
                  </a:ext>
                </a:extLst>
              </p:cNvPr>
              <p:cNvSpPr>
                <a:spLocks noChangeArrowheads="1"/>
              </p:cNvSpPr>
              <p:nvPr/>
            </p:nvSpPr>
            <p:spPr bwMode="auto">
              <a:xfrm>
                <a:off x="420" y="643"/>
                <a:ext cx="144"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87.5</a:t>
                </a:r>
                <a:endParaRPr lang="en-US" altLang="en-US" b="1"/>
              </a:p>
            </p:txBody>
          </p:sp>
          <p:sp>
            <p:nvSpPr>
              <p:cNvPr id="393" name="Line 184">
                <a:extLst>
                  <a:ext uri="{FF2B5EF4-FFF2-40B4-BE49-F238E27FC236}">
                    <a16:creationId xmlns:a16="http://schemas.microsoft.com/office/drawing/2014/main" id="{383344DD-E363-6AA7-C394-285C1033835E}"/>
                  </a:ext>
                </a:extLst>
              </p:cNvPr>
              <p:cNvSpPr>
                <a:spLocks noChangeShapeType="1"/>
              </p:cNvSpPr>
              <p:nvPr/>
            </p:nvSpPr>
            <p:spPr bwMode="auto">
              <a:xfrm flipH="1">
                <a:off x="527" y="63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4" name="Line 185">
                <a:extLst>
                  <a:ext uri="{FF2B5EF4-FFF2-40B4-BE49-F238E27FC236}">
                    <a16:creationId xmlns:a16="http://schemas.microsoft.com/office/drawing/2014/main" id="{2E6C49F9-FA3D-5AE4-1CFF-39B9556057F9}"/>
                  </a:ext>
                </a:extLst>
              </p:cNvPr>
              <p:cNvSpPr>
                <a:spLocks noChangeShapeType="1"/>
              </p:cNvSpPr>
              <p:nvPr/>
            </p:nvSpPr>
            <p:spPr bwMode="auto">
              <a:xfrm flipH="1">
                <a:off x="527" y="60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5" name="Line 186">
                <a:extLst>
                  <a:ext uri="{FF2B5EF4-FFF2-40B4-BE49-F238E27FC236}">
                    <a16:creationId xmlns:a16="http://schemas.microsoft.com/office/drawing/2014/main" id="{E8F61987-50B9-BA4F-5863-9014A5123478}"/>
                  </a:ext>
                </a:extLst>
              </p:cNvPr>
              <p:cNvSpPr>
                <a:spLocks noChangeShapeType="1"/>
              </p:cNvSpPr>
              <p:nvPr/>
            </p:nvSpPr>
            <p:spPr bwMode="auto">
              <a:xfrm flipH="1">
                <a:off x="527" y="56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6" name="Line 187">
                <a:extLst>
                  <a:ext uri="{FF2B5EF4-FFF2-40B4-BE49-F238E27FC236}">
                    <a16:creationId xmlns:a16="http://schemas.microsoft.com/office/drawing/2014/main" id="{89EDB0B5-F6AA-CB7D-29A0-67DE3DBE603E}"/>
                  </a:ext>
                </a:extLst>
              </p:cNvPr>
              <p:cNvSpPr>
                <a:spLocks noChangeShapeType="1"/>
              </p:cNvSpPr>
              <p:nvPr/>
            </p:nvSpPr>
            <p:spPr bwMode="auto">
              <a:xfrm flipH="1">
                <a:off x="527" y="53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7" name="Line 188">
                <a:extLst>
                  <a:ext uri="{FF2B5EF4-FFF2-40B4-BE49-F238E27FC236}">
                    <a16:creationId xmlns:a16="http://schemas.microsoft.com/office/drawing/2014/main" id="{11160C1B-713D-0D3E-D516-41239F2117CB}"/>
                  </a:ext>
                </a:extLst>
              </p:cNvPr>
              <p:cNvSpPr>
                <a:spLocks noChangeShapeType="1"/>
              </p:cNvSpPr>
              <p:nvPr/>
            </p:nvSpPr>
            <p:spPr bwMode="auto">
              <a:xfrm flipH="1">
                <a:off x="519" y="49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398" name="Rectangle 189">
                <a:extLst>
                  <a:ext uri="{FF2B5EF4-FFF2-40B4-BE49-F238E27FC236}">
                    <a16:creationId xmlns:a16="http://schemas.microsoft.com/office/drawing/2014/main" id="{B13EBE64-18D6-A984-0E69-37A3FB656A5A}"/>
                  </a:ext>
                </a:extLst>
              </p:cNvPr>
              <p:cNvSpPr>
                <a:spLocks noChangeArrowheads="1"/>
              </p:cNvSpPr>
              <p:nvPr/>
            </p:nvSpPr>
            <p:spPr bwMode="auto">
              <a:xfrm>
                <a:off x="394" y="469"/>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00.0</a:t>
                </a:r>
                <a:endParaRPr lang="en-US" altLang="en-US" b="1"/>
              </a:p>
            </p:txBody>
          </p:sp>
          <p:sp>
            <p:nvSpPr>
              <p:cNvPr id="399" name="Line 190">
                <a:extLst>
                  <a:ext uri="{FF2B5EF4-FFF2-40B4-BE49-F238E27FC236}">
                    <a16:creationId xmlns:a16="http://schemas.microsoft.com/office/drawing/2014/main" id="{D167A059-FA31-66CB-1450-DFF3BF1CD19E}"/>
                  </a:ext>
                </a:extLst>
              </p:cNvPr>
              <p:cNvSpPr>
                <a:spLocks noChangeShapeType="1"/>
              </p:cNvSpPr>
              <p:nvPr/>
            </p:nvSpPr>
            <p:spPr bwMode="auto">
              <a:xfrm flipH="1">
                <a:off x="527" y="46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0" name="Line 191">
                <a:extLst>
                  <a:ext uri="{FF2B5EF4-FFF2-40B4-BE49-F238E27FC236}">
                    <a16:creationId xmlns:a16="http://schemas.microsoft.com/office/drawing/2014/main" id="{DDA269AC-B2B9-A9F7-2C18-936F43F51A79}"/>
                  </a:ext>
                </a:extLst>
              </p:cNvPr>
              <p:cNvSpPr>
                <a:spLocks noChangeShapeType="1"/>
              </p:cNvSpPr>
              <p:nvPr/>
            </p:nvSpPr>
            <p:spPr bwMode="auto">
              <a:xfrm flipH="1">
                <a:off x="527" y="42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1" name="Line 192">
                <a:extLst>
                  <a:ext uri="{FF2B5EF4-FFF2-40B4-BE49-F238E27FC236}">
                    <a16:creationId xmlns:a16="http://schemas.microsoft.com/office/drawing/2014/main" id="{2F205453-BCF0-D28C-E313-87B321BE5C6C}"/>
                  </a:ext>
                </a:extLst>
              </p:cNvPr>
              <p:cNvSpPr>
                <a:spLocks noChangeShapeType="1"/>
              </p:cNvSpPr>
              <p:nvPr/>
            </p:nvSpPr>
            <p:spPr bwMode="auto">
              <a:xfrm flipH="1">
                <a:off x="527" y="39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2" name="Line 193">
                <a:extLst>
                  <a:ext uri="{FF2B5EF4-FFF2-40B4-BE49-F238E27FC236}">
                    <a16:creationId xmlns:a16="http://schemas.microsoft.com/office/drawing/2014/main" id="{5960427C-6CB0-D8CD-A6A5-773D711EDCBE}"/>
                  </a:ext>
                </a:extLst>
              </p:cNvPr>
              <p:cNvSpPr>
                <a:spLocks noChangeShapeType="1"/>
              </p:cNvSpPr>
              <p:nvPr/>
            </p:nvSpPr>
            <p:spPr bwMode="auto">
              <a:xfrm flipH="1">
                <a:off x="527" y="35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3" name="Line 194">
                <a:extLst>
                  <a:ext uri="{FF2B5EF4-FFF2-40B4-BE49-F238E27FC236}">
                    <a16:creationId xmlns:a16="http://schemas.microsoft.com/office/drawing/2014/main" id="{13D0F265-0EFA-4C8B-9BB1-39222D823471}"/>
                  </a:ext>
                </a:extLst>
              </p:cNvPr>
              <p:cNvSpPr>
                <a:spLocks noChangeShapeType="1"/>
              </p:cNvSpPr>
              <p:nvPr/>
            </p:nvSpPr>
            <p:spPr bwMode="auto">
              <a:xfrm flipH="1">
                <a:off x="519" y="322"/>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4" name="Rectangle 195">
                <a:extLst>
                  <a:ext uri="{FF2B5EF4-FFF2-40B4-BE49-F238E27FC236}">
                    <a16:creationId xmlns:a16="http://schemas.microsoft.com/office/drawing/2014/main" id="{7563AC24-831B-F88F-C9D0-FB514F867EBF}"/>
                  </a:ext>
                </a:extLst>
              </p:cNvPr>
              <p:cNvSpPr>
                <a:spLocks noChangeArrowheads="1"/>
              </p:cNvSpPr>
              <p:nvPr/>
            </p:nvSpPr>
            <p:spPr bwMode="auto">
              <a:xfrm>
                <a:off x="394" y="295"/>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dirty="0">
                    <a:solidFill>
                      <a:srgbClr val="000000"/>
                    </a:solidFill>
                  </a:rPr>
                  <a:t>112.5</a:t>
                </a:r>
                <a:endParaRPr lang="en-US" altLang="en-US" b="1" dirty="0"/>
              </a:p>
            </p:txBody>
          </p:sp>
          <p:sp>
            <p:nvSpPr>
              <p:cNvPr id="405" name="Line 196">
                <a:extLst>
                  <a:ext uri="{FF2B5EF4-FFF2-40B4-BE49-F238E27FC236}">
                    <a16:creationId xmlns:a16="http://schemas.microsoft.com/office/drawing/2014/main" id="{A1975349-9752-606A-9424-F0D7B5695E13}"/>
                  </a:ext>
                </a:extLst>
              </p:cNvPr>
              <p:cNvSpPr>
                <a:spLocks noChangeShapeType="1"/>
              </p:cNvSpPr>
              <p:nvPr/>
            </p:nvSpPr>
            <p:spPr bwMode="auto">
              <a:xfrm flipH="1">
                <a:off x="527" y="28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6" name="Line 197">
                <a:extLst>
                  <a:ext uri="{FF2B5EF4-FFF2-40B4-BE49-F238E27FC236}">
                    <a16:creationId xmlns:a16="http://schemas.microsoft.com/office/drawing/2014/main" id="{5E9F4A37-9D7C-6F32-ACF3-034AC7311861}"/>
                  </a:ext>
                </a:extLst>
              </p:cNvPr>
              <p:cNvSpPr>
                <a:spLocks noChangeShapeType="1"/>
              </p:cNvSpPr>
              <p:nvPr/>
            </p:nvSpPr>
            <p:spPr bwMode="auto">
              <a:xfrm flipH="1">
                <a:off x="527" y="25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7" name="Line 198">
                <a:extLst>
                  <a:ext uri="{FF2B5EF4-FFF2-40B4-BE49-F238E27FC236}">
                    <a16:creationId xmlns:a16="http://schemas.microsoft.com/office/drawing/2014/main" id="{BF424956-7173-020C-C991-7016D2DAFA62}"/>
                  </a:ext>
                </a:extLst>
              </p:cNvPr>
              <p:cNvSpPr>
                <a:spLocks noChangeShapeType="1"/>
              </p:cNvSpPr>
              <p:nvPr/>
            </p:nvSpPr>
            <p:spPr bwMode="auto">
              <a:xfrm flipH="1">
                <a:off x="527" y="21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8" name="Line 199">
                <a:extLst>
                  <a:ext uri="{FF2B5EF4-FFF2-40B4-BE49-F238E27FC236}">
                    <a16:creationId xmlns:a16="http://schemas.microsoft.com/office/drawing/2014/main" id="{E89013AD-42A0-ED4F-245E-A8F37C208449}"/>
                  </a:ext>
                </a:extLst>
              </p:cNvPr>
              <p:cNvSpPr>
                <a:spLocks noChangeShapeType="1"/>
              </p:cNvSpPr>
              <p:nvPr/>
            </p:nvSpPr>
            <p:spPr bwMode="auto">
              <a:xfrm flipH="1">
                <a:off x="519" y="21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09" name="Rectangle 200">
                <a:extLst>
                  <a:ext uri="{FF2B5EF4-FFF2-40B4-BE49-F238E27FC236}">
                    <a16:creationId xmlns:a16="http://schemas.microsoft.com/office/drawing/2014/main" id="{D1BEEF37-F56F-7F2F-644F-AABBC2ACA9C5}"/>
                  </a:ext>
                </a:extLst>
              </p:cNvPr>
              <p:cNvSpPr>
                <a:spLocks noChangeArrowheads="1"/>
              </p:cNvSpPr>
              <p:nvPr/>
            </p:nvSpPr>
            <p:spPr bwMode="auto">
              <a:xfrm>
                <a:off x="394" y="189"/>
                <a:ext cx="185"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dirty="0">
                    <a:solidFill>
                      <a:srgbClr val="000000"/>
                    </a:solidFill>
                  </a:rPr>
                  <a:t>120.0</a:t>
                </a:r>
                <a:endParaRPr lang="en-US" altLang="en-US" b="1" dirty="0"/>
              </a:p>
            </p:txBody>
          </p:sp>
          <p:sp>
            <p:nvSpPr>
              <p:cNvPr id="410" name="Rectangle 201">
                <a:extLst>
                  <a:ext uri="{FF2B5EF4-FFF2-40B4-BE49-F238E27FC236}">
                    <a16:creationId xmlns:a16="http://schemas.microsoft.com/office/drawing/2014/main" id="{1666FBA5-4B12-D5EA-7C29-48022BF25D76}"/>
                  </a:ext>
                </a:extLst>
              </p:cNvPr>
              <p:cNvSpPr>
                <a:spLocks noChangeArrowheads="1"/>
              </p:cNvSpPr>
              <p:nvPr/>
            </p:nvSpPr>
            <p:spPr bwMode="auto">
              <a:xfrm>
                <a:off x="555" y="217"/>
                <a:ext cx="6524" cy="196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81213" tIns="40607" rIns="81213" bIns="40607" numCol="1" anchor="t" anchorCtr="0" compatLnSpc="1">
                <a:prstTxWarp prst="textNoShape">
                  <a:avLst/>
                </a:prstTxWarp>
              </a:bodyPr>
              <a:lstStyle/>
              <a:p>
                <a:endParaRPr lang="en-US" b="1"/>
              </a:p>
            </p:txBody>
          </p:sp>
          <p:sp>
            <p:nvSpPr>
              <p:cNvPr id="411" name="Freeform 202">
                <a:extLst>
                  <a:ext uri="{FF2B5EF4-FFF2-40B4-BE49-F238E27FC236}">
                    <a16:creationId xmlns:a16="http://schemas.microsoft.com/office/drawing/2014/main" id="{E38BAB6A-C22B-1D2E-FB8F-F02E36B10D76}"/>
                  </a:ext>
                </a:extLst>
              </p:cNvPr>
              <p:cNvSpPr>
                <a:spLocks/>
              </p:cNvSpPr>
              <p:nvPr/>
            </p:nvSpPr>
            <p:spPr bwMode="auto">
              <a:xfrm>
                <a:off x="555" y="314"/>
                <a:ext cx="6524" cy="1615"/>
              </a:xfrm>
              <a:custGeom>
                <a:avLst/>
                <a:gdLst>
                  <a:gd name="T0" fmla="*/ 105 w 6524"/>
                  <a:gd name="T1" fmla="*/ 1577 h 1615"/>
                  <a:gd name="T2" fmla="*/ 213 w 6524"/>
                  <a:gd name="T3" fmla="*/ 1577 h 1615"/>
                  <a:gd name="T4" fmla="*/ 322 w 6524"/>
                  <a:gd name="T5" fmla="*/ 1577 h 1615"/>
                  <a:gd name="T6" fmla="*/ 431 w 6524"/>
                  <a:gd name="T7" fmla="*/ 1577 h 1615"/>
                  <a:gd name="T8" fmla="*/ 540 w 6524"/>
                  <a:gd name="T9" fmla="*/ 1576 h 1615"/>
                  <a:gd name="T10" fmla="*/ 648 w 6524"/>
                  <a:gd name="T11" fmla="*/ 1575 h 1615"/>
                  <a:gd name="T12" fmla="*/ 757 w 6524"/>
                  <a:gd name="T13" fmla="*/ 1547 h 1615"/>
                  <a:gd name="T14" fmla="*/ 849 w 6524"/>
                  <a:gd name="T15" fmla="*/ 1613 h 1615"/>
                  <a:gd name="T16" fmla="*/ 957 w 6524"/>
                  <a:gd name="T17" fmla="*/ 1602 h 1615"/>
                  <a:gd name="T18" fmla="*/ 1062 w 6524"/>
                  <a:gd name="T19" fmla="*/ 1184 h 1615"/>
                  <a:gd name="T20" fmla="*/ 1153 w 6524"/>
                  <a:gd name="T21" fmla="*/ 1555 h 1615"/>
                  <a:gd name="T22" fmla="*/ 1262 w 6524"/>
                  <a:gd name="T23" fmla="*/ 1565 h 1615"/>
                  <a:gd name="T24" fmla="*/ 1370 w 6524"/>
                  <a:gd name="T25" fmla="*/ 1547 h 1615"/>
                  <a:gd name="T26" fmla="*/ 1479 w 6524"/>
                  <a:gd name="T27" fmla="*/ 1552 h 1615"/>
                  <a:gd name="T28" fmla="*/ 1588 w 6524"/>
                  <a:gd name="T29" fmla="*/ 1535 h 1615"/>
                  <a:gd name="T30" fmla="*/ 1696 w 6524"/>
                  <a:gd name="T31" fmla="*/ 1537 h 1615"/>
                  <a:gd name="T32" fmla="*/ 1805 w 6524"/>
                  <a:gd name="T33" fmla="*/ 1507 h 1615"/>
                  <a:gd name="T34" fmla="*/ 1897 w 6524"/>
                  <a:gd name="T35" fmla="*/ 1230 h 1615"/>
                  <a:gd name="T36" fmla="*/ 1992 w 6524"/>
                  <a:gd name="T37" fmla="*/ 1458 h 1615"/>
                  <a:gd name="T38" fmla="*/ 2101 w 6524"/>
                  <a:gd name="T39" fmla="*/ 1506 h 1615"/>
                  <a:gd name="T40" fmla="*/ 2205 w 6524"/>
                  <a:gd name="T41" fmla="*/ 1296 h 1615"/>
                  <a:gd name="T42" fmla="*/ 2305 w 6524"/>
                  <a:gd name="T43" fmla="*/ 1515 h 1615"/>
                  <a:gd name="T44" fmla="*/ 2401 w 6524"/>
                  <a:gd name="T45" fmla="*/ 1535 h 1615"/>
                  <a:gd name="T46" fmla="*/ 2510 w 6524"/>
                  <a:gd name="T47" fmla="*/ 1447 h 1615"/>
                  <a:gd name="T48" fmla="*/ 2618 w 6524"/>
                  <a:gd name="T49" fmla="*/ 1548 h 1615"/>
                  <a:gd name="T50" fmla="*/ 2727 w 6524"/>
                  <a:gd name="T51" fmla="*/ 1557 h 1615"/>
                  <a:gd name="T52" fmla="*/ 2836 w 6524"/>
                  <a:gd name="T53" fmla="*/ 1562 h 1615"/>
                  <a:gd name="T54" fmla="*/ 2919 w 6524"/>
                  <a:gd name="T55" fmla="*/ 105 h 1615"/>
                  <a:gd name="T56" fmla="*/ 3006 w 6524"/>
                  <a:gd name="T57" fmla="*/ 1572 h 1615"/>
                  <a:gd name="T58" fmla="*/ 3114 w 6524"/>
                  <a:gd name="T59" fmla="*/ 1576 h 1615"/>
                  <a:gd name="T60" fmla="*/ 3223 w 6524"/>
                  <a:gd name="T61" fmla="*/ 1583 h 1615"/>
                  <a:gd name="T62" fmla="*/ 3332 w 6524"/>
                  <a:gd name="T63" fmla="*/ 1586 h 1615"/>
                  <a:gd name="T64" fmla="*/ 3440 w 6524"/>
                  <a:gd name="T65" fmla="*/ 1565 h 1615"/>
                  <a:gd name="T66" fmla="*/ 3549 w 6524"/>
                  <a:gd name="T67" fmla="*/ 1588 h 1615"/>
                  <a:gd name="T68" fmla="*/ 3658 w 6524"/>
                  <a:gd name="T69" fmla="*/ 1591 h 1615"/>
                  <a:gd name="T70" fmla="*/ 3767 w 6524"/>
                  <a:gd name="T71" fmla="*/ 1587 h 1615"/>
                  <a:gd name="T72" fmla="*/ 3875 w 6524"/>
                  <a:gd name="T73" fmla="*/ 1590 h 1615"/>
                  <a:gd name="T74" fmla="*/ 3984 w 6524"/>
                  <a:gd name="T75" fmla="*/ 1594 h 1615"/>
                  <a:gd name="T76" fmla="*/ 4093 w 6524"/>
                  <a:gd name="T77" fmla="*/ 1593 h 1615"/>
                  <a:gd name="T78" fmla="*/ 4202 w 6524"/>
                  <a:gd name="T79" fmla="*/ 1537 h 1615"/>
                  <a:gd name="T80" fmla="*/ 4310 w 6524"/>
                  <a:gd name="T81" fmla="*/ 1595 h 1615"/>
                  <a:gd name="T82" fmla="*/ 4419 w 6524"/>
                  <a:gd name="T83" fmla="*/ 1597 h 1615"/>
                  <a:gd name="T84" fmla="*/ 4528 w 6524"/>
                  <a:gd name="T85" fmla="*/ 1600 h 1615"/>
                  <a:gd name="T86" fmla="*/ 4637 w 6524"/>
                  <a:gd name="T87" fmla="*/ 1596 h 1615"/>
                  <a:gd name="T88" fmla="*/ 4745 w 6524"/>
                  <a:gd name="T89" fmla="*/ 1600 h 1615"/>
                  <a:gd name="T90" fmla="*/ 4836 w 6524"/>
                  <a:gd name="T91" fmla="*/ 1599 h 1615"/>
                  <a:gd name="T92" fmla="*/ 4945 w 6524"/>
                  <a:gd name="T93" fmla="*/ 1576 h 1615"/>
                  <a:gd name="T94" fmla="*/ 5054 w 6524"/>
                  <a:gd name="T95" fmla="*/ 1611 h 1615"/>
                  <a:gd name="T96" fmla="*/ 5163 w 6524"/>
                  <a:gd name="T97" fmla="*/ 1505 h 1615"/>
                  <a:gd name="T98" fmla="*/ 5271 w 6524"/>
                  <a:gd name="T99" fmla="*/ 1564 h 1615"/>
                  <a:gd name="T100" fmla="*/ 5380 w 6524"/>
                  <a:gd name="T101" fmla="*/ 1595 h 1615"/>
                  <a:gd name="T102" fmla="*/ 5489 w 6524"/>
                  <a:gd name="T103" fmla="*/ 1600 h 1615"/>
                  <a:gd name="T104" fmla="*/ 5597 w 6524"/>
                  <a:gd name="T105" fmla="*/ 1600 h 1615"/>
                  <a:gd name="T106" fmla="*/ 5706 w 6524"/>
                  <a:gd name="T107" fmla="*/ 1600 h 1615"/>
                  <a:gd name="T108" fmla="*/ 5815 w 6524"/>
                  <a:gd name="T109" fmla="*/ 1600 h 1615"/>
                  <a:gd name="T110" fmla="*/ 5924 w 6524"/>
                  <a:gd name="T111" fmla="*/ 1601 h 1615"/>
                  <a:gd name="T112" fmla="*/ 6032 w 6524"/>
                  <a:gd name="T113" fmla="*/ 1604 h 1615"/>
                  <a:gd name="T114" fmla="*/ 6141 w 6524"/>
                  <a:gd name="T115" fmla="*/ 1610 h 1615"/>
                  <a:gd name="T116" fmla="*/ 6250 w 6524"/>
                  <a:gd name="T117" fmla="*/ 1612 h 1615"/>
                  <a:gd name="T118" fmla="*/ 6359 w 6524"/>
                  <a:gd name="T119" fmla="*/ 1604 h 1615"/>
                  <a:gd name="T120" fmla="*/ 6467 w 6524"/>
                  <a:gd name="T121" fmla="*/ 1589 h 161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 ang="0">
                    <a:pos x="T120" y="T121"/>
                  </a:cxn>
                </a:cxnLst>
                <a:rect l="0" t="0" r="r" b="b"/>
                <a:pathLst>
                  <a:path w="6524" h="1615">
                    <a:moveTo>
                      <a:pt x="0" y="1579"/>
                    </a:moveTo>
                    <a:lnTo>
                      <a:pt x="5" y="1579"/>
                    </a:lnTo>
                    <a:lnTo>
                      <a:pt x="9" y="1579"/>
                    </a:lnTo>
                    <a:lnTo>
                      <a:pt x="14" y="1579"/>
                    </a:lnTo>
                    <a:lnTo>
                      <a:pt x="18" y="1578"/>
                    </a:lnTo>
                    <a:lnTo>
                      <a:pt x="22" y="1578"/>
                    </a:lnTo>
                    <a:lnTo>
                      <a:pt x="26" y="1578"/>
                    </a:lnTo>
                    <a:lnTo>
                      <a:pt x="31" y="1578"/>
                    </a:lnTo>
                    <a:lnTo>
                      <a:pt x="35" y="1578"/>
                    </a:lnTo>
                    <a:lnTo>
                      <a:pt x="39" y="1578"/>
                    </a:lnTo>
                    <a:lnTo>
                      <a:pt x="44" y="1578"/>
                    </a:lnTo>
                    <a:lnTo>
                      <a:pt x="48" y="1578"/>
                    </a:lnTo>
                    <a:lnTo>
                      <a:pt x="53" y="1578"/>
                    </a:lnTo>
                    <a:lnTo>
                      <a:pt x="57" y="1578"/>
                    </a:lnTo>
                    <a:lnTo>
                      <a:pt x="61" y="1578"/>
                    </a:lnTo>
                    <a:lnTo>
                      <a:pt x="66" y="1578"/>
                    </a:lnTo>
                    <a:lnTo>
                      <a:pt x="70" y="1578"/>
                    </a:lnTo>
                    <a:lnTo>
                      <a:pt x="74" y="1578"/>
                    </a:lnTo>
                    <a:lnTo>
                      <a:pt x="79" y="1578"/>
                    </a:lnTo>
                    <a:lnTo>
                      <a:pt x="83" y="1578"/>
                    </a:lnTo>
                    <a:lnTo>
                      <a:pt x="87" y="1577"/>
                    </a:lnTo>
                    <a:lnTo>
                      <a:pt x="92" y="1578"/>
                    </a:lnTo>
                    <a:lnTo>
                      <a:pt x="96" y="1578"/>
                    </a:lnTo>
                    <a:lnTo>
                      <a:pt x="100" y="1578"/>
                    </a:lnTo>
                    <a:lnTo>
                      <a:pt x="105" y="1577"/>
                    </a:lnTo>
                    <a:lnTo>
                      <a:pt x="109" y="1577"/>
                    </a:lnTo>
                    <a:lnTo>
                      <a:pt x="113" y="1577"/>
                    </a:lnTo>
                    <a:lnTo>
                      <a:pt x="118" y="1578"/>
                    </a:lnTo>
                    <a:lnTo>
                      <a:pt x="122" y="1577"/>
                    </a:lnTo>
                    <a:lnTo>
                      <a:pt x="127" y="1577"/>
                    </a:lnTo>
                    <a:lnTo>
                      <a:pt x="131" y="1577"/>
                    </a:lnTo>
                    <a:lnTo>
                      <a:pt x="135" y="1577"/>
                    </a:lnTo>
                    <a:lnTo>
                      <a:pt x="139" y="1577"/>
                    </a:lnTo>
                    <a:lnTo>
                      <a:pt x="144" y="1577"/>
                    </a:lnTo>
                    <a:lnTo>
                      <a:pt x="148" y="1577"/>
                    </a:lnTo>
                    <a:lnTo>
                      <a:pt x="153" y="1577"/>
                    </a:lnTo>
                    <a:lnTo>
                      <a:pt x="157" y="1577"/>
                    </a:lnTo>
                    <a:lnTo>
                      <a:pt x="161" y="1577"/>
                    </a:lnTo>
                    <a:lnTo>
                      <a:pt x="166" y="1578"/>
                    </a:lnTo>
                    <a:lnTo>
                      <a:pt x="170" y="1577"/>
                    </a:lnTo>
                    <a:lnTo>
                      <a:pt x="174" y="1577"/>
                    </a:lnTo>
                    <a:lnTo>
                      <a:pt x="179" y="1577"/>
                    </a:lnTo>
                    <a:lnTo>
                      <a:pt x="183" y="1577"/>
                    </a:lnTo>
                    <a:lnTo>
                      <a:pt x="187" y="1577"/>
                    </a:lnTo>
                    <a:lnTo>
                      <a:pt x="192" y="1577"/>
                    </a:lnTo>
                    <a:lnTo>
                      <a:pt x="196" y="1577"/>
                    </a:lnTo>
                    <a:lnTo>
                      <a:pt x="200" y="1577"/>
                    </a:lnTo>
                    <a:lnTo>
                      <a:pt x="205" y="1577"/>
                    </a:lnTo>
                    <a:lnTo>
                      <a:pt x="209" y="1577"/>
                    </a:lnTo>
                    <a:lnTo>
                      <a:pt x="213" y="1577"/>
                    </a:lnTo>
                    <a:lnTo>
                      <a:pt x="218" y="1577"/>
                    </a:lnTo>
                    <a:lnTo>
                      <a:pt x="222" y="1577"/>
                    </a:lnTo>
                    <a:lnTo>
                      <a:pt x="227" y="1577"/>
                    </a:lnTo>
                    <a:lnTo>
                      <a:pt x="231" y="1577"/>
                    </a:lnTo>
                    <a:lnTo>
                      <a:pt x="235" y="1577"/>
                    </a:lnTo>
                    <a:lnTo>
                      <a:pt x="240" y="1577"/>
                    </a:lnTo>
                    <a:lnTo>
                      <a:pt x="244" y="1577"/>
                    </a:lnTo>
                    <a:lnTo>
                      <a:pt x="248" y="1577"/>
                    </a:lnTo>
                    <a:lnTo>
                      <a:pt x="253" y="1577"/>
                    </a:lnTo>
                    <a:lnTo>
                      <a:pt x="257" y="1577"/>
                    </a:lnTo>
                    <a:lnTo>
                      <a:pt x="261" y="1577"/>
                    </a:lnTo>
                    <a:lnTo>
                      <a:pt x="266" y="1577"/>
                    </a:lnTo>
                    <a:lnTo>
                      <a:pt x="270" y="1577"/>
                    </a:lnTo>
                    <a:lnTo>
                      <a:pt x="274" y="1577"/>
                    </a:lnTo>
                    <a:lnTo>
                      <a:pt x="279" y="1577"/>
                    </a:lnTo>
                    <a:lnTo>
                      <a:pt x="283" y="1577"/>
                    </a:lnTo>
                    <a:lnTo>
                      <a:pt x="287" y="1577"/>
                    </a:lnTo>
                    <a:lnTo>
                      <a:pt x="292" y="1577"/>
                    </a:lnTo>
                    <a:lnTo>
                      <a:pt x="296" y="1577"/>
                    </a:lnTo>
                    <a:lnTo>
                      <a:pt x="301" y="1577"/>
                    </a:lnTo>
                    <a:lnTo>
                      <a:pt x="305" y="1577"/>
                    </a:lnTo>
                    <a:lnTo>
                      <a:pt x="309" y="1577"/>
                    </a:lnTo>
                    <a:lnTo>
                      <a:pt x="314" y="1577"/>
                    </a:lnTo>
                    <a:lnTo>
                      <a:pt x="318" y="1577"/>
                    </a:lnTo>
                    <a:lnTo>
                      <a:pt x="322" y="1577"/>
                    </a:lnTo>
                    <a:lnTo>
                      <a:pt x="326" y="1577"/>
                    </a:lnTo>
                    <a:lnTo>
                      <a:pt x="331" y="1577"/>
                    </a:lnTo>
                    <a:lnTo>
                      <a:pt x="335" y="1577"/>
                    </a:lnTo>
                    <a:lnTo>
                      <a:pt x="340" y="1577"/>
                    </a:lnTo>
                    <a:lnTo>
                      <a:pt x="344" y="1577"/>
                    </a:lnTo>
                    <a:lnTo>
                      <a:pt x="348" y="1577"/>
                    </a:lnTo>
                    <a:lnTo>
                      <a:pt x="353" y="1577"/>
                    </a:lnTo>
                    <a:lnTo>
                      <a:pt x="357" y="1577"/>
                    </a:lnTo>
                    <a:lnTo>
                      <a:pt x="361" y="1577"/>
                    </a:lnTo>
                    <a:lnTo>
                      <a:pt x="366" y="1577"/>
                    </a:lnTo>
                    <a:lnTo>
                      <a:pt x="370" y="1577"/>
                    </a:lnTo>
                    <a:lnTo>
                      <a:pt x="375" y="1577"/>
                    </a:lnTo>
                    <a:lnTo>
                      <a:pt x="379" y="1577"/>
                    </a:lnTo>
                    <a:lnTo>
                      <a:pt x="383" y="1577"/>
                    </a:lnTo>
                    <a:lnTo>
                      <a:pt x="387" y="1577"/>
                    </a:lnTo>
                    <a:lnTo>
                      <a:pt x="392" y="1577"/>
                    </a:lnTo>
                    <a:lnTo>
                      <a:pt x="396" y="1577"/>
                    </a:lnTo>
                    <a:lnTo>
                      <a:pt x="400" y="1577"/>
                    </a:lnTo>
                    <a:lnTo>
                      <a:pt x="405" y="1577"/>
                    </a:lnTo>
                    <a:lnTo>
                      <a:pt x="409" y="1577"/>
                    </a:lnTo>
                    <a:lnTo>
                      <a:pt x="414" y="1577"/>
                    </a:lnTo>
                    <a:lnTo>
                      <a:pt x="418" y="1577"/>
                    </a:lnTo>
                    <a:lnTo>
                      <a:pt x="422" y="1577"/>
                    </a:lnTo>
                    <a:lnTo>
                      <a:pt x="427" y="1577"/>
                    </a:lnTo>
                    <a:lnTo>
                      <a:pt x="431" y="1577"/>
                    </a:lnTo>
                    <a:lnTo>
                      <a:pt x="435" y="1577"/>
                    </a:lnTo>
                    <a:lnTo>
                      <a:pt x="440" y="1577"/>
                    </a:lnTo>
                    <a:lnTo>
                      <a:pt x="444" y="1577"/>
                    </a:lnTo>
                    <a:lnTo>
                      <a:pt x="448" y="1577"/>
                    </a:lnTo>
                    <a:lnTo>
                      <a:pt x="453" y="1577"/>
                    </a:lnTo>
                    <a:lnTo>
                      <a:pt x="457" y="1577"/>
                    </a:lnTo>
                    <a:lnTo>
                      <a:pt x="461" y="1577"/>
                    </a:lnTo>
                    <a:lnTo>
                      <a:pt x="466" y="1577"/>
                    </a:lnTo>
                    <a:lnTo>
                      <a:pt x="470" y="1577"/>
                    </a:lnTo>
                    <a:lnTo>
                      <a:pt x="474" y="1577"/>
                    </a:lnTo>
                    <a:lnTo>
                      <a:pt x="479" y="1577"/>
                    </a:lnTo>
                    <a:lnTo>
                      <a:pt x="483" y="1577"/>
                    </a:lnTo>
                    <a:lnTo>
                      <a:pt x="488" y="1576"/>
                    </a:lnTo>
                    <a:lnTo>
                      <a:pt x="492" y="1576"/>
                    </a:lnTo>
                    <a:lnTo>
                      <a:pt x="496" y="1576"/>
                    </a:lnTo>
                    <a:lnTo>
                      <a:pt x="500" y="1577"/>
                    </a:lnTo>
                    <a:lnTo>
                      <a:pt x="505" y="1576"/>
                    </a:lnTo>
                    <a:lnTo>
                      <a:pt x="509" y="1576"/>
                    </a:lnTo>
                    <a:lnTo>
                      <a:pt x="514" y="1576"/>
                    </a:lnTo>
                    <a:lnTo>
                      <a:pt x="518" y="1576"/>
                    </a:lnTo>
                    <a:lnTo>
                      <a:pt x="522" y="1576"/>
                    </a:lnTo>
                    <a:lnTo>
                      <a:pt x="527" y="1576"/>
                    </a:lnTo>
                    <a:lnTo>
                      <a:pt x="531" y="1576"/>
                    </a:lnTo>
                    <a:lnTo>
                      <a:pt x="535" y="1576"/>
                    </a:lnTo>
                    <a:lnTo>
                      <a:pt x="540" y="1576"/>
                    </a:lnTo>
                    <a:lnTo>
                      <a:pt x="544" y="1576"/>
                    </a:lnTo>
                    <a:lnTo>
                      <a:pt x="548" y="1576"/>
                    </a:lnTo>
                    <a:lnTo>
                      <a:pt x="553" y="1576"/>
                    </a:lnTo>
                    <a:lnTo>
                      <a:pt x="557" y="1576"/>
                    </a:lnTo>
                    <a:lnTo>
                      <a:pt x="561" y="1576"/>
                    </a:lnTo>
                    <a:lnTo>
                      <a:pt x="566" y="1576"/>
                    </a:lnTo>
                    <a:lnTo>
                      <a:pt x="570" y="1576"/>
                    </a:lnTo>
                    <a:lnTo>
                      <a:pt x="574" y="1576"/>
                    </a:lnTo>
                    <a:lnTo>
                      <a:pt x="579" y="1576"/>
                    </a:lnTo>
                    <a:lnTo>
                      <a:pt x="583" y="1576"/>
                    </a:lnTo>
                    <a:lnTo>
                      <a:pt x="587" y="1576"/>
                    </a:lnTo>
                    <a:lnTo>
                      <a:pt x="592" y="1576"/>
                    </a:lnTo>
                    <a:lnTo>
                      <a:pt x="596" y="1576"/>
                    </a:lnTo>
                    <a:lnTo>
                      <a:pt x="601" y="1576"/>
                    </a:lnTo>
                    <a:lnTo>
                      <a:pt x="605" y="1576"/>
                    </a:lnTo>
                    <a:lnTo>
                      <a:pt x="609" y="1576"/>
                    </a:lnTo>
                    <a:lnTo>
                      <a:pt x="614" y="1576"/>
                    </a:lnTo>
                    <a:lnTo>
                      <a:pt x="618" y="1576"/>
                    </a:lnTo>
                    <a:lnTo>
                      <a:pt x="622" y="1576"/>
                    </a:lnTo>
                    <a:lnTo>
                      <a:pt x="627" y="1576"/>
                    </a:lnTo>
                    <a:lnTo>
                      <a:pt x="631" y="1576"/>
                    </a:lnTo>
                    <a:lnTo>
                      <a:pt x="635" y="1576"/>
                    </a:lnTo>
                    <a:lnTo>
                      <a:pt x="640" y="1576"/>
                    </a:lnTo>
                    <a:lnTo>
                      <a:pt x="644" y="1575"/>
                    </a:lnTo>
                    <a:lnTo>
                      <a:pt x="648" y="1575"/>
                    </a:lnTo>
                    <a:lnTo>
                      <a:pt x="653" y="1574"/>
                    </a:lnTo>
                    <a:lnTo>
                      <a:pt x="657" y="1574"/>
                    </a:lnTo>
                    <a:lnTo>
                      <a:pt x="661" y="1574"/>
                    </a:lnTo>
                    <a:lnTo>
                      <a:pt x="666" y="1573"/>
                    </a:lnTo>
                    <a:lnTo>
                      <a:pt x="670" y="1573"/>
                    </a:lnTo>
                    <a:lnTo>
                      <a:pt x="675" y="1572"/>
                    </a:lnTo>
                    <a:lnTo>
                      <a:pt x="679" y="1572"/>
                    </a:lnTo>
                    <a:lnTo>
                      <a:pt x="683" y="1571"/>
                    </a:lnTo>
                    <a:lnTo>
                      <a:pt x="687" y="1571"/>
                    </a:lnTo>
                    <a:lnTo>
                      <a:pt x="692" y="1570"/>
                    </a:lnTo>
                    <a:lnTo>
                      <a:pt x="696" y="1569"/>
                    </a:lnTo>
                    <a:lnTo>
                      <a:pt x="701" y="1567"/>
                    </a:lnTo>
                    <a:lnTo>
                      <a:pt x="705" y="1565"/>
                    </a:lnTo>
                    <a:lnTo>
                      <a:pt x="709" y="1565"/>
                    </a:lnTo>
                    <a:lnTo>
                      <a:pt x="714" y="1564"/>
                    </a:lnTo>
                    <a:lnTo>
                      <a:pt x="718" y="1564"/>
                    </a:lnTo>
                    <a:lnTo>
                      <a:pt x="722" y="1564"/>
                    </a:lnTo>
                    <a:lnTo>
                      <a:pt x="727" y="1564"/>
                    </a:lnTo>
                    <a:lnTo>
                      <a:pt x="731" y="1564"/>
                    </a:lnTo>
                    <a:lnTo>
                      <a:pt x="735" y="1564"/>
                    </a:lnTo>
                    <a:lnTo>
                      <a:pt x="740" y="1563"/>
                    </a:lnTo>
                    <a:lnTo>
                      <a:pt x="744" y="1562"/>
                    </a:lnTo>
                    <a:lnTo>
                      <a:pt x="748" y="1560"/>
                    </a:lnTo>
                    <a:lnTo>
                      <a:pt x="753" y="1556"/>
                    </a:lnTo>
                    <a:lnTo>
                      <a:pt x="757" y="1547"/>
                    </a:lnTo>
                    <a:lnTo>
                      <a:pt x="761" y="1532"/>
                    </a:lnTo>
                    <a:lnTo>
                      <a:pt x="766" y="1509"/>
                    </a:lnTo>
                    <a:lnTo>
                      <a:pt x="768" y="1411"/>
                    </a:lnTo>
                    <a:lnTo>
                      <a:pt x="770" y="962"/>
                    </a:lnTo>
                    <a:lnTo>
                      <a:pt x="772" y="800"/>
                    </a:lnTo>
                    <a:lnTo>
                      <a:pt x="775" y="1071"/>
                    </a:lnTo>
                    <a:lnTo>
                      <a:pt x="777" y="1279"/>
                    </a:lnTo>
                    <a:lnTo>
                      <a:pt x="779" y="1377"/>
                    </a:lnTo>
                    <a:lnTo>
                      <a:pt x="781" y="1421"/>
                    </a:lnTo>
                    <a:lnTo>
                      <a:pt x="783" y="1442"/>
                    </a:lnTo>
                    <a:lnTo>
                      <a:pt x="788" y="1461"/>
                    </a:lnTo>
                    <a:lnTo>
                      <a:pt x="792" y="1472"/>
                    </a:lnTo>
                    <a:lnTo>
                      <a:pt x="796" y="1481"/>
                    </a:lnTo>
                    <a:lnTo>
                      <a:pt x="800" y="1489"/>
                    </a:lnTo>
                    <a:lnTo>
                      <a:pt x="805" y="1495"/>
                    </a:lnTo>
                    <a:lnTo>
                      <a:pt x="809" y="1499"/>
                    </a:lnTo>
                    <a:lnTo>
                      <a:pt x="814" y="1505"/>
                    </a:lnTo>
                    <a:lnTo>
                      <a:pt x="818" y="1514"/>
                    </a:lnTo>
                    <a:lnTo>
                      <a:pt x="822" y="1541"/>
                    </a:lnTo>
                    <a:lnTo>
                      <a:pt x="827" y="1561"/>
                    </a:lnTo>
                    <a:lnTo>
                      <a:pt x="831" y="1581"/>
                    </a:lnTo>
                    <a:lnTo>
                      <a:pt x="835" y="1600"/>
                    </a:lnTo>
                    <a:lnTo>
                      <a:pt x="840" y="1609"/>
                    </a:lnTo>
                    <a:lnTo>
                      <a:pt x="844" y="1612"/>
                    </a:lnTo>
                    <a:lnTo>
                      <a:pt x="849" y="1613"/>
                    </a:lnTo>
                    <a:lnTo>
                      <a:pt x="853" y="1614"/>
                    </a:lnTo>
                    <a:lnTo>
                      <a:pt x="857" y="1613"/>
                    </a:lnTo>
                    <a:lnTo>
                      <a:pt x="861" y="1611"/>
                    </a:lnTo>
                    <a:lnTo>
                      <a:pt x="866" y="1610"/>
                    </a:lnTo>
                    <a:lnTo>
                      <a:pt x="870" y="1613"/>
                    </a:lnTo>
                    <a:lnTo>
                      <a:pt x="874" y="1615"/>
                    </a:lnTo>
                    <a:lnTo>
                      <a:pt x="879" y="1615"/>
                    </a:lnTo>
                    <a:lnTo>
                      <a:pt x="883" y="1614"/>
                    </a:lnTo>
                    <a:lnTo>
                      <a:pt x="888" y="1613"/>
                    </a:lnTo>
                    <a:lnTo>
                      <a:pt x="892" y="1611"/>
                    </a:lnTo>
                    <a:lnTo>
                      <a:pt x="896" y="1611"/>
                    </a:lnTo>
                    <a:lnTo>
                      <a:pt x="901" y="1610"/>
                    </a:lnTo>
                    <a:lnTo>
                      <a:pt x="905" y="1609"/>
                    </a:lnTo>
                    <a:lnTo>
                      <a:pt x="909" y="1608"/>
                    </a:lnTo>
                    <a:lnTo>
                      <a:pt x="914" y="1605"/>
                    </a:lnTo>
                    <a:lnTo>
                      <a:pt x="918" y="1601"/>
                    </a:lnTo>
                    <a:lnTo>
                      <a:pt x="922" y="1598"/>
                    </a:lnTo>
                    <a:lnTo>
                      <a:pt x="927" y="1595"/>
                    </a:lnTo>
                    <a:lnTo>
                      <a:pt x="931" y="1595"/>
                    </a:lnTo>
                    <a:lnTo>
                      <a:pt x="935" y="1596"/>
                    </a:lnTo>
                    <a:lnTo>
                      <a:pt x="940" y="1598"/>
                    </a:lnTo>
                    <a:lnTo>
                      <a:pt x="944" y="1599"/>
                    </a:lnTo>
                    <a:lnTo>
                      <a:pt x="948" y="1601"/>
                    </a:lnTo>
                    <a:lnTo>
                      <a:pt x="953" y="1601"/>
                    </a:lnTo>
                    <a:lnTo>
                      <a:pt x="957" y="1602"/>
                    </a:lnTo>
                    <a:lnTo>
                      <a:pt x="962" y="1601"/>
                    </a:lnTo>
                    <a:lnTo>
                      <a:pt x="966" y="1601"/>
                    </a:lnTo>
                    <a:lnTo>
                      <a:pt x="970" y="1600"/>
                    </a:lnTo>
                    <a:lnTo>
                      <a:pt x="975" y="1599"/>
                    </a:lnTo>
                    <a:lnTo>
                      <a:pt x="979" y="1596"/>
                    </a:lnTo>
                    <a:lnTo>
                      <a:pt x="983" y="1594"/>
                    </a:lnTo>
                    <a:lnTo>
                      <a:pt x="988" y="1591"/>
                    </a:lnTo>
                    <a:lnTo>
                      <a:pt x="992" y="1588"/>
                    </a:lnTo>
                    <a:lnTo>
                      <a:pt x="996" y="1585"/>
                    </a:lnTo>
                    <a:lnTo>
                      <a:pt x="1001" y="1581"/>
                    </a:lnTo>
                    <a:lnTo>
                      <a:pt x="1005" y="1577"/>
                    </a:lnTo>
                    <a:lnTo>
                      <a:pt x="1009" y="1573"/>
                    </a:lnTo>
                    <a:lnTo>
                      <a:pt x="1014" y="1569"/>
                    </a:lnTo>
                    <a:lnTo>
                      <a:pt x="1018" y="1564"/>
                    </a:lnTo>
                    <a:lnTo>
                      <a:pt x="1022" y="1559"/>
                    </a:lnTo>
                    <a:lnTo>
                      <a:pt x="1027" y="1554"/>
                    </a:lnTo>
                    <a:lnTo>
                      <a:pt x="1031" y="1548"/>
                    </a:lnTo>
                    <a:lnTo>
                      <a:pt x="1036" y="1541"/>
                    </a:lnTo>
                    <a:lnTo>
                      <a:pt x="1040" y="1534"/>
                    </a:lnTo>
                    <a:lnTo>
                      <a:pt x="1044" y="1527"/>
                    </a:lnTo>
                    <a:lnTo>
                      <a:pt x="1048" y="1517"/>
                    </a:lnTo>
                    <a:lnTo>
                      <a:pt x="1053" y="1505"/>
                    </a:lnTo>
                    <a:lnTo>
                      <a:pt x="1057" y="1483"/>
                    </a:lnTo>
                    <a:lnTo>
                      <a:pt x="1059" y="1436"/>
                    </a:lnTo>
                    <a:lnTo>
                      <a:pt x="1062" y="1184"/>
                    </a:lnTo>
                    <a:lnTo>
                      <a:pt x="1064" y="899"/>
                    </a:lnTo>
                    <a:lnTo>
                      <a:pt x="1066" y="900"/>
                    </a:lnTo>
                    <a:lnTo>
                      <a:pt x="1068" y="1052"/>
                    </a:lnTo>
                    <a:lnTo>
                      <a:pt x="1070" y="1280"/>
                    </a:lnTo>
                    <a:lnTo>
                      <a:pt x="1072" y="1444"/>
                    </a:lnTo>
                    <a:lnTo>
                      <a:pt x="1075" y="1511"/>
                    </a:lnTo>
                    <a:lnTo>
                      <a:pt x="1077" y="1532"/>
                    </a:lnTo>
                    <a:lnTo>
                      <a:pt x="1079" y="1541"/>
                    </a:lnTo>
                    <a:lnTo>
                      <a:pt x="1083" y="1547"/>
                    </a:lnTo>
                    <a:lnTo>
                      <a:pt x="1088" y="1550"/>
                    </a:lnTo>
                    <a:lnTo>
                      <a:pt x="1092" y="1553"/>
                    </a:lnTo>
                    <a:lnTo>
                      <a:pt x="1096" y="1556"/>
                    </a:lnTo>
                    <a:lnTo>
                      <a:pt x="1101" y="1558"/>
                    </a:lnTo>
                    <a:lnTo>
                      <a:pt x="1105" y="1558"/>
                    </a:lnTo>
                    <a:lnTo>
                      <a:pt x="1109" y="1559"/>
                    </a:lnTo>
                    <a:lnTo>
                      <a:pt x="1114" y="1559"/>
                    </a:lnTo>
                    <a:lnTo>
                      <a:pt x="1118" y="1559"/>
                    </a:lnTo>
                    <a:lnTo>
                      <a:pt x="1122" y="1557"/>
                    </a:lnTo>
                    <a:lnTo>
                      <a:pt x="1127" y="1553"/>
                    </a:lnTo>
                    <a:lnTo>
                      <a:pt x="1131" y="1549"/>
                    </a:lnTo>
                    <a:lnTo>
                      <a:pt x="1136" y="1544"/>
                    </a:lnTo>
                    <a:lnTo>
                      <a:pt x="1140" y="1543"/>
                    </a:lnTo>
                    <a:lnTo>
                      <a:pt x="1144" y="1545"/>
                    </a:lnTo>
                    <a:lnTo>
                      <a:pt x="1149" y="1550"/>
                    </a:lnTo>
                    <a:lnTo>
                      <a:pt x="1153" y="1555"/>
                    </a:lnTo>
                    <a:lnTo>
                      <a:pt x="1157" y="1559"/>
                    </a:lnTo>
                    <a:lnTo>
                      <a:pt x="1161" y="1561"/>
                    </a:lnTo>
                    <a:lnTo>
                      <a:pt x="1166" y="1563"/>
                    </a:lnTo>
                    <a:lnTo>
                      <a:pt x="1170" y="1564"/>
                    </a:lnTo>
                    <a:lnTo>
                      <a:pt x="1175" y="1565"/>
                    </a:lnTo>
                    <a:lnTo>
                      <a:pt x="1179" y="1566"/>
                    </a:lnTo>
                    <a:lnTo>
                      <a:pt x="1183" y="1566"/>
                    </a:lnTo>
                    <a:lnTo>
                      <a:pt x="1188" y="1566"/>
                    </a:lnTo>
                    <a:lnTo>
                      <a:pt x="1192" y="1567"/>
                    </a:lnTo>
                    <a:lnTo>
                      <a:pt x="1196" y="1567"/>
                    </a:lnTo>
                    <a:lnTo>
                      <a:pt x="1201" y="1567"/>
                    </a:lnTo>
                    <a:lnTo>
                      <a:pt x="1205" y="1567"/>
                    </a:lnTo>
                    <a:lnTo>
                      <a:pt x="1209" y="1567"/>
                    </a:lnTo>
                    <a:lnTo>
                      <a:pt x="1214" y="1567"/>
                    </a:lnTo>
                    <a:lnTo>
                      <a:pt x="1218" y="1567"/>
                    </a:lnTo>
                    <a:lnTo>
                      <a:pt x="1222" y="1567"/>
                    </a:lnTo>
                    <a:lnTo>
                      <a:pt x="1227" y="1567"/>
                    </a:lnTo>
                    <a:lnTo>
                      <a:pt x="1231" y="1567"/>
                    </a:lnTo>
                    <a:lnTo>
                      <a:pt x="1235" y="1566"/>
                    </a:lnTo>
                    <a:lnTo>
                      <a:pt x="1240" y="1565"/>
                    </a:lnTo>
                    <a:lnTo>
                      <a:pt x="1244" y="1565"/>
                    </a:lnTo>
                    <a:lnTo>
                      <a:pt x="1249" y="1565"/>
                    </a:lnTo>
                    <a:lnTo>
                      <a:pt x="1253" y="1565"/>
                    </a:lnTo>
                    <a:lnTo>
                      <a:pt x="1257" y="1565"/>
                    </a:lnTo>
                    <a:lnTo>
                      <a:pt x="1262" y="1565"/>
                    </a:lnTo>
                    <a:lnTo>
                      <a:pt x="1266" y="1565"/>
                    </a:lnTo>
                    <a:lnTo>
                      <a:pt x="1270" y="1566"/>
                    </a:lnTo>
                    <a:lnTo>
                      <a:pt x="1275" y="1566"/>
                    </a:lnTo>
                    <a:lnTo>
                      <a:pt x="1279" y="1566"/>
                    </a:lnTo>
                    <a:lnTo>
                      <a:pt x="1283" y="1566"/>
                    </a:lnTo>
                    <a:lnTo>
                      <a:pt x="1288" y="1565"/>
                    </a:lnTo>
                    <a:lnTo>
                      <a:pt x="1292" y="1565"/>
                    </a:lnTo>
                    <a:lnTo>
                      <a:pt x="1296" y="1564"/>
                    </a:lnTo>
                    <a:lnTo>
                      <a:pt x="1301" y="1563"/>
                    </a:lnTo>
                    <a:lnTo>
                      <a:pt x="1305" y="1561"/>
                    </a:lnTo>
                    <a:lnTo>
                      <a:pt x="1309" y="1559"/>
                    </a:lnTo>
                    <a:lnTo>
                      <a:pt x="1314" y="1555"/>
                    </a:lnTo>
                    <a:lnTo>
                      <a:pt x="1318" y="1549"/>
                    </a:lnTo>
                    <a:lnTo>
                      <a:pt x="1323" y="1541"/>
                    </a:lnTo>
                    <a:lnTo>
                      <a:pt x="1327" y="1531"/>
                    </a:lnTo>
                    <a:lnTo>
                      <a:pt x="1331" y="1519"/>
                    </a:lnTo>
                    <a:lnTo>
                      <a:pt x="1335" y="1507"/>
                    </a:lnTo>
                    <a:lnTo>
                      <a:pt x="1340" y="1498"/>
                    </a:lnTo>
                    <a:lnTo>
                      <a:pt x="1344" y="1493"/>
                    </a:lnTo>
                    <a:lnTo>
                      <a:pt x="1348" y="1494"/>
                    </a:lnTo>
                    <a:lnTo>
                      <a:pt x="1353" y="1501"/>
                    </a:lnTo>
                    <a:lnTo>
                      <a:pt x="1357" y="1512"/>
                    </a:lnTo>
                    <a:lnTo>
                      <a:pt x="1362" y="1525"/>
                    </a:lnTo>
                    <a:lnTo>
                      <a:pt x="1366" y="1537"/>
                    </a:lnTo>
                    <a:lnTo>
                      <a:pt x="1370" y="1547"/>
                    </a:lnTo>
                    <a:lnTo>
                      <a:pt x="1375" y="1554"/>
                    </a:lnTo>
                    <a:lnTo>
                      <a:pt x="1379" y="1558"/>
                    </a:lnTo>
                    <a:lnTo>
                      <a:pt x="1383" y="1561"/>
                    </a:lnTo>
                    <a:lnTo>
                      <a:pt x="1388" y="1563"/>
                    </a:lnTo>
                    <a:lnTo>
                      <a:pt x="1392" y="1563"/>
                    </a:lnTo>
                    <a:lnTo>
                      <a:pt x="1397" y="1563"/>
                    </a:lnTo>
                    <a:lnTo>
                      <a:pt x="1401" y="1563"/>
                    </a:lnTo>
                    <a:lnTo>
                      <a:pt x="1405" y="1563"/>
                    </a:lnTo>
                    <a:lnTo>
                      <a:pt x="1409" y="1562"/>
                    </a:lnTo>
                    <a:lnTo>
                      <a:pt x="1414" y="1561"/>
                    </a:lnTo>
                    <a:lnTo>
                      <a:pt x="1418" y="1561"/>
                    </a:lnTo>
                    <a:lnTo>
                      <a:pt x="1422" y="1560"/>
                    </a:lnTo>
                    <a:lnTo>
                      <a:pt x="1427" y="1560"/>
                    </a:lnTo>
                    <a:lnTo>
                      <a:pt x="1431" y="1559"/>
                    </a:lnTo>
                    <a:lnTo>
                      <a:pt x="1436" y="1558"/>
                    </a:lnTo>
                    <a:lnTo>
                      <a:pt x="1440" y="1558"/>
                    </a:lnTo>
                    <a:lnTo>
                      <a:pt x="1444" y="1557"/>
                    </a:lnTo>
                    <a:lnTo>
                      <a:pt x="1449" y="1556"/>
                    </a:lnTo>
                    <a:lnTo>
                      <a:pt x="1453" y="1556"/>
                    </a:lnTo>
                    <a:lnTo>
                      <a:pt x="1457" y="1555"/>
                    </a:lnTo>
                    <a:lnTo>
                      <a:pt x="1462" y="1555"/>
                    </a:lnTo>
                    <a:lnTo>
                      <a:pt x="1466" y="1554"/>
                    </a:lnTo>
                    <a:lnTo>
                      <a:pt x="1470" y="1553"/>
                    </a:lnTo>
                    <a:lnTo>
                      <a:pt x="1475" y="1552"/>
                    </a:lnTo>
                    <a:lnTo>
                      <a:pt x="1479" y="1552"/>
                    </a:lnTo>
                    <a:lnTo>
                      <a:pt x="1483" y="1551"/>
                    </a:lnTo>
                    <a:lnTo>
                      <a:pt x="1488" y="1551"/>
                    </a:lnTo>
                    <a:lnTo>
                      <a:pt x="1492" y="1550"/>
                    </a:lnTo>
                    <a:lnTo>
                      <a:pt x="1496" y="1549"/>
                    </a:lnTo>
                    <a:lnTo>
                      <a:pt x="1501" y="1549"/>
                    </a:lnTo>
                    <a:lnTo>
                      <a:pt x="1505" y="1548"/>
                    </a:lnTo>
                    <a:lnTo>
                      <a:pt x="1510" y="1547"/>
                    </a:lnTo>
                    <a:lnTo>
                      <a:pt x="1514" y="1547"/>
                    </a:lnTo>
                    <a:lnTo>
                      <a:pt x="1518" y="1546"/>
                    </a:lnTo>
                    <a:lnTo>
                      <a:pt x="1522" y="1546"/>
                    </a:lnTo>
                    <a:lnTo>
                      <a:pt x="1527" y="1546"/>
                    </a:lnTo>
                    <a:lnTo>
                      <a:pt x="1531" y="1545"/>
                    </a:lnTo>
                    <a:lnTo>
                      <a:pt x="1536" y="1545"/>
                    </a:lnTo>
                    <a:lnTo>
                      <a:pt x="1540" y="1543"/>
                    </a:lnTo>
                    <a:lnTo>
                      <a:pt x="1544" y="1543"/>
                    </a:lnTo>
                    <a:lnTo>
                      <a:pt x="1549" y="1542"/>
                    </a:lnTo>
                    <a:lnTo>
                      <a:pt x="1553" y="1542"/>
                    </a:lnTo>
                    <a:lnTo>
                      <a:pt x="1557" y="1542"/>
                    </a:lnTo>
                    <a:lnTo>
                      <a:pt x="1562" y="1542"/>
                    </a:lnTo>
                    <a:lnTo>
                      <a:pt x="1566" y="1542"/>
                    </a:lnTo>
                    <a:lnTo>
                      <a:pt x="1570" y="1541"/>
                    </a:lnTo>
                    <a:lnTo>
                      <a:pt x="1575" y="1540"/>
                    </a:lnTo>
                    <a:lnTo>
                      <a:pt x="1579" y="1540"/>
                    </a:lnTo>
                    <a:lnTo>
                      <a:pt x="1583" y="1538"/>
                    </a:lnTo>
                    <a:lnTo>
                      <a:pt x="1588" y="1535"/>
                    </a:lnTo>
                    <a:lnTo>
                      <a:pt x="1592" y="1531"/>
                    </a:lnTo>
                    <a:lnTo>
                      <a:pt x="1596" y="1527"/>
                    </a:lnTo>
                    <a:lnTo>
                      <a:pt x="1601" y="1526"/>
                    </a:lnTo>
                    <a:lnTo>
                      <a:pt x="1605" y="1528"/>
                    </a:lnTo>
                    <a:lnTo>
                      <a:pt x="1610" y="1534"/>
                    </a:lnTo>
                    <a:lnTo>
                      <a:pt x="1614" y="1538"/>
                    </a:lnTo>
                    <a:lnTo>
                      <a:pt x="1618" y="1541"/>
                    </a:lnTo>
                    <a:lnTo>
                      <a:pt x="1623" y="1542"/>
                    </a:lnTo>
                    <a:lnTo>
                      <a:pt x="1627" y="1543"/>
                    </a:lnTo>
                    <a:lnTo>
                      <a:pt x="1631" y="1543"/>
                    </a:lnTo>
                    <a:lnTo>
                      <a:pt x="1635" y="1543"/>
                    </a:lnTo>
                    <a:lnTo>
                      <a:pt x="1640" y="1543"/>
                    </a:lnTo>
                    <a:lnTo>
                      <a:pt x="1644" y="1543"/>
                    </a:lnTo>
                    <a:lnTo>
                      <a:pt x="1649" y="1543"/>
                    </a:lnTo>
                    <a:lnTo>
                      <a:pt x="1653" y="1542"/>
                    </a:lnTo>
                    <a:lnTo>
                      <a:pt x="1657" y="1541"/>
                    </a:lnTo>
                    <a:lnTo>
                      <a:pt x="1662" y="1539"/>
                    </a:lnTo>
                    <a:lnTo>
                      <a:pt x="1666" y="1537"/>
                    </a:lnTo>
                    <a:lnTo>
                      <a:pt x="1670" y="1534"/>
                    </a:lnTo>
                    <a:lnTo>
                      <a:pt x="1675" y="1531"/>
                    </a:lnTo>
                    <a:lnTo>
                      <a:pt x="1679" y="1528"/>
                    </a:lnTo>
                    <a:lnTo>
                      <a:pt x="1684" y="1528"/>
                    </a:lnTo>
                    <a:lnTo>
                      <a:pt x="1688" y="1533"/>
                    </a:lnTo>
                    <a:lnTo>
                      <a:pt x="1692" y="1537"/>
                    </a:lnTo>
                    <a:lnTo>
                      <a:pt x="1696" y="1537"/>
                    </a:lnTo>
                    <a:lnTo>
                      <a:pt x="1701" y="1536"/>
                    </a:lnTo>
                    <a:lnTo>
                      <a:pt x="1705" y="1535"/>
                    </a:lnTo>
                    <a:lnTo>
                      <a:pt x="1709" y="1536"/>
                    </a:lnTo>
                    <a:lnTo>
                      <a:pt x="1714" y="1537"/>
                    </a:lnTo>
                    <a:lnTo>
                      <a:pt x="1718" y="1539"/>
                    </a:lnTo>
                    <a:lnTo>
                      <a:pt x="1723" y="1540"/>
                    </a:lnTo>
                    <a:lnTo>
                      <a:pt x="1727" y="1540"/>
                    </a:lnTo>
                    <a:lnTo>
                      <a:pt x="1731" y="1540"/>
                    </a:lnTo>
                    <a:lnTo>
                      <a:pt x="1736" y="1539"/>
                    </a:lnTo>
                    <a:lnTo>
                      <a:pt x="1740" y="1537"/>
                    </a:lnTo>
                    <a:lnTo>
                      <a:pt x="1744" y="1535"/>
                    </a:lnTo>
                    <a:lnTo>
                      <a:pt x="1749" y="1532"/>
                    </a:lnTo>
                    <a:lnTo>
                      <a:pt x="1753" y="1529"/>
                    </a:lnTo>
                    <a:lnTo>
                      <a:pt x="1758" y="1526"/>
                    </a:lnTo>
                    <a:lnTo>
                      <a:pt x="1762" y="1523"/>
                    </a:lnTo>
                    <a:lnTo>
                      <a:pt x="1766" y="1519"/>
                    </a:lnTo>
                    <a:lnTo>
                      <a:pt x="1770" y="1516"/>
                    </a:lnTo>
                    <a:lnTo>
                      <a:pt x="1775" y="1515"/>
                    </a:lnTo>
                    <a:lnTo>
                      <a:pt x="1779" y="1516"/>
                    </a:lnTo>
                    <a:lnTo>
                      <a:pt x="1783" y="1516"/>
                    </a:lnTo>
                    <a:lnTo>
                      <a:pt x="1788" y="1515"/>
                    </a:lnTo>
                    <a:lnTo>
                      <a:pt x="1792" y="1512"/>
                    </a:lnTo>
                    <a:lnTo>
                      <a:pt x="1797" y="1509"/>
                    </a:lnTo>
                    <a:lnTo>
                      <a:pt x="1801" y="1507"/>
                    </a:lnTo>
                    <a:lnTo>
                      <a:pt x="1805" y="1507"/>
                    </a:lnTo>
                    <a:lnTo>
                      <a:pt x="1810" y="1508"/>
                    </a:lnTo>
                    <a:lnTo>
                      <a:pt x="1814" y="1508"/>
                    </a:lnTo>
                    <a:lnTo>
                      <a:pt x="1818" y="1507"/>
                    </a:lnTo>
                    <a:lnTo>
                      <a:pt x="1823" y="1507"/>
                    </a:lnTo>
                    <a:lnTo>
                      <a:pt x="1827" y="1507"/>
                    </a:lnTo>
                    <a:lnTo>
                      <a:pt x="1831" y="1506"/>
                    </a:lnTo>
                    <a:lnTo>
                      <a:pt x="1836" y="1503"/>
                    </a:lnTo>
                    <a:lnTo>
                      <a:pt x="1840" y="1500"/>
                    </a:lnTo>
                    <a:lnTo>
                      <a:pt x="1844" y="1496"/>
                    </a:lnTo>
                    <a:lnTo>
                      <a:pt x="1849" y="1494"/>
                    </a:lnTo>
                    <a:lnTo>
                      <a:pt x="1853" y="1496"/>
                    </a:lnTo>
                    <a:lnTo>
                      <a:pt x="1857" y="1500"/>
                    </a:lnTo>
                    <a:lnTo>
                      <a:pt x="1862" y="1503"/>
                    </a:lnTo>
                    <a:lnTo>
                      <a:pt x="1866" y="1506"/>
                    </a:lnTo>
                    <a:lnTo>
                      <a:pt x="1871" y="1507"/>
                    </a:lnTo>
                    <a:lnTo>
                      <a:pt x="1875" y="1503"/>
                    </a:lnTo>
                    <a:lnTo>
                      <a:pt x="1879" y="1481"/>
                    </a:lnTo>
                    <a:lnTo>
                      <a:pt x="1881" y="1457"/>
                    </a:lnTo>
                    <a:lnTo>
                      <a:pt x="1883" y="1421"/>
                    </a:lnTo>
                    <a:lnTo>
                      <a:pt x="1886" y="1373"/>
                    </a:lnTo>
                    <a:lnTo>
                      <a:pt x="1888" y="1316"/>
                    </a:lnTo>
                    <a:lnTo>
                      <a:pt x="1890" y="1258"/>
                    </a:lnTo>
                    <a:lnTo>
                      <a:pt x="1892" y="1217"/>
                    </a:lnTo>
                    <a:lnTo>
                      <a:pt x="1894" y="1206"/>
                    </a:lnTo>
                    <a:lnTo>
                      <a:pt x="1897" y="1230"/>
                    </a:lnTo>
                    <a:lnTo>
                      <a:pt x="1899" y="1283"/>
                    </a:lnTo>
                    <a:lnTo>
                      <a:pt x="1901" y="1347"/>
                    </a:lnTo>
                    <a:lnTo>
                      <a:pt x="1903" y="1408"/>
                    </a:lnTo>
                    <a:lnTo>
                      <a:pt x="1905" y="1455"/>
                    </a:lnTo>
                    <a:lnTo>
                      <a:pt x="1907" y="1487"/>
                    </a:lnTo>
                    <a:lnTo>
                      <a:pt x="1910" y="1505"/>
                    </a:lnTo>
                    <a:lnTo>
                      <a:pt x="1914" y="1521"/>
                    </a:lnTo>
                    <a:lnTo>
                      <a:pt x="1918" y="1526"/>
                    </a:lnTo>
                    <a:lnTo>
                      <a:pt x="1923" y="1528"/>
                    </a:lnTo>
                    <a:lnTo>
                      <a:pt x="1927" y="1529"/>
                    </a:lnTo>
                    <a:lnTo>
                      <a:pt x="1931" y="1527"/>
                    </a:lnTo>
                    <a:lnTo>
                      <a:pt x="1936" y="1524"/>
                    </a:lnTo>
                    <a:lnTo>
                      <a:pt x="1940" y="1517"/>
                    </a:lnTo>
                    <a:lnTo>
                      <a:pt x="1944" y="1510"/>
                    </a:lnTo>
                    <a:lnTo>
                      <a:pt x="1949" y="1506"/>
                    </a:lnTo>
                    <a:lnTo>
                      <a:pt x="1953" y="1509"/>
                    </a:lnTo>
                    <a:lnTo>
                      <a:pt x="1957" y="1514"/>
                    </a:lnTo>
                    <a:lnTo>
                      <a:pt x="1962" y="1519"/>
                    </a:lnTo>
                    <a:lnTo>
                      <a:pt x="1966" y="1522"/>
                    </a:lnTo>
                    <a:lnTo>
                      <a:pt x="1971" y="1522"/>
                    </a:lnTo>
                    <a:lnTo>
                      <a:pt x="1975" y="1520"/>
                    </a:lnTo>
                    <a:lnTo>
                      <a:pt x="1979" y="1516"/>
                    </a:lnTo>
                    <a:lnTo>
                      <a:pt x="1984" y="1506"/>
                    </a:lnTo>
                    <a:lnTo>
                      <a:pt x="1988" y="1487"/>
                    </a:lnTo>
                    <a:lnTo>
                      <a:pt x="1992" y="1458"/>
                    </a:lnTo>
                    <a:lnTo>
                      <a:pt x="1996" y="1435"/>
                    </a:lnTo>
                    <a:lnTo>
                      <a:pt x="2001" y="1438"/>
                    </a:lnTo>
                    <a:lnTo>
                      <a:pt x="2005" y="1465"/>
                    </a:lnTo>
                    <a:lnTo>
                      <a:pt x="2010" y="1491"/>
                    </a:lnTo>
                    <a:lnTo>
                      <a:pt x="2014" y="1507"/>
                    </a:lnTo>
                    <a:lnTo>
                      <a:pt x="2018" y="1515"/>
                    </a:lnTo>
                    <a:lnTo>
                      <a:pt x="2023" y="1521"/>
                    </a:lnTo>
                    <a:lnTo>
                      <a:pt x="2027" y="1525"/>
                    </a:lnTo>
                    <a:lnTo>
                      <a:pt x="2031" y="1525"/>
                    </a:lnTo>
                    <a:lnTo>
                      <a:pt x="2036" y="1522"/>
                    </a:lnTo>
                    <a:lnTo>
                      <a:pt x="2040" y="1516"/>
                    </a:lnTo>
                    <a:lnTo>
                      <a:pt x="2044" y="1511"/>
                    </a:lnTo>
                    <a:lnTo>
                      <a:pt x="2049" y="1513"/>
                    </a:lnTo>
                    <a:lnTo>
                      <a:pt x="2053" y="1519"/>
                    </a:lnTo>
                    <a:lnTo>
                      <a:pt x="2057" y="1522"/>
                    </a:lnTo>
                    <a:lnTo>
                      <a:pt x="2062" y="1524"/>
                    </a:lnTo>
                    <a:lnTo>
                      <a:pt x="2066" y="1525"/>
                    </a:lnTo>
                    <a:lnTo>
                      <a:pt x="2070" y="1528"/>
                    </a:lnTo>
                    <a:lnTo>
                      <a:pt x="2075" y="1530"/>
                    </a:lnTo>
                    <a:lnTo>
                      <a:pt x="2079" y="1530"/>
                    </a:lnTo>
                    <a:lnTo>
                      <a:pt x="2084" y="1527"/>
                    </a:lnTo>
                    <a:lnTo>
                      <a:pt x="2088" y="1523"/>
                    </a:lnTo>
                    <a:lnTo>
                      <a:pt x="2092" y="1519"/>
                    </a:lnTo>
                    <a:lnTo>
                      <a:pt x="2097" y="1514"/>
                    </a:lnTo>
                    <a:lnTo>
                      <a:pt x="2101" y="1506"/>
                    </a:lnTo>
                    <a:lnTo>
                      <a:pt x="2105" y="1493"/>
                    </a:lnTo>
                    <a:lnTo>
                      <a:pt x="2110" y="1479"/>
                    </a:lnTo>
                    <a:lnTo>
                      <a:pt x="2114" y="1466"/>
                    </a:lnTo>
                    <a:lnTo>
                      <a:pt x="2118" y="1459"/>
                    </a:lnTo>
                    <a:lnTo>
                      <a:pt x="2123" y="1457"/>
                    </a:lnTo>
                    <a:lnTo>
                      <a:pt x="2127" y="1460"/>
                    </a:lnTo>
                    <a:lnTo>
                      <a:pt x="2131" y="1459"/>
                    </a:lnTo>
                    <a:lnTo>
                      <a:pt x="2136" y="1437"/>
                    </a:lnTo>
                    <a:lnTo>
                      <a:pt x="2140" y="1400"/>
                    </a:lnTo>
                    <a:lnTo>
                      <a:pt x="2142" y="1389"/>
                    </a:lnTo>
                    <a:lnTo>
                      <a:pt x="2144" y="1392"/>
                    </a:lnTo>
                    <a:lnTo>
                      <a:pt x="2149" y="1429"/>
                    </a:lnTo>
                    <a:lnTo>
                      <a:pt x="2153" y="1477"/>
                    </a:lnTo>
                    <a:lnTo>
                      <a:pt x="2158" y="1506"/>
                    </a:lnTo>
                    <a:lnTo>
                      <a:pt x="2162" y="1515"/>
                    </a:lnTo>
                    <a:lnTo>
                      <a:pt x="2166" y="1518"/>
                    </a:lnTo>
                    <a:lnTo>
                      <a:pt x="2171" y="1518"/>
                    </a:lnTo>
                    <a:lnTo>
                      <a:pt x="2175" y="1516"/>
                    </a:lnTo>
                    <a:lnTo>
                      <a:pt x="2179" y="1511"/>
                    </a:lnTo>
                    <a:lnTo>
                      <a:pt x="2183" y="1501"/>
                    </a:lnTo>
                    <a:lnTo>
                      <a:pt x="2188" y="1481"/>
                    </a:lnTo>
                    <a:lnTo>
                      <a:pt x="2192" y="1446"/>
                    </a:lnTo>
                    <a:lnTo>
                      <a:pt x="2197" y="1394"/>
                    </a:lnTo>
                    <a:lnTo>
                      <a:pt x="2201" y="1337"/>
                    </a:lnTo>
                    <a:lnTo>
                      <a:pt x="2205" y="1296"/>
                    </a:lnTo>
                    <a:lnTo>
                      <a:pt x="2207" y="1290"/>
                    </a:lnTo>
                    <a:lnTo>
                      <a:pt x="2210" y="1297"/>
                    </a:lnTo>
                    <a:lnTo>
                      <a:pt x="2212" y="1316"/>
                    </a:lnTo>
                    <a:lnTo>
                      <a:pt x="2214" y="1344"/>
                    </a:lnTo>
                    <a:lnTo>
                      <a:pt x="2218" y="1410"/>
                    </a:lnTo>
                    <a:lnTo>
                      <a:pt x="2223" y="1459"/>
                    </a:lnTo>
                    <a:lnTo>
                      <a:pt x="2227" y="1484"/>
                    </a:lnTo>
                    <a:lnTo>
                      <a:pt x="2232" y="1493"/>
                    </a:lnTo>
                    <a:lnTo>
                      <a:pt x="2236" y="1488"/>
                    </a:lnTo>
                    <a:lnTo>
                      <a:pt x="2240" y="1475"/>
                    </a:lnTo>
                    <a:lnTo>
                      <a:pt x="2244" y="1461"/>
                    </a:lnTo>
                    <a:lnTo>
                      <a:pt x="2249" y="1457"/>
                    </a:lnTo>
                    <a:lnTo>
                      <a:pt x="2253" y="1460"/>
                    </a:lnTo>
                    <a:lnTo>
                      <a:pt x="2257" y="1464"/>
                    </a:lnTo>
                    <a:lnTo>
                      <a:pt x="2262" y="1461"/>
                    </a:lnTo>
                    <a:lnTo>
                      <a:pt x="2266" y="1455"/>
                    </a:lnTo>
                    <a:lnTo>
                      <a:pt x="2271" y="1454"/>
                    </a:lnTo>
                    <a:lnTo>
                      <a:pt x="2275" y="1461"/>
                    </a:lnTo>
                    <a:lnTo>
                      <a:pt x="2279" y="1478"/>
                    </a:lnTo>
                    <a:lnTo>
                      <a:pt x="2284" y="1498"/>
                    </a:lnTo>
                    <a:lnTo>
                      <a:pt x="2288" y="1512"/>
                    </a:lnTo>
                    <a:lnTo>
                      <a:pt x="2292" y="1519"/>
                    </a:lnTo>
                    <a:lnTo>
                      <a:pt x="2297" y="1519"/>
                    </a:lnTo>
                    <a:lnTo>
                      <a:pt x="2301" y="1516"/>
                    </a:lnTo>
                    <a:lnTo>
                      <a:pt x="2305" y="1515"/>
                    </a:lnTo>
                    <a:lnTo>
                      <a:pt x="2310" y="1515"/>
                    </a:lnTo>
                    <a:lnTo>
                      <a:pt x="2314" y="1519"/>
                    </a:lnTo>
                    <a:lnTo>
                      <a:pt x="2318" y="1522"/>
                    </a:lnTo>
                    <a:lnTo>
                      <a:pt x="2323" y="1523"/>
                    </a:lnTo>
                    <a:lnTo>
                      <a:pt x="2327" y="1522"/>
                    </a:lnTo>
                    <a:lnTo>
                      <a:pt x="2331" y="1518"/>
                    </a:lnTo>
                    <a:lnTo>
                      <a:pt x="2336" y="1509"/>
                    </a:lnTo>
                    <a:lnTo>
                      <a:pt x="2340" y="1497"/>
                    </a:lnTo>
                    <a:lnTo>
                      <a:pt x="2345" y="1475"/>
                    </a:lnTo>
                    <a:lnTo>
                      <a:pt x="2349" y="1436"/>
                    </a:lnTo>
                    <a:lnTo>
                      <a:pt x="2353" y="1369"/>
                    </a:lnTo>
                    <a:lnTo>
                      <a:pt x="2357" y="1294"/>
                    </a:lnTo>
                    <a:lnTo>
                      <a:pt x="2360" y="1274"/>
                    </a:lnTo>
                    <a:lnTo>
                      <a:pt x="2362" y="1275"/>
                    </a:lnTo>
                    <a:lnTo>
                      <a:pt x="2364" y="1298"/>
                    </a:lnTo>
                    <a:lnTo>
                      <a:pt x="2366" y="1337"/>
                    </a:lnTo>
                    <a:lnTo>
                      <a:pt x="2371" y="1424"/>
                    </a:lnTo>
                    <a:lnTo>
                      <a:pt x="2373" y="1459"/>
                    </a:lnTo>
                    <a:lnTo>
                      <a:pt x="2375" y="1485"/>
                    </a:lnTo>
                    <a:lnTo>
                      <a:pt x="2379" y="1514"/>
                    </a:lnTo>
                    <a:lnTo>
                      <a:pt x="2384" y="1526"/>
                    </a:lnTo>
                    <a:lnTo>
                      <a:pt x="2388" y="1530"/>
                    </a:lnTo>
                    <a:lnTo>
                      <a:pt x="2392" y="1532"/>
                    </a:lnTo>
                    <a:lnTo>
                      <a:pt x="2397" y="1533"/>
                    </a:lnTo>
                    <a:lnTo>
                      <a:pt x="2401" y="1535"/>
                    </a:lnTo>
                    <a:lnTo>
                      <a:pt x="2405" y="1537"/>
                    </a:lnTo>
                    <a:lnTo>
                      <a:pt x="2410" y="1538"/>
                    </a:lnTo>
                    <a:lnTo>
                      <a:pt x="2414" y="1537"/>
                    </a:lnTo>
                    <a:lnTo>
                      <a:pt x="2418" y="1535"/>
                    </a:lnTo>
                    <a:lnTo>
                      <a:pt x="2423" y="1531"/>
                    </a:lnTo>
                    <a:lnTo>
                      <a:pt x="2427" y="1526"/>
                    </a:lnTo>
                    <a:lnTo>
                      <a:pt x="2431" y="1522"/>
                    </a:lnTo>
                    <a:lnTo>
                      <a:pt x="2436" y="1521"/>
                    </a:lnTo>
                    <a:lnTo>
                      <a:pt x="2440" y="1524"/>
                    </a:lnTo>
                    <a:lnTo>
                      <a:pt x="2445" y="1527"/>
                    </a:lnTo>
                    <a:lnTo>
                      <a:pt x="2449" y="1526"/>
                    </a:lnTo>
                    <a:lnTo>
                      <a:pt x="2453" y="1522"/>
                    </a:lnTo>
                    <a:lnTo>
                      <a:pt x="2458" y="1512"/>
                    </a:lnTo>
                    <a:lnTo>
                      <a:pt x="2462" y="1502"/>
                    </a:lnTo>
                    <a:lnTo>
                      <a:pt x="2466" y="1496"/>
                    </a:lnTo>
                    <a:lnTo>
                      <a:pt x="2471" y="1493"/>
                    </a:lnTo>
                    <a:lnTo>
                      <a:pt x="2475" y="1483"/>
                    </a:lnTo>
                    <a:lnTo>
                      <a:pt x="2479" y="1466"/>
                    </a:lnTo>
                    <a:lnTo>
                      <a:pt x="2484" y="1453"/>
                    </a:lnTo>
                    <a:lnTo>
                      <a:pt x="2488" y="1450"/>
                    </a:lnTo>
                    <a:lnTo>
                      <a:pt x="2492" y="1442"/>
                    </a:lnTo>
                    <a:lnTo>
                      <a:pt x="2497" y="1425"/>
                    </a:lnTo>
                    <a:lnTo>
                      <a:pt x="2501" y="1411"/>
                    </a:lnTo>
                    <a:lnTo>
                      <a:pt x="2505" y="1419"/>
                    </a:lnTo>
                    <a:lnTo>
                      <a:pt x="2510" y="1447"/>
                    </a:lnTo>
                    <a:lnTo>
                      <a:pt x="2514" y="1479"/>
                    </a:lnTo>
                    <a:lnTo>
                      <a:pt x="2519" y="1501"/>
                    </a:lnTo>
                    <a:lnTo>
                      <a:pt x="2523" y="1513"/>
                    </a:lnTo>
                    <a:lnTo>
                      <a:pt x="2527" y="1518"/>
                    </a:lnTo>
                    <a:lnTo>
                      <a:pt x="2532" y="1521"/>
                    </a:lnTo>
                    <a:lnTo>
                      <a:pt x="2536" y="1525"/>
                    </a:lnTo>
                    <a:lnTo>
                      <a:pt x="2540" y="1531"/>
                    </a:lnTo>
                    <a:lnTo>
                      <a:pt x="2544" y="1533"/>
                    </a:lnTo>
                    <a:lnTo>
                      <a:pt x="2549" y="1532"/>
                    </a:lnTo>
                    <a:lnTo>
                      <a:pt x="2553" y="1530"/>
                    </a:lnTo>
                    <a:lnTo>
                      <a:pt x="2558" y="1529"/>
                    </a:lnTo>
                    <a:lnTo>
                      <a:pt x="2562" y="1531"/>
                    </a:lnTo>
                    <a:lnTo>
                      <a:pt x="2566" y="1534"/>
                    </a:lnTo>
                    <a:lnTo>
                      <a:pt x="2571" y="1536"/>
                    </a:lnTo>
                    <a:lnTo>
                      <a:pt x="2575" y="1536"/>
                    </a:lnTo>
                    <a:lnTo>
                      <a:pt x="2579" y="1532"/>
                    </a:lnTo>
                    <a:lnTo>
                      <a:pt x="2584" y="1526"/>
                    </a:lnTo>
                    <a:lnTo>
                      <a:pt x="2588" y="1520"/>
                    </a:lnTo>
                    <a:lnTo>
                      <a:pt x="2593" y="1520"/>
                    </a:lnTo>
                    <a:lnTo>
                      <a:pt x="2597" y="1528"/>
                    </a:lnTo>
                    <a:lnTo>
                      <a:pt x="2601" y="1537"/>
                    </a:lnTo>
                    <a:lnTo>
                      <a:pt x="2605" y="1544"/>
                    </a:lnTo>
                    <a:lnTo>
                      <a:pt x="2610" y="1548"/>
                    </a:lnTo>
                    <a:lnTo>
                      <a:pt x="2614" y="1549"/>
                    </a:lnTo>
                    <a:lnTo>
                      <a:pt x="2618" y="1548"/>
                    </a:lnTo>
                    <a:lnTo>
                      <a:pt x="2623" y="1543"/>
                    </a:lnTo>
                    <a:lnTo>
                      <a:pt x="2627" y="1535"/>
                    </a:lnTo>
                    <a:lnTo>
                      <a:pt x="2632" y="1524"/>
                    </a:lnTo>
                    <a:lnTo>
                      <a:pt x="2636" y="1519"/>
                    </a:lnTo>
                    <a:lnTo>
                      <a:pt x="2640" y="1524"/>
                    </a:lnTo>
                    <a:lnTo>
                      <a:pt x="2645" y="1533"/>
                    </a:lnTo>
                    <a:lnTo>
                      <a:pt x="2649" y="1540"/>
                    </a:lnTo>
                    <a:lnTo>
                      <a:pt x="2653" y="1541"/>
                    </a:lnTo>
                    <a:lnTo>
                      <a:pt x="2658" y="1542"/>
                    </a:lnTo>
                    <a:lnTo>
                      <a:pt x="2662" y="1542"/>
                    </a:lnTo>
                    <a:lnTo>
                      <a:pt x="2666" y="1542"/>
                    </a:lnTo>
                    <a:lnTo>
                      <a:pt x="2671" y="1543"/>
                    </a:lnTo>
                    <a:lnTo>
                      <a:pt x="2675" y="1544"/>
                    </a:lnTo>
                    <a:lnTo>
                      <a:pt x="2679" y="1544"/>
                    </a:lnTo>
                    <a:lnTo>
                      <a:pt x="2684" y="1545"/>
                    </a:lnTo>
                    <a:lnTo>
                      <a:pt x="2688" y="1547"/>
                    </a:lnTo>
                    <a:lnTo>
                      <a:pt x="2692" y="1550"/>
                    </a:lnTo>
                    <a:lnTo>
                      <a:pt x="2697" y="1552"/>
                    </a:lnTo>
                    <a:lnTo>
                      <a:pt x="2701" y="1553"/>
                    </a:lnTo>
                    <a:lnTo>
                      <a:pt x="2706" y="1554"/>
                    </a:lnTo>
                    <a:lnTo>
                      <a:pt x="2710" y="1554"/>
                    </a:lnTo>
                    <a:lnTo>
                      <a:pt x="2714" y="1554"/>
                    </a:lnTo>
                    <a:lnTo>
                      <a:pt x="2718" y="1554"/>
                    </a:lnTo>
                    <a:lnTo>
                      <a:pt x="2723" y="1555"/>
                    </a:lnTo>
                    <a:lnTo>
                      <a:pt x="2727" y="1557"/>
                    </a:lnTo>
                    <a:lnTo>
                      <a:pt x="2732" y="1559"/>
                    </a:lnTo>
                    <a:lnTo>
                      <a:pt x="2736" y="1561"/>
                    </a:lnTo>
                    <a:lnTo>
                      <a:pt x="2740" y="1562"/>
                    </a:lnTo>
                    <a:lnTo>
                      <a:pt x="2745" y="1563"/>
                    </a:lnTo>
                    <a:lnTo>
                      <a:pt x="2749" y="1564"/>
                    </a:lnTo>
                    <a:lnTo>
                      <a:pt x="2753" y="1563"/>
                    </a:lnTo>
                    <a:lnTo>
                      <a:pt x="2758" y="1560"/>
                    </a:lnTo>
                    <a:lnTo>
                      <a:pt x="2762" y="1556"/>
                    </a:lnTo>
                    <a:lnTo>
                      <a:pt x="2766" y="1551"/>
                    </a:lnTo>
                    <a:lnTo>
                      <a:pt x="2771" y="1550"/>
                    </a:lnTo>
                    <a:lnTo>
                      <a:pt x="2775" y="1554"/>
                    </a:lnTo>
                    <a:lnTo>
                      <a:pt x="2779" y="1560"/>
                    </a:lnTo>
                    <a:lnTo>
                      <a:pt x="2784" y="1563"/>
                    </a:lnTo>
                    <a:lnTo>
                      <a:pt x="2788" y="1565"/>
                    </a:lnTo>
                    <a:lnTo>
                      <a:pt x="2792" y="1565"/>
                    </a:lnTo>
                    <a:lnTo>
                      <a:pt x="2797" y="1564"/>
                    </a:lnTo>
                    <a:lnTo>
                      <a:pt x="2801" y="1563"/>
                    </a:lnTo>
                    <a:lnTo>
                      <a:pt x="2805" y="1562"/>
                    </a:lnTo>
                    <a:lnTo>
                      <a:pt x="2810" y="1562"/>
                    </a:lnTo>
                    <a:lnTo>
                      <a:pt x="2814" y="1562"/>
                    </a:lnTo>
                    <a:lnTo>
                      <a:pt x="2819" y="1562"/>
                    </a:lnTo>
                    <a:lnTo>
                      <a:pt x="2823" y="1562"/>
                    </a:lnTo>
                    <a:lnTo>
                      <a:pt x="2827" y="1563"/>
                    </a:lnTo>
                    <a:lnTo>
                      <a:pt x="2832" y="1563"/>
                    </a:lnTo>
                    <a:lnTo>
                      <a:pt x="2836" y="1562"/>
                    </a:lnTo>
                    <a:lnTo>
                      <a:pt x="2840" y="1558"/>
                    </a:lnTo>
                    <a:lnTo>
                      <a:pt x="2845" y="1550"/>
                    </a:lnTo>
                    <a:lnTo>
                      <a:pt x="2849" y="1536"/>
                    </a:lnTo>
                    <a:lnTo>
                      <a:pt x="2853" y="1523"/>
                    </a:lnTo>
                    <a:lnTo>
                      <a:pt x="2858" y="1519"/>
                    </a:lnTo>
                    <a:lnTo>
                      <a:pt x="2862" y="1527"/>
                    </a:lnTo>
                    <a:lnTo>
                      <a:pt x="2866" y="1542"/>
                    </a:lnTo>
                    <a:lnTo>
                      <a:pt x="2871" y="1554"/>
                    </a:lnTo>
                    <a:lnTo>
                      <a:pt x="2875" y="1559"/>
                    </a:lnTo>
                    <a:lnTo>
                      <a:pt x="2879" y="1560"/>
                    </a:lnTo>
                    <a:lnTo>
                      <a:pt x="2884" y="1555"/>
                    </a:lnTo>
                    <a:lnTo>
                      <a:pt x="2888" y="1538"/>
                    </a:lnTo>
                    <a:lnTo>
                      <a:pt x="2890" y="1522"/>
                    </a:lnTo>
                    <a:lnTo>
                      <a:pt x="2893" y="1496"/>
                    </a:lnTo>
                    <a:lnTo>
                      <a:pt x="2895" y="1459"/>
                    </a:lnTo>
                    <a:lnTo>
                      <a:pt x="2897" y="1404"/>
                    </a:lnTo>
                    <a:lnTo>
                      <a:pt x="2899" y="1323"/>
                    </a:lnTo>
                    <a:lnTo>
                      <a:pt x="2901" y="1207"/>
                    </a:lnTo>
                    <a:lnTo>
                      <a:pt x="2903" y="1048"/>
                    </a:lnTo>
                    <a:lnTo>
                      <a:pt x="2905" y="844"/>
                    </a:lnTo>
                    <a:lnTo>
                      <a:pt x="2910" y="359"/>
                    </a:lnTo>
                    <a:lnTo>
                      <a:pt x="2912" y="147"/>
                    </a:lnTo>
                    <a:lnTo>
                      <a:pt x="2914" y="16"/>
                    </a:lnTo>
                    <a:lnTo>
                      <a:pt x="2916" y="0"/>
                    </a:lnTo>
                    <a:lnTo>
                      <a:pt x="2919" y="105"/>
                    </a:lnTo>
                    <a:lnTo>
                      <a:pt x="2921" y="308"/>
                    </a:lnTo>
                    <a:lnTo>
                      <a:pt x="2923" y="564"/>
                    </a:lnTo>
                    <a:lnTo>
                      <a:pt x="2925" y="824"/>
                    </a:lnTo>
                    <a:lnTo>
                      <a:pt x="2927" y="1051"/>
                    </a:lnTo>
                    <a:lnTo>
                      <a:pt x="2929" y="1225"/>
                    </a:lnTo>
                    <a:lnTo>
                      <a:pt x="2932" y="1345"/>
                    </a:lnTo>
                    <a:lnTo>
                      <a:pt x="2934" y="1418"/>
                    </a:lnTo>
                    <a:lnTo>
                      <a:pt x="2936" y="1460"/>
                    </a:lnTo>
                    <a:lnTo>
                      <a:pt x="2938" y="1481"/>
                    </a:lnTo>
                    <a:lnTo>
                      <a:pt x="2940" y="1493"/>
                    </a:lnTo>
                    <a:lnTo>
                      <a:pt x="2945" y="1510"/>
                    </a:lnTo>
                    <a:lnTo>
                      <a:pt x="2949" y="1531"/>
                    </a:lnTo>
                    <a:lnTo>
                      <a:pt x="2953" y="1550"/>
                    </a:lnTo>
                    <a:lnTo>
                      <a:pt x="2958" y="1564"/>
                    </a:lnTo>
                    <a:lnTo>
                      <a:pt x="2962" y="1570"/>
                    </a:lnTo>
                    <a:lnTo>
                      <a:pt x="2966" y="1572"/>
                    </a:lnTo>
                    <a:lnTo>
                      <a:pt x="2971" y="1573"/>
                    </a:lnTo>
                    <a:lnTo>
                      <a:pt x="2975" y="1572"/>
                    </a:lnTo>
                    <a:lnTo>
                      <a:pt x="2979" y="1570"/>
                    </a:lnTo>
                    <a:lnTo>
                      <a:pt x="2984" y="1567"/>
                    </a:lnTo>
                    <a:lnTo>
                      <a:pt x="2988" y="1563"/>
                    </a:lnTo>
                    <a:lnTo>
                      <a:pt x="2993" y="1562"/>
                    </a:lnTo>
                    <a:lnTo>
                      <a:pt x="2997" y="1564"/>
                    </a:lnTo>
                    <a:lnTo>
                      <a:pt x="3001" y="1568"/>
                    </a:lnTo>
                    <a:lnTo>
                      <a:pt x="3006" y="1572"/>
                    </a:lnTo>
                    <a:lnTo>
                      <a:pt x="3010" y="1574"/>
                    </a:lnTo>
                    <a:lnTo>
                      <a:pt x="3014" y="1575"/>
                    </a:lnTo>
                    <a:lnTo>
                      <a:pt x="3018" y="1575"/>
                    </a:lnTo>
                    <a:lnTo>
                      <a:pt x="3023" y="1576"/>
                    </a:lnTo>
                    <a:lnTo>
                      <a:pt x="3027" y="1576"/>
                    </a:lnTo>
                    <a:lnTo>
                      <a:pt x="3032" y="1574"/>
                    </a:lnTo>
                    <a:lnTo>
                      <a:pt x="3036" y="1573"/>
                    </a:lnTo>
                    <a:lnTo>
                      <a:pt x="3040" y="1572"/>
                    </a:lnTo>
                    <a:lnTo>
                      <a:pt x="3045" y="1569"/>
                    </a:lnTo>
                    <a:lnTo>
                      <a:pt x="3049" y="1567"/>
                    </a:lnTo>
                    <a:lnTo>
                      <a:pt x="3053" y="1564"/>
                    </a:lnTo>
                    <a:lnTo>
                      <a:pt x="3058" y="1560"/>
                    </a:lnTo>
                    <a:lnTo>
                      <a:pt x="3062" y="1558"/>
                    </a:lnTo>
                    <a:lnTo>
                      <a:pt x="3067" y="1558"/>
                    </a:lnTo>
                    <a:lnTo>
                      <a:pt x="3071" y="1560"/>
                    </a:lnTo>
                    <a:lnTo>
                      <a:pt x="3075" y="1561"/>
                    </a:lnTo>
                    <a:lnTo>
                      <a:pt x="3079" y="1560"/>
                    </a:lnTo>
                    <a:lnTo>
                      <a:pt x="3084" y="1559"/>
                    </a:lnTo>
                    <a:lnTo>
                      <a:pt x="3088" y="1559"/>
                    </a:lnTo>
                    <a:lnTo>
                      <a:pt x="3092" y="1562"/>
                    </a:lnTo>
                    <a:lnTo>
                      <a:pt x="3097" y="1567"/>
                    </a:lnTo>
                    <a:lnTo>
                      <a:pt x="3101" y="1571"/>
                    </a:lnTo>
                    <a:lnTo>
                      <a:pt x="3106" y="1574"/>
                    </a:lnTo>
                    <a:lnTo>
                      <a:pt x="3110" y="1575"/>
                    </a:lnTo>
                    <a:lnTo>
                      <a:pt x="3114" y="1576"/>
                    </a:lnTo>
                    <a:lnTo>
                      <a:pt x="3119" y="1576"/>
                    </a:lnTo>
                    <a:lnTo>
                      <a:pt x="3123" y="1575"/>
                    </a:lnTo>
                    <a:lnTo>
                      <a:pt x="3127" y="1572"/>
                    </a:lnTo>
                    <a:lnTo>
                      <a:pt x="3132" y="1568"/>
                    </a:lnTo>
                    <a:lnTo>
                      <a:pt x="3136" y="1560"/>
                    </a:lnTo>
                    <a:lnTo>
                      <a:pt x="3140" y="1548"/>
                    </a:lnTo>
                    <a:lnTo>
                      <a:pt x="3145" y="1539"/>
                    </a:lnTo>
                    <a:lnTo>
                      <a:pt x="3149" y="1538"/>
                    </a:lnTo>
                    <a:lnTo>
                      <a:pt x="3153" y="1546"/>
                    </a:lnTo>
                    <a:lnTo>
                      <a:pt x="3158" y="1558"/>
                    </a:lnTo>
                    <a:lnTo>
                      <a:pt x="3162" y="1568"/>
                    </a:lnTo>
                    <a:lnTo>
                      <a:pt x="3166" y="1573"/>
                    </a:lnTo>
                    <a:lnTo>
                      <a:pt x="3171" y="1575"/>
                    </a:lnTo>
                    <a:lnTo>
                      <a:pt x="3175" y="1575"/>
                    </a:lnTo>
                    <a:lnTo>
                      <a:pt x="3180" y="1576"/>
                    </a:lnTo>
                    <a:lnTo>
                      <a:pt x="3184" y="1576"/>
                    </a:lnTo>
                    <a:lnTo>
                      <a:pt x="3188" y="1576"/>
                    </a:lnTo>
                    <a:lnTo>
                      <a:pt x="3193" y="1576"/>
                    </a:lnTo>
                    <a:lnTo>
                      <a:pt x="3197" y="1577"/>
                    </a:lnTo>
                    <a:lnTo>
                      <a:pt x="3201" y="1577"/>
                    </a:lnTo>
                    <a:lnTo>
                      <a:pt x="3206" y="1579"/>
                    </a:lnTo>
                    <a:lnTo>
                      <a:pt x="3210" y="1580"/>
                    </a:lnTo>
                    <a:lnTo>
                      <a:pt x="3214" y="1582"/>
                    </a:lnTo>
                    <a:lnTo>
                      <a:pt x="3219" y="1583"/>
                    </a:lnTo>
                    <a:lnTo>
                      <a:pt x="3223" y="1583"/>
                    </a:lnTo>
                    <a:lnTo>
                      <a:pt x="3227" y="1583"/>
                    </a:lnTo>
                    <a:lnTo>
                      <a:pt x="3232" y="1583"/>
                    </a:lnTo>
                    <a:lnTo>
                      <a:pt x="3236" y="1583"/>
                    </a:lnTo>
                    <a:lnTo>
                      <a:pt x="3240" y="1583"/>
                    </a:lnTo>
                    <a:lnTo>
                      <a:pt x="3245" y="1583"/>
                    </a:lnTo>
                    <a:lnTo>
                      <a:pt x="3249" y="1582"/>
                    </a:lnTo>
                    <a:lnTo>
                      <a:pt x="3254" y="1582"/>
                    </a:lnTo>
                    <a:lnTo>
                      <a:pt x="3258" y="1581"/>
                    </a:lnTo>
                    <a:lnTo>
                      <a:pt x="3262" y="1579"/>
                    </a:lnTo>
                    <a:lnTo>
                      <a:pt x="3266" y="1577"/>
                    </a:lnTo>
                    <a:lnTo>
                      <a:pt x="3271" y="1574"/>
                    </a:lnTo>
                    <a:lnTo>
                      <a:pt x="3275" y="1569"/>
                    </a:lnTo>
                    <a:lnTo>
                      <a:pt x="3280" y="1564"/>
                    </a:lnTo>
                    <a:lnTo>
                      <a:pt x="3284" y="1560"/>
                    </a:lnTo>
                    <a:lnTo>
                      <a:pt x="3288" y="1559"/>
                    </a:lnTo>
                    <a:lnTo>
                      <a:pt x="3293" y="1561"/>
                    </a:lnTo>
                    <a:lnTo>
                      <a:pt x="3297" y="1567"/>
                    </a:lnTo>
                    <a:lnTo>
                      <a:pt x="3301" y="1573"/>
                    </a:lnTo>
                    <a:lnTo>
                      <a:pt x="3306" y="1578"/>
                    </a:lnTo>
                    <a:lnTo>
                      <a:pt x="3310" y="1581"/>
                    </a:lnTo>
                    <a:lnTo>
                      <a:pt x="3314" y="1583"/>
                    </a:lnTo>
                    <a:lnTo>
                      <a:pt x="3319" y="1584"/>
                    </a:lnTo>
                    <a:lnTo>
                      <a:pt x="3323" y="1585"/>
                    </a:lnTo>
                    <a:lnTo>
                      <a:pt x="3327" y="1585"/>
                    </a:lnTo>
                    <a:lnTo>
                      <a:pt x="3332" y="1586"/>
                    </a:lnTo>
                    <a:lnTo>
                      <a:pt x="3336" y="1586"/>
                    </a:lnTo>
                    <a:lnTo>
                      <a:pt x="3340" y="1586"/>
                    </a:lnTo>
                    <a:lnTo>
                      <a:pt x="3345" y="1585"/>
                    </a:lnTo>
                    <a:lnTo>
                      <a:pt x="3349" y="1585"/>
                    </a:lnTo>
                    <a:lnTo>
                      <a:pt x="3354" y="1585"/>
                    </a:lnTo>
                    <a:lnTo>
                      <a:pt x="3358" y="1584"/>
                    </a:lnTo>
                    <a:lnTo>
                      <a:pt x="3362" y="1584"/>
                    </a:lnTo>
                    <a:lnTo>
                      <a:pt x="3367" y="1584"/>
                    </a:lnTo>
                    <a:lnTo>
                      <a:pt x="3371" y="1584"/>
                    </a:lnTo>
                    <a:lnTo>
                      <a:pt x="3375" y="1584"/>
                    </a:lnTo>
                    <a:lnTo>
                      <a:pt x="3379" y="1585"/>
                    </a:lnTo>
                    <a:lnTo>
                      <a:pt x="3384" y="1584"/>
                    </a:lnTo>
                    <a:lnTo>
                      <a:pt x="3388" y="1585"/>
                    </a:lnTo>
                    <a:lnTo>
                      <a:pt x="3393" y="1585"/>
                    </a:lnTo>
                    <a:lnTo>
                      <a:pt x="3397" y="1585"/>
                    </a:lnTo>
                    <a:lnTo>
                      <a:pt x="3401" y="1585"/>
                    </a:lnTo>
                    <a:lnTo>
                      <a:pt x="3406" y="1582"/>
                    </a:lnTo>
                    <a:lnTo>
                      <a:pt x="3410" y="1579"/>
                    </a:lnTo>
                    <a:lnTo>
                      <a:pt x="3414" y="1575"/>
                    </a:lnTo>
                    <a:lnTo>
                      <a:pt x="3419" y="1571"/>
                    </a:lnTo>
                    <a:lnTo>
                      <a:pt x="3423" y="1566"/>
                    </a:lnTo>
                    <a:lnTo>
                      <a:pt x="3427" y="1561"/>
                    </a:lnTo>
                    <a:lnTo>
                      <a:pt x="3432" y="1559"/>
                    </a:lnTo>
                    <a:lnTo>
                      <a:pt x="3436" y="1560"/>
                    </a:lnTo>
                    <a:lnTo>
                      <a:pt x="3440" y="1565"/>
                    </a:lnTo>
                    <a:lnTo>
                      <a:pt x="3445" y="1571"/>
                    </a:lnTo>
                    <a:lnTo>
                      <a:pt x="3449" y="1576"/>
                    </a:lnTo>
                    <a:lnTo>
                      <a:pt x="3453" y="1579"/>
                    </a:lnTo>
                    <a:lnTo>
                      <a:pt x="3458" y="1580"/>
                    </a:lnTo>
                    <a:lnTo>
                      <a:pt x="3462" y="1581"/>
                    </a:lnTo>
                    <a:lnTo>
                      <a:pt x="3467" y="1583"/>
                    </a:lnTo>
                    <a:lnTo>
                      <a:pt x="3471" y="1584"/>
                    </a:lnTo>
                    <a:lnTo>
                      <a:pt x="3475" y="1585"/>
                    </a:lnTo>
                    <a:lnTo>
                      <a:pt x="3480" y="1587"/>
                    </a:lnTo>
                    <a:lnTo>
                      <a:pt x="3484" y="1587"/>
                    </a:lnTo>
                    <a:lnTo>
                      <a:pt x="3488" y="1588"/>
                    </a:lnTo>
                    <a:lnTo>
                      <a:pt x="3493" y="1589"/>
                    </a:lnTo>
                    <a:lnTo>
                      <a:pt x="3497" y="1589"/>
                    </a:lnTo>
                    <a:lnTo>
                      <a:pt x="3501" y="1588"/>
                    </a:lnTo>
                    <a:lnTo>
                      <a:pt x="3506" y="1588"/>
                    </a:lnTo>
                    <a:lnTo>
                      <a:pt x="3510" y="1587"/>
                    </a:lnTo>
                    <a:lnTo>
                      <a:pt x="3514" y="1585"/>
                    </a:lnTo>
                    <a:lnTo>
                      <a:pt x="3519" y="1583"/>
                    </a:lnTo>
                    <a:lnTo>
                      <a:pt x="3523" y="1581"/>
                    </a:lnTo>
                    <a:lnTo>
                      <a:pt x="3527" y="1580"/>
                    </a:lnTo>
                    <a:lnTo>
                      <a:pt x="3532" y="1580"/>
                    </a:lnTo>
                    <a:lnTo>
                      <a:pt x="3536" y="1582"/>
                    </a:lnTo>
                    <a:lnTo>
                      <a:pt x="3541" y="1585"/>
                    </a:lnTo>
                    <a:lnTo>
                      <a:pt x="3545" y="1587"/>
                    </a:lnTo>
                    <a:lnTo>
                      <a:pt x="3549" y="1588"/>
                    </a:lnTo>
                    <a:lnTo>
                      <a:pt x="3554" y="1589"/>
                    </a:lnTo>
                    <a:lnTo>
                      <a:pt x="3558" y="1590"/>
                    </a:lnTo>
                    <a:lnTo>
                      <a:pt x="3562" y="1590"/>
                    </a:lnTo>
                    <a:lnTo>
                      <a:pt x="3566" y="1590"/>
                    </a:lnTo>
                    <a:lnTo>
                      <a:pt x="3571" y="1589"/>
                    </a:lnTo>
                    <a:lnTo>
                      <a:pt x="3575" y="1589"/>
                    </a:lnTo>
                    <a:lnTo>
                      <a:pt x="3580" y="1588"/>
                    </a:lnTo>
                    <a:lnTo>
                      <a:pt x="3584" y="1587"/>
                    </a:lnTo>
                    <a:lnTo>
                      <a:pt x="3588" y="1587"/>
                    </a:lnTo>
                    <a:lnTo>
                      <a:pt x="3593" y="1587"/>
                    </a:lnTo>
                    <a:lnTo>
                      <a:pt x="3597" y="1587"/>
                    </a:lnTo>
                    <a:lnTo>
                      <a:pt x="3601" y="1587"/>
                    </a:lnTo>
                    <a:lnTo>
                      <a:pt x="3606" y="1588"/>
                    </a:lnTo>
                    <a:lnTo>
                      <a:pt x="3610" y="1588"/>
                    </a:lnTo>
                    <a:lnTo>
                      <a:pt x="3615" y="1588"/>
                    </a:lnTo>
                    <a:lnTo>
                      <a:pt x="3619" y="1588"/>
                    </a:lnTo>
                    <a:lnTo>
                      <a:pt x="3623" y="1589"/>
                    </a:lnTo>
                    <a:lnTo>
                      <a:pt x="3627" y="1590"/>
                    </a:lnTo>
                    <a:lnTo>
                      <a:pt x="3632" y="1590"/>
                    </a:lnTo>
                    <a:lnTo>
                      <a:pt x="3636" y="1591"/>
                    </a:lnTo>
                    <a:lnTo>
                      <a:pt x="3640" y="1591"/>
                    </a:lnTo>
                    <a:lnTo>
                      <a:pt x="3645" y="1591"/>
                    </a:lnTo>
                    <a:lnTo>
                      <a:pt x="3649" y="1591"/>
                    </a:lnTo>
                    <a:lnTo>
                      <a:pt x="3654" y="1591"/>
                    </a:lnTo>
                    <a:lnTo>
                      <a:pt x="3658" y="1591"/>
                    </a:lnTo>
                    <a:lnTo>
                      <a:pt x="3662" y="1591"/>
                    </a:lnTo>
                    <a:lnTo>
                      <a:pt x="3667" y="1591"/>
                    </a:lnTo>
                    <a:lnTo>
                      <a:pt x="3671" y="1590"/>
                    </a:lnTo>
                    <a:lnTo>
                      <a:pt x="3675" y="1590"/>
                    </a:lnTo>
                    <a:lnTo>
                      <a:pt x="3680" y="1590"/>
                    </a:lnTo>
                    <a:lnTo>
                      <a:pt x="3684" y="1590"/>
                    </a:lnTo>
                    <a:lnTo>
                      <a:pt x="3688" y="1590"/>
                    </a:lnTo>
                    <a:lnTo>
                      <a:pt x="3693" y="1590"/>
                    </a:lnTo>
                    <a:lnTo>
                      <a:pt x="3697" y="1589"/>
                    </a:lnTo>
                    <a:lnTo>
                      <a:pt x="3701" y="1588"/>
                    </a:lnTo>
                    <a:lnTo>
                      <a:pt x="3706" y="1587"/>
                    </a:lnTo>
                    <a:lnTo>
                      <a:pt x="3710" y="1585"/>
                    </a:lnTo>
                    <a:lnTo>
                      <a:pt x="3714" y="1582"/>
                    </a:lnTo>
                    <a:lnTo>
                      <a:pt x="3719" y="1578"/>
                    </a:lnTo>
                    <a:lnTo>
                      <a:pt x="3723" y="1573"/>
                    </a:lnTo>
                    <a:lnTo>
                      <a:pt x="3728" y="1569"/>
                    </a:lnTo>
                    <a:lnTo>
                      <a:pt x="3732" y="1568"/>
                    </a:lnTo>
                    <a:lnTo>
                      <a:pt x="3736" y="1570"/>
                    </a:lnTo>
                    <a:lnTo>
                      <a:pt x="3740" y="1575"/>
                    </a:lnTo>
                    <a:lnTo>
                      <a:pt x="3745" y="1580"/>
                    </a:lnTo>
                    <a:lnTo>
                      <a:pt x="3749" y="1583"/>
                    </a:lnTo>
                    <a:lnTo>
                      <a:pt x="3754" y="1585"/>
                    </a:lnTo>
                    <a:lnTo>
                      <a:pt x="3758" y="1585"/>
                    </a:lnTo>
                    <a:lnTo>
                      <a:pt x="3762" y="1586"/>
                    </a:lnTo>
                    <a:lnTo>
                      <a:pt x="3767" y="1587"/>
                    </a:lnTo>
                    <a:lnTo>
                      <a:pt x="3771" y="1588"/>
                    </a:lnTo>
                    <a:lnTo>
                      <a:pt x="3775" y="1590"/>
                    </a:lnTo>
                    <a:lnTo>
                      <a:pt x="3780" y="1591"/>
                    </a:lnTo>
                    <a:lnTo>
                      <a:pt x="3784" y="1591"/>
                    </a:lnTo>
                    <a:lnTo>
                      <a:pt x="3788" y="1592"/>
                    </a:lnTo>
                    <a:lnTo>
                      <a:pt x="3793" y="1592"/>
                    </a:lnTo>
                    <a:lnTo>
                      <a:pt x="3797" y="1592"/>
                    </a:lnTo>
                    <a:lnTo>
                      <a:pt x="3801" y="1592"/>
                    </a:lnTo>
                    <a:lnTo>
                      <a:pt x="3806" y="1591"/>
                    </a:lnTo>
                    <a:lnTo>
                      <a:pt x="3810" y="1591"/>
                    </a:lnTo>
                    <a:lnTo>
                      <a:pt x="3814" y="1590"/>
                    </a:lnTo>
                    <a:lnTo>
                      <a:pt x="3819" y="1589"/>
                    </a:lnTo>
                    <a:lnTo>
                      <a:pt x="3823" y="1589"/>
                    </a:lnTo>
                    <a:lnTo>
                      <a:pt x="3828" y="1590"/>
                    </a:lnTo>
                    <a:lnTo>
                      <a:pt x="3832" y="1590"/>
                    </a:lnTo>
                    <a:lnTo>
                      <a:pt x="3836" y="1590"/>
                    </a:lnTo>
                    <a:lnTo>
                      <a:pt x="3841" y="1590"/>
                    </a:lnTo>
                    <a:lnTo>
                      <a:pt x="3845" y="1590"/>
                    </a:lnTo>
                    <a:lnTo>
                      <a:pt x="3849" y="1589"/>
                    </a:lnTo>
                    <a:lnTo>
                      <a:pt x="3854" y="1588"/>
                    </a:lnTo>
                    <a:lnTo>
                      <a:pt x="3858" y="1587"/>
                    </a:lnTo>
                    <a:lnTo>
                      <a:pt x="3862" y="1587"/>
                    </a:lnTo>
                    <a:lnTo>
                      <a:pt x="3867" y="1587"/>
                    </a:lnTo>
                    <a:lnTo>
                      <a:pt x="3871" y="1588"/>
                    </a:lnTo>
                    <a:lnTo>
                      <a:pt x="3875" y="1590"/>
                    </a:lnTo>
                    <a:lnTo>
                      <a:pt x="3880" y="1591"/>
                    </a:lnTo>
                    <a:lnTo>
                      <a:pt x="3884" y="1592"/>
                    </a:lnTo>
                    <a:lnTo>
                      <a:pt x="3888" y="1592"/>
                    </a:lnTo>
                    <a:lnTo>
                      <a:pt x="3893" y="1593"/>
                    </a:lnTo>
                    <a:lnTo>
                      <a:pt x="3897" y="1592"/>
                    </a:lnTo>
                    <a:lnTo>
                      <a:pt x="3902" y="1592"/>
                    </a:lnTo>
                    <a:lnTo>
                      <a:pt x="3906" y="1592"/>
                    </a:lnTo>
                    <a:lnTo>
                      <a:pt x="3910" y="1592"/>
                    </a:lnTo>
                    <a:lnTo>
                      <a:pt x="3915" y="1593"/>
                    </a:lnTo>
                    <a:lnTo>
                      <a:pt x="3919" y="1593"/>
                    </a:lnTo>
                    <a:lnTo>
                      <a:pt x="3923" y="1593"/>
                    </a:lnTo>
                    <a:lnTo>
                      <a:pt x="3927" y="1593"/>
                    </a:lnTo>
                    <a:lnTo>
                      <a:pt x="3932" y="1593"/>
                    </a:lnTo>
                    <a:lnTo>
                      <a:pt x="3936" y="1593"/>
                    </a:lnTo>
                    <a:lnTo>
                      <a:pt x="3941" y="1594"/>
                    </a:lnTo>
                    <a:lnTo>
                      <a:pt x="3945" y="1594"/>
                    </a:lnTo>
                    <a:lnTo>
                      <a:pt x="3949" y="1594"/>
                    </a:lnTo>
                    <a:lnTo>
                      <a:pt x="3954" y="1594"/>
                    </a:lnTo>
                    <a:lnTo>
                      <a:pt x="3958" y="1594"/>
                    </a:lnTo>
                    <a:lnTo>
                      <a:pt x="3962" y="1594"/>
                    </a:lnTo>
                    <a:lnTo>
                      <a:pt x="3967" y="1593"/>
                    </a:lnTo>
                    <a:lnTo>
                      <a:pt x="3971" y="1594"/>
                    </a:lnTo>
                    <a:lnTo>
                      <a:pt x="3976" y="1594"/>
                    </a:lnTo>
                    <a:lnTo>
                      <a:pt x="3980" y="1594"/>
                    </a:lnTo>
                    <a:lnTo>
                      <a:pt x="3984" y="1594"/>
                    </a:lnTo>
                    <a:lnTo>
                      <a:pt x="3988" y="1594"/>
                    </a:lnTo>
                    <a:lnTo>
                      <a:pt x="3993" y="1593"/>
                    </a:lnTo>
                    <a:lnTo>
                      <a:pt x="3997" y="1591"/>
                    </a:lnTo>
                    <a:lnTo>
                      <a:pt x="4001" y="1589"/>
                    </a:lnTo>
                    <a:lnTo>
                      <a:pt x="4006" y="1586"/>
                    </a:lnTo>
                    <a:lnTo>
                      <a:pt x="4010" y="1582"/>
                    </a:lnTo>
                    <a:lnTo>
                      <a:pt x="4015" y="1576"/>
                    </a:lnTo>
                    <a:lnTo>
                      <a:pt x="4019" y="1569"/>
                    </a:lnTo>
                    <a:lnTo>
                      <a:pt x="4023" y="1558"/>
                    </a:lnTo>
                    <a:lnTo>
                      <a:pt x="4028" y="1545"/>
                    </a:lnTo>
                    <a:lnTo>
                      <a:pt x="4032" y="1528"/>
                    </a:lnTo>
                    <a:lnTo>
                      <a:pt x="4036" y="1512"/>
                    </a:lnTo>
                    <a:lnTo>
                      <a:pt x="4041" y="1504"/>
                    </a:lnTo>
                    <a:lnTo>
                      <a:pt x="4045" y="1507"/>
                    </a:lnTo>
                    <a:lnTo>
                      <a:pt x="4049" y="1520"/>
                    </a:lnTo>
                    <a:lnTo>
                      <a:pt x="4054" y="1538"/>
                    </a:lnTo>
                    <a:lnTo>
                      <a:pt x="4058" y="1554"/>
                    </a:lnTo>
                    <a:lnTo>
                      <a:pt x="4062" y="1565"/>
                    </a:lnTo>
                    <a:lnTo>
                      <a:pt x="4067" y="1573"/>
                    </a:lnTo>
                    <a:lnTo>
                      <a:pt x="4071" y="1580"/>
                    </a:lnTo>
                    <a:lnTo>
                      <a:pt x="4075" y="1585"/>
                    </a:lnTo>
                    <a:lnTo>
                      <a:pt x="4080" y="1589"/>
                    </a:lnTo>
                    <a:lnTo>
                      <a:pt x="4084" y="1591"/>
                    </a:lnTo>
                    <a:lnTo>
                      <a:pt x="4089" y="1593"/>
                    </a:lnTo>
                    <a:lnTo>
                      <a:pt x="4093" y="1593"/>
                    </a:lnTo>
                    <a:lnTo>
                      <a:pt x="4097" y="1594"/>
                    </a:lnTo>
                    <a:lnTo>
                      <a:pt x="4101" y="1594"/>
                    </a:lnTo>
                    <a:lnTo>
                      <a:pt x="4106" y="1594"/>
                    </a:lnTo>
                    <a:lnTo>
                      <a:pt x="4110" y="1593"/>
                    </a:lnTo>
                    <a:lnTo>
                      <a:pt x="4115" y="1592"/>
                    </a:lnTo>
                    <a:lnTo>
                      <a:pt x="4119" y="1591"/>
                    </a:lnTo>
                    <a:lnTo>
                      <a:pt x="4123" y="1590"/>
                    </a:lnTo>
                    <a:lnTo>
                      <a:pt x="4128" y="1590"/>
                    </a:lnTo>
                    <a:lnTo>
                      <a:pt x="4132" y="1590"/>
                    </a:lnTo>
                    <a:lnTo>
                      <a:pt x="4136" y="1589"/>
                    </a:lnTo>
                    <a:lnTo>
                      <a:pt x="4141" y="1588"/>
                    </a:lnTo>
                    <a:lnTo>
                      <a:pt x="4145" y="1586"/>
                    </a:lnTo>
                    <a:lnTo>
                      <a:pt x="4149" y="1583"/>
                    </a:lnTo>
                    <a:lnTo>
                      <a:pt x="4154" y="1578"/>
                    </a:lnTo>
                    <a:lnTo>
                      <a:pt x="4158" y="1572"/>
                    </a:lnTo>
                    <a:lnTo>
                      <a:pt x="4162" y="1564"/>
                    </a:lnTo>
                    <a:lnTo>
                      <a:pt x="4167" y="1552"/>
                    </a:lnTo>
                    <a:lnTo>
                      <a:pt x="4171" y="1536"/>
                    </a:lnTo>
                    <a:lnTo>
                      <a:pt x="4175" y="1516"/>
                    </a:lnTo>
                    <a:lnTo>
                      <a:pt x="4180" y="1497"/>
                    </a:lnTo>
                    <a:lnTo>
                      <a:pt x="4184" y="1485"/>
                    </a:lnTo>
                    <a:lnTo>
                      <a:pt x="4188" y="1486"/>
                    </a:lnTo>
                    <a:lnTo>
                      <a:pt x="4193" y="1498"/>
                    </a:lnTo>
                    <a:lnTo>
                      <a:pt x="4197" y="1518"/>
                    </a:lnTo>
                    <a:lnTo>
                      <a:pt x="4202" y="1537"/>
                    </a:lnTo>
                    <a:lnTo>
                      <a:pt x="4206" y="1552"/>
                    </a:lnTo>
                    <a:lnTo>
                      <a:pt x="4210" y="1564"/>
                    </a:lnTo>
                    <a:lnTo>
                      <a:pt x="4215" y="1573"/>
                    </a:lnTo>
                    <a:lnTo>
                      <a:pt x="4219" y="1580"/>
                    </a:lnTo>
                    <a:lnTo>
                      <a:pt x="4223" y="1585"/>
                    </a:lnTo>
                    <a:lnTo>
                      <a:pt x="4228" y="1589"/>
                    </a:lnTo>
                    <a:lnTo>
                      <a:pt x="4232" y="1592"/>
                    </a:lnTo>
                    <a:lnTo>
                      <a:pt x="4236" y="1593"/>
                    </a:lnTo>
                    <a:lnTo>
                      <a:pt x="4241" y="1594"/>
                    </a:lnTo>
                    <a:lnTo>
                      <a:pt x="4245" y="1594"/>
                    </a:lnTo>
                    <a:lnTo>
                      <a:pt x="4249" y="1595"/>
                    </a:lnTo>
                    <a:lnTo>
                      <a:pt x="4254" y="1595"/>
                    </a:lnTo>
                    <a:lnTo>
                      <a:pt x="4258" y="1595"/>
                    </a:lnTo>
                    <a:lnTo>
                      <a:pt x="4262" y="1595"/>
                    </a:lnTo>
                    <a:lnTo>
                      <a:pt x="4267" y="1595"/>
                    </a:lnTo>
                    <a:lnTo>
                      <a:pt x="4271" y="1595"/>
                    </a:lnTo>
                    <a:lnTo>
                      <a:pt x="4276" y="1595"/>
                    </a:lnTo>
                    <a:lnTo>
                      <a:pt x="4280" y="1595"/>
                    </a:lnTo>
                    <a:lnTo>
                      <a:pt x="4284" y="1594"/>
                    </a:lnTo>
                    <a:lnTo>
                      <a:pt x="4288" y="1595"/>
                    </a:lnTo>
                    <a:lnTo>
                      <a:pt x="4293" y="1595"/>
                    </a:lnTo>
                    <a:lnTo>
                      <a:pt x="4297" y="1595"/>
                    </a:lnTo>
                    <a:lnTo>
                      <a:pt x="4302" y="1595"/>
                    </a:lnTo>
                    <a:lnTo>
                      <a:pt x="4306" y="1596"/>
                    </a:lnTo>
                    <a:lnTo>
                      <a:pt x="4310" y="1595"/>
                    </a:lnTo>
                    <a:lnTo>
                      <a:pt x="4315" y="1595"/>
                    </a:lnTo>
                    <a:lnTo>
                      <a:pt x="4319" y="1595"/>
                    </a:lnTo>
                    <a:lnTo>
                      <a:pt x="4323" y="1595"/>
                    </a:lnTo>
                    <a:lnTo>
                      <a:pt x="4328" y="1595"/>
                    </a:lnTo>
                    <a:lnTo>
                      <a:pt x="4332" y="1595"/>
                    </a:lnTo>
                    <a:lnTo>
                      <a:pt x="4336" y="1595"/>
                    </a:lnTo>
                    <a:lnTo>
                      <a:pt x="4341" y="1595"/>
                    </a:lnTo>
                    <a:lnTo>
                      <a:pt x="4345" y="1596"/>
                    </a:lnTo>
                    <a:lnTo>
                      <a:pt x="4349" y="1595"/>
                    </a:lnTo>
                    <a:lnTo>
                      <a:pt x="4354" y="1596"/>
                    </a:lnTo>
                    <a:lnTo>
                      <a:pt x="4358" y="1595"/>
                    </a:lnTo>
                    <a:lnTo>
                      <a:pt x="4362" y="1595"/>
                    </a:lnTo>
                    <a:lnTo>
                      <a:pt x="4367" y="1595"/>
                    </a:lnTo>
                    <a:lnTo>
                      <a:pt x="4371" y="1595"/>
                    </a:lnTo>
                    <a:lnTo>
                      <a:pt x="4376" y="1595"/>
                    </a:lnTo>
                    <a:lnTo>
                      <a:pt x="4380" y="1596"/>
                    </a:lnTo>
                    <a:lnTo>
                      <a:pt x="4384" y="1596"/>
                    </a:lnTo>
                    <a:lnTo>
                      <a:pt x="4389" y="1596"/>
                    </a:lnTo>
                    <a:lnTo>
                      <a:pt x="4393" y="1596"/>
                    </a:lnTo>
                    <a:lnTo>
                      <a:pt x="4397" y="1596"/>
                    </a:lnTo>
                    <a:lnTo>
                      <a:pt x="4402" y="1596"/>
                    </a:lnTo>
                    <a:lnTo>
                      <a:pt x="4406" y="1596"/>
                    </a:lnTo>
                    <a:lnTo>
                      <a:pt x="4410" y="1596"/>
                    </a:lnTo>
                    <a:lnTo>
                      <a:pt x="4415" y="1596"/>
                    </a:lnTo>
                    <a:lnTo>
                      <a:pt x="4419" y="1597"/>
                    </a:lnTo>
                    <a:lnTo>
                      <a:pt x="4423" y="1597"/>
                    </a:lnTo>
                    <a:lnTo>
                      <a:pt x="4428" y="1598"/>
                    </a:lnTo>
                    <a:lnTo>
                      <a:pt x="4432" y="1599"/>
                    </a:lnTo>
                    <a:lnTo>
                      <a:pt x="4436" y="1599"/>
                    </a:lnTo>
                    <a:lnTo>
                      <a:pt x="4441" y="1599"/>
                    </a:lnTo>
                    <a:lnTo>
                      <a:pt x="4445" y="1599"/>
                    </a:lnTo>
                    <a:lnTo>
                      <a:pt x="4450" y="1600"/>
                    </a:lnTo>
                    <a:lnTo>
                      <a:pt x="4454" y="1600"/>
                    </a:lnTo>
                    <a:lnTo>
                      <a:pt x="4458" y="1600"/>
                    </a:lnTo>
                    <a:lnTo>
                      <a:pt x="4462" y="1600"/>
                    </a:lnTo>
                    <a:lnTo>
                      <a:pt x="4467" y="1600"/>
                    </a:lnTo>
                    <a:lnTo>
                      <a:pt x="4471" y="1600"/>
                    </a:lnTo>
                    <a:lnTo>
                      <a:pt x="4475" y="1600"/>
                    </a:lnTo>
                    <a:lnTo>
                      <a:pt x="4480" y="1600"/>
                    </a:lnTo>
                    <a:lnTo>
                      <a:pt x="4484" y="1600"/>
                    </a:lnTo>
                    <a:lnTo>
                      <a:pt x="4489" y="1600"/>
                    </a:lnTo>
                    <a:lnTo>
                      <a:pt x="4493" y="1600"/>
                    </a:lnTo>
                    <a:lnTo>
                      <a:pt x="4497" y="1600"/>
                    </a:lnTo>
                    <a:lnTo>
                      <a:pt x="4502" y="1599"/>
                    </a:lnTo>
                    <a:lnTo>
                      <a:pt x="4506" y="1599"/>
                    </a:lnTo>
                    <a:lnTo>
                      <a:pt x="4510" y="1599"/>
                    </a:lnTo>
                    <a:lnTo>
                      <a:pt x="4515" y="1599"/>
                    </a:lnTo>
                    <a:lnTo>
                      <a:pt x="4519" y="1600"/>
                    </a:lnTo>
                    <a:lnTo>
                      <a:pt x="4523" y="1600"/>
                    </a:lnTo>
                    <a:lnTo>
                      <a:pt x="4528" y="1600"/>
                    </a:lnTo>
                    <a:lnTo>
                      <a:pt x="4532" y="1599"/>
                    </a:lnTo>
                    <a:lnTo>
                      <a:pt x="4536" y="1599"/>
                    </a:lnTo>
                    <a:lnTo>
                      <a:pt x="4541" y="1599"/>
                    </a:lnTo>
                    <a:lnTo>
                      <a:pt x="4545" y="1599"/>
                    </a:lnTo>
                    <a:lnTo>
                      <a:pt x="4549" y="1599"/>
                    </a:lnTo>
                    <a:lnTo>
                      <a:pt x="4554" y="1599"/>
                    </a:lnTo>
                    <a:lnTo>
                      <a:pt x="4558" y="1599"/>
                    </a:lnTo>
                    <a:lnTo>
                      <a:pt x="4563" y="1599"/>
                    </a:lnTo>
                    <a:lnTo>
                      <a:pt x="4567" y="1599"/>
                    </a:lnTo>
                    <a:lnTo>
                      <a:pt x="4571" y="1599"/>
                    </a:lnTo>
                    <a:lnTo>
                      <a:pt x="4576" y="1600"/>
                    </a:lnTo>
                    <a:lnTo>
                      <a:pt x="4580" y="1600"/>
                    </a:lnTo>
                    <a:lnTo>
                      <a:pt x="4584" y="1600"/>
                    </a:lnTo>
                    <a:lnTo>
                      <a:pt x="4589" y="1601"/>
                    </a:lnTo>
                    <a:lnTo>
                      <a:pt x="4593" y="1601"/>
                    </a:lnTo>
                    <a:lnTo>
                      <a:pt x="4597" y="1602"/>
                    </a:lnTo>
                    <a:lnTo>
                      <a:pt x="4602" y="1602"/>
                    </a:lnTo>
                    <a:lnTo>
                      <a:pt x="4606" y="1602"/>
                    </a:lnTo>
                    <a:lnTo>
                      <a:pt x="4610" y="1603"/>
                    </a:lnTo>
                    <a:lnTo>
                      <a:pt x="4615" y="1603"/>
                    </a:lnTo>
                    <a:lnTo>
                      <a:pt x="4619" y="1602"/>
                    </a:lnTo>
                    <a:lnTo>
                      <a:pt x="4623" y="1602"/>
                    </a:lnTo>
                    <a:lnTo>
                      <a:pt x="4628" y="1600"/>
                    </a:lnTo>
                    <a:lnTo>
                      <a:pt x="4632" y="1598"/>
                    </a:lnTo>
                    <a:lnTo>
                      <a:pt x="4637" y="1596"/>
                    </a:lnTo>
                    <a:lnTo>
                      <a:pt x="4641" y="1592"/>
                    </a:lnTo>
                    <a:lnTo>
                      <a:pt x="4645" y="1587"/>
                    </a:lnTo>
                    <a:lnTo>
                      <a:pt x="4649" y="1583"/>
                    </a:lnTo>
                    <a:lnTo>
                      <a:pt x="4654" y="1581"/>
                    </a:lnTo>
                    <a:lnTo>
                      <a:pt x="4658" y="1581"/>
                    </a:lnTo>
                    <a:lnTo>
                      <a:pt x="4663" y="1581"/>
                    </a:lnTo>
                    <a:lnTo>
                      <a:pt x="4667" y="1577"/>
                    </a:lnTo>
                    <a:lnTo>
                      <a:pt x="4671" y="1574"/>
                    </a:lnTo>
                    <a:lnTo>
                      <a:pt x="4676" y="1575"/>
                    </a:lnTo>
                    <a:lnTo>
                      <a:pt x="4680" y="1580"/>
                    </a:lnTo>
                    <a:lnTo>
                      <a:pt x="4684" y="1587"/>
                    </a:lnTo>
                    <a:lnTo>
                      <a:pt x="4689" y="1593"/>
                    </a:lnTo>
                    <a:lnTo>
                      <a:pt x="4693" y="1596"/>
                    </a:lnTo>
                    <a:lnTo>
                      <a:pt x="4697" y="1595"/>
                    </a:lnTo>
                    <a:lnTo>
                      <a:pt x="4702" y="1593"/>
                    </a:lnTo>
                    <a:lnTo>
                      <a:pt x="4706" y="1591"/>
                    </a:lnTo>
                    <a:lnTo>
                      <a:pt x="4710" y="1591"/>
                    </a:lnTo>
                    <a:lnTo>
                      <a:pt x="4715" y="1594"/>
                    </a:lnTo>
                    <a:lnTo>
                      <a:pt x="4719" y="1597"/>
                    </a:lnTo>
                    <a:lnTo>
                      <a:pt x="4723" y="1599"/>
                    </a:lnTo>
                    <a:lnTo>
                      <a:pt x="4728" y="1599"/>
                    </a:lnTo>
                    <a:lnTo>
                      <a:pt x="4732" y="1598"/>
                    </a:lnTo>
                    <a:lnTo>
                      <a:pt x="4737" y="1597"/>
                    </a:lnTo>
                    <a:lnTo>
                      <a:pt x="4741" y="1598"/>
                    </a:lnTo>
                    <a:lnTo>
                      <a:pt x="4745" y="1600"/>
                    </a:lnTo>
                    <a:lnTo>
                      <a:pt x="4750" y="1601"/>
                    </a:lnTo>
                    <a:lnTo>
                      <a:pt x="4754" y="1603"/>
                    </a:lnTo>
                    <a:lnTo>
                      <a:pt x="4758" y="1605"/>
                    </a:lnTo>
                    <a:lnTo>
                      <a:pt x="4762" y="1605"/>
                    </a:lnTo>
                    <a:lnTo>
                      <a:pt x="4767" y="1605"/>
                    </a:lnTo>
                    <a:lnTo>
                      <a:pt x="4771" y="1603"/>
                    </a:lnTo>
                    <a:lnTo>
                      <a:pt x="4776" y="1597"/>
                    </a:lnTo>
                    <a:lnTo>
                      <a:pt x="4780" y="1585"/>
                    </a:lnTo>
                    <a:lnTo>
                      <a:pt x="4784" y="1564"/>
                    </a:lnTo>
                    <a:lnTo>
                      <a:pt x="4789" y="1532"/>
                    </a:lnTo>
                    <a:lnTo>
                      <a:pt x="4793" y="1488"/>
                    </a:lnTo>
                    <a:lnTo>
                      <a:pt x="4797" y="1432"/>
                    </a:lnTo>
                    <a:lnTo>
                      <a:pt x="4802" y="1364"/>
                    </a:lnTo>
                    <a:lnTo>
                      <a:pt x="4806" y="1280"/>
                    </a:lnTo>
                    <a:lnTo>
                      <a:pt x="4811" y="1202"/>
                    </a:lnTo>
                    <a:lnTo>
                      <a:pt x="4813" y="1182"/>
                    </a:lnTo>
                    <a:lnTo>
                      <a:pt x="4815" y="1184"/>
                    </a:lnTo>
                    <a:lnTo>
                      <a:pt x="4817" y="1211"/>
                    </a:lnTo>
                    <a:lnTo>
                      <a:pt x="4819" y="1262"/>
                    </a:lnTo>
                    <a:lnTo>
                      <a:pt x="4823" y="1395"/>
                    </a:lnTo>
                    <a:lnTo>
                      <a:pt x="4826" y="1457"/>
                    </a:lnTo>
                    <a:lnTo>
                      <a:pt x="4828" y="1509"/>
                    </a:lnTo>
                    <a:lnTo>
                      <a:pt x="4830" y="1546"/>
                    </a:lnTo>
                    <a:lnTo>
                      <a:pt x="4832" y="1572"/>
                    </a:lnTo>
                    <a:lnTo>
                      <a:pt x="4836" y="1599"/>
                    </a:lnTo>
                    <a:lnTo>
                      <a:pt x="4841" y="1608"/>
                    </a:lnTo>
                    <a:lnTo>
                      <a:pt x="4845" y="1610"/>
                    </a:lnTo>
                    <a:lnTo>
                      <a:pt x="4850" y="1610"/>
                    </a:lnTo>
                    <a:lnTo>
                      <a:pt x="4854" y="1610"/>
                    </a:lnTo>
                    <a:lnTo>
                      <a:pt x="4858" y="1610"/>
                    </a:lnTo>
                    <a:lnTo>
                      <a:pt x="4863" y="1611"/>
                    </a:lnTo>
                    <a:lnTo>
                      <a:pt x="4867" y="1611"/>
                    </a:lnTo>
                    <a:lnTo>
                      <a:pt x="4871" y="1611"/>
                    </a:lnTo>
                    <a:lnTo>
                      <a:pt x="4876" y="1610"/>
                    </a:lnTo>
                    <a:lnTo>
                      <a:pt x="4880" y="1607"/>
                    </a:lnTo>
                    <a:lnTo>
                      <a:pt x="4884" y="1602"/>
                    </a:lnTo>
                    <a:lnTo>
                      <a:pt x="4889" y="1594"/>
                    </a:lnTo>
                    <a:lnTo>
                      <a:pt x="4893" y="1580"/>
                    </a:lnTo>
                    <a:lnTo>
                      <a:pt x="4897" y="1562"/>
                    </a:lnTo>
                    <a:lnTo>
                      <a:pt x="4902" y="1540"/>
                    </a:lnTo>
                    <a:lnTo>
                      <a:pt x="4906" y="1521"/>
                    </a:lnTo>
                    <a:lnTo>
                      <a:pt x="4910" y="1506"/>
                    </a:lnTo>
                    <a:lnTo>
                      <a:pt x="4915" y="1496"/>
                    </a:lnTo>
                    <a:lnTo>
                      <a:pt x="4919" y="1494"/>
                    </a:lnTo>
                    <a:lnTo>
                      <a:pt x="4924" y="1506"/>
                    </a:lnTo>
                    <a:lnTo>
                      <a:pt x="4928" y="1528"/>
                    </a:lnTo>
                    <a:lnTo>
                      <a:pt x="4932" y="1547"/>
                    </a:lnTo>
                    <a:lnTo>
                      <a:pt x="4937" y="1556"/>
                    </a:lnTo>
                    <a:lnTo>
                      <a:pt x="4941" y="1563"/>
                    </a:lnTo>
                    <a:lnTo>
                      <a:pt x="4945" y="1576"/>
                    </a:lnTo>
                    <a:lnTo>
                      <a:pt x="4950" y="1593"/>
                    </a:lnTo>
                    <a:lnTo>
                      <a:pt x="4954" y="1605"/>
                    </a:lnTo>
                    <a:lnTo>
                      <a:pt x="4958" y="1611"/>
                    </a:lnTo>
                    <a:lnTo>
                      <a:pt x="4963" y="1612"/>
                    </a:lnTo>
                    <a:lnTo>
                      <a:pt x="4967" y="1612"/>
                    </a:lnTo>
                    <a:lnTo>
                      <a:pt x="4971" y="1611"/>
                    </a:lnTo>
                    <a:lnTo>
                      <a:pt x="4976" y="1611"/>
                    </a:lnTo>
                    <a:lnTo>
                      <a:pt x="4980" y="1613"/>
                    </a:lnTo>
                    <a:lnTo>
                      <a:pt x="4984" y="1613"/>
                    </a:lnTo>
                    <a:lnTo>
                      <a:pt x="4989" y="1612"/>
                    </a:lnTo>
                    <a:lnTo>
                      <a:pt x="4993" y="1611"/>
                    </a:lnTo>
                    <a:lnTo>
                      <a:pt x="4998" y="1611"/>
                    </a:lnTo>
                    <a:lnTo>
                      <a:pt x="5002" y="1611"/>
                    </a:lnTo>
                    <a:lnTo>
                      <a:pt x="5006" y="1610"/>
                    </a:lnTo>
                    <a:lnTo>
                      <a:pt x="5010" y="1610"/>
                    </a:lnTo>
                    <a:lnTo>
                      <a:pt x="5015" y="1610"/>
                    </a:lnTo>
                    <a:lnTo>
                      <a:pt x="5019" y="1610"/>
                    </a:lnTo>
                    <a:lnTo>
                      <a:pt x="5023" y="1610"/>
                    </a:lnTo>
                    <a:lnTo>
                      <a:pt x="5028" y="1610"/>
                    </a:lnTo>
                    <a:lnTo>
                      <a:pt x="5032" y="1611"/>
                    </a:lnTo>
                    <a:lnTo>
                      <a:pt x="5037" y="1611"/>
                    </a:lnTo>
                    <a:lnTo>
                      <a:pt x="5041" y="1612"/>
                    </a:lnTo>
                    <a:lnTo>
                      <a:pt x="5045" y="1612"/>
                    </a:lnTo>
                    <a:lnTo>
                      <a:pt x="5050" y="1612"/>
                    </a:lnTo>
                    <a:lnTo>
                      <a:pt x="5054" y="1611"/>
                    </a:lnTo>
                    <a:lnTo>
                      <a:pt x="5058" y="1611"/>
                    </a:lnTo>
                    <a:lnTo>
                      <a:pt x="5063" y="1612"/>
                    </a:lnTo>
                    <a:lnTo>
                      <a:pt x="5067" y="1612"/>
                    </a:lnTo>
                    <a:lnTo>
                      <a:pt x="5071" y="1613"/>
                    </a:lnTo>
                    <a:lnTo>
                      <a:pt x="5076" y="1613"/>
                    </a:lnTo>
                    <a:lnTo>
                      <a:pt x="5080" y="1612"/>
                    </a:lnTo>
                    <a:lnTo>
                      <a:pt x="5084" y="1612"/>
                    </a:lnTo>
                    <a:lnTo>
                      <a:pt x="5089" y="1612"/>
                    </a:lnTo>
                    <a:lnTo>
                      <a:pt x="5093" y="1613"/>
                    </a:lnTo>
                    <a:lnTo>
                      <a:pt x="5097" y="1614"/>
                    </a:lnTo>
                    <a:lnTo>
                      <a:pt x="5102" y="1614"/>
                    </a:lnTo>
                    <a:lnTo>
                      <a:pt x="5106" y="1613"/>
                    </a:lnTo>
                    <a:lnTo>
                      <a:pt x="5111" y="1611"/>
                    </a:lnTo>
                    <a:lnTo>
                      <a:pt x="5115" y="1608"/>
                    </a:lnTo>
                    <a:lnTo>
                      <a:pt x="5119" y="1604"/>
                    </a:lnTo>
                    <a:lnTo>
                      <a:pt x="5123" y="1599"/>
                    </a:lnTo>
                    <a:lnTo>
                      <a:pt x="5128" y="1593"/>
                    </a:lnTo>
                    <a:lnTo>
                      <a:pt x="5132" y="1586"/>
                    </a:lnTo>
                    <a:lnTo>
                      <a:pt x="5137" y="1577"/>
                    </a:lnTo>
                    <a:lnTo>
                      <a:pt x="5141" y="1567"/>
                    </a:lnTo>
                    <a:lnTo>
                      <a:pt x="5145" y="1555"/>
                    </a:lnTo>
                    <a:lnTo>
                      <a:pt x="5150" y="1542"/>
                    </a:lnTo>
                    <a:lnTo>
                      <a:pt x="5154" y="1529"/>
                    </a:lnTo>
                    <a:lnTo>
                      <a:pt x="5158" y="1517"/>
                    </a:lnTo>
                    <a:lnTo>
                      <a:pt x="5163" y="1505"/>
                    </a:lnTo>
                    <a:lnTo>
                      <a:pt x="5167" y="1495"/>
                    </a:lnTo>
                    <a:lnTo>
                      <a:pt x="5171" y="1485"/>
                    </a:lnTo>
                    <a:lnTo>
                      <a:pt x="5176" y="1478"/>
                    </a:lnTo>
                    <a:lnTo>
                      <a:pt x="5180" y="1473"/>
                    </a:lnTo>
                    <a:lnTo>
                      <a:pt x="5184" y="1471"/>
                    </a:lnTo>
                    <a:lnTo>
                      <a:pt x="5189" y="1472"/>
                    </a:lnTo>
                    <a:lnTo>
                      <a:pt x="5193" y="1473"/>
                    </a:lnTo>
                    <a:lnTo>
                      <a:pt x="5197" y="1477"/>
                    </a:lnTo>
                    <a:lnTo>
                      <a:pt x="5202" y="1482"/>
                    </a:lnTo>
                    <a:lnTo>
                      <a:pt x="5206" y="1487"/>
                    </a:lnTo>
                    <a:lnTo>
                      <a:pt x="5211" y="1494"/>
                    </a:lnTo>
                    <a:lnTo>
                      <a:pt x="5215" y="1500"/>
                    </a:lnTo>
                    <a:lnTo>
                      <a:pt x="5219" y="1506"/>
                    </a:lnTo>
                    <a:lnTo>
                      <a:pt x="5224" y="1513"/>
                    </a:lnTo>
                    <a:lnTo>
                      <a:pt x="5228" y="1519"/>
                    </a:lnTo>
                    <a:lnTo>
                      <a:pt x="5232" y="1525"/>
                    </a:lnTo>
                    <a:lnTo>
                      <a:pt x="5237" y="1531"/>
                    </a:lnTo>
                    <a:lnTo>
                      <a:pt x="5241" y="1537"/>
                    </a:lnTo>
                    <a:lnTo>
                      <a:pt x="5245" y="1542"/>
                    </a:lnTo>
                    <a:lnTo>
                      <a:pt x="5250" y="1546"/>
                    </a:lnTo>
                    <a:lnTo>
                      <a:pt x="5254" y="1551"/>
                    </a:lnTo>
                    <a:lnTo>
                      <a:pt x="5258" y="1554"/>
                    </a:lnTo>
                    <a:lnTo>
                      <a:pt x="5263" y="1558"/>
                    </a:lnTo>
                    <a:lnTo>
                      <a:pt x="5267" y="1561"/>
                    </a:lnTo>
                    <a:lnTo>
                      <a:pt x="5271" y="1564"/>
                    </a:lnTo>
                    <a:lnTo>
                      <a:pt x="5276" y="1567"/>
                    </a:lnTo>
                    <a:lnTo>
                      <a:pt x="5280" y="1569"/>
                    </a:lnTo>
                    <a:lnTo>
                      <a:pt x="5285" y="1572"/>
                    </a:lnTo>
                    <a:lnTo>
                      <a:pt x="5289" y="1574"/>
                    </a:lnTo>
                    <a:lnTo>
                      <a:pt x="5293" y="1576"/>
                    </a:lnTo>
                    <a:lnTo>
                      <a:pt x="5298" y="1578"/>
                    </a:lnTo>
                    <a:lnTo>
                      <a:pt x="5302" y="1579"/>
                    </a:lnTo>
                    <a:lnTo>
                      <a:pt x="5306" y="1581"/>
                    </a:lnTo>
                    <a:lnTo>
                      <a:pt x="5310" y="1582"/>
                    </a:lnTo>
                    <a:lnTo>
                      <a:pt x="5315" y="1583"/>
                    </a:lnTo>
                    <a:lnTo>
                      <a:pt x="5319" y="1585"/>
                    </a:lnTo>
                    <a:lnTo>
                      <a:pt x="5324" y="1586"/>
                    </a:lnTo>
                    <a:lnTo>
                      <a:pt x="5328" y="1587"/>
                    </a:lnTo>
                    <a:lnTo>
                      <a:pt x="5332" y="1588"/>
                    </a:lnTo>
                    <a:lnTo>
                      <a:pt x="5337" y="1588"/>
                    </a:lnTo>
                    <a:lnTo>
                      <a:pt x="5341" y="1590"/>
                    </a:lnTo>
                    <a:lnTo>
                      <a:pt x="5345" y="1590"/>
                    </a:lnTo>
                    <a:lnTo>
                      <a:pt x="5350" y="1591"/>
                    </a:lnTo>
                    <a:lnTo>
                      <a:pt x="5354" y="1591"/>
                    </a:lnTo>
                    <a:lnTo>
                      <a:pt x="5359" y="1592"/>
                    </a:lnTo>
                    <a:lnTo>
                      <a:pt x="5363" y="1592"/>
                    </a:lnTo>
                    <a:lnTo>
                      <a:pt x="5367" y="1593"/>
                    </a:lnTo>
                    <a:lnTo>
                      <a:pt x="5371" y="1594"/>
                    </a:lnTo>
                    <a:lnTo>
                      <a:pt x="5376" y="1594"/>
                    </a:lnTo>
                    <a:lnTo>
                      <a:pt x="5380" y="1595"/>
                    </a:lnTo>
                    <a:lnTo>
                      <a:pt x="5384" y="1595"/>
                    </a:lnTo>
                    <a:lnTo>
                      <a:pt x="5389" y="1595"/>
                    </a:lnTo>
                    <a:lnTo>
                      <a:pt x="5393" y="1596"/>
                    </a:lnTo>
                    <a:lnTo>
                      <a:pt x="5398" y="1596"/>
                    </a:lnTo>
                    <a:lnTo>
                      <a:pt x="5402" y="1596"/>
                    </a:lnTo>
                    <a:lnTo>
                      <a:pt x="5406" y="1597"/>
                    </a:lnTo>
                    <a:lnTo>
                      <a:pt x="5411" y="1597"/>
                    </a:lnTo>
                    <a:lnTo>
                      <a:pt x="5415" y="1597"/>
                    </a:lnTo>
                    <a:lnTo>
                      <a:pt x="5419" y="1597"/>
                    </a:lnTo>
                    <a:lnTo>
                      <a:pt x="5424" y="1597"/>
                    </a:lnTo>
                    <a:lnTo>
                      <a:pt x="5428" y="1598"/>
                    </a:lnTo>
                    <a:lnTo>
                      <a:pt x="5432" y="1598"/>
                    </a:lnTo>
                    <a:lnTo>
                      <a:pt x="5437" y="1598"/>
                    </a:lnTo>
                    <a:lnTo>
                      <a:pt x="5441" y="1598"/>
                    </a:lnTo>
                    <a:lnTo>
                      <a:pt x="5445" y="1599"/>
                    </a:lnTo>
                    <a:lnTo>
                      <a:pt x="5450" y="1599"/>
                    </a:lnTo>
                    <a:lnTo>
                      <a:pt x="5454" y="1599"/>
                    </a:lnTo>
                    <a:lnTo>
                      <a:pt x="5458" y="1599"/>
                    </a:lnTo>
                    <a:lnTo>
                      <a:pt x="5463" y="1599"/>
                    </a:lnTo>
                    <a:lnTo>
                      <a:pt x="5467" y="1599"/>
                    </a:lnTo>
                    <a:lnTo>
                      <a:pt x="5472" y="1599"/>
                    </a:lnTo>
                    <a:lnTo>
                      <a:pt x="5476" y="1599"/>
                    </a:lnTo>
                    <a:lnTo>
                      <a:pt x="5480" y="1600"/>
                    </a:lnTo>
                    <a:lnTo>
                      <a:pt x="5484" y="1599"/>
                    </a:lnTo>
                    <a:lnTo>
                      <a:pt x="5489" y="1600"/>
                    </a:lnTo>
                    <a:lnTo>
                      <a:pt x="5493" y="1600"/>
                    </a:lnTo>
                    <a:lnTo>
                      <a:pt x="5498" y="1600"/>
                    </a:lnTo>
                    <a:lnTo>
                      <a:pt x="5502" y="1600"/>
                    </a:lnTo>
                    <a:lnTo>
                      <a:pt x="5506" y="1600"/>
                    </a:lnTo>
                    <a:lnTo>
                      <a:pt x="5511" y="1600"/>
                    </a:lnTo>
                    <a:lnTo>
                      <a:pt x="5515" y="1600"/>
                    </a:lnTo>
                    <a:lnTo>
                      <a:pt x="5519" y="1600"/>
                    </a:lnTo>
                    <a:lnTo>
                      <a:pt x="5524" y="1600"/>
                    </a:lnTo>
                    <a:lnTo>
                      <a:pt x="5528" y="1600"/>
                    </a:lnTo>
                    <a:lnTo>
                      <a:pt x="5532" y="1600"/>
                    </a:lnTo>
                    <a:lnTo>
                      <a:pt x="5537" y="1600"/>
                    </a:lnTo>
                    <a:lnTo>
                      <a:pt x="5541" y="1600"/>
                    </a:lnTo>
                    <a:lnTo>
                      <a:pt x="5545" y="1600"/>
                    </a:lnTo>
                    <a:lnTo>
                      <a:pt x="5550" y="1600"/>
                    </a:lnTo>
                    <a:lnTo>
                      <a:pt x="5554" y="1600"/>
                    </a:lnTo>
                    <a:lnTo>
                      <a:pt x="5558" y="1600"/>
                    </a:lnTo>
                    <a:lnTo>
                      <a:pt x="5563" y="1600"/>
                    </a:lnTo>
                    <a:lnTo>
                      <a:pt x="5567" y="1600"/>
                    </a:lnTo>
                    <a:lnTo>
                      <a:pt x="5572" y="1600"/>
                    </a:lnTo>
                    <a:lnTo>
                      <a:pt x="5576" y="1600"/>
                    </a:lnTo>
                    <a:lnTo>
                      <a:pt x="5580" y="1600"/>
                    </a:lnTo>
                    <a:lnTo>
                      <a:pt x="5585" y="1600"/>
                    </a:lnTo>
                    <a:lnTo>
                      <a:pt x="5589" y="1600"/>
                    </a:lnTo>
                    <a:lnTo>
                      <a:pt x="5593" y="1600"/>
                    </a:lnTo>
                    <a:lnTo>
                      <a:pt x="5597" y="1600"/>
                    </a:lnTo>
                    <a:lnTo>
                      <a:pt x="5602" y="1600"/>
                    </a:lnTo>
                    <a:lnTo>
                      <a:pt x="5606" y="1600"/>
                    </a:lnTo>
                    <a:lnTo>
                      <a:pt x="5611" y="1600"/>
                    </a:lnTo>
                    <a:lnTo>
                      <a:pt x="5615" y="1600"/>
                    </a:lnTo>
                    <a:lnTo>
                      <a:pt x="5619" y="1600"/>
                    </a:lnTo>
                    <a:lnTo>
                      <a:pt x="5624" y="1600"/>
                    </a:lnTo>
                    <a:lnTo>
                      <a:pt x="5628" y="1600"/>
                    </a:lnTo>
                    <a:lnTo>
                      <a:pt x="5632" y="1600"/>
                    </a:lnTo>
                    <a:lnTo>
                      <a:pt x="5637" y="1600"/>
                    </a:lnTo>
                    <a:lnTo>
                      <a:pt x="5641" y="1600"/>
                    </a:lnTo>
                    <a:lnTo>
                      <a:pt x="5645" y="1600"/>
                    </a:lnTo>
                    <a:lnTo>
                      <a:pt x="5650" y="1600"/>
                    </a:lnTo>
                    <a:lnTo>
                      <a:pt x="5654" y="1600"/>
                    </a:lnTo>
                    <a:lnTo>
                      <a:pt x="5659" y="1600"/>
                    </a:lnTo>
                    <a:lnTo>
                      <a:pt x="5663" y="1600"/>
                    </a:lnTo>
                    <a:lnTo>
                      <a:pt x="5667" y="1600"/>
                    </a:lnTo>
                    <a:lnTo>
                      <a:pt x="5671" y="1600"/>
                    </a:lnTo>
                    <a:lnTo>
                      <a:pt x="5676" y="1600"/>
                    </a:lnTo>
                    <a:lnTo>
                      <a:pt x="5680" y="1600"/>
                    </a:lnTo>
                    <a:lnTo>
                      <a:pt x="5685" y="1600"/>
                    </a:lnTo>
                    <a:lnTo>
                      <a:pt x="5689" y="1600"/>
                    </a:lnTo>
                    <a:lnTo>
                      <a:pt x="5693" y="1600"/>
                    </a:lnTo>
                    <a:lnTo>
                      <a:pt x="5698" y="1600"/>
                    </a:lnTo>
                    <a:lnTo>
                      <a:pt x="5702" y="1600"/>
                    </a:lnTo>
                    <a:lnTo>
                      <a:pt x="5706" y="1600"/>
                    </a:lnTo>
                    <a:lnTo>
                      <a:pt x="5711" y="1600"/>
                    </a:lnTo>
                    <a:lnTo>
                      <a:pt x="5715" y="1600"/>
                    </a:lnTo>
                    <a:lnTo>
                      <a:pt x="5719" y="1600"/>
                    </a:lnTo>
                    <a:lnTo>
                      <a:pt x="5724" y="1600"/>
                    </a:lnTo>
                    <a:lnTo>
                      <a:pt x="5728" y="1600"/>
                    </a:lnTo>
                    <a:lnTo>
                      <a:pt x="5732" y="1600"/>
                    </a:lnTo>
                    <a:lnTo>
                      <a:pt x="5737" y="1600"/>
                    </a:lnTo>
                    <a:lnTo>
                      <a:pt x="5741" y="1600"/>
                    </a:lnTo>
                    <a:lnTo>
                      <a:pt x="5745" y="1600"/>
                    </a:lnTo>
                    <a:lnTo>
                      <a:pt x="5750" y="1600"/>
                    </a:lnTo>
                    <a:lnTo>
                      <a:pt x="5754" y="1600"/>
                    </a:lnTo>
                    <a:lnTo>
                      <a:pt x="5759" y="1600"/>
                    </a:lnTo>
                    <a:lnTo>
                      <a:pt x="5763" y="1600"/>
                    </a:lnTo>
                    <a:lnTo>
                      <a:pt x="5767" y="1600"/>
                    </a:lnTo>
                    <a:lnTo>
                      <a:pt x="5772" y="1600"/>
                    </a:lnTo>
                    <a:lnTo>
                      <a:pt x="5776" y="1600"/>
                    </a:lnTo>
                    <a:lnTo>
                      <a:pt x="5780" y="1600"/>
                    </a:lnTo>
                    <a:lnTo>
                      <a:pt x="5784" y="1600"/>
                    </a:lnTo>
                    <a:lnTo>
                      <a:pt x="5789" y="1600"/>
                    </a:lnTo>
                    <a:lnTo>
                      <a:pt x="5793" y="1600"/>
                    </a:lnTo>
                    <a:lnTo>
                      <a:pt x="5798" y="1600"/>
                    </a:lnTo>
                    <a:lnTo>
                      <a:pt x="5802" y="1600"/>
                    </a:lnTo>
                    <a:lnTo>
                      <a:pt x="5806" y="1600"/>
                    </a:lnTo>
                    <a:lnTo>
                      <a:pt x="5811" y="1600"/>
                    </a:lnTo>
                    <a:lnTo>
                      <a:pt x="5815" y="1600"/>
                    </a:lnTo>
                    <a:lnTo>
                      <a:pt x="5819" y="1600"/>
                    </a:lnTo>
                    <a:lnTo>
                      <a:pt x="5824" y="1600"/>
                    </a:lnTo>
                    <a:lnTo>
                      <a:pt x="5828" y="1600"/>
                    </a:lnTo>
                    <a:lnTo>
                      <a:pt x="5833" y="1600"/>
                    </a:lnTo>
                    <a:lnTo>
                      <a:pt x="5837" y="1600"/>
                    </a:lnTo>
                    <a:lnTo>
                      <a:pt x="5841" y="1600"/>
                    </a:lnTo>
                    <a:lnTo>
                      <a:pt x="5845" y="1600"/>
                    </a:lnTo>
                    <a:lnTo>
                      <a:pt x="5850" y="1600"/>
                    </a:lnTo>
                    <a:lnTo>
                      <a:pt x="5854" y="1600"/>
                    </a:lnTo>
                    <a:lnTo>
                      <a:pt x="5858" y="1600"/>
                    </a:lnTo>
                    <a:lnTo>
                      <a:pt x="5863" y="1600"/>
                    </a:lnTo>
                    <a:lnTo>
                      <a:pt x="5867" y="1600"/>
                    </a:lnTo>
                    <a:lnTo>
                      <a:pt x="5872" y="1601"/>
                    </a:lnTo>
                    <a:lnTo>
                      <a:pt x="5876" y="1600"/>
                    </a:lnTo>
                    <a:lnTo>
                      <a:pt x="5880" y="1601"/>
                    </a:lnTo>
                    <a:lnTo>
                      <a:pt x="5885" y="1601"/>
                    </a:lnTo>
                    <a:lnTo>
                      <a:pt x="5889" y="1601"/>
                    </a:lnTo>
                    <a:lnTo>
                      <a:pt x="5893" y="1601"/>
                    </a:lnTo>
                    <a:lnTo>
                      <a:pt x="5898" y="1601"/>
                    </a:lnTo>
                    <a:lnTo>
                      <a:pt x="5902" y="1601"/>
                    </a:lnTo>
                    <a:lnTo>
                      <a:pt x="5906" y="1601"/>
                    </a:lnTo>
                    <a:lnTo>
                      <a:pt x="5911" y="1601"/>
                    </a:lnTo>
                    <a:lnTo>
                      <a:pt x="5915" y="1601"/>
                    </a:lnTo>
                    <a:lnTo>
                      <a:pt x="5919" y="1601"/>
                    </a:lnTo>
                    <a:lnTo>
                      <a:pt x="5924" y="1601"/>
                    </a:lnTo>
                    <a:lnTo>
                      <a:pt x="5928" y="1601"/>
                    </a:lnTo>
                    <a:lnTo>
                      <a:pt x="5932" y="1601"/>
                    </a:lnTo>
                    <a:lnTo>
                      <a:pt x="5937" y="1601"/>
                    </a:lnTo>
                    <a:lnTo>
                      <a:pt x="5941" y="1601"/>
                    </a:lnTo>
                    <a:lnTo>
                      <a:pt x="5946" y="1602"/>
                    </a:lnTo>
                    <a:lnTo>
                      <a:pt x="5950" y="1602"/>
                    </a:lnTo>
                    <a:lnTo>
                      <a:pt x="5954" y="1602"/>
                    </a:lnTo>
                    <a:lnTo>
                      <a:pt x="5958" y="1602"/>
                    </a:lnTo>
                    <a:lnTo>
                      <a:pt x="5963" y="1602"/>
                    </a:lnTo>
                    <a:lnTo>
                      <a:pt x="5967" y="1602"/>
                    </a:lnTo>
                    <a:lnTo>
                      <a:pt x="5972" y="1602"/>
                    </a:lnTo>
                    <a:lnTo>
                      <a:pt x="5976" y="1602"/>
                    </a:lnTo>
                    <a:lnTo>
                      <a:pt x="5980" y="1603"/>
                    </a:lnTo>
                    <a:lnTo>
                      <a:pt x="5985" y="1603"/>
                    </a:lnTo>
                    <a:lnTo>
                      <a:pt x="5989" y="1603"/>
                    </a:lnTo>
                    <a:lnTo>
                      <a:pt x="5993" y="1603"/>
                    </a:lnTo>
                    <a:lnTo>
                      <a:pt x="5998" y="1603"/>
                    </a:lnTo>
                    <a:lnTo>
                      <a:pt x="6002" y="1603"/>
                    </a:lnTo>
                    <a:lnTo>
                      <a:pt x="6006" y="1604"/>
                    </a:lnTo>
                    <a:lnTo>
                      <a:pt x="6011" y="1604"/>
                    </a:lnTo>
                    <a:lnTo>
                      <a:pt x="6015" y="1604"/>
                    </a:lnTo>
                    <a:lnTo>
                      <a:pt x="6020" y="1604"/>
                    </a:lnTo>
                    <a:lnTo>
                      <a:pt x="6024" y="1604"/>
                    </a:lnTo>
                    <a:lnTo>
                      <a:pt x="6028" y="1604"/>
                    </a:lnTo>
                    <a:lnTo>
                      <a:pt x="6032" y="1604"/>
                    </a:lnTo>
                    <a:lnTo>
                      <a:pt x="6037" y="1605"/>
                    </a:lnTo>
                    <a:lnTo>
                      <a:pt x="6041" y="1605"/>
                    </a:lnTo>
                    <a:lnTo>
                      <a:pt x="6046" y="1605"/>
                    </a:lnTo>
                    <a:lnTo>
                      <a:pt x="6050" y="1605"/>
                    </a:lnTo>
                    <a:lnTo>
                      <a:pt x="6054" y="1605"/>
                    </a:lnTo>
                    <a:lnTo>
                      <a:pt x="6059" y="1605"/>
                    </a:lnTo>
                    <a:lnTo>
                      <a:pt x="6063" y="1606"/>
                    </a:lnTo>
                    <a:lnTo>
                      <a:pt x="6067" y="1606"/>
                    </a:lnTo>
                    <a:lnTo>
                      <a:pt x="6072" y="1606"/>
                    </a:lnTo>
                    <a:lnTo>
                      <a:pt x="6076" y="1606"/>
                    </a:lnTo>
                    <a:lnTo>
                      <a:pt x="6080" y="1606"/>
                    </a:lnTo>
                    <a:lnTo>
                      <a:pt x="6085" y="1607"/>
                    </a:lnTo>
                    <a:lnTo>
                      <a:pt x="6089" y="1607"/>
                    </a:lnTo>
                    <a:lnTo>
                      <a:pt x="6093" y="1607"/>
                    </a:lnTo>
                    <a:lnTo>
                      <a:pt x="6098" y="1608"/>
                    </a:lnTo>
                    <a:lnTo>
                      <a:pt x="6102" y="1608"/>
                    </a:lnTo>
                    <a:lnTo>
                      <a:pt x="6106" y="1608"/>
                    </a:lnTo>
                    <a:lnTo>
                      <a:pt x="6111" y="1608"/>
                    </a:lnTo>
                    <a:lnTo>
                      <a:pt x="6115" y="1609"/>
                    </a:lnTo>
                    <a:lnTo>
                      <a:pt x="6120" y="1609"/>
                    </a:lnTo>
                    <a:lnTo>
                      <a:pt x="6124" y="1609"/>
                    </a:lnTo>
                    <a:lnTo>
                      <a:pt x="6128" y="1609"/>
                    </a:lnTo>
                    <a:lnTo>
                      <a:pt x="6133" y="1609"/>
                    </a:lnTo>
                    <a:lnTo>
                      <a:pt x="6137" y="1610"/>
                    </a:lnTo>
                    <a:lnTo>
                      <a:pt x="6141" y="1610"/>
                    </a:lnTo>
                    <a:lnTo>
                      <a:pt x="6145" y="1610"/>
                    </a:lnTo>
                    <a:lnTo>
                      <a:pt x="6150" y="1610"/>
                    </a:lnTo>
                    <a:lnTo>
                      <a:pt x="6154" y="1610"/>
                    </a:lnTo>
                    <a:lnTo>
                      <a:pt x="6159" y="1610"/>
                    </a:lnTo>
                    <a:lnTo>
                      <a:pt x="6163" y="1611"/>
                    </a:lnTo>
                    <a:lnTo>
                      <a:pt x="6167" y="1611"/>
                    </a:lnTo>
                    <a:lnTo>
                      <a:pt x="6172" y="1611"/>
                    </a:lnTo>
                    <a:lnTo>
                      <a:pt x="6176" y="1611"/>
                    </a:lnTo>
                    <a:lnTo>
                      <a:pt x="6180" y="1611"/>
                    </a:lnTo>
                    <a:lnTo>
                      <a:pt x="6185" y="1611"/>
                    </a:lnTo>
                    <a:lnTo>
                      <a:pt x="6189" y="1611"/>
                    </a:lnTo>
                    <a:lnTo>
                      <a:pt x="6194" y="1612"/>
                    </a:lnTo>
                    <a:lnTo>
                      <a:pt x="6198" y="1612"/>
                    </a:lnTo>
                    <a:lnTo>
                      <a:pt x="6202" y="1612"/>
                    </a:lnTo>
                    <a:lnTo>
                      <a:pt x="6206" y="1612"/>
                    </a:lnTo>
                    <a:lnTo>
                      <a:pt x="6211" y="1612"/>
                    </a:lnTo>
                    <a:lnTo>
                      <a:pt x="6215" y="1612"/>
                    </a:lnTo>
                    <a:lnTo>
                      <a:pt x="6219" y="1612"/>
                    </a:lnTo>
                    <a:lnTo>
                      <a:pt x="6224" y="1612"/>
                    </a:lnTo>
                    <a:lnTo>
                      <a:pt x="6228" y="1612"/>
                    </a:lnTo>
                    <a:lnTo>
                      <a:pt x="6233" y="1612"/>
                    </a:lnTo>
                    <a:lnTo>
                      <a:pt x="6237" y="1612"/>
                    </a:lnTo>
                    <a:lnTo>
                      <a:pt x="6241" y="1612"/>
                    </a:lnTo>
                    <a:lnTo>
                      <a:pt x="6246" y="1612"/>
                    </a:lnTo>
                    <a:lnTo>
                      <a:pt x="6250" y="1612"/>
                    </a:lnTo>
                    <a:lnTo>
                      <a:pt x="6254" y="1612"/>
                    </a:lnTo>
                    <a:lnTo>
                      <a:pt x="6259" y="1611"/>
                    </a:lnTo>
                    <a:lnTo>
                      <a:pt x="6263" y="1611"/>
                    </a:lnTo>
                    <a:lnTo>
                      <a:pt x="6267" y="1611"/>
                    </a:lnTo>
                    <a:lnTo>
                      <a:pt x="6272" y="1611"/>
                    </a:lnTo>
                    <a:lnTo>
                      <a:pt x="6276" y="1611"/>
                    </a:lnTo>
                    <a:lnTo>
                      <a:pt x="6280" y="1611"/>
                    </a:lnTo>
                    <a:lnTo>
                      <a:pt x="6285" y="1611"/>
                    </a:lnTo>
                    <a:lnTo>
                      <a:pt x="6289" y="1610"/>
                    </a:lnTo>
                    <a:lnTo>
                      <a:pt x="6293" y="1610"/>
                    </a:lnTo>
                    <a:lnTo>
                      <a:pt x="6298" y="1610"/>
                    </a:lnTo>
                    <a:lnTo>
                      <a:pt x="6302" y="1610"/>
                    </a:lnTo>
                    <a:lnTo>
                      <a:pt x="6307" y="1609"/>
                    </a:lnTo>
                    <a:lnTo>
                      <a:pt x="6311" y="1609"/>
                    </a:lnTo>
                    <a:lnTo>
                      <a:pt x="6315" y="1608"/>
                    </a:lnTo>
                    <a:lnTo>
                      <a:pt x="6319" y="1608"/>
                    </a:lnTo>
                    <a:lnTo>
                      <a:pt x="6324" y="1608"/>
                    </a:lnTo>
                    <a:lnTo>
                      <a:pt x="6328" y="1607"/>
                    </a:lnTo>
                    <a:lnTo>
                      <a:pt x="6333" y="1607"/>
                    </a:lnTo>
                    <a:lnTo>
                      <a:pt x="6337" y="1606"/>
                    </a:lnTo>
                    <a:lnTo>
                      <a:pt x="6341" y="1606"/>
                    </a:lnTo>
                    <a:lnTo>
                      <a:pt x="6346" y="1606"/>
                    </a:lnTo>
                    <a:lnTo>
                      <a:pt x="6350" y="1605"/>
                    </a:lnTo>
                    <a:lnTo>
                      <a:pt x="6354" y="1604"/>
                    </a:lnTo>
                    <a:lnTo>
                      <a:pt x="6359" y="1604"/>
                    </a:lnTo>
                    <a:lnTo>
                      <a:pt x="6363" y="1603"/>
                    </a:lnTo>
                    <a:lnTo>
                      <a:pt x="6367" y="1603"/>
                    </a:lnTo>
                    <a:lnTo>
                      <a:pt x="6372" y="1602"/>
                    </a:lnTo>
                    <a:lnTo>
                      <a:pt x="6376" y="1602"/>
                    </a:lnTo>
                    <a:lnTo>
                      <a:pt x="6380" y="1601"/>
                    </a:lnTo>
                    <a:lnTo>
                      <a:pt x="6385" y="1601"/>
                    </a:lnTo>
                    <a:lnTo>
                      <a:pt x="6389" y="1600"/>
                    </a:lnTo>
                    <a:lnTo>
                      <a:pt x="6393" y="1599"/>
                    </a:lnTo>
                    <a:lnTo>
                      <a:pt x="6398" y="1599"/>
                    </a:lnTo>
                    <a:lnTo>
                      <a:pt x="6402" y="1598"/>
                    </a:lnTo>
                    <a:lnTo>
                      <a:pt x="6406" y="1597"/>
                    </a:lnTo>
                    <a:lnTo>
                      <a:pt x="6411" y="1597"/>
                    </a:lnTo>
                    <a:lnTo>
                      <a:pt x="6415" y="1596"/>
                    </a:lnTo>
                    <a:lnTo>
                      <a:pt x="6420" y="1596"/>
                    </a:lnTo>
                    <a:lnTo>
                      <a:pt x="6424" y="1595"/>
                    </a:lnTo>
                    <a:lnTo>
                      <a:pt x="6428" y="1594"/>
                    </a:lnTo>
                    <a:lnTo>
                      <a:pt x="6433" y="1594"/>
                    </a:lnTo>
                    <a:lnTo>
                      <a:pt x="6437" y="1593"/>
                    </a:lnTo>
                    <a:lnTo>
                      <a:pt x="6441" y="1592"/>
                    </a:lnTo>
                    <a:lnTo>
                      <a:pt x="6446" y="1592"/>
                    </a:lnTo>
                    <a:lnTo>
                      <a:pt x="6450" y="1591"/>
                    </a:lnTo>
                    <a:lnTo>
                      <a:pt x="6454" y="1591"/>
                    </a:lnTo>
                    <a:lnTo>
                      <a:pt x="6459" y="1590"/>
                    </a:lnTo>
                    <a:lnTo>
                      <a:pt x="6463" y="1590"/>
                    </a:lnTo>
                    <a:lnTo>
                      <a:pt x="6467" y="1589"/>
                    </a:lnTo>
                    <a:lnTo>
                      <a:pt x="6472" y="1588"/>
                    </a:lnTo>
                    <a:lnTo>
                      <a:pt x="6476" y="1588"/>
                    </a:lnTo>
                    <a:lnTo>
                      <a:pt x="6480" y="1588"/>
                    </a:lnTo>
                    <a:lnTo>
                      <a:pt x="6485" y="1587"/>
                    </a:lnTo>
                    <a:lnTo>
                      <a:pt x="6489" y="1587"/>
                    </a:lnTo>
                    <a:lnTo>
                      <a:pt x="6494" y="1586"/>
                    </a:lnTo>
                    <a:lnTo>
                      <a:pt x="6498" y="1586"/>
                    </a:lnTo>
                    <a:lnTo>
                      <a:pt x="6502" y="1586"/>
                    </a:lnTo>
                    <a:lnTo>
                      <a:pt x="6506" y="1585"/>
                    </a:lnTo>
                    <a:lnTo>
                      <a:pt x="6511" y="1585"/>
                    </a:lnTo>
                    <a:lnTo>
                      <a:pt x="6515" y="1585"/>
                    </a:lnTo>
                    <a:lnTo>
                      <a:pt x="6520" y="1584"/>
                    </a:lnTo>
                    <a:lnTo>
                      <a:pt x="6524" y="1584"/>
                    </a:lnTo>
                  </a:path>
                </a:pathLst>
              </a:custGeom>
              <a:noFill/>
              <a:ln w="190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81213" tIns="40607" rIns="81213" bIns="40607" numCol="1" anchor="t" anchorCtr="0" compatLnSpc="1">
                <a:prstTxWarp prst="textNoShape">
                  <a:avLst/>
                </a:prstTxWarp>
              </a:bodyPr>
              <a:lstStyle/>
              <a:p>
                <a:endParaRPr lang="en-US" b="1"/>
              </a:p>
            </p:txBody>
          </p:sp>
          <p:sp>
            <p:nvSpPr>
              <p:cNvPr id="412" name="Rectangle 203">
                <a:extLst>
                  <a:ext uri="{FF2B5EF4-FFF2-40B4-BE49-F238E27FC236}">
                    <a16:creationId xmlns:a16="http://schemas.microsoft.com/office/drawing/2014/main" id="{E7BF5FFB-759E-76DC-7113-2DE9812E36CF}"/>
                  </a:ext>
                </a:extLst>
              </p:cNvPr>
              <p:cNvSpPr>
                <a:spLocks noChangeArrowheads="1"/>
              </p:cNvSpPr>
              <p:nvPr/>
            </p:nvSpPr>
            <p:spPr bwMode="auto">
              <a:xfrm>
                <a:off x="6977" y="2103"/>
                <a:ext cx="132" cy="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min</a:t>
                </a:r>
                <a:endParaRPr lang="en-US" altLang="en-US" b="1"/>
              </a:p>
            </p:txBody>
          </p:sp>
          <p:sp>
            <p:nvSpPr>
              <p:cNvPr id="413" name="Rectangle 204">
                <a:extLst>
                  <a:ext uri="{FF2B5EF4-FFF2-40B4-BE49-F238E27FC236}">
                    <a16:creationId xmlns:a16="http://schemas.microsoft.com/office/drawing/2014/main" id="{77E891E0-F2FE-8A32-8E43-ECB18155A2D4}"/>
                  </a:ext>
                </a:extLst>
              </p:cNvPr>
              <p:cNvSpPr>
                <a:spLocks noChangeArrowheads="1"/>
              </p:cNvSpPr>
              <p:nvPr/>
            </p:nvSpPr>
            <p:spPr bwMode="auto">
              <a:xfrm>
                <a:off x="576" y="236"/>
                <a:ext cx="222" cy="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900" b="1" dirty="0">
                    <a:solidFill>
                      <a:srgbClr val="000000"/>
                    </a:solidFill>
                  </a:rPr>
                  <a:t>mAU</a:t>
                </a:r>
                <a:endParaRPr lang="en-US" altLang="en-US" sz="2800" b="1" dirty="0"/>
              </a:p>
            </p:txBody>
          </p:sp>
        </p:grpSp>
        <p:sp>
          <p:nvSpPr>
            <p:cNvPr id="214" name="Rectangle 206">
              <a:extLst>
                <a:ext uri="{FF2B5EF4-FFF2-40B4-BE49-F238E27FC236}">
                  <a16:creationId xmlns:a16="http://schemas.microsoft.com/office/drawing/2014/main" id="{23DCCF76-C05C-477A-0AFE-ACA0D822A6C6}"/>
                </a:ext>
              </a:extLst>
            </p:cNvPr>
            <p:cNvSpPr>
              <a:spLocks noChangeArrowheads="1"/>
            </p:cNvSpPr>
            <p:nvPr/>
          </p:nvSpPr>
          <p:spPr bwMode="auto">
            <a:xfrm>
              <a:off x="555" y="233"/>
              <a:ext cx="6524" cy="1960"/>
            </a:xfrm>
            <a:prstGeom prst="rect">
              <a:avLst/>
            </a:prstGeom>
            <a:noFill/>
            <a:ln w="190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81213" tIns="40607" rIns="81213" bIns="40607" numCol="1" anchor="t" anchorCtr="0" compatLnSpc="1">
              <a:prstTxWarp prst="textNoShape">
                <a:avLst/>
              </a:prstTxWarp>
            </a:bodyPr>
            <a:lstStyle/>
            <a:p>
              <a:endParaRPr lang="en-US" b="1"/>
            </a:p>
          </p:txBody>
        </p:sp>
        <p:pic>
          <p:nvPicPr>
            <p:cNvPr id="215" name="Picture 210">
              <a:extLst>
                <a:ext uri="{FF2B5EF4-FFF2-40B4-BE49-F238E27FC236}">
                  <a16:creationId xmlns:a16="http://schemas.microsoft.com/office/drawing/2014/main" id="{C17FC5FA-F8D5-8EF0-4779-FC593234F14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59" y="160"/>
              <a:ext cx="51" cy="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417" name="TextBox 416">
            <a:extLst>
              <a:ext uri="{FF2B5EF4-FFF2-40B4-BE49-F238E27FC236}">
                <a16:creationId xmlns:a16="http://schemas.microsoft.com/office/drawing/2014/main" id="{C1193E06-3D36-1822-526C-DFD152E53B10}"/>
              </a:ext>
            </a:extLst>
          </p:cNvPr>
          <p:cNvSpPr txBox="1"/>
          <p:nvPr/>
        </p:nvSpPr>
        <p:spPr>
          <a:xfrm>
            <a:off x="3273447" y="616509"/>
            <a:ext cx="575434" cy="270660"/>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FVSE</a:t>
            </a:r>
          </a:p>
        </p:txBody>
      </p:sp>
      <p:sp>
        <p:nvSpPr>
          <p:cNvPr id="418" name="직사각형 417"/>
          <p:cNvSpPr/>
          <p:nvPr/>
        </p:nvSpPr>
        <p:spPr>
          <a:xfrm>
            <a:off x="7193303" y="1771730"/>
            <a:ext cx="740368" cy="230061"/>
          </a:xfrm>
          <a:prstGeom prst="rect">
            <a:avLst/>
          </a:prstGeom>
        </p:spPr>
        <p:txBody>
          <a:bodyPr wrap="none">
            <a:spAutoFit/>
          </a:bodyPr>
          <a:lstStyle/>
          <a:p>
            <a:r>
              <a:rPr lang="en-US" sz="1100" b="1" dirty="0">
                <a:latin typeface="Arial" panose="020B0604020202020204" pitchFamily="34" charset="0"/>
                <a:cs typeface="Arial" panose="020B0604020202020204" pitchFamily="34" charset="0"/>
              </a:rPr>
              <a:t>‘anethole’</a:t>
            </a:r>
            <a:endParaRPr lang="en-US" sz="1100" dirty="0"/>
          </a:p>
        </p:txBody>
      </p:sp>
      <p:sp>
        <p:nvSpPr>
          <p:cNvPr id="2" name="Arrow: Down 1544">
            <a:extLst>
              <a:ext uri="{FF2B5EF4-FFF2-40B4-BE49-F238E27FC236}">
                <a16:creationId xmlns:a16="http://schemas.microsoft.com/office/drawing/2014/main" id="{9ECB4F76-8029-6358-CEF9-98ACEF20FD28}"/>
              </a:ext>
            </a:extLst>
          </p:cNvPr>
          <p:cNvSpPr/>
          <p:nvPr/>
        </p:nvSpPr>
        <p:spPr>
          <a:xfrm rot="5400000">
            <a:off x="7095642" y="1824250"/>
            <a:ext cx="67156" cy="148919"/>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sz="2000">
              <a:ln w="0">
                <a:solidFill>
                  <a:sysClr val="windowText" lastClr="000000"/>
                </a:solidFill>
              </a:ln>
              <a:solidFill>
                <a:schemeClr val="tx1"/>
              </a:solidFill>
              <a:effectLst>
                <a:outerShdw blurRad="38100" dist="19050" dir="2700000" algn="tl" rotWithShape="0">
                  <a:schemeClr val="dk1">
                    <a:alpha val="40000"/>
                  </a:schemeClr>
                </a:outerShdw>
              </a:effectLst>
            </a:endParaRPr>
          </a:p>
        </p:txBody>
      </p:sp>
      <p:grpSp>
        <p:nvGrpSpPr>
          <p:cNvPr id="425" name="그룹 424">
            <a:extLst>
              <a:ext uri="{FF2B5EF4-FFF2-40B4-BE49-F238E27FC236}">
                <a16:creationId xmlns:a16="http://schemas.microsoft.com/office/drawing/2014/main" id="{52882793-25FD-4A1C-9F5B-EB8709BAF052}"/>
              </a:ext>
            </a:extLst>
          </p:cNvPr>
          <p:cNvGrpSpPr/>
          <p:nvPr/>
        </p:nvGrpSpPr>
        <p:grpSpPr>
          <a:xfrm>
            <a:off x="1767555" y="2803993"/>
            <a:ext cx="7204407" cy="2000970"/>
            <a:chOff x="1767555" y="2803993"/>
            <a:chExt cx="7272714" cy="2019942"/>
          </a:xfrm>
        </p:grpSpPr>
        <p:sp>
          <p:nvSpPr>
            <p:cNvPr id="5" name="AutoShape 3">
              <a:extLst>
                <a:ext uri="{FF2B5EF4-FFF2-40B4-BE49-F238E27FC236}">
                  <a16:creationId xmlns:a16="http://schemas.microsoft.com/office/drawing/2014/main" id="{C6302D27-88F2-19FA-0183-07852B9B120E}"/>
                </a:ext>
              </a:extLst>
            </p:cNvPr>
            <p:cNvSpPr>
              <a:spLocks noChangeAspect="1" noChangeArrowheads="1" noTextEdit="1"/>
            </p:cNvSpPr>
            <p:nvPr/>
          </p:nvSpPr>
          <p:spPr bwMode="auto">
            <a:xfrm>
              <a:off x="1767555" y="2803993"/>
              <a:ext cx="7066505" cy="19732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81213" tIns="40607" rIns="81213" bIns="40607" numCol="1" anchor="t" anchorCtr="0" compatLnSpc="1">
              <a:prstTxWarp prst="textNoShape">
                <a:avLst/>
              </a:prstTxWarp>
            </a:bodyPr>
            <a:lstStyle/>
            <a:p>
              <a:endParaRPr lang="en-US" sz="2000"/>
            </a:p>
          </p:txBody>
        </p:sp>
        <p:grpSp>
          <p:nvGrpSpPr>
            <p:cNvPr id="6" name="Group 205">
              <a:extLst>
                <a:ext uri="{FF2B5EF4-FFF2-40B4-BE49-F238E27FC236}">
                  <a16:creationId xmlns:a16="http://schemas.microsoft.com/office/drawing/2014/main" id="{EE0BEFB9-EAD6-4A37-42D3-95745355F9E7}"/>
                </a:ext>
              </a:extLst>
            </p:cNvPr>
            <p:cNvGrpSpPr>
              <a:grpSpLocks/>
            </p:cNvGrpSpPr>
            <p:nvPr/>
          </p:nvGrpSpPr>
          <p:grpSpPr bwMode="auto">
            <a:xfrm>
              <a:off x="1776789" y="2839935"/>
              <a:ext cx="7263480" cy="1984000"/>
              <a:chOff x="339" y="1640"/>
              <a:chExt cx="7080" cy="2208"/>
            </a:xfrm>
          </p:grpSpPr>
          <p:sp>
            <p:nvSpPr>
              <p:cNvPr id="13" name="Line 5">
                <a:extLst>
                  <a:ext uri="{FF2B5EF4-FFF2-40B4-BE49-F238E27FC236}">
                    <a16:creationId xmlns:a16="http://schemas.microsoft.com/office/drawing/2014/main" id="{FF945137-4B33-F323-3389-E445A1DBBF54}"/>
                  </a:ext>
                </a:extLst>
              </p:cNvPr>
              <p:cNvSpPr>
                <a:spLocks noChangeShapeType="1"/>
              </p:cNvSpPr>
              <p:nvPr/>
            </p:nvSpPr>
            <p:spPr bwMode="auto">
              <a:xfrm>
                <a:off x="466" y="3722"/>
                <a:ext cx="6823"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 name="Line 6">
                <a:extLst>
                  <a:ext uri="{FF2B5EF4-FFF2-40B4-BE49-F238E27FC236}">
                    <a16:creationId xmlns:a16="http://schemas.microsoft.com/office/drawing/2014/main" id="{89F3CD89-A565-C982-D109-D931C0BF5B62}"/>
                  </a:ext>
                </a:extLst>
              </p:cNvPr>
              <p:cNvSpPr>
                <a:spLocks noChangeShapeType="1"/>
              </p:cNvSpPr>
              <p:nvPr/>
            </p:nvSpPr>
            <p:spPr bwMode="auto">
              <a:xfrm>
                <a:off x="466"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 name="Rectangle 7">
                <a:extLst>
                  <a:ext uri="{FF2B5EF4-FFF2-40B4-BE49-F238E27FC236}">
                    <a16:creationId xmlns:a16="http://schemas.microsoft.com/office/drawing/2014/main" id="{B6B136E2-0718-F5F5-0BB6-8DADF2F44A8C}"/>
                  </a:ext>
                </a:extLst>
              </p:cNvPr>
              <p:cNvSpPr>
                <a:spLocks noChangeArrowheads="1"/>
              </p:cNvSpPr>
              <p:nvPr/>
            </p:nvSpPr>
            <p:spPr bwMode="auto">
              <a:xfrm>
                <a:off x="418"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0.01</a:t>
                </a:r>
                <a:endParaRPr lang="en-US" altLang="en-US" sz="700" b="1"/>
              </a:p>
            </p:txBody>
          </p:sp>
          <p:sp>
            <p:nvSpPr>
              <p:cNvPr id="16" name="Line 8">
                <a:extLst>
                  <a:ext uri="{FF2B5EF4-FFF2-40B4-BE49-F238E27FC236}">
                    <a16:creationId xmlns:a16="http://schemas.microsoft.com/office/drawing/2014/main" id="{560DDE9D-C903-AF7C-0189-8E95ED28BE5C}"/>
                  </a:ext>
                </a:extLst>
              </p:cNvPr>
              <p:cNvSpPr>
                <a:spLocks noChangeShapeType="1"/>
              </p:cNvSpPr>
              <p:nvPr/>
            </p:nvSpPr>
            <p:spPr bwMode="auto">
              <a:xfrm>
                <a:off x="53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 name="Line 9">
                <a:extLst>
                  <a:ext uri="{FF2B5EF4-FFF2-40B4-BE49-F238E27FC236}">
                    <a16:creationId xmlns:a16="http://schemas.microsoft.com/office/drawing/2014/main" id="{26A2AF06-C7EA-C682-21C6-2D0BBDCC82D8}"/>
                  </a:ext>
                </a:extLst>
              </p:cNvPr>
              <p:cNvSpPr>
                <a:spLocks noChangeShapeType="1"/>
              </p:cNvSpPr>
              <p:nvPr/>
            </p:nvSpPr>
            <p:spPr bwMode="auto">
              <a:xfrm>
                <a:off x="60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 name="Line 10">
                <a:extLst>
                  <a:ext uri="{FF2B5EF4-FFF2-40B4-BE49-F238E27FC236}">
                    <a16:creationId xmlns:a16="http://schemas.microsoft.com/office/drawing/2014/main" id="{46F9317C-0C33-BFED-47F8-515A7B034E60}"/>
                  </a:ext>
                </a:extLst>
              </p:cNvPr>
              <p:cNvSpPr>
                <a:spLocks noChangeShapeType="1"/>
              </p:cNvSpPr>
              <p:nvPr/>
            </p:nvSpPr>
            <p:spPr bwMode="auto">
              <a:xfrm>
                <a:off x="66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 name="Line 11">
                <a:extLst>
                  <a:ext uri="{FF2B5EF4-FFF2-40B4-BE49-F238E27FC236}">
                    <a16:creationId xmlns:a16="http://schemas.microsoft.com/office/drawing/2014/main" id="{C5BFEE66-0290-72B6-88B1-61A04F87823A}"/>
                  </a:ext>
                </a:extLst>
              </p:cNvPr>
              <p:cNvSpPr>
                <a:spLocks noChangeShapeType="1"/>
              </p:cNvSpPr>
              <p:nvPr/>
            </p:nvSpPr>
            <p:spPr bwMode="auto">
              <a:xfrm>
                <a:off x="73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 name="Line 12">
                <a:extLst>
                  <a:ext uri="{FF2B5EF4-FFF2-40B4-BE49-F238E27FC236}">
                    <a16:creationId xmlns:a16="http://schemas.microsoft.com/office/drawing/2014/main" id="{19FA9B46-2298-5FBA-18C0-72A97322C1EE}"/>
                  </a:ext>
                </a:extLst>
              </p:cNvPr>
              <p:cNvSpPr>
                <a:spLocks noChangeShapeType="1"/>
              </p:cNvSpPr>
              <p:nvPr/>
            </p:nvSpPr>
            <p:spPr bwMode="auto">
              <a:xfrm>
                <a:off x="805"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1" name="Rectangle 13">
                <a:extLst>
                  <a:ext uri="{FF2B5EF4-FFF2-40B4-BE49-F238E27FC236}">
                    <a16:creationId xmlns:a16="http://schemas.microsoft.com/office/drawing/2014/main" id="{9F0C5CE2-EFAC-2CCC-9508-C287D5A4AD8F}"/>
                  </a:ext>
                </a:extLst>
              </p:cNvPr>
              <p:cNvSpPr>
                <a:spLocks noChangeArrowheads="1"/>
              </p:cNvSpPr>
              <p:nvPr/>
            </p:nvSpPr>
            <p:spPr bwMode="auto">
              <a:xfrm>
                <a:off x="756"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a:t>
                </a:r>
                <a:endParaRPr lang="en-US" altLang="en-US" sz="700" b="1"/>
              </a:p>
            </p:txBody>
          </p:sp>
          <p:sp>
            <p:nvSpPr>
              <p:cNvPr id="22" name="Line 14">
                <a:extLst>
                  <a:ext uri="{FF2B5EF4-FFF2-40B4-BE49-F238E27FC236}">
                    <a16:creationId xmlns:a16="http://schemas.microsoft.com/office/drawing/2014/main" id="{0A7A0259-9A74-A691-2037-0AE4528B8543}"/>
                  </a:ext>
                </a:extLst>
              </p:cNvPr>
              <p:cNvSpPr>
                <a:spLocks noChangeShapeType="1"/>
              </p:cNvSpPr>
              <p:nvPr/>
            </p:nvSpPr>
            <p:spPr bwMode="auto">
              <a:xfrm>
                <a:off x="87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3" name="Line 15">
                <a:extLst>
                  <a:ext uri="{FF2B5EF4-FFF2-40B4-BE49-F238E27FC236}">
                    <a16:creationId xmlns:a16="http://schemas.microsoft.com/office/drawing/2014/main" id="{AAC6BE4B-6D6A-2376-DD02-A24E45ECB37A}"/>
                  </a:ext>
                </a:extLst>
              </p:cNvPr>
              <p:cNvSpPr>
                <a:spLocks noChangeShapeType="1"/>
              </p:cNvSpPr>
              <p:nvPr/>
            </p:nvSpPr>
            <p:spPr bwMode="auto">
              <a:xfrm>
                <a:off x="94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4" name="Line 16">
                <a:extLst>
                  <a:ext uri="{FF2B5EF4-FFF2-40B4-BE49-F238E27FC236}">
                    <a16:creationId xmlns:a16="http://schemas.microsoft.com/office/drawing/2014/main" id="{E487C06F-E4D1-771E-B6FC-CA835C267D25}"/>
                  </a:ext>
                </a:extLst>
              </p:cNvPr>
              <p:cNvSpPr>
                <a:spLocks noChangeShapeType="1"/>
              </p:cNvSpPr>
              <p:nvPr/>
            </p:nvSpPr>
            <p:spPr bwMode="auto">
              <a:xfrm>
                <a:off x="101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5" name="Line 17">
                <a:extLst>
                  <a:ext uri="{FF2B5EF4-FFF2-40B4-BE49-F238E27FC236}">
                    <a16:creationId xmlns:a16="http://schemas.microsoft.com/office/drawing/2014/main" id="{9FC567FB-2A88-8983-2E16-D0D88329CBBE}"/>
                  </a:ext>
                </a:extLst>
              </p:cNvPr>
              <p:cNvSpPr>
                <a:spLocks noChangeShapeType="1"/>
              </p:cNvSpPr>
              <p:nvPr/>
            </p:nvSpPr>
            <p:spPr bwMode="auto">
              <a:xfrm>
                <a:off x="107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6" name="Line 18">
                <a:extLst>
                  <a:ext uri="{FF2B5EF4-FFF2-40B4-BE49-F238E27FC236}">
                    <a16:creationId xmlns:a16="http://schemas.microsoft.com/office/drawing/2014/main" id="{4D59F80B-1A3B-C82F-470E-464623D6FC5A}"/>
                  </a:ext>
                </a:extLst>
              </p:cNvPr>
              <p:cNvSpPr>
                <a:spLocks noChangeShapeType="1"/>
              </p:cNvSpPr>
              <p:nvPr/>
            </p:nvSpPr>
            <p:spPr bwMode="auto">
              <a:xfrm>
                <a:off x="1146"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7" name="Rectangle 19">
                <a:extLst>
                  <a:ext uri="{FF2B5EF4-FFF2-40B4-BE49-F238E27FC236}">
                    <a16:creationId xmlns:a16="http://schemas.microsoft.com/office/drawing/2014/main" id="{1B796189-8CE0-3F44-E66E-108FB2B466C3}"/>
                  </a:ext>
                </a:extLst>
              </p:cNvPr>
              <p:cNvSpPr>
                <a:spLocks noChangeArrowheads="1"/>
              </p:cNvSpPr>
              <p:nvPr/>
            </p:nvSpPr>
            <p:spPr bwMode="auto">
              <a:xfrm>
                <a:off x="1099"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a:t>
                </a:r>
                <a:endParaRPr lang="en-US" altLang="en-US" sz="700" b="1"/>
              </a:p>
            </p:txBody>
          </p:sp>
          <p:sp>
            <p:nvSpPr>
              <p:cNvPr id="28" name="Line 20">
                <a:extLst>
                  <a:ext uri="{FF2B5EF4-FFF2-40B4-BE49-F238E27FC236}">
                    <a16:creationId xmlns:a16="http://schemas.microsoft.com/office/drawing/2014/main" id="{D078F486-5B45-BB21-5AFF-0B70CD10D353}"/>
                  </a:ext>
                </a:extLst>
              </p:cNvPr>
              <p:cNvSpPr>
                <a:spLocks noChangeShapeType="1"/>
              </p:cNvSpPr>
              <p:nvPr/>
            </p:nvSpPr>
            <p:spPr bwMode="auto">
              <a:xfrm>
                <a:off x="121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9" name="Line 21">
                <a:extLst>
                  <a:ext uri="{FF2B5EF4-FFF2-40B4-BE49-F238E27FC236}">
                    <a16:creationId xmlns:a16="http://schemas.microsoft.com/office/drawing/2014/main" id="{30C3B3C3-4EFA-F607-DD35-68AA8D05A86B}"/>
                  </a:ext>
                </a:extLst>
              </p:cNvPr>
              <p:cNvSpPr>
                <a:spLocks noChangeShapeType="1"/>
              </p:cNvSpPr>
              <p:nvPr/>
            </p:nvSpPr>
            <p:spPr bwMode="auto">
              <a:xfrm>
                <a:off x="128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0" name="Line 22">
                <a:extLst>
                  <a:ext uri="{FF2B5EF4-FFF2-40B4-BE49-F238E27FC236}">
                    <a16:creationId xmlns:a16="http://schemas.microsoft.com/office/drawing/2014/main" id="{9329F26A-7129-D9E0-6440-51F3E3BD5371}"/>
                  </a:ext>
                </a:extLst>
              </p:cNvPr>
              <p:cNvSpPr>
                <a:spLocks noChangeShapeType="1"/>
              </p:cNvSpPr>
              <p:nvPr/>
            </p:nvSpPr>
            <p:spPr bwMode="auto">
              <a:xfrm>
                <a:off x="135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1" name="Line 23">
                <a:extLst>
                  <a:ext uri="{FF2B5EF4-FFF2-40B4-BE49-F238E27FC236}">
                    <a16:creationId xmlns:a16="http://schemas.microsoft.com/office/drawing/2014/main" id="{57DDECE0-9E40-519C-F6AC-00990BAD2A45}"/>
                  </a:ext>
                </a:extLst>
              </p:cNvPr>
              <p:cNvSpPr>
                <a:spLocks noChangeShapeType="1"/>
              </p:cNvSpPr>
              <p:nvPr/>
            </p:nvSpPr>
            <p:spPr bwMode="auto">
              <a:xfrm>
                <a:off x="141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2" name="Line 24">
                <a:extLst>
                  <a:ext uri="{FF2B5EF4-FFF2-40B4-BE49-F238E27FC236}">
                    <a16:creationId xmlns:a16="http://schemas.microsoft.com/office/drawing/2014/main" id="{135BCB7D-F56A-13B6-883B-AC479F67233F}"/>
                  </a:ext>
                </a:extLst>
              </p:cNvPr>
              <p:cNvSpPr>
                <a:spLocks noChangeShapeType="1"/>
              </p:cNvSpPr>
              <p:nvPr/>
            </p:nvSpPr>
            <p:spPr bwMode="auto">
              <a:xfrm>
                <a:off x="1487"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3" name="Rectangle 25">
                <a:extLst>
                  <a:ext uri="{FF2B5EF4-FFF2-40B4-BE49-F238E27FC236}">
                    <a16:creationId xmlns:a16="http://schemas.microsoft.com/office/drawing/2014/main" id="{B5276C66-854E-64FA-B354-8EB9E73062C4}"/>
                  </a:ext>
                </a:extLst>
              </p:cNvPr>
              <p:cNvSpPr>
                <a:spLocks noChangeArrowheads="1"/>
              </p:cNvSpPr>
              <p:nvPr/>
            </p:nvSpPr>
            <p:spPr bwMode="auto">
              <a:xfrm>
                <a:off x="1437"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3.75</a:t>
                </a:r>
                <a:endParaRPr lang="en-US" altLang="en-US" sz="700" b="1"/>
              </a:p>
            </p:txBody>
          </p:sp>
          <p:sp>
            <p:nvSpPr>
              <p:cNvPr id="34" name="Line 26">
                <a:extLst>
                  <a:ext uri="{FF2B5EF4-FFF2-40B4-BE49-F238E27FC236}">
                    <a16:creationId xmlns:a16="http://schemas.microsoft.com/office/drawing/2014/main" id="{AD66DF7D-CBB2-C46C-A947-A7BCF2738244}"/>
                  </a:ext>
                </a:extLst>
              </p:cNvPr>
              <p:cNvSpPr>
                <a:spLocks noChangeShapeType="1"/>
              </p:cNvSpPr>
              <p:nvPr/>
            </p:nvSpPr>
            <p:spPr bwMode="auto">
              <a:xfrm>
                <a:off x="155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5" name="Line 27">
                <a:extLst>
                  <a:ext uri="{FF2B5EF4-FFF2-40B4-BE49-F238E27FC236}">
                    <a16:creationId xmlns:a16="http://schemas.microsoft.com/office/drawing/2014/main" id="{AED357EE-89BF-E99B-A4FC-86DD77CB9F52}"/>
                  </a:ext>
                </a:extLst>
              </p:cNvPr>
              <p:cNvSpPr>
                <a:spLocks noChangeShapeType="1"/>
              </p:cNvSpPr>
              <p:nvPr/>
            </p:nvSpPr>
            <p:spPr bwMode="auto">
              <a:xfrm>
                <a:off x="162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6" name="Line 28">
                <a:extLst>
                  <a:ext uri="{FF2B5EF4-FFF2-40B4-BE49-F238E27FC236}">
                    <a16:creationId xmlns:a16="http://schemas.microsoft.com/office/drawing/2014/main" id="{378EF97C-07BB-6591-92BB-9168950CA490}"/>
                  </a:ext>
                </a:extLst>
              </p:cNvPr>
              <p:cNvSpPr>
                <a:spLocks noChangeShapeType="1"/>
              </p:cNvSpPr>
              <p:nvPr/>
            </p:nvSpPr>
            <p:spPr bwMode="auto">
              <a:xfrm>
                <a:off x="169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7" name="Line 29">
                <a:extLst>
                  <a:ext uri="{FF2B5EF4-FFF2-40B4-BE49-F238E27FC236}">
                    <a16:creationId xmlns:a16="http://schemas.microsoft.com/office/drawing/2014/main" id="{37E30404-E832-0049-A216-92AD992F25C3}"/>
                  </a:ext>
                </a:extLst>
              </p:cNvPr>
              <p:cNvSpPr>
                <a:spLocks noChangeShapeType="1"/>
              </p:cNvSpPr>
              <p:nvPr/>
            </p:nvSpPr>
            <p:spPr bwMode="auto">
              <a:xfrm>
                <a:off x="176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8" name="Line 30">
                <a:extLst>
                  <a:ext uri="{FF2B5EF4-FFF2-40B4-BE49-F238E27FC236}">
                    <a16:creationId xmlns:a16="http://schemas.microsoft.com/office/drawing/2014/main" id="{0645BBC6-6311-D4DA-A9EE-4573DF4F0B6C}"/>
                  </a:ext>
                </a:extLst>
              </p:cNvPr>
              <p:cNvSpPr>
                <a:spLocks noChangeShapeType="1"/>
              </p:cNvSpPr>
              <p:nvPr/>
            </p:nvSpPr>
            <p:spPr bwMode="auto">
              <a:xfrm>
                <a:off x="1829"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39" name="Rectangle 31">
                <a:extLst>
                  <a:ext uri="{FF2B5EF4-FFF2-40B4-BE49-F238E27FC236}">
                    <a16:creationId xmlns:a16="http://schemas.microsoft.com/office/drawing/2014/main" id="{93159B0D-4C34-B86F-E2FC-DE3E45671363}"/>
                  </a:ext>
                </a:extLst>
              </p:cNvPr>
              <p:cNvSpPr>
                <a:spLocks noChangeArrowheads="1"/>
              </p:cNvSpPr>
              <p:nvPr/>
            </p:nvSpPr>
            <p:spPr bwMode="auto">
              <a:xfrm>
                <a:off x="1780"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5.00</a:t>
                </a:r>
                <a:endParaRPr lang="en-US" altLang="en-US" sz="700" b="1"/>
              </a:p>
            </p:txBody>
          </p:sp>
          <p:sp>
            <p:nvSpPr>
              <p:cNvPr id="40" name="Line 32">
                <a:extLst>
                  <a:ext uri="{FF2B5EF4-FFF2-40B4-BE49-F238E27FC236}">
                    <a16:creationId xmlns:a16="http://schemas.microsoft.com/office/drawing/2014/main" id="{FCA372C4-4231-B845-54B6-F75AE26BD559}"/>
                  </a:ext>
                </a:extLst>
              </p:cNvPr>
              <p:cNvSpPr>
                <a:spLocks noChangeShapeType="1"/>
              </p:cNvSpPr>
              <p:nvPr/>
            </p:nvSpPr>
            <p:spPr bwMode="auto">
              <a:xfrm>
                <a:off x="189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1" name="Line 33">
                <a:extLst>
                  <a:ext uri="{FF2B5EF4-FFF2-40B4-BE49-F238E27FC236}">
                    <a16:creationId xmlns:a16="http://schemas.microsoft.com/office/drawing/2014/main" id="{3C627F9C-2266-9E88-D4E8-052CBAE85E7D}"/>
                  </a:ext>
                </a:extLst>
              </p:cNvPr>
              <p:cNvSpPr>
                <a:spLocks noChangeShapeType="1"/>
              </p:cNvSpPr>
              <p:nvPr/>
            </p:nvSpPr>
            <p:spPr bwMode="auto">
              <a:xfrm>
                <a:off x="196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2" name="Line 34">
                <a:extLst>
                  <a:ext uri="{FF2B5EF4-FFF2-40B4-BE49-F238E27FC236}">
                    <a16:creationId xmlns:a16="http://schemas.microsoft.com/office/drawing/2014/main" id="{0726094B-5A35-75D0-1FFF-446A0F7A47B0}"/>
                  </a:ext>
                </a:extLst>
              </p:cNvPr>
              <p:cNvSpPr>
                <a:spLocks noChangeShapeType="1"/>
              </p:cNvSpPr>
              <p:nvPr/>
            </p:nvSpPr>
            <p:spPr bwMode="auto">
              <a:xfrm>
                <a:off x="203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3" name="Line 35">
                <a:extLst>
                  <a:ext uri="{FF2B5EF4-FFF2-40B4-BE49-F238E27FC236}">
                    <a16:creationId xmlns:a16="http://schemas.microsoft.com/office/drawing/2014/main" id="{0902EAFD-F399-659D-5A42-CF84A0B980FC}"/>
                  </a:ext>
                </a:extLst>
              </p:cNvPr>
              <p:cNvSpPr>
                <a:spLocks noChangeShapeType="1"/>
              </p:cNvSpPr>
              <p:nvPr/>
            </p:nvSpPr>
            <p:spPr bwMode="auto">
              <a:xfrm>
                <a:off x="210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4" name="Line 36">
                <a:extLst>
                  <a:ext uri="{FF2B5EF4-FFF2-40B4-BE49-F238E27FC236}">
                    <a16:creationId xmlns:a16="http://schemas.microsoft.com/office/drawing/2014/main" id="{076E89B8-67FF-8FF4-9CFB-8F44D58D0CEC}"/>
                  </a:ext>
                </a:extLst>
              </p:cNvPr>
              <p:cNvSpPr>
                <a:spLocks noChangeShapeType="1"/>
              </p:cNvSpPr>
              <p:nvPr/>
            </p:nvSpPr>
            <p:spPr bwMode="auto">
              <a:xfrm>
                <a:off x="2170"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5" name="Rectangle 37">
                <a:extLst>
                  <a:ext uri="{FF2B5EF4-FFF2-40B4-BE49-F238E27FC236}">
                    <a16:creationId xmlns:a16="http://schemas.microsoft.com/office/drawing/2014/main" id="{146F5AAA-17B6-0D65-E35B-0361D2C99A3B}"/>
                  </a:ext>
                </a:extLst>
              </p:cNvPr>
              <p:cNvSpPr>
                <a:spLocks noChangeArrowheads="1"/>
              </p:cNvSpPr>
              <p:nvPr/>
            </p:nvSpPr>
            <p:spPr bwMode="auto">
              <a:xfrm>
                <a:off x="2122"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6.25</a:t>
                </a:r>
                <a:endParaRPr lang="en-US" altLang="en-US" sz="700" b="1"/>
              </a:p>
            </p:txBody>
          </p:sp>
          <p:sp>
            <p:nvSpPr>
              <p:cNvPr id="46" name="Line 38">
                <a:extLst>
                  <a:ext uri="{FF2B5EF4-FFF2-40B4-BE49-F238E27FC236}">
                    <a16:creationId xmlns:a16="http://schemas.microsoft.com/office/drawing/2014/main" id="{172C4A7A-A06D-B9A1-F658-D200007DE4E5}"/>
                  </a:ext>
                </a:extLst>
              </p:cNvPr>
              <p:cNvSpPr>
                <a:spLocks noChangeShapeType="1"/>
              </p:cNvSpPr>
              <p:nvPr/>
            </p:nvSpPr>
            <p:spPr bwMode="auto">
              <a:xfrm>
                <a:off x="223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7" name="Line 39">
                <a:extLst>
                  <a:ext uri="{FF2B5EF4-FFF2-40B4-BE49-F238E27FC236}">
                    <a16:creationId xmlns:a16="http://schemas.microsoft.com/office/drawing/2014/main" id="{5ED98453-07B4-F0CF-96DA-F2DD01B97962}"/>
                  </a:ext>
                </a:extLst>
              </p:cNvPr>
              <p:cNvSpPr>
                <a:spLocks noChangeShapeType="1"/>
              </p:cNvSpPr>
              <p:nvPr/>
            </p:nvSpPr>
            <p:spPr bwMode="auto">
              <a:xfrm>
                <a:off x="230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8" name="Line 40">
                <a:extLst>
                  <a:ext uri="{FF2B5EF4-FFF2-40B4-BE49-F238E27FC236}">
                    <a16:creationId xmlns:a16="http://schemas.microsoft.com/office/drawing/2014/main" id="{3CE412B8-037C-CBA4-666A-1C1E03E50DE6}"/>
                  </a:ext>
                </a:extLst>
              </p:cNvPr>
              <p:cNvSpPr>
                <a:spLocks noChangeShapeType="1"/>
              </p:cNvSpPr>
              <p:nvPr/>
            </p:nvSpPr>
            <p:spPr bwMode="auto">
              <a:xfrm>
                <a:off x="237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49" name="Line 41">
                <a:extLst>
                  <a:ext uri="{FF2B5EF4-FFF2-40B4-BE49-F238E27FC236}">
                    <a16:creationId xmlns:a16="http://schemas.microsoft.com/office/drawing/2014/main" id="{FE416EE8-0BE8-1892-45DC-4D8B086B6BD7}"/>
                  </a:ext>
                </a:extLst>
              </p:cNvPr>
              <p:cNvSpPr>
                <a:spLocks noChangeShapeType="1"/>
              </p:cNvSpPr>
              <p:nvPr/>
            </p:nvSpPr>
            <p:spPr bwMode="auto">
              <a:xfrm>
                <a:off x="244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0" name="Line 42">
                <a:extLst>
                  <a:ext uri="{FF2B5EF4-FFF2-40B4-BE49-F238E27FC236}">
                    <a16:creationId xmlns:a16="http://schemas.microsoft.com/office/drawing/2014/main" id="{CDA3F0CE-D30B-CC21-5A1F-7C1E85AA9BCD}"/>
                  </a:ext>
                </a:extLst>
              </p:cNvPr>
              <p:cNvSpPr>
                <a:spLocks noChangeShapeType="1"/>
              </p:cNvSpPr>
              <p:nvPr/>
            </p:nvSpPr>
            <p:spPr bwMode="auto">
              <a:xfrm>
                <a:off x="2511"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1" name="Rectangle 43">
                <a:extLst>
                  <a:ext uri="{FF2B5EF4-FFF2-40B4-BE49-F238E27FC236}">
                    <a16:creationId xmlns:a16="http://schemas.microsoft.com/office/drawing/2014/main" id="{B721C561-85B8-04A3-CFF9-A2D9170A27D9}"/>
                  </a:ext>
                </a:extLst>
              </p:cNvPr>
              <p:cNvSpPr>
                <a:spLocks noChangeArrowheads="1"/>
              </p:cNvSpPr>
              <p:nvPr/>
            </p:nvSpPr>
            <p:spPr bwMode="auto">
              <a:xfrm>
                <a:off x="2461"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7.50</a:t>
                </a:r>
                <a:endParaRPr lang="en-US" altLang="en-US" sz="700" b="1"/>
              </a:p>
            </p:txBody>
          </p:sp>
          <p:sp>
            <p:nvSpPr>
              <p:cNvPr id="52" name="Line 44">
                <a:extLst>
                  <a:ext uri="{FF2B5EF4-FFF2-40B4-BE49-F238E27FC236}">
                    <a16:creationId xmlns:a16="http://schemas.microsoft.com/office/drawing/2014/main" id="{1C960FE5-7880-A0BA-5D1E-EAA4D6492E85}"/>
                  </a:ext>
                </a:extLst>
              </p:cNvPr>
              <p:cNvSpPr>
                <a:spLocks noChangeShapeType="1"/>
              </p:cNvSpPr>
              <p:nvPr/>
            </p:nvSpPr>
            <p:spPr bwMode="auto">
              <a:xfrm>
                <a:off x="257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3" name="Line 45">
                <a:extLst>
                  <a:ext uri="{FF2B5EF4-FFF2-40B4-BE49-F238E27FC236}">
                    <a16:creationId xmlns:a16="http://schemas.microsoft.com/office/drawing/2014/main" id="{8C32BADF-6576-C88A-310B-007264CAEC74}"/>
                  </a:ext>
                </a:extLst>
              </p:cNvPr>
              <p:cNvSpPr>
                <a:spLocks noChangeShapeType="1"/>
              </p:cNvSpPr>
              <p:nvPr/>
            </p:nvSpPr>
            <p:spPr bwMode="auto">
              <a:xfrm>
                <a:off x="264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4" name="Line 46">
                <a:extLst>
                  <a:ext uri="{FF2B5EF4-FFF2-40B4-BE49-F238E27FC236}">
                    <a16:creationId xmlns:a16="http://schemas.microsoft.com/office/drawing/2014/main" id="{EA5AF9D7-E895-D06A-A79C-1CB4EBF120D9}"/>
                  </a:ext>
                </a:extLst>
              </p:cNvPr>
              <p:cNvSpPr>
                <a:spLocks noChangeShapeType="1"/>
              </p:cNvSpPr>
              <p:nvPr/>
            </p:nvSpPr>
            <p:spPr bwMode="auto">
              <a:xfrm>
                <a:off x="271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5" name="Line 47">
                <a:extLst>
                  <a:ext uri="{FF2B5EF4-FFF2-40B4-BE49-F238E27FC236}">
                    <a16:creationId xmlns:a16="http://schemas.microsoft.com/office/drawing/2014/main" id="{45B096BF-ACA2-3EE4-68F7-BB8CE0047C9F}"/>
                  </a:ext>
                </a:extLst>
              </p:cNvPr>
              <p:cNvSpPr>
                <a:spLocks noChangeShapeType="1"/>
              </p:cNvSpPr>
              <p:nvPr/>
            </p:nvSpPr>
            <p:spPr bwMode="auto">
              <a:xfrm>
                <a:off x="278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6" name="Line 48">
                <a:extLst>
                  <a:ext uri="{FF2B5EF4-FFF2-40B4-BE49-F238E27FC236}">
                    <a16:creationId xmlns:a16="http://schemas.microsoft.com/office/drawing/2014/main" id="{7B5AF6A8-8380-7014-E430-B654EC6DE2DB}"/>
                  </a:ext>
                </a:extLst>
              </p:cNvPr>
              <p:cNvSpPr>
                <a:spLocks noChangeShapeType="1"/>
              </p:cNvSpPr>
              <p:nvPr/>
            </p:nvSpPr>
            <p:spPr bwMode="auto">
              <a:xfrm>
                <a:off x="2852"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7" name="Rectangle 49">
                <a:extLst>
                  <a:ext uri="{FF2B5EF4-FFF2-40B4-BE49-F238E27FC236}">
                    <a16:creationId xmlns:a16="http://schemas.microsoft.com/office/drawing/2014/main" id="{1DF15BC2-B968-34D3-BC55-B2EBBBB2198C}"/>
                  </a:ext>
                </a:extLst>
              </p:cNvPr>
              <p:cNvSpPr>
                <a:spLocks noChangeArrowheads="1"/>
              </p:cNvSpPr>
              <p:nvPr/>
            </p:nvSpPr>
            <p:spPr bwMode="auto">
              <a:xfrm>
                <a:off x="2803" y="3743"/>
                <a:ext cx="150"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8.75</a:t>
                </a:r>
                <a:endParaRPr lang="en-US" altLang="en-US" sz="700" b="1"/>
              </a:p>
            </p:txBody>
          </p:sp>
          <p:sp>
            <p:nvSpPr>
              <p:cNvPr id="58" name="Line 50">
                <a:extLst>
                  <a:ext uri="{FF2B5EF4-FFF2-40B4-BE49-F238E27FC236}">
                    <a16:creationId xmlns:a16="http://schemas.microsoft.com/office/drawing/2014/main" id="{ADE58CD9-8FB3-A8B6-CC22-72466E40E6DF}"/>
                  </a:ext>
                </a:extLst>
              </p:cNvPr>
              <p:cNvSpPr>
                <a:spLocks noChangeShapeType="1"/>
              </p:cNvSpPr>
              <p:nvPr/>
            </p:nvSpPr>
            <p:spPr bwMode="auto">
              <a:xfrm>
                <a:off x="292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59" name="Line 51">
                <a:extLst>
                  <a:ext uri="{FF2B5EF4-FFF2-40B4-BE49-F238E27FC236}">
                    <a16:creationId xmlns:a16="http://schemas.microsoft.com/office/drawing/2014/main" id="{62EEB929-9CFB-4A66-5537-C9F3349B3879}"/>
                  </a:ext>
                </a:extLst>
              </p:cNvPr>
              <p:cNvSpPr>
                <a:spLocks noChangeShapeType="1"/>
              </p:cNvSpPr>
              <p:nvPr/>
            </p:nvSpPr>
            <p:spPr bwMode="auto">
              <a:xfrm>
                <a:off x="298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0" name="Line 52">
                <a:extLst>
                  <a:ext uri="{FF2B5EF4-FFF2-40B4-BE49-F238E27FC236}">
                    <a16:creationId xmlns:a16="http://schemas.microsoft.com/office/drawing/2014/main" id="{3F26AF86-D674-B679-9FC0-1229A7643EE2}"/>
                  </a:ext>
                </a:extLst>
              </p:cNvPr>
              <p:cNvSpPr>
                <a:spLocks noChangeShapeType="1"/>
              </p:cNvSpPr>
              <p:nvPr/>
            </p:nvSpPr>
            <p:spPr bwMode="auto">
              <a:xfrm>
                <a:off x="305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1" name="Line 53">
                <a:extLst>
                  <a:ext uri="{FF2B5EF4-FFF2-40B4-BE49-F238E27FC236}">
                    <a16:creationId xmlns:a16="http://schemas.microsoft.com/office/drawing/2014/main" id="{6430716F-B4AA-87D3-3A0A-A202AAD4E07C}"/>
                  </a:ext>
                </a:extLst>
              </p:cNvPr>
              <p:cNvSpPr>
                <a:spLocks noChangeShapeType="1"/>
              </p:cNvSpPr>
              <p:nvPr/>
            </p:nvSpPr>
            <p:spPr bwMode="auto">
              <a:xfrm>
                <a:off x="312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2" name="Line 54">
                <a:extLst>
                  <a:ext uri="{FF2B5EF4-FFF2-40B4-BE49-F238E27FC236}">
                    <a16:creationId xmlns:a16="http://schemas.microsoft.com/office/drawing/2014/main" id="{4E84C3D4-4E6F-EFA3-96E2-19333ABDD72B}"/>
                  </a:ext>
                </a:extLst>
              </p:cNvPr>
              <p:cNvSpPr>
                <a:spLocks noChangeShapeType="1"/>
              </p:cNvSpPr>
              <p:nvPr/>
            </p:nvSpPr>
            <p:spPr bwMode="auto">
              <a:xfrm>
                <a:off x="3193"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3" name="Rectangle 55">
                <a:extLst>
                  <a:ext uri="{FF2B5EF4-FFF2-40B4-BE49-F238E27FC236}">
                    <a16:creationId xmlns:a16="http://schemas.microsoft.com/office/drawing/2014/main" id="{F2C90171-CA80-9A71-D091-A275BCC3BB88}"/>
                  </a:ext>
                </a:extLst>
              </p:cNvPr>
              <p:cNvSpPr>
                <a:spLocks noChangeArrowheads="1"/>
              </p:cNvSpPr>
              <p:nvPr/>
            </p:nvSpPr>
            <p:spPr bwMode="auto">
              <a:xfrm>
                <a:off x="3128"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0.00</a:t>
                </a:r>
                <a:endParaRPr lang="en-US" altLang="en-US" sz="700" b="1"/>
              </a:p>
            </p:txBody>
          </p:sp>
          <p:sp>
            <p:nvSpPr>
              <p:cNvPr id="64" name="Line 56">
                <a:extLst>
                  <a:ext uri="{FF2B5EF4-FFF2-40B4-BE49-F238E27FC236}">
                    <a16:creationId xmlns:a16="http://schemas.microsoft.com/office/drawing/2014/main" id="{EC740178-6507-713D-8A0C-A8DA26C949D7}"/>
                  </a:ext>
                </a:extLst>
              </p:cNvPr>
              <p:cNvSpPr>
                <a:spLocks noChangeShapeType="1"/>
              </p:cNvSpPr>
              <p:nvPr/>
            </p:nvSpPr>
            <p:spPr bwMode="auto">
              <a:xfrm>
                <a:off x="326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5" name="Line 57">
                <a:extLst>
                  <a:ext uri="{FF2B5EF4-FFF2-40B4-BE49-F238E27FC236}">
                    <a16:creationId xmlns:a16="http://schemas.microsoft.com/office/drawing/2014/main" id="{7327D91F-4199-D708-C368-008E69DD9951}"/>
                  </a:ext>
                </a:extLst>
              </p:cNvPr>
              <p:cNvSpPr>
                <a:spLocks noChangeShapeType="1"/>
              </p:cNvSpPr>
              <p:nvPr/>
            </p:nvSpPr>
            <p:spPr bwMode="auto">
              <a:xfrm>
                <a:off x="332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6" name="Line 58">
                <a:extLst>
                  <a:ext uri="{FF2B5EF4-FFF2-40B4-BE49-F238E27FC236}">
                    <a16:creationId xmlns:a16="http://schemas.microsoft.com/office/drawing/2014/main" id="{21D68302-7E8D-1315-68E8-A3ECE4E91842}"/>
                  </a:ext>
                </a:extLst>
              </p:cNvPr>
              <p:cNvSpPr>
                <a:spLocks noChangeShapeType="1"/>
              </p:cNvSpPr>
              <p:nvPr/>
            </p:nvSpPr>
            <p:spPr bwMode="auto">
              <a:xfrm>
                <a:off x="339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7" name="Line 59">
                <a:extLst>
                  <a:ext uri="{FF2B5EF4-FFF2-40B4-BE49-F238E27FC236}">
                    <a16:creationId xmlns:a16="http://schemas.microsoft.com/office/drawing/2014/main" id="{2F77F161-4446-4BC8-8A92-7DF26D5F7BA3}"/>
                  </a:ext>
                </a:extLst>
              </p:cNvPr>
              <p:cNvSpPr>
                <a:spLocks noChangeShapeType="1"/>
              </p:cNvSpPr>
              <p:nvPr/>
            </p:nvSpPr>
            <p:spPr bwMode="auto">
              <a:xfrm>
                <a:off x="346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8" name="Line 60">
                <a:extLst>
                  <a:ext uri="{FF2B5EF4-FFF2-40B4-BE49-F238E27FC236}">
                    <a16:creationId xmlns:a16="http://schemas.microsoft.com/office/drawing/2014/main" id="{8D951936-35A7-ACED-1633-8005408C242D}"/>
                  </a:ext>
                </a:extLst>
              </p:cNvPr>
              <p:cNvSpPr>
                <a:spLocks noChangeShapeType="1"/>
              </p:cNvSpPr>
              <p:nvPr/>
            </p:nvSpPr>
            <p:spPr bwMode="auto">
              <a:xfrm>
                <a:off x="3534"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69" name="Rectangle 61">
                <a:extLst>
                  <a:ext uri="{FF2B5EF4-FFF2-40B4-BE49-F238E27FC236}">
                    <a16:creationId xmlns:a16="http://schemas.microsoft.com/office/drawing/2014/main" id="{B14D2A41-7F07-D301-44F9-AA3050C1BDB5}"/>
                  </a:ext>
                </a:extLst>
              </p:cNvPr>
              <p:cNvSpPr>
                <a:spLocks noChangeArrowheads="1"/>
              </p:cNvSpPr>
              <p:nvPr/>
            </p:nvSpPr>
            <p:spPr bwMode="auto">
              <a:xfrm>
                <a:off x="3471"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1.25</a:t>
                </a:r>
                <a:endParaRPr lang="en-US" altLang="en-US" sz="700" b="1"/>
              </a:p>
            </p:txBody>
          </p:sp>
          <p:sp>
            <p:nvSpPr>
              <p:cNvPr id="70" name="Line 62">
                <a:extLst>
                  <a:ext uri="{FF2B5EF4-FFF2-40B4-BE49-F238E27FC236}">
                    <a16:creationId xmlns:a16="http://schemas.microsoft.com/office/drawing/2014/main" id="{C809A578-6F06-07CD-205B-8ADA3D2ABCEC}"/>
                  </a:ext>
                </a:extLst>
              </p:cNvPr>
              <p:cNvSpPr>
                <a:spLocks noChangeShapeType="1"/>
              </p:cNvSpPr>
              <p:nvPr/>
            </p:nvSpPr>
            <p:spPr bwMode="auto">
              <a:xfrm>
                <a:off x="360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1" name="Line 63">
                <a:extLst>
                  <a:ext uri="{FF2B5EF4-FFF2-40B4-BE49-F238E27FC236}">
                    <a16:creationId xmlns:a16="http://schemas.microsoft.com/office/drawing/2014/main" id="{62382406-DC35-1B37-2B74-A928B34F2EDC}"/>
                  </a:ext>
                </a:extLst>
              </p:cNvPr>
              <p:cNvSpPr>
                <a:spLocks noChangeShapeType="1"/>
              </p:cNvSpPr>
              <p:nvPr/>
            </p:nvSpPr>
            <p:spPr bwMode="auto">
              <a:xfrm>
                <a:off x="367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2" name="Line 64">
                <a:extLst>
                  <a:ext uri="{FF2B5EF4-FFF2-40B4-BE49-F238E27FC236}">
                    <a16:creationId xmlns:a16="http://schemas.microsoft.com/office/drawing/2014/main" id="{41F24844-D563-A0D7-0D3D-EA0CECDB9DB7}"/>
                  </a:ext>
                </a:extLst>
              </p:cNvPr>
              <p:cNvSpPr>
                <a:spLocks noChangeShapeType="1"/>
              </p:cNvSpPr>
              <p:nvPr/>
            </p:nvSpPr>
            <p:spPr bwMode="auto">
              <a:xfrm>
                <a:off x="373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3" name="Line 65">
                <a:extLst>
                  <a:ext uri="{FF2B5EF4-FFF2-40B4-BE49-F238E27FC236}">
                    <a16:creationId xmlns:a16="http://schemas.microsoft.com/office/drawing/2014/main" id="{B3EDC708-2150-948C-F8D0-CE3407A58B7A}"/>
                  </a:ext>
                </a:extLst>
              </p:cNvPr>
              <p:cNvSpPr>
                <a:spLocks noChangeShapeType="1"/>
              </p:cNvSpPr>
              <p:nvPr/>
            </p:nvSpPr>
            <p:spPr bwMode="auto">
              <a:xfrm>
                <a:off x="380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4" name="Line 66">
                <a:extLst>
                  <a:ext uri="{FF2B5EF4-FFF2-40B4-BE49-F238E27FC236}">
                    <a16:creationId xmlns:a16="http://schemas.microsoft.com/office/drawing/2014/main" id="{D98C8E8B-B438-DB06-B788-8E45A2C8E0D7}"/>
                  </a:ext>
                </a:extLst>
              </p:cNvPr>
              <p:cNvSpPr>
                <a:spLocks noChangeShapeType="1"/>
              </p:cNvSpPr>
              <p:nvPr/>
            </p:nvSpPr>
            <p:spPr bwMode="auto">
              <a:xfrm>
                <a:off x="3875"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5" name="Rectangle 67">
                <a:extLst>
                  <a:ext uri="{FF2B5EF4-FFF2-40B4-BE49-F238E27FC236}">
                    <a16:creationId xmlns:a16="http://schemas.microsoft.com/office/drawing/2014/main" id="{E52A45AF-FC53-1F83-2CBB-03CE04E734AE}"/>
                  </a:ext>
                </a:extLst>
              </p:cNvPr>
              <p:cNvSpPr>
                <a:spLocks noChangeArrowheads="1"/>
              </p:cNvSpPr>
              <p:nvPr/>
            </p:nvSpPr>
            <p:spPr bwMode="auto">
              <a:xfrm>
                <a:off x="3814"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0</a:t>
                </a:r>
                <a:endParaRPr lang="en-US" altLang="en-US" sz="700" b="1"/>
              </a:p>
            </p:txBody>
          </p:sp>
          <p:sp>
            <p:nvSpPr>
              <p:cNvPr id="76" name="Line 68">
                <a:extLst>
                  <a:ext uri="{FF2B5EF4-FFF2-40B4-BE49-F238E27FC236}">
                    <a16:creationId xmlns:a16="http://schemas.microsoft.com/office/drawing/2014/main" id="{52181176-B1B7-8BE1-B9E5-CFCA1831D9B3}"/>
                  </a:ext>
                </a:extLst>
              </p:cNvPr>
              <p:cNvSpPr>
                <a:spLocks noChangeShapeType="1"/>
              </p:cNvSpPr>
              <p:nvPr/>
            </p:nvSpPr>
            <p:spPr bwMode="auto">
              <a:xfrm>
                <a:off x="394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7" name="Line 69">
                <a:extLst>
                  <a:ext uri="{FF2B5EF4-FFF2-40B4-BE49-F238E27FC236}">
                    <a16:creationId xmlns:a16="http://schemas.microsoft.com/office/drawing/2014/main" id="{B446D802-5D8D-88D3-9B68-D4D48BCD5AB0}"/>
                  </a:ext>
                </a:extLst>
              </p:cNvPr>
              <p:cNvSpPr>
                <a:spLocks noChangeShapeType="1"/>
              </p:cNvSpPr>
              <p:nvPr/>
            </p:nvSpPr>
            <p:spPr bwMode="auto">
              <a:xfrm>
                <a:off x="401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8" name="Line 70">
                <a:extLst>
                  <a:ext uri="{FF2B5EF4-FFF2-40B4-BE49-F238E27FC236}">
                    <a16:creationId xmlns:a16="http://schemas.microsoft.com/office/drawing/2014/main" id="{3A265076-2DEB-23E3-BC02-D602C397E27A}"/>
                  </a:ext>
                </a:extLst>
              </p:cNvPr>
              <p:cNvSpPr>
                <a:spLocks noChangeShapeType="1"/>
              </p:cNvSpPr>
              <p:nvPr/>
            </p:nvSpPr>
            <p:spPr bwMode="auto">
              <a:xfrm>
                <a:off x="408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79" name="Line 71">
                <a:extLst>
                  <a:ext uri="{FF2B5EF4-FFF2-40B4-BE49-F238E27FC236}">
                    <a16:creationId xmlns:a16="http://schemas.microsoft.com/office/drawing/2014/main" id="{031ACAA8-F542-4EF9-152A-E4E202943E05}"/>
                  </a:ext>
                </a:extLst>
              </p:cNvPr>
              <p:cNvSpPr>
                <a:spLocks noChangeShapeType="1"/>
              </p:cNvSpPr>
              <p:nvPr/>
            </p:nvSpPr>
            <p:spPr bwMode="auto">
              <a:xfrm>
                <a:off x="414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0" name="Line 72">
                <a:extLst>
                  <a:ext uri="{FF2B5EF4-FFF2-40B4-BE49-F238E27FC236}">
                    <a16:creationId xmlns:a16="http://schemas.microsoft.com/office/drawing/2014/main" id="{441B2296-8923-EE32-061F-30296EFE699D}"/>
                  </a:ext>
                </a:extLst>
              </p:cNvPr>
              <p:cNvSpPr>
                <a:spLocks noChangeShapeType="1"/>
              </p:cNvSpPr>
              <p:nvPr/>
            </p:nvSpPr>
            <p:spPr bwMode="auto">
              <a:xfrm>
                <a:off x="4216"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1" name="Rectangle 73">
                <a:extLst>
                  <a:ext uri="{FF2B5EF4-FFF2-40B4-BE49-F238E27FC236}">
                    <a16:creationId xmlns:a16="http://schemas.microsoft.com/office/drawing/2014/main" id="{D1B6B2CD-1535-8340-A6B0-8501B0F73770}"/>
                  </a:ext>
                </a:extLst>
              </p:cNvPr>
              <p:cNvSpPr>
                <a:spLocks noChangeArrowheads="1"/>
              </p:cNvSpPr>
              <p:nvPr/>
            </p:nvSpPr>
            <p:spPr bwMode="auto">
              <a:xfrm>
                <a:off x="4152"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3.75</a:t>
                </a:r>
                <a:endParaRPr lang="en-US" altLang="en-US" sz="700" b="1"/>
              </a:p>
            </p:txBody>
          </p:sp>
          <p:sp>
            <p:nvSpPr>
              <p:cNvPr id="82" name="Line 74">
                <a:extLst>
                  <a:ext uri="{FF2B5EF4-FFF2-40B4-BE49-F238E27FC236}">
                    <a16:creationId xmlns:a16="http://schemas.microsoft.com/office/drawing/2014/main" id="{8D27824B-275A-1C19-C728-E8804CA1AE15}"/>
                  </a:ext>
                </a:extLst>
              </p:cNvPr>
              <p:cNvSpPr>
                <a:spLocks noChangeShapeType="1"/>
              </p:cNvSpPr>
              <p:nvPr/>
            </p:nvSpPr>
            <p:spPr bwMode="auto">
              <a:xfrm>
                <a:off x="428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3" name="Line 75">
                <a:extLst>
                  <a:ext uri="{FF2B5EF4-FFF2-40B4-BE49-F238E27FC236}">
                    <a16:creationId xmlns:a16="http://schemas.microsoft.com/office/drawing/2014/main" id="{ABEA9B47-F5AB-342D-7902-B05621FD1945}"/>
                  </a:ext>
                </a:extLst>
              </p:cNvPr>
              <p:cNvSpPr>
                <a:spLocks noChangeShapeType="1"/>
              </p:cNvSpPr>
              <p:nvPr/>
            </p:nvSpPr>
            <p:spPr bwMode="auto">
              <a:xfrm>
                <a:off x="435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4" name="Line 76">
                <a:extLst>
                  <a:ext uri="{FF2B5EF4-FFF2-40B4-BE49-F238E27FC236}">
                    <a16:creationId xmlns:a16="http://schemas.microsoft.com/office/drawing/2014/main" id="{F656199A-1782-3D9E-C462-982D8803DE6B}"/>
                  </a:ext>
                </a:extLst>
              </p:cNvPr>
              <p:cNvSpPr>
                <a:spLocks noChangeShapeType="1"/>
              </p:cNvSpPr>
              <p:nvPr/>
            </p:nvSpPr>
            <p:spPr bwMode="auto">
              <a:xfrm>
                <a:off x="442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5" name="Line 77">
                <a:extLst>
                  <a:ext uri="{FF2B5EF4-FFF2-40B4-BE49-F238E27FC236}">
                    <a16:creationId xmlns:a16="http://schemas.microsoft.com/office/drawing/2014/main" id="{B6138DE0-F21E-0234-7380-532082FF3D00}"/>
                  </a:ext>
                </a:extLst>
              </p:cNvPr>
              <p:cNvSpPr>
                <a:spLocks noChangeShapeType="1"/>
              </p:cNvSpPr>
              <p:nvPr/>
            </p:nvSpPr>
            <p:spPr bwMode="auto">
              <a:xfrm>
                <a:off x="448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6" name="Line 78">
                <a:extLst>
                  <a:ext uri="{FF2B5EF4-FFF2-40B4-BE49-F238E27FC236}">
                    <a16:creationId xmlns:a16="http://schemas.microsoft.com/office/drawing/2014/main" id="{A09A112B-6BC8-B92C-8278-28C43D979917}"/>
                  </a:ext>
                </a:extLst>
              </p:cNvPr>
              <p:cNvSpPr>
                <a:spLocks noChangeShapeType="1"/>
              </p:cNvSpPr>
              <p:nvPr/>
            </p:nvSpPr>
            <p:spPr bwMode="auto">
              <a:xfrm>
                <a:off x="4557"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7" name="Rectangle 79">
                <a:extLst>
                  <a:ext uri="{FF2B5EF4-FFF2-40B4-BE49-F238E27FC236}">
                    <a16:creationId xmlns:a16="http://schemas.microsoft.com/office/drawing/2014/main" id="{E2CCBAE9-587D-D0ED-53EC-76C79C651408}"/>
                  </a:ext>
                </a:extLst>
              </p:cNvPr>
              <p:cNvSpPr>
                <a:spLocks noChangeArrowheads="1"/>
              </p:cNvSpPr>
              <p:nvPr/>
            </p:nvSpPr>
            <p:spPr bwMode="auto">
              <a:xfrm>
                <a:off x="4495"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5.00</a:t>
                </a:r>
                <a:endParaRPr lang="en-US" altLang="en-US" sz="700" b="1"/>
              </a:p>
            </p:txBody>
          </p:sp>
          <p:sp>
            <p:nvSpPr>
              <p:cNvPr id="88" name="Line 80">
                <a:extLst>
                  <a:ext uri="{FF2B5EF4-FFF2-40B4-BE49-F238E27FC236}">
                    <a16:creationId xmlns:a16="http://schemas.microsoft.com/office/drawing/2014/main" id="{9829F08C-0495-30D4-C327-713C80D69EE2}"/>
                  </a:ext>
                </a:extLst>
              </p:cNvPr>
              <p:cNvSpPr>
                <a:spLocks noChangeShapeType="1"/>
              </p:cNvSpPr>
              <p:nvPr/>
            </p:nvSpPr>
            <p:spPr bwMode="auto">
              <a:xfrm>
                <a:off x="462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89" name="Line 81">
                <a:extLst>
                  <a:ext uri="{FF2B5EF4-FFF2-40B4-BE49-F238E27FC236}">
                    <a16:creationId xmlns:a16="http://schemas.microsoft.com/office/drawing/2014/main" id="{069463D1-06DF-8CE8-FD20-30D7992D5380}"/>
                  </a:ext>
                </a:extLst>
              </p:cNvPr>
              <p:cNvSpPr>
                <a:spLocks noChangeShapeType="1"/>
              </p:cNvSpPr>
              <p:nvPr/>
            </p:nvSpPr>
            <p:spPr bwMode="auto">
              <a:xfrm>
                <a:off x="469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0" name="Line 82">
                <a:extLst>
                  <a:ext uri="{FF2B5EF4-FFF2-40B4-BE49-F238E27FC236}">
                    <a16:creationId xmlns:a16="http://schemas.microsoft.com/office/drawing/2014/main" id="{443CD244-6181-41E3-BF83-E3E8854522F8}"/>
                  </a:ext>
                </a:extLst>
              </p:cNvPr>
              <p:cNvSpPr>
                <a:spLocks noChangeShapeType="1"/>
              </p:cNvSpPr>
              <p:nvPr/>
            </p:nvSpPr>
            <p:spPr bwMode="auto">
              <a:xfrm>
                <a:off x="476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1" name="Line 83">
                <a:extLst>
                  <a:ext uri="{FF2B5EF4-FFF2-40B4-BE49-F238E27FC236}">
                    <a16:creationId xmlns:a16="http://schemas.microsoft.com/office/drawing/2014/main" id="{601A0F52-558D-30DE-53AC-76E1C598E242}"/>
                  </a:ext>
                </a:extLst>
              </p:cNvPr>
              <p:cNvSpPr>
                <a:spLocks noChangeShapeType="1"/>
              </p:cNvSpPr>
              <p:nvPr/>
            </p:nvSpPr>
            <p:spPr bwMode="auto">
              <a:xfrm>
                <a:off x="483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2" name="Line 84">
                <a:extLst>
                  <a:ext uri="{FF2B5EF4-FFF2-40B4-BE49-F238E27FC236}">
                    <a16:creationId xmlns:a16="http://schemas.microsoft.com/office/drawing/2014/main" id="{2C62C20F-0B32-057C-37D6-42FC30066901}"/>
                  </a:ext>
                </a:extLst>
              </p:cNvPr>
              <p:cNvSpPr>
                <a:spLocks noChangeShapeType="1"/>
              </p:cNvSpPr>
              <p:nvPr/>
            </p:nvSpPr>
            <p:spPr bwMode="auto">
              <a:xfrm>
                <a:off x="4899"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3" name="Rectangle 85">
                <a:extLst>
                  <a:ext uri="{FF2B5EF4-FFF2-40B4-BE49-F238E27FC236}">
                    <a16:creationId xmlns:a16="http://schemas.microsoft.com/office/drawing/2014/main" id="{06CBEB86-5E15-28EF-B706-C762BAAA06AA}"/>
                  </a:ext>
                </a:extLst>
              </p:cNvPr>
              <p:cNvSpPr>
                <a:spLocks noChangeArrowheads="1"/>
              </p:cNvSpPr>
              <p:nvPr/>
            </p:nvSpPr>
            <p:spPr bwMode="auto">
              <a:xfrm>
                <a:off x="4837"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6.25</a:t>
                </a:r>
                <a:endParaRPr lang="en-US" altLang="en-US" sz="700" b="1"/>
              </a:p>
            </p:txBody>
          </p:sp>
          <p:sp>
            <p:nvSpPr>
              <p:cNvPr id="94" name="Line 86">
                <a:extLst>
                  <a:ext uri="{FF2B5EF4-FFF2-40B4-BE49-F238E27FC236}">
                    <a16:creationId xmlns:a16="http://schemas.microsoft.com/office/drawing/2014/main" id="{EB431D8D-CC14-B2D3-15A8-AA9250E07335}"/>
                  </a:ext>
                </a:extLst>
              </p:cNvPr>
              <p:cNvSpPr>
                <a:spLocks noChangeShapeType="1"/>
              </p:cNvSpPr>
              <p:nvPr/>
            </p:nvSpPr>
            <p:spPr bwMode="auto">
              <a:xfrm>
                <a:off x="496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5" name="Line 87">
                <a:extLst>
                  <a:ext uri="{FF2B5EF4-FFF2-40B4-BE49-F238E27FC236}">
                    <a16:creationId xmlns:a16="http://schemas.microsoft.com/office/drawing/2014/main" id="{F0F754D2-2BBB-E79A-2904-4F2DC9FCD86F}"/>
                  </a:ext>
                </a:extLst>
              </p:cNvPr>
              <p:cNvSpPr>
                <a:spLocks noChangeShapeType="1"/>
              </p:cNvSpPr>
              <p:nvPr/>
            </p:nvSpPr>
            <p:spPr bwMode="auto">
              <a:xfrm>
                <a:off x="503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6" name="Line 88">
                <a:extLst>
                  <a:ext uri="{FF2B5EF4-FFF2-40B4-BE49-F238E27FC236}">
                    <a16:creationId xmlns:a16="http://schemas.microsoft.com/office/drawing/2014/main" id="{8A3E62A1-53BF-1CDD-2085-A67DCAF4F2BB}"/>
                  </a:ext>
                </a:extLst>
              </p:cNvPr>
              <p:cNvSpPr>
                <a:spLocks noChangeShapeType="1"/>
              </p:cNvSpPr>
              <p:nvPr/>
            </p:nvSpPr>
            <p:spPr bwMode="auto">
              <a:xfrm>
                <a:off x="510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7" name="Line 89">
                <a:extLst>
                  <a:ext uri="{FF2B5EF4-FFF2-40B4-BE49-F238E27FC236}">
                    <a16:creationId xmlns:a16="http://schemas.microsoft.com/office/drawing/2014/main" id="{71959D3D-7C39-B232-CA12-6AD0DE5E60E3}"/>
                  </a:ext>
                </a:extLst>
              </p:cNvPr>
              <p:cNvSpPr>
                <a:spLocks noChangeShapeType="1"/>
              </p:cNvSpPr>
              <p:nvPr/>
            </p:nvSpPr>
            <p:spPr bwMode="auto">
              <a:xfrm>
                <a:off x="517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8" name="Line 90">
                <a:extLst>
                  <a:ext uri="{FF2B5EF4-FFF2-40B4-BE49-F238E27FC236}">
                    <a16:creationId xmlns:a16="http://schemas.microsoft.com/office/drawing/2014/main" id="{F09FDC94-1C88-DC2F-0609-0A8E5AAD0BF0}"/>
                  </a:ext>
                </a:extLst>
              </p:cNvPr>
              <p:cNvSpPr>
                <a:spLocks noChangeShapeType="1"/>
              </p:cNvSpPr>
              <p:nvPr/>
            </p:nvSpPr>
            <p:spPr bwMode="auto">
              <a:xfrm>
                <a:off x="5240"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99" name="Rectangle 91">
                <a:extLst>
                  <a:ext uri="{FF2B5EF4-FFF2-40B4-BE49-F238E27FC236}">
                    <a16:creationId xmlns:a16="http://schemas.microsoft.com/office/drawing/2014/main" id="{BBAC9D33-39D3-BD58-280B-6BD0D5788BAF}"/>
                  </a:ext>
                </a:extLst>
              </p:cNvPr>
              <p:cNvSpPr>
                <a:spLocks noChangeArrowheads="1"/>
              </p:cNvSpPr>
              <p:nvPr/>
            </p:nvSpPr>
            <p:spPr bwMode="auto">
              <a:xfrm>
                <a:off x="5176"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7.50</a:t>
                </a:r>
                <a:endParaRPr lang="en-US" altLang="en-US" sz="700" b="1"/>
              </a:p>
            </p:txBody>
          </p:sp>
          <p:sp>
            <p:nvSpPr>
              <p:cNvPr id="100" name="Line 92">
                <a:extLst>
                  <a:ext uri="{FF2B5EF4-FFF2-40B4-BE49-F238E27FC236}">
                    <a16:creationId xmlns:a16="http://schemas.microsoft.com/office/drawing/2014/main" id="{3535F92E-C6BC-796E-35B2-B87CC9A6244E}"/>
                  </a:ext>
                </a:extLst>
              </p:cNvPr>
              <p:cNvSpPr>
                <a:spLocks noChangeShapeType="1"/>
              </p:cNvSpPr>
              <p:nvPr/>
            </p:nvSpPr>
            <p:spPr bwMode="auto">
              <a:xfrm>
                <a:off x="530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1" name="Line 93">
                <a:extLst>
                  <a:ext uri="{FF2B5EF4-FFF2-40B4-BE49-F238E27FC236}">
                    <a16:creationId xmlns:a16="http://schemas.microsoft.com/office/drawing/2014/main" id="{0BCF9187-8CF9-1B26-2E94-ED2EE8C9F2AC}"/>
                  </a:ext>
                </a:extLst>
              </p:cNvPr>
              <p:cNvSpPr>
                <a:spLocks noChangeShapeType="1"/>
              </p:cNvSpPr>
              <p:nvPr/>
            </p:nvSpPr>
            <p:spPr bwMode="auto">
              <a:xfrm>
                <a:off x="537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2" name="Line 94">
                <a:extLst>
                  <a:ext uri="{FF2B5EF4-FFF2-40B4-BE49-F238E27FC236}">
                    <a16:creationId xmlns:a16="http://schemas.microsoft.com/office/drawing/2014/main" id="{7CEBA1C8-2047-59B8-D0F1-E88DE3BB0453}"/>
                  </a:ext>
                </a:extLst>
              </p:cNvPr>
              <p:cNvSpPr>
                <a:spLocks noChangeShapeType="1"/>
              </p:cNvSpPr>
              <p:nvPr/>
            </p:nvSpPr>
            <p:spPr bwMode="auto">
              <a:xfrm>
                <a:off x="544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3" name="Line 95">
                <a:extLst>
                  <a:ext uri="{FF2B5EF4-FFF2-40B4-BE49-F238E27FC236}">
                    <a16:creationId xmlns:a16="http://schemas.microsoft.com/office/drawing/2014/main" id="{CC8FA99F-19A3-73E9-CA07-747AFAD60120}"/>
                  </a:ext>
                </a:extLst>
              </p:cNvPr>
              <p:cNvSpPr>
                <a:spLocks noChangeShapeType="1"/>
              </p:cNvSpPr>
              <p:nvPr/>
            </p:nvSpPr>
            <p:spPr bwMode="auto">
              <a:xfrm>
                <a:off x="5513"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4" name="Line 96">
                <a:extLst>
                  <a:ext uri="{FF2B5EF4-FFF2-40B4-BE49-F238E27FC236}">
                    <a16:creationId xmlns:a16="http://schemas.microsoft.com/office/drawing/2014/main" id="{85869AFA-4EFA-8026-3B37-36D595E22B8E}"/>
                  </a:ext>
                </a:extLst>
              </p:cNvPr>
              <p:cNvSpPr>
                <a:spLocks noChangeShapeType="1"/>
              </p:cNvSpPr>
              <p:nvPr/>
            </p:nvSpPr>
            <p:spPr bwMode="auto">
              <a:xfrm>
                <a:off x="5581"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5" name="Rectangle 97">
                <a:extLst>
                  <a:ext uri="{FF2B5EF4-FFF2-40B4-BE49-F238E27FC236}">
                    <a16:creationId xmlns:a16="http://schemas.microsoft.com/office/drawing/2014/main" id="{3DDD763B-3147-3627-01C0-D226A3BC9AB8}"/>
                  </a:ext>
                </a:extLst>
              </p:cNvPr>
              <p:cNvSpPr>
                <a:spLocks noChangeArrowheads="1"/>
              </p:cNvSpPr>
              <p:nvPr/>
            </p:nvSpPr>
            <p:spPr bwMode="auto">
              <a:xfrm>
                <a:off x="5518"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8.75</a:t>
                </a:r>
                <a:endParaRPr lang="en-US" altLang="en-US" sz="700" b="1"/>
              </a:p>
            </p:txBody>
          </p:sp>
          <p:sp>
            <p:nvSpPr>
              <p:cNvPr id="106" name="Line 98">
                <a:extLst>
                  <a:ext uri="{FF2B5EF4-FFF2-40B4-BE49-F238E27FC236}">
                    <a16:creationId xmlns:a16="http://schemas.microsoft.com/office/drawing/2014/main" id="{F4E0F4CC-6593-F658-089A-66DCA9844596}"/>
                  </a:ext>
                </a:extLst>
              </p:cNvPr>
              <p:cNvSpPr>
                <a:spLocks noChangeShapeType="1"/>
              </p:cNvSpPr>
              <p:nvPr/>
            </p:nvSpPr>
            <p:spPr bwMode="auto">
              <a:xfrm>
                <a:off x="564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7" name="Line 99">
                <a:extLst>
                  <a:ext uri="{FF2B5EF4-FFF2-40B4-BE49-F238E27FC236}">
                    <a16:creationId xmlns:a16="http://schemas.microsoft.com/office/drawing/2014/main" id="{671B821D-2F01-0B08-D03D-2468865AB387}"/>
                  </a:ext>
                </a:extLst>
              </p:cNvPr>
              <p:cNvSpPr>
                <a:spLocks noChangeShapeType="1"/>
              </p:cNvSpPr>
              <p:nvPr/>
            </p:nvSpPr>
            <p:spPr bwMode="auto">
              <a:xfrm>
                <a:off x="571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8" name="Line 100">
                <a:extLst>
                  <a:ext uri="{FF2B5EF4-FFF2-40B4-BE49-F238E27FC236}">
                    <a16:creationId xmlns:a16="http://schemas.microsoft.com/office/drawing/2014/main" id="{6702BEB8-2A89-59D9-7DE8-3281849A906A}"/>
                  </a:ext>
                </a:extLst>
              </p:cNvPr>
              <p:cNvSpPr>
                <a:spLocks noChangeShapeType="1"/>
              </p:cNvSpPr>
              <p:nvPr/>
            </p:nvSpPr>
            <p:spPr bwMode="auto">
              <a:xfrm>
                <a:off x="578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09" name="Line 101">
                <a:extLst>
                  <a:ext uri="{FF2B5EF4-FFF2-40B4-BE49-F238E27FC236}">
                    <a16:creationId xmlns:a16="http://schemas.microsoft.com/office/drawing/2014/main" id="{DF13F29B-3430-CA7A-A7C4-BF40633CFFC6}"/>
                  </a:ext>
                </a:extLst>
              </p:cNvPr>
              <p:cNvSpPr>
                <a:spLocks noChangeShapeType="1"/>
              </p:cNvSpPr>
              <p:nvPr/>
            </p:nvSpPr>
            <p:spPr bwMode="auto">
              <a:xfrm>
                <a:off x="585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0" name="Line 102">
                <a:extLst>
                  <a:ext uri="{FF2B5EF4-FFF2-40B4-BE49-F238E27FC236}">
                    <a16:creationId xmlns:a16="http://schemas.microsoft.com/office/drawing/2014/main" id="{723C019A-92AC-7151-2F42-2C6BB8CE66E9}"/>
                  </a:ext>
                </a:extLst>
              </p:cNvPr>
              <p:cNvSpPr>
                <a:spLocks noChangeShapeType="1"/>
              </p:cNvSpPr>
              <p:nvPr/>
            </p:nvSpPr>
            <p:spPr bwMode="auto">
              <a:xfrm>
                <a:off x="5922"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1" name="Rectangle 103">
                <a:extLst>
                  <a:ext uri="{FF2B5EF4-FFF2-40B4-BE49-F238E27FC236}">
                    <a16:creationId xmlns:a16="http://schemas.microsoft.com/office/drawing/2014/main" id="{D7E4555D-5D9F-1D0D-DCFC-B5C2527C450C}"/>
                  </a:ext>
                </a:extLst>
              </p:cNvPr>
              <p:cNvSpPr>
                <a:spLocks noChangeArrowheads="1"/>
              </p:cNvSpPr>
              <p:nvPr/>
            </p:nvSpPr>
            <p:spPr bwMode="auto">
              <a:xfrm>
                <a:off x="5861"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0.00</a:t>
                </a:r>
                <a:endParaRPr lang="en-US" altLang="en-US" sz="700" b="1"/>
              </a:p>
            </p:txBody>
          </p:sp>
          <p:sp>
            <p:nvSpPr>
              <p:cNvPr id="112" name="Line 104">
                <a:extLst>
                  <a:ext uri="{FF2B5EF4-FFF2-40B4-BE49-F238E27FC236}">
                    <a16:creationId xmlns:a16="http://schemas.microsoft.com/office/drawing/2014/main" id="{FC1D3A2F-3D6F-5FA9-EF9B-E63389B2DD23}"/>
                  </a:ext>
                </a:extLst>
              </p:cNvPr>
              <p:cNvSpPr>
                <a:spLocks noChangeShapeType="1"/>
              </p:cNvSpPr>
              <p:nvPr/>
            </p:nvSpPr>
            <p:spPr bwMode="auto">
              <a:xfrm>
                <a:off x="599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3" name="Line 105">
                <a:extLst>
                  <a:ext uri="{FF2B5EF4-FFF2-40B4-BE49-F238E27FC236}">
                    <a16:creationId xmlns:a16="http://schemas.microsoft.com/office/drawing/2014/main" id="{A00BD3AA-B703-8B82-5D29-B75F157D49C7}"/>
                  </a:ext>
                </a:extLst>
              </p:cNvPr>
              <p:cNvSpPr>
                <a:spLocks noChangeShapeType="1"/>
              </p:cNvSpPr>
              <p:nvPr/>
            </p:nvSpPr>
            <p:spPr bwMode="auto">
              <a:xfrm>
                <a:off x="605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4" name="Line 106">
                <a:extLst>
                  <a:ext uri="{FF2B5EF4-FFF2-40B4-BE49-F238E27FC236}">
                    <a16:creationId xmlns:a16="http://schemas.microsoft.com/office/drawing/2014/main" id="{CC5D751A-0232-89E9-9774-2431A9D3ADF7}"/>
                  </a:ext>
                </a:extLst>
              </p:cNvPr>
              <p:cNvSpPr>
                <a:spLocks noChangeShapeType="1"/>
              </p:cNvSpPr>
              <p:nvPr/>
            </p:nvSpPr>
            <p:spPr bwMode="auto">
              <a:xfrm>
                <a:off x="612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5" name="Line 107">
                <a:extLst>
                  <a:ext uri="{FF2B5EF4-FFF2-40B4-BE49-F238E27FC236}">
                    <a16:creationId xmlns:a16="http://schemas.microsoft.com/office/drawing/2014/main" id="{5BD7507F-1E3E-7B44-90DD-5F9A38F2C47A}"/>
                  </a:ext>
                </a:extLst>
              </p:cNvPr>
              <p:cNvSpPr>
                <a:spLocks noChangeShapeType="1"/>
              </p:cNvSpPr>
              <p:nvPr/>
            </p:nvSpPr>
            <p:spPr bwMode="auto">
              <a:xfrm>
                <a:off x="6195"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6" name="Line 108">
                <a:extLst>
                  <a:ext uri="{FF2B5EF4-FFF2-40B4-BE49-F238E27FC236}">
                    <a16:creationId xmlns:a16="http://schemas.microsoft.com/office/drawing/2014/main" id="{6DECDA78-7136-4A63-10E6-68A40491CA66}"/>
                  </a:ext>
                </a:extLst>
              </p:cNvPr>
              <p:cNvSpPr>
                <a:spLocks noChangeShapeType="1"/>
              </p:cNvSpPr>
              <p:nvPr/>
            </p:nvSpPr>
            <p:spPr bwMode="auto">
              <a:xfrm>
                <a:off x="6263"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7" name="Rectangle 109">
                <a:extLst>
                  <a:ext uri="{FF2B5EF4-FFF2-40B4-BE49-F238E27FC236}">
                    <a16:creationId xmlns:a16="http://schemas.microsoft.com/office/drawing/2014/main" id="{BFF1A609-28EE-71A0-7B26-0BD5431C3AF3}"/>
                  </a:ext>
                </a:extLst>
              </p:cNvPr>
              <p:cNvSpPr>
                <a:spLocks noChangeArrowheads="1"/>
              </p:cNvSpPr>
              <p:nvPr/>
            </p:nvSpPr>
            <p:spPr bwMode="auto">
              <a:xfrm>
                <a:off x="6199"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1.25</a:t>
                </a:r>
                <a:endParaRPr lang="en-US" altLang="en-US" sz="700" b="1"/>
              </a:p>
            </p:txBody>
          </p:sp>
          <p:sp>
            <p:nvSpPr>
              <p:cNvPr id="118" name="Line 110">
                <a:extLst>
                  <a:ext uri="{FF2B5EF4-FFF2-40B4-BE49-F238E27FC236}">
                    <a16:creationId xmlns:a16="http://schemas.microsoft.com/office/drawing/2014/main" id="{6B60145C-76FA-F310-D9AB-E40B8A18A9FC}"/>
                  </a:ext>
                </a:extLst>
              </p:cNvPr>
              <p:cNvSpPr>
                <a:spLocks noChangeShapeType="1"/>
              </p:cNvSpPr>
              <p:nvPr/>
            </p:nvSpPr>
            <p:spPr bwMode="auto">
              <a:xfrm>
                <a:off x="633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19" name="Line 111">
                <a:extLst>
                  <a:ext uri="{FF2B5EF4-FFF2-40B4-BE49-F238E27FC236}">
                    <a16:creationId xmlns:a16="http://schemas.microsoft.com/office/drawing/2014/main" id="{828A94C3-1E6F-0E6E-0E49-BE37BFA78549}"/>
                  </a:ext>
                </a:extLst>
              </p:cNvPr>
              <p:cNvSpPr>
                <a:spLocks noChangeShapeType="1"/>
              </p:cNvSpPr>
              <p:nvPr/>
            </p:nvSpPr>
            <p:spPr bwMode="auto">
              <a:xfrm>
                <a:off x="640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0" name="Line 112">
                <a:extLst>
                  <a:ext uri="{FF2B5EF4-FFF2-40B4-BE49-F238E27FC236}">
                    <a16:creationId xmlns:a16="http://schemas.microsoft.com/office/drawing/2014/main" id="{638D7D81-4C96-0D28-1D26-B34FB65705AA}"/>
                  </a:ext>
                </a:extLst>
              </p:cNvPr>
              <p:cNvSpPr>
                <a:spLocks noChangeShapeType="1"/>
              </p:cNvSpPr>
              <p:nvPr/>
            </p:nvSpPr>
            <p:spPr bwMode="auto">
              <a:xfrm>
                <a:off x="646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1" name="Line 113">
                <a:extLst>
                  <a:ext uri="{FF2B5EF4-FFF2-40B4-BE49-F238E27FC236}">
                    <a16:creationId xmlns:a16="http://schemas.microsoft.com/office/drawing/2014/main" id="{DC1BA858-9F0F-3938-03C5-72F0F3DB50BD}"/>
                  </a:ext>
                </a:extLst>
              </p:cNvPr>
              <p:cNvSpPr>
                <a:spLocks noChangeShapeType="1"/>
              </p:cNvSpPr>
              <p:nvPr/>
            </p:nvSpPr>
            <p:spPr bwMode="auto">
              <a:xfrm>
                <a:off x="6536"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2" name="Line 114">
                <a:extLst>
                  <a:ext uri="{FF2B5EF4-FFF2-40B4-BE49-F238E27FC236}">
                    <a16:creationId xmlns:a16="http://schemas.microsoft.com/office/drawing/2014/main" id="{92F13096-1278-66C9-EAE6-E7890740C464}"/>
                  </a:ext>
                </a:extLst>
              </p:cNvPr>
              <p:cNvSpPr>
                <a:spLocks noChangeShapeType="1"/>
              </p:cNvSpPr>
              <p:nvPr/>
            </p:nvSpPr>
            <p:spPr bwMode="auto">
              <a:xfrm>
                <a:off x="6604"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3" name="Rectangle 115">
                <a:extLst>
                  <a:ext uri="{FF2B5EF4-FFF2-40B4-BE49-F238E27FC236}">
                    <a16:creationId xmlns:a16="http://schemas.microsoft.com/office/drawing/2014/main" id="{198A08C4-F10F-16AE-1863-83F2B15706AA}"/>
                  </a:ext>
                </a:extLst>
              </p:cNvPr>
              <p:cNvSpPr>
                <a:spLocks noChangeArrowheads="1"/>
              </p:cNvSpPr>
              <p:nvPr/>
            </p:nvSpPr>
            <p:spPr bwMode="auto">
              <a:xfrm>
                <a:off x="6542"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2.50</a:t>
                </a:r>
                <a:endParaRPr lang="en-US" altLang="en-US" sz="700" b="1"/>
              </a:p>
            </p:txBody>
          </p:sp>
          <p:sp>
            <p:nvSpPr>
              <p:cNvPr id="124" name="Line 116">
                <a:extLst>
                  <a:ext uri="{FF2B5EF4-FFF2-40B4-BE49-F238E27FC236}">
                    <a16:creationId xmlns:a16="http://schemas.microsoft.com/office/drawing/2014/main" id="{BE4E9746-94AD-8788-04AA-24574CA7988F}"/>
                  </a:ext>
                </a:extLst>
              </p:cNvPr>
              <p:cNvSpPr>
                <a:spLocks noChangeShapeType="1"/>
              </p:cNvSpPr>
              <p:nvPr/>
            </p:nvSpPr>
            <p:spPr bwMode="auto">
              <a:xfrm>
                <a:off x="667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5" name="Line 117">
                <a:extLst>
                  <a:ext uri="{FF2B5EF4-FFF2-40B4-BE49-F238E27FC236}">
                    <a16:creationId xmlns:a16="http://schemas.microsoft.com/office/drawing/2014/main" id="{E4F6C1A0-35CB-6B4E-3ABB-6398AEE8BD82}"/>
                  </a:ext>
                </a:extLst>
              </p:cNvPr>
              <p:cNvSpPr>
                <a:spLocks noChangeShapeType="1"/>
              </p:cNvSpPr>
              <p:nvPr/>
            </p:nvSpPr>
            <p:spPr bwMode="auto">
              <a:xfrm>
                <a:off x="6741"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6" name="Line 118">
                <a:extLst>
                  <a:ext uri="{FF2B5EF4-FFF2-40B4-BE49-F238E27FC236}">
                    <a16:creationId xmlns:a16="http://schemas.microsoft.com/office/drawing/2014/main" id="{74E60028-F897-06FF-E2DD-F3D632A74878}"/>
                  </a:ext>
                </a:extLst>
              </p:cNvPr>
              <p:cNvSpPr>
                <a:spLocks noChangeShapeType="1"/>
              </p:cNvSpPr>
              <p:nvPr/>
            </p:nvSpPr>
            <p:spPr bwMode="auto">
              <a:xfrm>
                <a:off x="6809"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7" name="Line 119">
                <a:extLst>
                  <a:ext uri="{FF2B5EF4-FFF2-40B4-BE49-F238E27FC236}">
                    <a16:creationId xmlns:a16="http://schemas.microsoft.com/office/drawing/2014/main" id="{0AB4D125-4393-AAF9-D7A5-D36649F7BE50}"/>
                  </a:ext>
                </a:extLst>
              </p:cNvPr>
              <p:cNvSpPr>
                <a:spLocks noChangeShapeType="1"/>
              </p:cNvSpPr>
              <p:nvPr/>
            </p:nvSpPr>
            <p:spPr bwMode="auto">
              <a:xfrm>
                <a:off x="6877"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8" name="Line 120">
                <a:extLst>
                  <a:ext uri="{FF2B5EF4-FFF2-40B4-BE49-F238E27FC236}">
                    <a16:creationId xmlns:a16="http://schemas.microsoft.com/office/drawing/2014/main" id="{E4126138-4B42-3692-9B16-4A30451DE88E}"/>
                  </a:ext>
                </a:extLst>
              </p:cNvPr>
              <p:cNvSpPr>
                <a:spLocks noChangeShapeType="1"/>
              </p:cNvSpPr>
              <p:nvPr/>
            </p:nvSpPr>
            <p:spPr bwMode="auto">
              <a:xfrm>
                <a:off x="6945"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29" name="Rectangle 121">
                <a:extLst>
                  <a:ext uri="{FF2B5EF4-FFF2-40B4-BE49-F238E27FC236}">
                    <a16:creationId xmlns:a16="http://schemas.microsoft.com/office/drawing/2014/main" id="{C22009F1-7E53-42CD-C5FE-F60E6525C6B8}"/>
                  </a:ext>
                </a:extLst>
              </p:cNvPr>
              <p:cNvSpPr>
                <a:spLocks noChangeArrowheads="1"/>
              </p:cNvSpPr>
              <p:nvPr/>
            </p:nvSpPr>
            <p:spPr bwMode="auto">
              <a:xfrm>
                <a:off x="6884"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3.75</a:t>
                </a:r>
                <a:endParaRPr lang="en-US" altLang="en-US" sz="700" b="1"/>
              </a:p>
            </p:txBody>
          </p:sp>
          <p:sp>
            <p:nvSpPr>
              <p:cNvPr id="130" name="Line 122">
                <a:extLst>
                  <a:ext uri="{FF2B5EF4-FFF2-40B4-BE49-F238E27FC236}">
                    <a16:creationId xmlns:a16="http://schemas.microsoft.com/office/drawing/2014/main" id="{DC6BCFB4-E53D-CDB9-EAF1-286CD24DE7AD}"/>
                  </a:ext>
                </a:extLst>
              </p:cNvPr>
              <p:cNvSpPr>
                <a:spLocks noChangeShapeType="1"/>
              </p:cNvSpPr>
              <p:nvPr/>
            </p:nvSpPr>
            <p:spPr bwMode="auto">
              <a:xfrm>
                <a:off x="7014"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1" name="Line 123">
                <a:extLst>
                  <a:ext uri="{FF2B5EF4-FFF2-40B4-BE49-F238E27FC236}">
                    <a16:creationId xmlns:a16="http://schemas.microsoft.com/office/drawing/2014/main" id="{055B341D-0057-4D6A-4852-95A2AA22FBFC}"/>
                  </a:ext>
                </a:extLst>
              </p:cNvPr>
              <p:cNvSpPr>
                <a:spLocks noChangeShapeType="1"/>
              </p:cNvSpPr>
              <p:nvPr/>
            </p:nvSpPr>
            <p:spPr bwMode="auto">
              <a:xfrm>
                <a:off x="7082"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2" name="Line 124">
                <a:extLst>
                  <a:ext uri="{FF2B5EF4-FFF2-40B4-BE49-F238E27FC236}">
                    <a16:creationId xmlns:a16="http://schemas.microsoft.com/office/drawing/2014/main" id="{3FB05B02-1F24-C97C-C2F6-686665A723B0}"/>
                  </a:ext>
                </a:extLst>
              </p:cNvPr>
              <p:cNvSpPr>
                <a:spLocks noChangeShapeType="1"/>
              </p:cNvSpPr>
              <p:nvPr/>
            </p:nvSpPr>
            <p:spPr bwMode="auto">
              <a:xfrm>
                <a:off x="7150"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3" name="Line 125">
                <a:extLst>
                  <a:ext uri="{FF2B5EF4-FFF2-40B4-BE49-F238E27FC236}">
                    <a16:creationId xmlns:a16="http://schemas.microsoft.com/office/drawing/2014/main" id="{B7069B9D-5EEF-B5D7-E6ED-E2EC3D0CD171}"/>
                  </a:ext>
                </a:extLst>
              </p:cNvPr>
              <p:cNvSpPr>
                <a:spLocks noChangeShapeType="1"/>
              </p:cNvSpPr>
              <p:nvPr/>
            </p:nvSpPr>
            <p:spPr bwMode="auto">
              <a:xfrm>
                <a:off x="7218" y="3722"/>
                <a:ext cx="0" cy="13"/>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4" name="Line 126">
                <a:extLst>
                  <a:ext uri="{FF2B5EF4-FFF2-40B4-BE49-F238E27FC236}">
                    <a16:creationId xmlns:a16="http://schemas.microsoft.com/office/drawing/2014/main" id="{B05F58AA-C12F-7BD3-DAAC-6870F8F73945}"/>
                  </a:ext>
                </a:extLst>
              </p:cNvPr>
              <p:cNvSpPr>
                <a:spLocks noChangeShapeType="1"/>
              </p:cNvSpPr>
              <p:nvPr/>
            </p:nvSpPr>
            <p:spPr bwMode="auto">
              <a:xfrm>
                <a:off x="7287"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5" name="Line 127">
                <a:extLst>
                  <a:ext uri="{FF2B5EF4-FFF2-40B4-BE49-F238E27FC236}">
                    <a16:creationId xmlns:a16="http://schemas.microsoft.com/office/drawing/2014/main" id="{2D9C11B2-16E0-61FB-2F1E-9CB22ED955C2}"/>
                  </a:ext>
                </a:extLst>
              </p:cNvPr>
              <p:cNvSpPr>
                <a:spLocks noChangeShapeType="1"/>
              </p:cNvSpPr>
              <p:nvPr/>
            </p:nvSpPr>
            <p:spPr bwMode="auto">
              <a:xfrm>
                <a:off x="7289" y="3722"/>
                <a:ext cx="0" cy="21"/>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6" name="Rectangle 128">
                <a:extLst>
                  <a:ext uri="{FF2B5EF4-FFF2-40B4-BE49-F238E27FC236}">
                    <a16:creationId xmlns:a16="http://schemas.microsoft.com/office/drawing/2014/main" id="{2E4438C1-994C-DFBF-1A93-DE8A2B697061}"/>
                  </a:ext>
                </a:extLst>
              </p:cNvPr>
              <p:cNvSpPr>
                <a:spLocks noChangeArrowheads="1"/>
              </p:cNvSpPr>
              <p:nvPr/>
            </p:nvSpPr>
            <p:spPr bwMode="auto">
              <a:xfrm>
                <a:off x="7227" y="3743"/>
                <a:ext cx="192"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1</a:t>
                </a:r>
                <a:endParaRPr lang="en-US" altLang="en-US" sz="700" b="1"/>
              </a:p>
            </p:txBody>
          </p:sp>
          <p:sp>
            <p:nvSpPr>
              <p:cNvPr id="137" name="Line 129">
                <a:extLst>
                  <a:ext uri="{FF2B5EF4-FFF2-40B4-BE49-F238E27FC236}">
                    <a16:creationId xmlns:a16="http://schemas.microsoft.com/office/drawing/2014/main" id="{7D6DBB07-953D-FF34-C7B5-7569B8134CAE}"/>
                  </a:ext>
                </a:extLst>
              </p:cNvPr>
              <p:cNvSpPr>
                <a:spLocks noChangeShapeType="1"/>
              </p:cNvSpPr>
              <p:nvPr/>
            </p:nvSpPr>
            <p:spPr bwMode="auto">
              <a:xfrm>
                <a:off x="449" y="1669"/>
                <a:ext cx="0" cy="2036"/>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8" name="Line 130">
                <a:extLst>
                  <a:ext uri="{FF2B5EF4-FFF2-40B4-BE49-F238E27FC236}">
                    <a16:creationId xmlns:a16="http://schemas.microsoft.com/office/drawing/2014/main" id="{D6523B37-BD31-8E62-C122-03DE77FBA3CD}"/>
                  </a:ext>
                </a:extLst>
              </p:cNvPr>
              <p:cNvSpPr>
                <a:spLocks noChangeShapeType="1"/>
              </p:cNvSpPr>
              <p:nvPr/>
            </p:nvSpPr>
            <p:spPr bwMode="auto">
              <a:xfrm flipH="1">
                <a:off x="429" y="3705"/>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39" name="Line 132">
                <a:extLst>
                  <a:ext uri="{FF2B5EF4-FFF2-40B4-BE49-F238E27FC236}">
                    <a16:creationId xmlns:a16="http://schemas.microsoft.com/office/drawing/2014/main" id="{D7D84670-019C-5A48-D143-8BBBA590D869}"/>
                  </a:ext>
                </a:extLst>
              </p:cNvPr>
              <p:cNvSpPr>
                <a:spLocks noChangeShapeType="1"/>
              </p:cNvSpPr>
              <p:nvPr/>
            </p:nvSpPr>
            <p:spPr bwMode="auto">
              <a:xfrm flipH="1">
                <a:off x="429" y="3705"/>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0" name="Line 133">
                <a:extLst>
                  <a:ext uri="{FF2B5EF4-FFF2-40B4-BE49-F238E27FC236}">
                    <a16:creationId xmlns:a16="http://schemas.microsoft.com/office/drawing/2014/main" id="{697E57E1-E3A6-4258-5217-DFE6FE9529D9}"/>
                  </a:ext>
                </a:extLst>
              </p:cNvPr>
              <p:cNvSpPr>
                <a:spLocks noChangeShapeType="1"/>
              </p:cNvSpPr>
              <p:nvPr/>
            </p:nvSpPr>
            <p:spPr bwMode="auto">
              <a:xfrm flipH="1">
                <a:off x="437" y="367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1" name="Line 134">
                <a:extLst>
                  <a:ext uri="{FF2B5EF4-FFF2-40B4-BE49-F238E27FC236}">
                    <a16:creationId xmlns:a16="http://schemas.microsoft.com/office/drawing/2014/main" id="{37708EBA-92A1-A0FE-92B8-9025A87BE338}"/>
                  </a:ext>
                </a:extLst>
              </p:cNvPr>
              <p:cNvSpPr>
                <a:spLocks noChangeShapeType="1"/>
              </p:cNvSpPr>
              <p:nvPr/>
            </p:nvSpPr>
            <p:spPr bwMode="auto">
              <a:xfrm flipH="1">
                <a:off x="437" y="3638"/>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2" name="Line 135">
                <a:extLst>
                  <a:ext uri="{FF2B5EF4-FFF2-40B4-BE49-F238E27FC236}">
                    <a16:creationId xmlns:a16="http://schemas.microsoft.com/office/drawing/2014/main" id="{ADD1465D-EE75-8BA0-489E-29AD69D87410}"/>
                  </a:ext>
                </a:extLst>
              </p:cNvPr>
              <p:cNvSpPr>
                <a:spLocks noChangeShapeType="1"/>
              </p:cNvSpPr>
              <p:nvPr/>
            </p:nvSpPr>
            <p:spPr bwMode="auto">
              <a:xfrm flipH="1">
                <a:off x="437" y="360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3" name="Line 136">
                <a:extLst>
                  <a:ext uri="{FF2B5EF4-FFF2-40B4-BE49-F238E27FC236}">
                    <a16:creationId xmlns:a16="http://schemas.microsoft.com/office/drawing/2014/main" id="{7D279258-90A4-DF1E-C3DA-D56B83AE96B9}"/>
                  </a:ext>
                </a:extLst>
              </p:cNvPr>
              <p:cNvSpPr>
                <a:spLocks noChangeShapeType="1"/>
              </p:cNvSpPr>
              <p:nvPr/>
            </p:nvSpPr>
            <p:spPr bwMode="auto">
              <a:xfrm flipH="1">
                <a:off x="437" y="357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4" name="Line 137">
                <a:extLst>
                  <a:ext uri="{FF2B5EF4-FFF2-40B4-BE49-F238E27FC236}">
                    <a16:creationId xmlns:a16="http://schemas.microsoft.com/office/drawing/2014/main" id="{3575C42D-4915-0B4F-71F4-0852F0CA505B}"/>
                  </a:ext>
                </a:extLst>
              </p:cNvPr>
              <p:cNvSpPr>
                <a:spLocks noChangeShapeType="1"/>
              </p:cNvSpPr>
              <p:nvPr/>
            </p:nvSpPr>
            <p:spPr bwMode="auto">
              <a:xfrm flipH="1">
                <a:off x="429" y="3536"/>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5" name="Line 139">
                <a:extLst>
                  <a:ext uri="{FF2B5EF4-FFF2-40B4-BE49-F238E27FC236}">
                    <a16:creationId xmlns:a16="http://schemas.microsoft.com/office/drawing/2014/main" id="{5F7B5872-E84C-8491-A93F-27482CCE55DE}"/>
                  </a:ext>
                </a:extLst>
              </p:cNvPr>
              <p:cNvSpPr>
                <a:spLocks noChangeShapeType="1"/>
              </p:cNvSpPr>
              <p:nvPr/>
            </p:nvSpPr>
            <p:spPr bwMode="auto">
              <a:xfrm flipH="1">
                <a:off x="437" y="350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6" name="Line 140">
                <a:extLst>
                  <a:ext uri="{FF2B5EF4-FFF2-40B4-BE49-F238E27FC236}">
                    <a16:creationId xmlns:a16="http://schemas.microsoft.com/office/drawing/2014/main" id="{8329C61F-AFEC-2BB0-86DA-2ACD6A077753}"/>
                  </a:ext>
                </a:extLst>
              </p:cNvPr>
              <p:cNvSpPr>
                <a:spLocks noChangeShapeType="1"/>
              </p:cNvSpPr>
              <p:nvPr/>
            </p:nvSpPr>
            <p:spPr bwMode="auto">
              <a:xfrm flipH="1">
                <a:off x="437" y="3468"/>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7" name="Line 141">
                <a:extLst>
                  <a:ext uri="{FF2B5EF4-FFF2-40B4-BE49-F238E27FC236}">
                    <a16:creationId xmlns:a16="http://schemas.microsoft.com/office/drawing/2014/main" id="{524CE05E-4CA9-27F7-B0D1-686FDCD5EF51}"/>
                  </a:ext>
                </a:extLst>
              </p:cNvPr>
              <p:cNvSpPr>
                <a:spLocks noChangeShapeType="1"/>
              </p:cNvSpPr>
              <p:nvPr/>
            </p:nvSpPr>
            <p:spPr bwMode="auto">
              <a:xfrm flipH="1">
                <a:off x="437" y="343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8" name="Line 142">
                <a:extLst>
                  <a:ext uri="{FF2B5EF4-FFF2-40B4-BE49-F238E27FC236}">
                    <a16:creationId xmlns:a16="http://schemas.microsoft.com/office/drawing/2014/main" id="{2C963C4A-2705-E5A5-716B-A07F975DCF68}"/>
                  </a:ext>
                </a:extLst>
              </p:cNvPr>
              <p:cNvSpPr>
                <a:spLocks noChangeShapeType="1"/>
              </p:cNvSpPr>
              <p:nvPr/>
            </p:nvSpPr>
            <p:spPr bwMode="auto">
              <a:xfrm flipH="1">
                <a:off x="437" y="340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49" name="Line 143">
                <a:extLst>
                  <a:ext uri="{FF2B5EF4-FFF2-40B4-BE49-F238E27FC236}">
                    <a16:creationId xmlns:a16="http://schemas.microsoft.com/office/drawing/2014/main" id="{0A64F00F-7C1F-BD5E-32BB-6EBB9628AB9D}"/>
                  </a:ext>
                </a:extLst>
              </p:cNvPr>
              <p:cNvSpPr>
                <a:spLocks noChangeShapeType="1"/>
              </p:cNvSpPr>
              <p:nvPr/>
            </p:nvSpPr>
            <p:spPr bwMode="auto">
              <a:xfrm flipH="1">
                <a:off x="429" y="3366"/>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0" name="Rectangle 144">
                <a:extLst>
                  <a:ext uri="{FF2B5EF4-FFF2-40B4-BE49-F238E27FC236}">
                    <a16:creationId xmlns:a16="http://schemas.microsoft.com/office/drawing/2014/main" id="{F6F2256B-ABB1-72D1-BED4-C503F671F1FD}"/>
                  </a:ext>
                </a:extLst>
              </p:cNvPr>
              <p:cNvSpPr>
                <a:spLocks noChangeArrowheads="1"/>
              </p:cNvSpPr>
              <p:nvPr/>
            </p:nvSpPr>
            <p:spPr bwMode="auto">
              <a:xfrm>
                <a:off x="392" y="3338"/>
                <a:ext cx="43"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0</a:t>
                </a:r>
                <a:endParaRPr lang="en-US" altLang="en-US" sz="700" b="1"/>
              </a:p>
            </p:txBody>
          </p:sp>
          <p:sp>
            <p:nvSpPr>
              <p:cNvPr id="151" name="Line 145">
                <a:extLst>
                  <a:ext uri="{FF2B5EF4-FFF2-40B4-BE49-F238E27FC236}">
                    <a16:creationId xmlns:a16="http://schemas.microsoft.com/office/drawing/2014/main" id="{E7FCDED5-8619-0371-7248-0129FF622E20}"/>
                  </a:ext>
                </a:extLst>
              </p:cNvPr>
              <p:cNvSpPr>
                <a:spLocks noChangeShapeType="1"/>
              </p:cNvSpPr>
              <p:nvPr/>
            </p:nvSpPr>
            <p:spPr bwMode="auto">
              <a:xfrm flipH="1">
                <a:off x="437" y="333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2" name="Line 146">
                <a:extLst>
                  <a:ext uri="{FF2B5EF4-FFF2-40B4-BE49-F238E27FC236}">
                    <a16:creationId xmlns:a16="http://schemas.microsoft.com/office/drawing/2014/main" id="{65D9E780-ADE6-EFFE-EEF8-740D2B61DAFC}"/>
                  </a:ext>
                </a:extLst>
              </p:cNvPr>
              <p:cNvSpPr>
                <a:spLocks noChangeShapeType="1"/>
              </p:cNvSpPr>
              <p:nvPr/>
            </p:nvSpPr>
            <p:spPr bwMode="auto">
              <a:xfrm flipH="1">
                <a:off x="437" y="3298"/>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3" name="Line 147">
                <a:extLst>
                  <a:ext uri="{FF2B5EF4-FFF2-40B4-BE49-F238E27FC236}">
                    <a16:creationId xmlns:a16="http://schemas.microsoft.com/office/drawing/2014/main" id="{A6EFD1F4-81F3-5433-A050-83F25D30A864}"/>
                  </a:ext>
                </a:extLst>
              </p:cNvPr>
              <p:cNvSpPr>
                <a:spLocks noChangeShapeType="1"/>
              </p:cNvSpPr>
              <p:nvPr/>
            </p:nvSpPr>
            <p:spPr bwMode="auto">
              <a:xfrm flipH="1">
                <a:off x="437" y="326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4" name="Line 148">
                <a:extLst>
                  <a:ext uri="{FF2B5EF4-FFF2-40B4-BE49-F238E27FC236}">
                    <a16:creationId xmlns:a16="http://schemas.microsoft.com/office/drawing/2014/main" id="{B9D7D362-7676-98D3-8E7F-DC4D3FE989D9}"/>
                  </a:ext>
                </a:extLst>
              </p:cNvPr>
              <p:cNvSpPr>
                <a:spLocks noChangeShapeType="1"/>
              </p:cNvSpPr>
              <p:nvPr/>
            </p:nvSpPr>
            <p:spPr bwMode="auto">
              <a:xfrm flipH="1">
                <a:off x="437" y="323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5" name="Line 149">
                <a:extLst>
                  <a:ext uri="{FF2B5EF4-FFF2-40B4-BE49-F238E27FC236}">
                    <a16:creationId xmlns:a16="http://schemas.microsoft.com/office/drawing/2014/main" id="{8DF766B0-7E05-76D1-A517-7257EEDFD0A7}"/>
                  </a:ext>
                </a:extLst>
              </p:cNvPr>
              <p:cNvSpPr>
                <a:spLocks noChangeShapeType="1"/>
              </p:cNvSpPr>
              <p:nvPr/>
            </p:nvSpPr>
            <p:spPr bwMode="auto">
              <a:xfrm flipH="1">
                <a:off x="429" y="3196"/>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6" name="Rectangle 150">
                <a:extLst>
                  <a:ext uri="{FF2B5EF4-FFF2-40B4-BE49-F238E27FC236}">
                    <a16:creationId xmlns:a16="http://schemas.microsoft.com/office/drawing/2014/main" id="{3D1C06B8-C691-947B-5250-987B9364C6B5}"/>
                  </a:ext>
                </a:extLst>
              </p:cNvPr>
              <p:cNvSpPr>
                <a:spLocks noChangeArrowheads="1"/>
              </p:cNvSpPr>
              <p:nvPr/>
            </p:nvSpPr>
            <p:spPr bwMode="auto">
              <a:xfrm>
                <a:off x="365" y="3167"/>
                <a:ext cx="85"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a:t>
                </a:r>
                <a:endParaRPr lang="en-US" altLang="en-US" sz="700" b="1"/>
              </a:p>
            </p:txBody>
          </p:sp>
          <p:sp>
            <p:nvSpPr>
              <p:cNvPr id="157" name="Line 151">
                <a:extLst>
                  <a:ext uri="{FF2B5EF4-FFF2-40B4-BE49-F238E27FC236}">
                    <a16:creationId xmlns:a16="http://schemas.microsoft.com/office/drawing/2014/main" id="{E5673438-F92E-04BF-33B3-879FB1FABB2B}"/>
                  </a:ext>
                </a:extLst>
              </p:cNvPr>
              <p:cNvSpPr>
                <a:spLocks noChangeShapeType="1"/>
              </p:cNvSpPr>
              <p:nvPr/>
            </p:nvSpPr>
            <p:spPr bwMode="auto">
              <a:xfrm flipH="1">
                <a:off x="437" y="316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8" name="Line 152">
                <a:extLst>
                  <a:ext uri="{FF2B5EF4-FFF2-40B4-BE49-F238E27FC236}">
                    <a16:creationId xmlns:a16="http://schemas.microsoft.com/office/drawing/2014/main" id="{7BDC1F2E-DC76-8D45-75A5-3160D20648C9}"/>
                  </a:ext>
                </a:extLst>
              </p:cNvPr>
              <p:cNvSpPr>
                <a:spLocks noChangeShapeType="1"/>
              </p:cNvSpPr>
              <p:nvPr/>
            </p:nvSpPr>
            <p:spPr bwMode="auto">
              <a:xfrm flipH="1">
                <a:off x="437" y="3128"/>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59" name="Line 153">
                <a:extLst>
                  <a:ext uri="{FF2B5EF4-FFF2-40B4-BE49-F238E27FC236}">
                    <a16:creationId xmlns:a16="http://schemas.microsoft.com/office/drawing/2014/main" id="{91905CA8-9E54-B864-1717-0F51F36F3AAB}"/>
                  </a:ext>
                </a:extLst>
              </p:cNvPr>
              <p:cNvSpPr>
                <a:spLocks noChangeShapeType="1"/>
              </p:cNvSpPr>
              <p:nvPr/>
            </p:nvSpPr>
            <p:spPr bwMode="auto">
              <a:xfrm flipH="1">
                <a:off x="437" y="309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0" name="Line 154">
                <a:extLst>
                  <a:ext uri="{FF2B5EF4-FFF2-40B4-BE49-F238E27FC236}">
                    <a16:creationId xmlns:a16="http://schemas.microsoft.com/office/drawing/2014/main" id="{ADEB8A9D-0E79-0C20-9709-F573C1D79A24}"/>
                  </a:ext>
                </a:extLst>
              </p:cNvPr>
              <p:cNvSpPr>
                <a:spLocks noChangeShapeType="1"/>
              </p:cNvSpPr>
              <p:nvPr/>
            </p:nvSpPr>
            <p:spPr bwMode="auto">
              <a:xfrm flipH="1">
                <a:off x="437" y="306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1" name="Line 155">
                <a:extLst>
                  <a:ext uri="{FF2B5EF4-FFF2-40B4-BE49-F238E27FC236}">
                    <a16:creationId xmlns:a16="http://schemas.microsoft.com/office/drawing/2014/main" id="{6DBF7F7E-64C7-E7BD-F010-75CEE4BEFD05}"/>
                  </a:ext>
                </a:extLst>
              </p:cNvPr>
              <p:cNvSpPr>
                <a:spLocks noChangeShapeType="1"/>
              </p:cNvSpPr>
              <p:nvPr/>
            </p:nvSpPr>
            <p:spPr bwMode="auto">
              <a:xfrm flipH="1">
                <a:off x="429" y="302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2" name="Rectangle 156">
                <a:extLst>
                  <a:ext uri="{FF2B5EF4-FFF2-40B4-BE49-F238E27FC236}">
                    <a16:creationId xmlns:a16="http://schemas.microsoft.com/office/drawing/2014/main" id="{D74EDB91-2CA8-B4D2-DA0B-E246B383EADF}"/>
                  </a:ext>
                </a:extLst>
              </p:cNvPr>
              <p:cNvSpPr>
                <a:spLocks noChangeArrowheads="1"/>
              </p:cNvSpPr>
              <p:nvPr/>
            </p:nvSpPr>
            <p:spPr bwMode="auto">
              <a:xfrm>
                <a:off x="365" y="2995"/>
                <a:ext cx="85"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50</a:t>
                </a:r>
                <a:endParaRPr lang="en-US" altLang="en-US" sz="700" b="1"/>
              </a:p>
            </p:txBody>
          </p:sp>
          <p:sp>
            <p:nvSpPr>
              <p:cNvPr id="163" name="Line 157">
                <a:extLst>
                  <a:ext uri="{FF2B5EF4-FFF2-40B4-BE49-F238E27FC236}">
                    <a16:creationId xmlns:a16="http://schemas.microsoft.com/office/drawing/2014/main" id="{DA15DE51-FDA7-54DF-57BA-A2F78DD2A301}"/>
                  </a:ext>
                </a:extLst>
              </p:cNvPr>
              <p:cNvSpPr>
                <a:spLocks noChangeShapeType="1"/>
              </p:cNvSpPr>
              <p:nvPr/>
            </p:nvSpPr>
            <p:spPr bwMode="auto">
              <a:xfrm flipH="1">
                <a:off x="437" y="299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4" name="Line 158">
                <a:extLst>
                  <a:ext uri="{FF2B5EF4-FFF2-40B4-BE49-F238E27FC236}">
                    <a16:creationId xmlns:a16="http://schemas.microsoft.com/office/drawing/2014/main" id="{FF4D43CE-9E4C-0653-C29B-89AA857A03CE}"/>
                  </a:ext>
                </a:extLst>
              </p:cNvPr>
              <p:cNvSpPr>
                <a:spLocks noChangeShapeType="1"/>
              </p:cNvSpPr>
              <p:nvPr/>
            </p:nvSpPr>
            <p:spPr bwMode="auto">
              <a:xfrm flipH="1">
                <a:off x="437" y="2959"/>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5" name="Line 159">
                <a:extLst>
                  <a:ext uri="{FF2B5EF4-FFF2-40B4-BE49-F238E27FC236}">
                    <a16:creationId xmlns:a16="http://schemas.microsoft.com/office/drawing/2014/main" id="{0679F970-D858-8F9C-65F0-C2D8B2C3B237}"/>
                  </a:ext>
                </a:extLst>
              </p:cNvPr>
              <p:cNvSpPr>
                <a:spLocks noChangeShapeType="1"/>
              </p:cNvSpPr>
              <p:nvPr/>
            </p:nvSpPr>
            <p:spPr bwMode="auto">
              <a:xfrm flipH="1">
                <a:off x="437" y="2925"/>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6" name="Line 160">
                <a:extLst>
                  <a:ext uri="{FF2B5EF4-FFF2-40B4-BE49-F238E27FC236}">
                    <a16:creationId xmlns:a16="http://schemas.microsoft.com/office/drawing/2014/main" id="{58ECFB1C-CA89-4A9C-A6AE-6EB57A0030D5}"/>
                  </a:ext>
                </a:extLst>
              </p:cNvPr>
              <p:cNvSpPr>
                <a:spLocks noChangeShapeType="1"/>
              </p:cNvSpPr>
              <p:nvPr/>
            </p:nvSpPr>
            <p:spPr bwMode="auto">
              <a:xfrm flipH="1">
                <a:off x="437" y="289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7" name="Line 161">
                <a:extLst>
                  <a:ext uri="{FF2B5EF4-FFF2-40B4-BE49-F238E27FC236}">
                    <a16:creationId xmlns:a16="http://schemas.microsoft.com/office/drawing/2014/main" id="{D0EB406D-353A-B828-218A-E6D1C37C8200}"/>
                  </a:ext>
                </a:extLst>
              </p:cNvPr>
              <p:cNvSpPr>
                <a:spLocks noChangeShapeType="1"/>
              </p:cNvSpPr>
              <p:nvPr/>
            </p:nvSpPr>
            <p:spPr bwMode="auto">
              <a:xfrm flipH="1">
                <a:off x="429" y="285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68" name="Rectangle 162">
                <a:extLst>
                  <a:ext uri="{FF2B5EF4-FFF2-40B4-BE49-F238E27FC236}">
                    <a16:creationId xmlns:a16="http://schemas.microsoft.com/office/drawing/2014/main" id="{E8F53C2F-918B-AEB9-CE42-33448FD27225}"/>
                  </a:ext>
                </a:extLst>
              </p:cNvPr>
              <p:cNvSpPr>
                <a:spLocks noChangeArrowheads="1"/>
              </p:cNvSpPr>
              <p:nvPr/>
            </p:nvSpPr>
            <p:spPr bwMode="auto">
              <a:xfrm>
                <a:off x="365" y="2828"/>
                <a:ext cx="85"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75</a:t>
                </a:r>
                <a:endParaRPr lang="en-US" altLang="en-US" sz="700" b="1"/>
              </a:p>
            </p:txBody>
          </p:sp>
          <p:sp>
            <p:nvSpPr>
              <p:cNvPr id="169" name="Line 163">
                <a:extLst>
                  <a:ext uri="{FF2B5EF4-FFF2-40B4-BE49-F238E27FC236}">
                    <a16:creationId xmlns:a16="http://schemas.microsoft.com/office/drawing/2014/main" id="{B3A1BC66-57ED-4C15-6AA8-A6E8F5981228}"/>
                  </a:ext>
                </a:extLst>
              </p:cNvPr>
              <p:cNvSpPr>
                <a:spLocks noChangeShapeType="1"/>
              </p:cNvSpPr>
              <p:nvPr/>
            </p:nvSpPr>
            <p:spPr bwMode="auto">
              <a:xfrm flipH="1">
                <a:off x="437" y="282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0" name="Line 164">
                <a:extLst>
                  <a:ext uri="{FF2B5EF4-FFF2-40B4-BE49-F238E27FC236}">
                    <a16:creationId xmlns:a16="http://schemas.microsoft.com/office/drawing/2014/main" id="{5446FE12-F7CE-9DEF-B06A-C0B07288A30C}"/>
                  </a:ext>
                </a:extLst>
              </p:cNvPr>
              <p:cNvSpPr>
                <a:spLocks noChangeShapeType="1"/>
              </p:cNvSpPr>
              <p:nvPr/>
            </p:nvSpPr>
            <p:spPr bwMode="auto">
              <a:xfrm flipH="1">
                <a:off x="437" y="2789"/>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1" name="Line 165">
                <a:extLst>
                  <a:ext uri="{FF2B5EF4-FFF2-40B4-BE49-F238E27FC236}">
                    <a16:creationId xmlns:a16="http://schemas.microsoft.com/office/drawing/2014/main" id="{168A0AC8-707D-3978-CD4E-9343673F5776}"/>
                  </a:ext>
                </a:extLst>
              </p:cNvPr>
              <p:cNvSpPr>
                <a:spLocks noChangeShapeType="1"/>
              </p:cNvSpPr>
              <p:nvPr/>
            </p:nvSpPr>
            <p:spPr bwMode="auto">
              <a:xfrm flipH="1">
                <a:off x="437" y="2755"/>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2" name="Line 166">
                <a:extLst>
                  <a:ext uri="{FF2B5EF4-FFF2-40B4-BE49-F238E27FC236}">
                    <a16:creationId xmlns:a16="http://schemas.microsoft.com/office/drawing/2014/main" id="{0113C444-9552-392F-7CC4-E336650C18FD}"/>
                  </a:ext>
                </a:extLst>
              </p:cNvPr>
              <p:cNvSpPr>
                <a:spLocks noChangeShapeType="1"/>
              </p:cNvSpPr>
              <p:nvPr/>
            </p:nvSpPr>
            <p:spPr bwMode="auto">
              <a:xfrm flipH="1">
                <a:off x="437" y="272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3" name="Line 167">
                <a:extLst>
                  <a:ext uri="{FF2B5EF4-FFF2-40B4-BE49-F238E27FC236}">
                    <a16:creationId xmlns:a16="http://schemas.microsoft.com/office/drawing/2014/main" id="{E83D10ED-80D6-907F-CC3D-B5A2B72CB614}"/>
                  </a:ext>
                </a:extLst>
              </p:cNvPr>
              <p:cNvSpPr>
                <a:spLocks noChangeShapeType="1"/>
              </p:cNvSpPr>
              <p:nvPr/>
            </p:nvSpPr>
            <p:spPr bwMode="auto">
              <a:xfrm flipH="1">
                <a:off x="429" y="268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4" name="Rectangle 168">
                <a:extLst>
                  <a:ext uri="{FF2B5EF4-FFF2-40B4-BE49-F238E27FC236}">
                    <a16:creationId xmlns:a16="http://schemas.microsoft.com/office/drawing/2014/main" id="{B6197DFE-33F1-1A0D-D2AE-28BE1E248365}"/>
                  </a:ext>
                </a:extLst>
              </p:cNvPr>
              <p:cNvSpPr>
                <a:spLocks noChangeArrowheads="1"/>
              </p:cNvSpPr>
              <p:nvPr/>
            </p:nvSpPr>
            <p:spPr bwMode="auto">
              <a:xfrm>
                <a:off x="339" y="2656"/>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00</a:t>
                </a:r>
                <a:endParaRPr lang="en-US" altLang="en-US" sz="700" b="1"/>
              </a:p>
            </p:txBody>
          </p:sp>
          <p:sp>
            <p:nvSpPr>
              <p:cNvPr id="175" name="Line 169">
                <a:extLst>
                  <a:ext uri="{FF2B5EF4-FFF2-40B4-BE49-F238E27FC236}">
                    <a16:creationId xmlns:a16="http://schemas.microsoft.com/office/drawing/2014/main" id="{8046C2AC-70A7-E58A-5D2E-3A41E1A03183}"/>
                  </a:ext>
                </a:extLst>
              </p:cNvPr>
              <p:cNvSpPr>
                <a:spLocks noChangeShapeType="1"/>
              </p:cNvSpPr>
              <p:nvPr/>
            </p:nvSpPr>
            <p:spPr bwMode="auto">
              <a:xfrm flipH="1">
                <a:off x="437" y="265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6" name="Line 170">
                <a:extLst>
                  <a:ext uri="{FF2B5EF4-FFF2-40B4-BE49-F238E27FC236}">
                    <a16:creationId xmlns:a16="http://schemas.microsoft.com/office/drawing/2014/main" id="{FB859357-02AE-114C-31C6-EDCD2B30BCF1}"/>
                  </a:ext>
                </a:extLst>
              </p:cNvPr>
              <p:cNvSpPr>
                <a:spLocks noChangeShapeType="1"/>
              </p:cNvSpPr>
              <p:nvPr/>
            </p:nvSpPr>
            <p:spPr bwMode="auto">
              <a:xfrm flipH="1">
                <a:off x="437" y="2619"/>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7" name="Line 171">
                <a:extLst>
                  <a:ext uri="{FF2B5EF4-FFF2-40B4-BE49-F238E27FC236}">
                    <a16:creationId xmlns:a16="http://schemas.microsoft.com/office/drawing/2014/main" id="{104BAB94-BEA1-E2BF-18F6-011CAAF0A4B6}"/>
                  </a:ext>
                </a:extLst>
              </p:cNvPr>
              <p:cNvSpPr>
                <a:spLocks noChangeShapeType="1"/>
              </p:cNvSpPr>
              <p:nvPr/>
            </p:nvSpPr>
            <p:spPr bwMode="auto">
              <a:xfrm flipH="1">
                <a:off x="437" y="2585"/>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8" name="Line 172">
                <a:extLst>
                  <a:ext uri="{FF2B5EF4-FFF2-40B4-BE49-F238E27FC236}">
                    <a16:creationId xmlns:a16="http://schemas.microsoft.com/office/drawing/2014/main" id="{CFDA9257-7A83-63BF-984E-A8029FB0085F}"/>
                  </a:ext>
                </a:extLst>
              </p:cNvPr>
              <p:cNvSpPr>
                <a:spLocks noChangeShapeType="1"/>
              </p:cNvSpPr>
              <p:nvPr/>
            </p:nvSpPr>
            <p:spPr bwMode="auto">
              <a:xfrm flipH="1">
                <a:off x="437" y="255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79" name="Line 173">
                <a:extLst>
                  <a:ext uri="{FF2B5EF4-FFF2-40B4-BE49-F238E27FC236}">
                    <a16:creationId xmlns:a16="http://schemas.microsoft.com/office/drawing/2014/main" id="{C1333FAA-2C22-1C98-C603-6EDC8AA4A0E1}"/>
                  </a:ext>
                </a:extLst>
              </p:cNvPr>
              <p:cNvSpPr>
                <a:spLocks noChangeShapeType="1"/>
              </p:cNvSpPr>
              <p:nvPr/>
            </p:nvSpPr>
            <p:spPr bwMode="auto">
              <a:xfrm flipH="1">
                <a:off x="429" y="2517"/>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0" name="Rectangle 174">
                <a:extLst>
                  <a:ext uri="{FF2B5EF4-FFF2-40B4-BE49-F238E27FC236}">
                    <a16:creationId xmlns:a16="http://schemas.microsoft.com/office/drawing/2014/main" id="{BAC38961-1F3E-9696-A6F1-25912373E648}"/>
                  </a:ext>
                </a:extLst>
              </p:cNvPr>
              <p:cNvSpPr>
                <a:spLocks noChangeArrowheads="1"/>
              </p:cNvSpPr>
              <p:nvPr/>
            </p:nvSpPr>
            <p:spPr bwMode="auto">
              <a:xfrm>
                <a:off x="339" y="2489"/>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25</a:t>
                </a:r>
                <a:endParaRPr lang="en-US" altLang="en-US" sz="700" b="1"/>
              </a:p>
            </p:txBody>
          </p:sp>
          <p:sp>
            <p:nvSpPr>
              <p:cNvPr id="181" name="Line 175">
                <a:extLst>
                  <a:ext uri="{FF2B5EF4-FFF2-40B4-BE49-F238E27FC236}">
                    <a16:creationId xmlns:a16="http://schemas.microsoft.com/office/drawing/2014/main" id="{EFDE4C4A-8275-5562-9AEE-AC4E2D94613B}"/>
                  </a:ext>
                </a:extLst>
              </p:cNvPr>
              <p:cNvSpPr>
                <a:spLocks noChangeShapeType="1"/>
              </p:cNvSpPr>
              <p:nvPr/>
            </p:nvSpPr>
            <p:spPr bwMode="auto">
              <a:xfrm flipH="1">
                <a:off x="437" y="248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2" name="Line 176">
                <a:extLst>
                  <a:ext uri="{FF2B5EF4-FFF2-40B4-BE49-F238E27FC236}">
                    <a16:creationId xmlns:a16="http://schemas.microsoft.com/office/drawing/2014/main" id="{D0D28D27-8FF6-E6DE-61FE-FE5C33F434D8}"/>
                  </a:ext>
                </a:extLst>
              </p:cNvPr>
              <p:cNvSpPr>
                <a:spLocks noChangeShapeType="1"/>
              </p:cNvSpPr>
              <p:nvPr/>
            </p:nvSpPr>
            <p:spPr bwMode="auto">
              <a:xfrm flipH="1">
                <a:off x="437" y="245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3" name="Line 177">
                <a:extLst>
                  <a:ext uri="{FF2B5EF4-FFF2-40B4-BE49-F238E27FC236}">
                    <a16:creationId xmlns:a16="http://schemas.microsoft.com/office/drawing/2014/main" id="{04B0E93C-BC74-775E-CB34-C49727BD4E47}"/>
                  </a:ext>
                </a:extLst>
              </p:cNvPr>
              <p:cNvSpPr>
                <a:spLocks noChangeShapeType="1"/>
              </p:cNvSpPr>
              <p:nvPr/>
            </p:nvSpPr>
            <p:spPr bwMode="auto">
              <a:xfrm flipH="1">
                <a:off x="437" y="2416"/>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4" name="Line 178">
                <a:extLst>
                  <a:ext uri="{FF2B5EF4-FFF2-40B4-BE49-F238E27FC236}">
                    <a16:creationId xmlns:a16="http://schemas.microsoft.com/office/drawing/2014/main" id="{DF2884C3-E8EF-7B69-919E-FF5D8467F03C}"/>
                  </a:ext>
                </a:extLst>
              </p:cNvPr>
              <p:cNvSpPr>
                <a:spLocks noChangeShapeType="1"/>
              </p:cNvSpPr>
              <p:nvPr/>
            </p:nvSpPr>
            <p:spPr bwMode="auto">
              <a:xfrm flipH="1">
                <a:off x="437" y="238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5" name="Line 179">
                <a:extLst>
                  <a:ext uri="{FF2B5EF4-FFF2-40B4-BE49-F238E27FC236}">
                    <a16:creationId xmlns:a16="http://schemas.microsoft.com/office/drawing/2014/main" id="{EC06E21C-1F04-2DA2-F261-765B48DA5E13}"/>
                  </a:ext>
                </a:extLst>
              </p:cNvPr>
              <p:cNvSpPr>
                <a:spLocks noChangeShapeType="1"/>
              </p:cNvSpPr>
              <p:nvPr/>
            </p:nvSpPr>
            <p:spPr bwMode="auto">
              <a:xfrm flipH="1">
                <a:off x="429" y="2348"/>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6" name="Rectangle 180">
                <a:extLst>
                  <a:ext uri="{FF2B5EF4-FFF2-40B4-BE49-F238E27FC236}">
                    <a16:creationId xmlns:a16="http://schemas.microsoft.com/office/drawing/2014/main" id="{1B2FBDE4-A24B-0B7C-A4C6-2DB52A663F6D}"/>
                  </a:ext>
                </a:extLst>
              </p:cNvPr>
              <p:cNvSpPr>
                <a:spLocks noChangeArrowheads="1"/>
              </p:cNvSpPr>
              <p:nvPr/>
            </p:nvSpPr>
            <p:spPr bwMode="auto">
              <a:xfrm>
                <a:off x="339" y="2317"/>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50</a:t>
                </a:r>
                <a:endParaRPr lang="en-US" altLang="en-US" sz="700" b="1"/>
              </a:p>
            </p:txBody>
          </p:sp>
          <p:sp>
            <p:nvSpPr>
              <p:cNvPr id="187" name="Line 181">
                <a:extLst>
                  <a:ext uri="{FF2B5EF4-FFF2-40B4-BE49-F238E27FC236}">
                    <a16:creationId xmlns:a16="http://schemas.microsoft.com/office/drawing/2014/main" id="{244C561D-F809-42D2-E4A0-33B36BECA2F8}"/>
                  </a:ext>
                </a:extLst>
              </p:cNvPr>
              <p:cNvSpPr>
                <a:spLocks noChangeShapeType="1"/>
              </p:cNvSpPr>
              <p:nvPr/>
            </p:nvSpPr>
            <p:spPr bwMode="auto">
              <a:xfrm flipH="1">
                <a:off x="437" y="231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8" name="Line 182">
                <a:extLst>
                  <a:ext uri="{FF2B5EF4-FFF2-40B4-BE49-F238E27FC236}">
                    <a16:creationId xmlns:a16="http://schemas.microsoft.com/office/drawing/2014/main" id="{CD326D7C-AD1D-6CF0-69F5-FDB73E78B25B}"/>
                  </a:ext>
                </a:extLst>
              </p:cNvPr>
              <p:cNvSpPr>
                <a:spLocks noChangeShapeType="1"/>
              </p:cNvSpPr>
              <p:nvPr/>
            </p:nvSpPr>
            <p:spPr bwMode="auto">
              <a:xfrm flipH="1">
                <a:off x="437" y="228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89" name="Line 183">
                <a:extLst>
                  <a:ext uri="{FF2B5EF4-FFF2-40B4-BE49-F238E27FC236}">
                    <a16:creationId xmlns:a16="http://schemas.microsoft.com/office/drawing/2014/main" id="{C5BBE2A9-772F-7CD7-6E3C-6896C8E2BC82}"/>
                  </a:ext>
                </a:extLst>
              </p:cNvPr>
              <p:cNvSpPr>
                <a:spLocks noChangeShapeType="1"/>
              </p:cNvSpPr>
              <p:nvPr/>
            </p:nvSpPr>
            <p:spPr bwMode="auto">
              <a:xfrm flipH="1">
                <a:off x="437" y="2246"/>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0" name="Line 184">
                <a:extLst>
                  <a:ext uri="{FF2B5EF4-FFF2-40B4-BE49-F238E27FC236}">
                    <a16:creationId xmlns:a16="http://schemas.microsoft.com/office/drawing/2014/main" id="{AB4EB06A-4FA8-9E86-A8A2-1A75FD834F9A}"/>
                  </a:ext>
                </a:extLst>
              </p:cNvPr>
              <p:cNvSpPr>
                <a:spLocks noChangeShapeType="1"/>
              </p:cNvSpPr>
              <p:nvPr/>
            </p:nvSpPr>
            <p:spPr bwMode="auto">
              <a:xfrm flipH="1">
                <a:off x="437" y="221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1" name="Line 185">
                <a:extLst>
                  <a:ext uri="{FF2B5EF4-FFF2-40B4-BE49-F238E27FC236}">
                    <a16:creationId xmlns:a16="http://schemas.microsoft.com/office/drawing/2014/main" id="{480F0FE8-96D5-B03B-3917-20CF7BC9A03B}"/>
                  </a:ext>
                </a:extLst>
              </p:cNvPr>
              <p:cNvSpPr>
                <a:spLocks noChangeShapeType="1"/>
              </p:cNvSpPr>
              <p:nvPr/>
            </p:nvSpPr>
            <p:spPr bwMode="auto">
              <a:xfrm flipH="1">
                <a:off x="429" y="2178"/>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2" name="Rectangle 186">
                <a:extLst>
                  <a:ext uri="{FF2B5EF4-FFF2-40B4-BE49-F238E27FC236}">
                    <a16:creationId xmlns:a16="http://schemas.microsoft.com/office/drawing/2014/main" id="{EF3DCF91-63C4-414F-09EC-EE752737D1F3}"/>
                  </a:ext>
                </a:extLst>
              </p:cNvPr>
              <p:cNvSpPr>
                <a:spLocks noChangeArrowheads="1"/>
              </p:cNvSpPr>
              <p:nvPr/>
            </p:nvSpPr>
            <p:spPr bwMode="auto">
              <a:xfrm>
                <a:off x="339" y="2150"/>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175</a:t>
                </a:r>
                <a:endParaRPr lang="en-US" altLang="en-US" sz="700" b="1"/>
              </a:p>
            </p:txBody>
          </p:sp>
          <p:sp>
            <p:nvSpPr>
              <p:cNvPr id="193" name="Line 187">
                <a:extLst>
                  <a:ext uri="{FF2B5EF4-FFF2-40B4-BE49-F238E27FC236}">
                    <a16:creationId xmlns:a16="http://schemas.microsoft.com/office/drawing/2014/main" id="{11330061-E9AB-B906-5170-D328882F06F2}"/>
                  </a:ext>
                </a:extLst>
              </p:cNvPr>
              <p:cNvSpPr>
                <a:spLocks noChangeShapeType="1"/>
              </p:cNvSpPr>
              <p:nvPr/>
            </p:nvSpPr>
            <p:spPr bwMode="auto">
              <a:xfrm flipH="1">
                <a:off x="437" y="214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4" name="Line 188">
                <a:extLst>
                  <a:ext uri="{FF2B5EF4-FFF2-40B4-BE49-F238E27FC236}">
                    <a16:creationId xmlns:a16="http://schemas.microsoft.com/office/drawing/2014/main" id="{A3494B37-7139-0C45-7EAC-C761AE45E48E}"/>
                  </a:ext>
                </a:extLst>
              </p:cNvPr>
              <p:cNvSpPr>
                <a:spLocks noChangeShapeType="1"/>
              </p:cNvSpPr>
              <p:nvPr/>
            </p:nvSpPr>
            <p:spPr bwMode="auto">
              <a:xfrm flipH="1">
                <a:off x="437" y="2110"/>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5" name="Line 189">
                <a:extLst>
                  <a:ext uri="{FF2B5EF4-FFF2-40B4-BE49-F238E27FC236}">
                    <a16:creationId xmlns:a16="http://schemas.microsoft.com/office/drawing/2014/main" id="{4B80E6CC-DA72-6FC3-D9E7-FAAEB43C4CCB}"/>
                  </a:ext>
                </a:extLst>
              </p:cNvPr>
              <p:cNvSpPr>
                <a:spLocks noChangeShapeType="1"/>
              </p:cNvSpPr>
              <p:nvPr/>
            </p:nvSpPr>
            <p:spPr bwMode="auto">
              <a:xfrm flipH="1">
                <a:off x="437" y="2076"/>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6" name="Line 190">
                <a:extLst>
                  <a:ext uri="{FF2B5EF4-FFF2-40B4-BE49-F238E27FC236}">
                    <a16:creationId xmlns:a16="http://schemas.microsoft.com/office/drawing/2014/main" id="{FA05F118-4136-F4F8-ED5E-7891FE477E52}"/>
                  </a:ext>
                </a:extLst>
              </p:cNvPr>
              <p:cNvSpPr>
                <a:spLocks noChangeShapeType="1"/>
              </p:cNvSpPr>
              <p:nvPr/>
            </p:nvSpPr>
            <p:spPr bwMode="auto">
              <a:xfrm flipH="1">
                <a:off x="437" y="2042"/>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7" name="Line 191">
                <a:extLst>
                  <a:ext uri="{FF2B5EF4-FFF2-40B4-BE49-F238E27FC236}">
                    <a16:creationId xmlns:a16="http://schemas.microsoft.com/office/drawing/2014/main" id="{5A5FED0C-48DE-97FE-5E9F-765A2EFF5E14}"/>
                  </a:ext>
                </a:extLst>
              </p:cNvPr>
              <p:cNvSpPr>
                <a:spLocks noChangeShapeType="1"/>
              </p:cNvSpPr>
              <p:nvPr/>
            </p:nvSpPr>
            <p:spPr bwMode="auto">
              <a:xfrm flipH="1">
                <a:off x="429" y="2008"/>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198" name="Rectangle 192">
                <a:extLst>
                  <a:ext uri="{FF2B5EF4-FFF2-40B4-BE49-F238E27FC236}">
                    <a16:creationId xmlns:a16="http://schemas.microsoft.com/office/drawing/2014/main" id="{B06D8418-868C-4548-87A5-AC73FD953FC4}"/>
                  </a:ext>
                </a:extLst>
              </p:cNvPr>
              <p:cNvSpPr>
                <a:spLocks noChangeArrowheads="1"/>
              </p:cNvSpPr>
              <p:nvPr/>
            </p:nvSpPr>
            <p:spPr bwMode="auto">
              <a:xfrm>
                <a:off x="339" y="1978"/>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dirty="0">
                    <a:solidFill>
                      <a:srgbClr val="000000"/>
                    </a:solidFill>
                  </a:rPr>
                  <a:t>200</a:t>
                </a:r>
                <a:endParaRPr lang="en-US" altLang="en-US" sz="700" b="1" dirty="0"/>
              </a:p>
            </p:txBody>
          </p:sp>
          <p:sp>
            <p:nvSpPr>
              <p:cNvPr id="199" name="Line 193">
                <a:extLst>
                  <a:ext uri="{FF2B5EF4-FFF2-40B4-BE49-F238E27FC236}">
                    <a16:creationId xmlns:a16="http://schemas.microsoft.com/office/drawing/2014/main" id="{8A7DDEBD-D147-932C-B8E9-7DFD23261486}"/>
                  </a:ext>
                </a:extLst>
              </p:cNvPr>
              <p:cNvSpPr>
                <a:spLocks noChangeShapeType="1"/>
              </p:cNvSpPr>
              <p:nvPr/>
            </p:nvSpPr>
            <p:spPr bwMode="auto">
              <a:xfrm flipH="1">
                <a:off x="437" y="1974"/>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0" name="Line 194">
                <a:extLst>
                  <a:ext uri="{FF2B5EF4-FFF2-40B4-BE49-F238E27FC236}">
                    <a16:creationId xmlns:a16="http://schemas.microsoft.com/office/drawing/2014/main" id="{EC6AEFD2-F2CE-DD4E-556B-87EBDDA0DCF0}"/>
                  </a:ext>
                </a:extLst>
              </p:cNvPr>
              <p:cNvSpPr>
                <a:spLocks noChangeShapeType="1"/>
              </p:cNvSpPr>
              <p:nvPr/>
            </p:nvSpPr>
            <p:spPr bwMode="auto">
              <a:xfrm flipH="1">
                <a:off x="437" y="194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1" name="Line 195">
                <a:extLst>
                  <a:ext uri="{FF2B5EF4-FFF2-40B4-BE49-F238E27FC236}">
                    <a16:creationId xmlns:a16="http://schemas.microsoft.com/office/drawing/2014/main" id="{FFA6FAD4-0F24-76C2-0B85-A3B195343965}"/>
                  </a:ext>
                </a:extLst>
              </p:cNvPr>
              <p:cNvSpPr>
                <a:spLocks noChangeShapeType="1"/>
              </p:cNvSpPr>
              <p:nvPr/>
            </p:nvSpPr>
            <p:spPr bwMode="auto">
              <a:xfrm flipH="1">
                <a:off x="437" y="1906"/>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2" name="Line 196">
                <a:extLst>
                  <a:ext uri="{FF2B5EF4-FFF2-40B4-BE49-F238E27FC236}">
                    <a16:creationId xmlns:a16="http://schemas.microsoft.com/office/drawing/2014/main" id="{51363909-468A-CF21-93E6-F7D5BC593CE4}"/>
                  </a:ext>
                </a:extLst>
              </p:cNvPr>
              <p:cNvSpPr>
                <a:spLocks noChangeShapeType="1"/>
              </p:cNvSpPr>
              <p:nvPr/>
            </p:nvSpPr>
            <p:spPr bwMode="auto">
              <a:xfrm flipH="1">
                <a:off x="437" y="187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3" name="Line 197">
                <a:extLst>
                  <a:ext uri="{FF2B5EF4-FFF2-40B4-BE49-F238E27FC236}">
                    <a16:creationId xmlns:a16="http://schemas.microsoft.com/office/drawing/2014/main" id="{BC021EBE-9D70-A32B-FEBC-438FD409D3D4}"/>
                  </a:ext>
                </a:extLst>
              </p:cNvPr>
              <p:cNvSpPr>
                <a:spLocks noChangeShapeType="1"/>
              </p:cNvSpPr>
              <p:nvPr/>
            </p:nvSpPr>
            <p:spPr bwMode="auto">
              <a:xfrm flipH="1">
                <a:off x="429" y="1838"/>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4" name="Rectangle 198">
                <a:extLst>
                  <a:ext uri="{FF2B5EF4-FFF2-40B4-BE49-F238E27FC236}">
                    <a16:creationId xmlns:a16="http://schemas.microsoft.com/office/drawing/2014/main" id="{BBF83149-DCE4-142C-C72E-56EE9A442588}"/>
                  </a:ext>
                </a:extLst>
              </p:cNvPr>
              <p:cNvSpPr>
                <a:spLocks noChangeArrowheads="1"/>
              </p:cNvSpPr>
              <p:nvPr/>
            </p:nvSpPr>
            <p:spPr bwMode="auto">
              <a:xfrm>
                <a:off x="339" y="1811"/>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25</a:t>
                </a:r>
                <a:endParaRPr lang="en-US" altLang="en-US" sz="700" b="1"/>
              </a:p>
            </p:txBody>
          </p:sp>
          <p:sp>
            <p:nvSpPr>
              <p:cNvPr id="205" name="Line 199">
                <a:extLst>
                  <a:ext uri="{FF2B5EF4-FFF2-40B4-BE49-F238E27FC236}">
                    <a16:creationId xmlns:a16="http://schemas.microsoft.com/office/drawing/2014/main" id="{79A14D9A-7870-2F51-C50F-6C6FCDBB8B94}"/>
                  </a:ext>
                </a:extLst>
              </p:cNvPr>
              <p:cNvSpPr>
                <a:spLocks noChangeShapeType="1"/>
              </p:cNvSpPr>
              <p:nvPr/>
            </p:nvSpPr>
            <p:spPr bwMode="auto">
              <a:xfrm flipH="1">
                <a:off x="437" y="1805"/>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6" name="Line 200">
                <a:extLst>
                  <a:ext uri="{FF2B5EF4-FFF2-40B4-BE49-F238E27FC236}">
                    <a16:creationId xmlns:a16="http://schemas.microsoft.com/office/drawing/2014/main" id="{D6EDA767-1F6A-D273-2AC0-778BA29637AE}"/>
                  </a:ext>
                </a:extLst>
              </p:cNvPr>
              <p:cNvSpPr>
                <a:spLocks noChangeShapeType="1"/>
              </p:cNvSpPr>
              <p:nvPr/>
            </p:nvSpPr>
            <p:spPr bwMode="auto">
              <a:xfrm flipH="1">
                <a:off x="437" y="1771"/>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7" name="Line 201">
                <a:extLst>
                  <a:ext uri="{FF2B5EF4-FFF2-40B4-BE49-F238E27FC236}">
                    <a16:creationId xmlns:a16="http://schemas.microsoft.com/office/drawing/2014/main" id="{A6604B85-31A5-BF8E-1130-450F42C1D854}"/>
                  </a:ext>
                </a:extLst>
              </p:cNvPr>
              <p:cNvSpPr>
                <a:spLocks noChangeShapeType="1"/>
              </p:cNvSpPr>
              <p:nvPr/>
            </p:nvSpPr>
            <p:spPr bwMode="auto">
              <a:xfrm flipH="1">
                <a:off x="437" y="1737"/>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8" name="Line 202">
                <a:extLst>
                  <a:ext uri="{FF2B5EF4-FFF2-40B4-BE49-F238E27FC236}">
                    <a16:creationId xmlns:a16="http://schemas.microsoft.com/office/drawing/2014/main" id="{BE39C956-93B2-C9D8-CEE0-72E7314BB34B}"/>
                  </a:ext>
                </a:extLst>
              </p:cNvPr>
              <p:cNvSpPr>
                <a:spLocks noChangeShapeType="1"/>
              </p:cNvSpPr>
              <p:nvPr/>
            </p:nvSpPr>
            <p:spPr bwMode="auto">
              <a:xfrm flipH="1">
                <a:off x="437" y="1703"/>
                <a:ext cx="12"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09" name="Line 203">
                <a:extLst>
                  <a:ext uri="{FF2B5EF4-FFF2-40B4-BE49-F238E27FC236}">
                    <a16:creationId xmlns:a16="http://schemas.microsoft.com/office/drawing/2014/main" id="{7D5D4B54-6D53-EC87-3588-8758474F6CA3}"/>
                  </a:ext>
                </a:extLst>
              </p:cNvPr>
              <p:cNvSpPr>
                <a:spLocks noChangeShapeType="1"/>
              </p:cNvSpPr>
              <p:nvPr/>
            </p:nvSpPr>
            <p:spPr bwMode="auto">
              <a:xfrm flipH="1">
                <a:off x="429" y="1669"/>
                <a:ext cx="20"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81213" tIns="40607" rIns="81213" bIns="40607" numCol="1" anchor="t" anchorCtr="0" compatLnSpc="1">
                <a:prstTxWarp prst="textNoShape">
                  <a:avLst/>
                </a:prstTxWarp>
              </a:bodyPr>
              <a:lstStyle/>
              <a:p>
                <a:endParaRPr lang="en-US" sz="700" b="1"/>
              </a:p>
            </p:txBody>
          </p:sp>
          <p:sp>
            <p:nvSpPr>
              <p:cNvPr id="210" name="Rectangle 204">
                <a:extLst>
                  <a:ext uri="{FF2B5EF4-FFF2-40B4-BE49-F238E27FC236}">
                    <a16:creationId xmlns:a16="http://schemas.microsoft.com/office/drawing/2014/main" id="{1C45F408-0D6D-E3E4-E635-EFA7DB5B4B52}"/>
                  </a:ext>
                </a:extLst>
              </p:cNvPr>
              <p:cNvSpPr>
                <a:spLocks noChangeArrowheads="1"/>
              </p:cNvSpPr>
              <p:nvPr/>
            </p:nvSpPr>
            <p:spPr bwMode="auto">
              <a:xfrm>
                <a:off x="339" y="1640"/>
                <a:ext cx="128" cy="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250</a:t>
                </a:r>
                <a:endParaRPr lang="en-US" altLang="en-US" sz="700" b="1"/>
              </a:p>
            </p:txBody>
          </p:sp>
        </p:grpSp>
        <p:sp>
          <p:nvSpPr>
            <p:cNvPr id="8" name="Freeform 207">
              <a:extLst>
                <a:ext uri="{FF2B5EF4-FFF2-40B4-BE49-F238E27FC236}">
                  <a16:creationId xmlns:a16="http://schemas.microsoft.com/office/drawing/2014/main" id="{62382D88-F0B7-BD87-2C2D-DC8F24C8676E}"/>
                </a:ext>
              </a:extLst>
            </p:cNvPr>
            <p:cNvSpPr>
              <a:spLocks/>
            </p:cNvSpPr>
            <p:nvPr/>
          </p:nvSpPr>
          <p:spPr bwMode="auto">
            <a:xfrm>
              <a:off x="1907079" y="3133761"/>
              <a:ext cx="6999820" cy="1265159"/>
            </a:xfrm>
            <a:custGeom>
              <a:avLst/>
              <a:gdLst>
                <a:gd name="T0" fmla="*/ 105 w 6823"/>
                <a:gd name="T1" fmla="*/ 1398 h 1408"/>
                <a:gd name="T2" fmla="*/ 214 w 6823"/>
                <a:gd name="T3" fmla="*/ 1398 h 1408"/>
                <a:gd name="T4" fmla="*/ 323 w 6823"/>
                <a:gd name="T5" fmla="*/ 1398 h 1408"/>
                <a:gd name="T6" fmla="*/ 432 w 6823"/>
                <a:gd name="T7" fmla="*/ 1398 h 1408"/>
                <a:gd name="T8" fmla="*/ 541 w 6823"/>
                <a:gd name="T9" fmla="*/ 1398 h 1408"/>
                <a:gd name="T10" fmla="*/ 650 w 6823"/>
                <a:gd name="T11" fmla="*/ 1398 h 1408"/>
                <a:gd name="T12" fmla="*/ 759 w 6823"/>
                <a:gd name="T13" fmla="*/ 1398 h 1408"/>
                <a:gd name="T14" fmla="*/ 869 w 6823"/>
                <a:gd name="T15" fmla="*/ 1400 h 1408"/>
                <a:gd name="T16" fmla="*/ 978 w 6823"/>
                <a:gd name="T17" fmla="*/ 1403 h 1408"/>
                <a:gd name="T18" fmla="*/ 1087 w 6823"/>
                <a:gd name="T19" fmla="*/ 1396 h 1408"/>
                <a:gd name="T20" fmla="*/ 1187 w 6823"/>
                <a:gd name="T21" fmla="*/ 1398 h 1408"/>
                <a:gd name="T22" fmla="*/ 1296 w 6823"/>
                <a:gd name="T23" fmla="*/ 1398 h 1408"/>
                <a:gd name="T24" fmla="*/ 1405 w 6823"/>
                <a:gd name="T25" fmla="*/ 1398 h 1408"/>
                <a:gd name="T26" fmla="*/ 1514 w 6823"/>
                <a:gd name="T27" fmla="*/ 1397 h 1408"/>
                <a:gd name="T28" fmla="*/ 1624 w 6823"/>
                <a:gd name="T29" fmla="*/ 1396 h 1408"/>
                <a:gd name="T30" fmla="*/ 1733 w 6823"/>
                <a:gd name="T31" fmla="*/ 1396 h 1408"/>
                <a:gd name="T32" fmla="*/ 1842 w 6823"/>
                <a:gd name="T33" fmla="*/ 1397 h 1408"/>
                <a:gd name="T34" fmla="*/ 1951 w 6823"/>
                <a:gd name="T35" fmla="*/ 1397 h 1408"/>
                <a:gd name="T36" fmla="*/ 2060 w 6823"/>
                <a:gd name="T37" fmla="*/ 1398 h 1408"/>
                <a:gd name="T38" fmla="*/ 2170 w 6823"/>
                <a:gd name="T39" fmla="*/ 1398 h 1408"/>
                <a:gd name="T40" fmla="*/ 2279 w 6823"/>
                <a:gd name="T41" fmla="*/ 1398 h 1408"/>
                <a:gd name="T42" fmla="*/ 2388 w 6823"/>
                <a:gd name="T43" fmla="*/ 1398 h 1408"/>
                <a:gd name="T44" fmla="*/ 2497 w 6823"/>
                <a:gd name="T45" fmla="*/ 1399 h 1408"/>
                <a:gd name="T46" fmla="*/ 2606 w 6823"/>
                <a:gd name="T47" fmla="*/ 1399 h 1408"/>
                <a:gd name="T48" fmla="*/ 2715 w 6823"/>
                <a:gd name="T49" fmla="*/ 1399 h 1408"/>
                <a:gd name="T50" fmla="*/ 2824 w 6823"/>
                <a:gd name="T51" fmla="*/ 1399 h 1408"/>
                <a:gd name="T52" fmla="*/ 2934 w 6823"/>
                <a:gd name="T53" fmla="*/ 1399 h 1408"/>
                <a:gd name="T54" fmla="*/ 3043 w 6823"/>
                <a:gd name="T55" fmla="*/ 1399 h 1408"/>
                <a:gd name="T56" fmla="*/ 3152 w 6823"/>
                <a:gd name="T57" fmla="*/ 1399 h 1408"/>
                <a:gd name="T58" fmla="*/ 3261 w 6823"/>
                <a:gd name="T59" fmla="*/ 1399 h 1408"/>
                <a:gd name="T60" fmla="*/ 3370 w 6823"/>
                <a:gd name="T61" fmla="*/ 1397 h 1408"/>
                <a:gd name="T62" fmla="*/ 3479 w 6823"/>
                <a:gd name="T63" fmla="*/ 1398 h 1408"/>
                <a:gd name="T64" fmla="*/ 3588 w 6823"/>
                <a:gd name="T65" fmla="*/ 1398 h 1408"/>
                <a:gd name="T66" fmla="*/ 3698 w 6823"/>
                <a:gd name="T67" fmla="*/ 1398 h 1408"/>
                <a:gd name="T68" fmla="*/ 3807 w 6823"/>
                <a:gd name="T69" fmla="*/ 1398 h 1408"/>
                <a:gd name="T70" fmla="*/ 3916 w 6823"/>
                <a:gd name="T71" fmla="*/ 1398 h 1408"/>
                <a:gd name="T72" fmla="*/ 4025 w 6823"/>
                <a:gd name="T73" fmla="*/ 1398 h 1408"/>
                <a:gd name="T74" fmla="*/ 4134 w 6823"/>
                <a:gd name="T75" fmla="*/ 1398 h 1408"/>
                <a:gd name="T76" fmla="*/ 4244 w 6823"/>
                <a:gd name="T77" fmla="*/ 1398 h 1408"/>
                <a:gd name="T78" fmla="*/ 4353 w 6823"/>
                <a:gd name="T79" fmla="*/ 1397 h 1408"/>
                <a:gd name="T80" fmla="*/ 4462 w 6823"/>
                <a:gd name="T81" fmla="*/ 1397 h 1408"/>
                <a:gd name="T82" fmla="*/ 4571 w 6823"/>
                <a:gd name="T83" fmla="*/ 1397 h 1408"/>
                <a:gd name="T84" fmla="*/ 4680 w 6823"/>
                <a:gd name="T85" fmla="*/ 1396 h 1408"/>
                <a:gd name="T86" fmla="*/ 4789 w 6823"/>
                <a:gd name="T87" fmla="*/ 1396 h 1408"/>
                <a:gd name="T88" fmla="*/ 4899 w 6823"/>
                <a:gd name="T89" fmla="*/ 1395 h 1408"/>
                <a:gd name="T90" fmla="*/ 4999 w 6823"/>
                <a:gd name="T91" fmla="*/ 963 h 1408"/>
                <a:gd name="T92" fmla="*/ 5071 w 6823"/>
                <a:gd name="T93" fmla="*/ 1391 h 1408"/>
                <a:gd name="T94" fmla="*/ 5181 w 6823"/>
                <a:gd name="T95" fmla="*/ 1391 h 1408"/>
                <a:gd name="T96" fmla="*/ 5290 w 6823"/>
                <a:gd name="T97" fmla="*/ 1386 h 1408"/>
                <a:gd name="T98" fmla="*/ 5399 w 6823"/>
                <a:gd name="T99" fmla="*/ 1388 h 1408"/>
                <a:gd name="T100" fmla="*/ 5508 w 6823"/>
                <a:gd name="T101" fmla="*/ 1396 h 1408"/>
                <a:gd name="T102" fmla="*/ 5617 w 6823"/>
                <a:gd name="T103" fmla="*/ 1399 h 1408"/>
                <a:gd name="T104" fmla="*/ 5726 w 6823"/>
                <a:gd name="T105" fmla="*/ 1399 h 1408"/>
                <a:gd name="T106" fmla="*/ 5835 w 6823"/>
                <a:gd name="T107" fmla="*/ 1399 h 1408"/>
                <a:gd name="T108" fmla="*/ 5945 w 6823"/>
                <a:gd name="T109" fmla="*/ 1400 h 1408"/>
                <a:gd name="T110" fmla="*/ 6054 w 6823"/>
                <a:gd name="T111" fmla="*/ 1400 h 1408"/>
                <a:gd name="T112" fmla="*/ 6163 w 6823"/>
                <a:gd name="T113" fmla="*/ 1399 h 1408"/>
                <a:gd name="T114" fmla="*/ 6272 w 6823"/>
                <a:gd name="T115" fmla="*/ 1400 h 1408"/>
                <a:gd name="T116" fmla="*/ 6381 w 6823"/>
                <a:gd name="T117" fmla="*/ 1400 h 1408"/>
                <a:gd name="T118" fmla="*/ 6491 w 6823"/>
                <a:gd name="T119" fmla="*/ 1400 h 1408"/>
                <a:gd name="T120" fmla="*/ 6600 w 6823"/>
                <a:gd name="T121" fmla="*/ 1400 h 1408"/>
                <a:gd name="T122" fmla="*/ 6709 w 6823"/>
                <a:gd name="T123" fmla="*/ 1399 h 1408"/>
                <a:gd name="T124" fmla="*/ 6818 w 6823"/>
                <a:gd name="T125" fmla="*/ 1399 h 140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 ang="0">
                  <a:pos x="T120" y="T121"/>
                </a:cxn>
                <a:cxn ang="0">
                  <a:pos x="T122" y="T123"/>
                </a:cxn>
                <a:cxn ang="0">
                  <a:pos x="T124" y="T125"/>
                </a:cxn>
              </a:cxnLst>
              <a:rect l="0" t="0" r="r" b="b"/>
              <a:pathLst>
                <a:path w="6823" h="1408">
                  <a:moveTo>
                    <a:pt x="0" y="1399"/>
                  </a:moveTo>
                  <a:lnTo>
                    <a:pt x="4" y="1399"/>
                  </a:lnTo>
                  <a:lnTo>
                    <a:pt x="9" y="1399"/>
                  </a:lnTo>
                  <a:lnTo>
                    <a:pt x="13" y="1399"/>
                  </a:lnTo>
                  <a:lnTo>
                    <a:pt x="18" y="1399"/>
                  </a:lnTo>
                  <a:lnTo>
                    <a:pt x="22" y="1398"/>
                  </a:lnTo>
                  <a:lnTo>
                    <a:pt x="27" y="1399"/>
                  </a:lnTo>
                  <a:lnTo>
                    <a:pt x="32" y="1399"/>
                  </a:lnTo>
                  <a:lnTo>
                    <a:pt x="36" y="1399"/>
                  </a:lnTo>
                  <a:lnTo>
                    <a:pt x="41" y="1399"/>
                  </a:lnTo>
                  <a:lnTo>
                    <a:pt x="45" y="1399"/>
                  </a:lnTo>
                  <a:lnTo>
                    <a:pt x="50" y="1398"/>
                  </a:lnTo>
                  <a:lnTo>
                    <a:pt x="54" y="1399"/>
                  </a:lnTo>
                  <a:lnTo>
                    <a:pt x="59" y="1398"/>
                  </a:lnTo>
                  <a:lnTo>
                    <a:pt x="64" y="1399"/>
                  </a:lnTo>
                  <a:lnTo>
                    <a:pt x="68" y="1399"/>
                  </a:lnTo>
                  <a:lnTo>
                    <a:pt x="73" y="1399"/>
                  </a:lnTo>
                  <a:lnTo>
                    <a:pt x="77" y="1398"/>
                  </a:lnTo>
                  <a:lnTo>
                    <a:pt x="82" y="1399"/>
                  </a:lnTo>
                  <a:lnTo>
                    <a:pt x="86" y="1398"/>
                  </a:lnTo>
                  <a:lnTo>
                    <a:pt x="91" y="1398"/>
                  </a:lnTo>
                  <a:lnTo>
                    <a:pt x="95" y="1399"/>
                  </a:lnTo>
                  <a:lnTo>
                    <a:pt x="100" y="1399"/>
                  </a:lnTo>
                  <a:lnTo>
                    <a:pt x="105" y="1398"/>
                  </a:lnTo>
                  <a:lnTo>
                    <a:pt x="109" y="1399"/>
                  </a:lnTo>
                  <a:lnTo>
                    <a:pt x="114" y="1398"/>
                  </a:lnTo>
                  <a:lnTo>
                    <a:pt x="118" y="1399"/>
                  </a:lnTo>
                  <a:lnTo>
                    <a:pt x="123" y="1398"/>
                  </a:lnTo>
                  <a:lnTo>
                    <a:pt x="127" y="1398"/>
                  </a:lnTo>
                  <a:lnTo>
                    <a:pt x="132" y="1398"/>
                  </a:lnTo>
                  <a:lnTo>
                    <a:pt x="136" y="1398"/>
                  </a:lnTo>
                  <a:lnTo>
                    <a:pt x="141" y="1399"/>
                  </a:lnTo>
                  <a:lnTo>
                    <a:pt x="145" y="1398"/>
                  </a:lnTo>
                  <a:lnTo>
                    <a:pt x="150" y="1398"/>
                  </a:lnTo>
                  <a:lnTo>
                    <a:pt x="155" y="1398"/>
                  </a:lnTo>
                  <a:lnTo>
                    <a:pt x="159" y="1398"/>
                  </a:lnTo>
                  <a:lnTo>
                    <a:pt x="164" y="1398"/>
                  </a:lnTo>
                  <a:lnTo>
                    <a:pt x="168" y="1398"/>
                  </a:lnTo>
                  <a:lnTo>
                    <a:pt x="173" y="1398"/>
                  </a:lnTo>
                  <a:lnTo>
                    <a:pt x="177" y="1398"/>
                  </a:lnTo>
                  <a:lnTo>
                    <a:pt x="182" y="1398"/>
                  </a:lnTo>
                  <a:lnTo>
                    <a:pt x="186" y="1398"/>
                  </a:lnTo>
                  <a:lnTo>
                    <a:pt x="191" y="1398"/>
                  </a:lnTo>
                  <a:lnTo>
                    <a:pt x="195" y="1398"/>
                  </a:lnTo>
                  <a:lnTo>
                    <a:pt x="200" y="1398"/>
                  </a:lnTo>
                  <a:lnTo>
                    <a:pt x="204" y="1398"/>
                  </a:lnTo>
                  <a:lnTo>
                    <a:pt x="209" y="1398"/>
                  </a:lnTo>
                  <a:lnTo>
                    <a:pt x="214" y="1398"/>
                  </a:lnTo>
                  <a:lnTo>
                    <a:pt x="218" y="1398"/>
                  </a:lnTo>
                  <a:lnTo>
                    <a:pt x="223" y="1398"/>
                  </a:lnTo>
                  <a:lnTo>
                    <a:pt x="227" y="1398"/>
                  </a:lnTo>
                  <a:lnTo>
                    <a:pt x="232" y="1398"/>
                  </a:lnTo>
                  <a:lnTo>
                    <a:pt x="236" y="1399"/>
                  </a:lnTo>
                  <a:lnTo>
                    <a:pt x="241" y="1398"/>
                  </a:lnTo>
                  <a:lnTo>
                    <a:pt x="245" y="1398"/>
                  </a:lnTo>
                  <a:lnTo>
                    <a:pt x="250" y="1398"/>
                  </a:lnTo>
                  <a:lnTo>
                    <a:pt x="254" y="1398"/>
                  </a:lnTo>
                  <a:lnTo>
                    <a:pt x="259" y="1398"/>
                  </a:lnTo>
                  <a:lnTo>
                    <a:pt x="264" y="1398"/>
                  </a:lnTo>
                  <a:lnTo>
                    <a:pt x="268" y="1398"/>
                  </a:lnTo>
                  <a:lnTo>
                    <a:pt x="273" y="1398"/>
                  </a:lnTo>
                  <a:lnTo>
                    <a:pt x="277" y="1398"/>
                  </a:lnTo>
                  <a:lnTo>
                    <a:pt x="282" y="1398"/>
                  </a:lnTo>
                  <a:lnTo>
                    <a:pt x="286" y="1398"/>
                  </a:lnTo>
                  <a:lnTo>
                    <a:pt x="291" y="1398"/>
                  </a:lnTo>
                  <a:lnTo>
                    <a:pt x="295" y="1398"/>
                  </a:lnTo>
                  <a:lnTo>
                    <a:pt x="300" y="1398"/>
                  </a:lnTo>
                  <a:lnTo>
                    <a:pt x="305" y="1399"/>
                  </a:lnTo>
                  <a:lnTo>
                    <a:pt x="309" y="1398"/>
                  </a:lnTo>
                  <a:lnTo>
                    <a:pt x="314" y="1398"/>
                  </a:lnTo>
                  <a:lnTo>
                    <a:pt x="318" y="1398"/>
                  </a:lnTo>
                  <a:lnTo>
                    <a:pt x="323" y="1398"/>
                  </a:lnTo>
                  <a:lnTo>
                    <a:pt x="327" y="1398"/>
                  </a:lnTo>
                  <a:lnTo>
                    <a:pt x="332" y="1398"/>
                  </a:lnTo>
                  <a:lnTo>
                    <a:pt x="336" y="1398"/>
                  </a:lnTo>
                  <a:lnTo>
                    <a:pt x="341" y="1398"/>
                  </a:lnTo>
                  <a:lnTo>
                    <a:pt x="346" y="1398"/>
                  </a:lnTo>
                  <a:lnTo>
                    <a:pt x="350" y="1398"/>
                  </a:lnTo>
                  <a:lnTo>
                    <a:pt x="355" y="1398"/>
                  </a:lnTo>
                  <a:lnTo>
                    <a:pt x="359" y="1398"/>
                  </a:lnTo>
                  <a:lnTo>
                    <a:pt x="364" y="1398"/>
                  </a:lnTo>
                  <a:lnTo>
                    <a:pt x="368" y="1398"/>
                  </a:lnTo>
                  <a:lnTo>
                    <a:pt x="373" y="1398"/>
                  </a:lnTo>
                  <a:lnTo>
                    <a:pt x="377" y="1398"/>
                  </a:lnTo>
                  <a:lnTo>
                    <a:pt x="382" y="1398"/>
                  </a:lnTo>
                  <a:lnTo>
                    <a:pt x="387" y="1398"/>
                  </a:lnTo>
                  <a:lnTo>
                    <a:pt x="391" y="1398"/>
                  </a:lnTo>
                  <a:lnTo>
                    <a:pt x="396" y="1398"/>
                  </a:lnTo>
                  <a:lnTo>
                    <a:pt x="400" y="1398"/>
                  </a:lnTo>
                  <a:lnTo>
                    <a:pt x="405" y="1398"/>
                  </a:lnTo>
                  <a:lnTo>
                    <a:pt x="409" y="1398"/>
                  </a:lnTo>
                  <a:lnTo>
                    <a:pt x="414" y="1398"/>
                  </a:lnTo>
                  <a:lnTo>
                    <a:pt x="418" y="1398"/>
                  </a:lnTo>
                  <a:lnTo>
                    <a:pt x="423" y="1398"/>
                  </a:lnTo>
                  <a:lnTo>
                    <a:pt x="427" y="1398"/>
                  </a:lnTo>
                  <a:lnTo>
                    <a:pt x="432" y="1398"/>
                  </a:lnTo>
                  <a:lnTo>
                    <a:pt x="436" y="1398"/>
                  </a:lnTo>
                  <a:lnTo>
                    <a:pt x="441" y="1398"/>
                  </a:lnTo>
                  <a:lnTo>
                    <a:pt x="446" y="1398"/>
                  </a:lnTo>
                  <a:lnTo>
                    <a:pt x="450" y="1398"/>
                  </a:lnTo>
                  <a:lnTo>
                    <a:pt x="455" y="1398"/>
                  </a:lnTo>
                  <a:lnTo>
                    <a:pt x="459" y="1398"/>
                  </a:lnTo>
                  <a:lnTo>
                    <a:pt x="464" y="1398"/>
                  </a:lnTo>
                  <a:lnTo>
                    <a:pt x="468" y="1398"/>
                  </a:lnTo>
                  <a:lnTo>
                    <a:pt x="473" y="1398"/>
                  </a:lnTo>
                  <a:lnTo>
                    <a:pt x="477" y="1398"/>
                  </a:lnTo>
                  <a:lnTo>
                    <a:pt x="482" y="1398"/>
                  </a:lnTo>
                  <a:lnTo>
                    <a:pt x="486" y="1398"/>
                  </a:lnTo>
                  <a:lnTo>
                    <a:pt x="491" y="1398"/>
                  </a:lnTo>
                  <a:lnTo>
                    <a:pt x="496" y="1398"/>
                  </a:lnTo>
                  <a:lnTo>
                    <a:pt x="500" y="1398"/>
                  </a:lnTo>
                  <a:lnTo>
                    <a:pt x="505" y="1398"/>
                  </a:lnTo>
                  <a:lnTo>
                    <a:pt x="509" y="1398"/>
                  </a:lnTo>
                  <a:lnTo>
                    <a:pt x="514" y="1398"/>
                  </a:lnTo>
                  <a:lnTo>
                    <a:pt x="518" y="1398"/>
                  </a:lnTo>
                  <a:lnTo>
                    <a:pt x="523" y="1398"/>
                  </a:lnTo>
                  <a:lnTo>
                    <a:pt x="527" y="1398"/>
                  </a:lnTo>
                  <a:lnTo>
                    <a:pt x="532" y="1398"/>
                  </a:lnTo>
                  <a:lnTo>
                    <a:pt x="536" y="1398"/>
                  </a:lnTo>
                  <a:lnTo>
                    <a:pt x="541" y="1398"/>
                  </a:lnTo>
                  <a:lnTo>
                    <a:pt x="546" y="1398"/>
                  </a:lnTo>
                  <a:lnTo>
                    <a:pt x="550" y="1398"/>
                  </a:lnTo>
                  <a:lnTo>
                    <a:pt x="555" y="1398"/>
                  </a:lnTo>
                  <a:lnTo>
                    <a:pt x="559" y="1398"/>
                  </a:lnTo>
                  <a:lnTo>
                    <a:pt x="564" y="1398"/>
                  </a:lnTo>
                  <a:lnTo>
                    <a:pt x="568" y="1398"/>
                  </a:lnTo>
                  <a:lnTo>
                    <a:pt x="573" y="1398"/>
                  </a:lnTo>
                  <a:lnTo>
                    <a:pt x="578" y="1398"/>
                  </a:lnTo>
                  <a:lnTo>
                    <a:pt x="582" y="1398"/>
                  </a:lnTo>
                  <a:lnTo>
                    <a:pt x="587" y="1398"/>
                  </a:lnTo>
                  <a:lnTo>
                    <a:pt x="591" y="1398"/>
                  </a:lnTo>
                  <a:lnTo>
                    <a:pt x="596" y="1398"/>
                  </a:lnTo>
                  <a:lnTo>
                    <a:pt x="600" y="1398"/>
                  </a:lnTo>
                  <a:lnTo>
                    <a:pt x="605" y="1398"/>
                  </a:lnTo>
                  <a:lnTo>
                    <a:pt x="609" y="1398"/>
                  </a:lnTo>
                  <a:lnTo>
                    <a:pt x="614" y="1398"/>
                  </a:lnTo>
                  <a:lnTo>
                    <a:pt x="619" y="1398"/>
                  </a:lnTo>
                  <a:lnTo>
                    <a:pt x="623" y="1398"/>
                  </a:lnTo>
                  <a:lnTo>
                    <a:pt x="628" y="1398"/>
                  </a:lnTo>
                  <a:lnTo>
                    <a:pt x="632" y="1398"/>
                  </a:lnTo>
                  <a:lnTo>
                    <a:pt x="637" y="1398"/>
                  </a:lnTo>
                  <a:lnTo>
                    <a:pt x="641" y="1398"/>
                  </a:lnTo>
                  <a:lnTo>
                    <a:pt x="646" y="1398"/>
                  </a:lnTo>
                  <a:lnTo>
                    <a:pt x="650" y="1398"/>
                  </a:lnTo>
                  <a:lnTo>
                    <a:pt x="655" y="1398"/>
                  </a:lnTo>
                  <a:lnTo>
                    <a:pt x="659" y="1398"/>
                  </a:lnTo>
                  <a:lnTo>
                    <a:pt x="664" y="1398"/>
                  </a:lnTo>
                  <a:lnTo>
                    <a:pt x="668" y="1398"/>
                  </a:lnTo>
                  <a:lnTo>
                    <a:pt x="673" y="1398"/>
                  </a:lnTo>
                  <a:lnTo>
                    <a:pt x="678" y="1398"/>
                  </a:lnTo>
                  <a:lnTo>
                    <a:pt x="682" y="1398"/>
                  </a:lnTo>
                  <a:lnTo>
                    <a:pt x="687" y="1398"/>
                  </a:lnTo>
                  <a:lnTo>
                    <a:pt x="691" y="1398"/>
                  </a:lnTo>
                  <a:lnTo>
                    <a:pt x="696" y="1398"/>
                  </a:lnTo>
                  <a:lnTo>
                    <a:pt x="700" y="1398"/>
                  </a:lnTo>
                  <a:lnTo>
                    <a:pt x="705" y="1398"/>
                  </a:lnTo>
                  <a:lnTo>
                    <a:pt x="709" y="1398"/>
                  </a:lnTo>
                  <a:lnTo>
                    <a:pt x="714" y="1398"/>
                  </a:lnTo>
                  <a:lnTo>
                    <a:pt x="718" y="1398"/>
                  </a:lnTo>
                  <a:lnTo>
                    <a:pt x="723" y="1398"/>
                  </a:lnTo>
                  <a:lnTo>
                    <a:pt x="728" y="1398"/>
                  </a:lnTo>
                  <a:lnTo>
                    <a:pt x="732" y="1398"/>
                  </a:lnTo>
                  <a:lnTo>
                    <a:pt x="737" y="1398"/>
                  </a:lnTo>
                  <a:lnTo>
                    <a:pt x="741" y="1398"/>
                  </a:lnTo>
                  <a:lnTo>
                    <a:pt x="746" y="1398"/>
                  </a:lnTo>
                  <a:lnTo>
                    <a:pt x="750" y="1398"/>
                  </a:lnTo>
                  <a:lnTo>
                    <a:pt x="755" y="1398"/>
                  </a:lnTo>
                  <a:lnTo>
                    <a:pt x="759" y="1398"/>
                  </a:lnTo>
                  <a:lnTo>
                    <a:pt x="764" y="1398"/>
                  </a:lnTo>
                  <a:lnTo>
                    <a:pt x="768" y="1398"/>
                  </a:lnTo>
                  <a:lnTo>
                    <a:pt x="773" y="1398"/>
                  </a:lnTo>
                  <a:lnTo>
                    <a:pt x="778" y="1398"/>
                  </a:lnTo>
                  <a:lnTo>
                    <a:pt x="782" y="1398"/>
                  </a:lnTo>
                  <a:lnTo>
                    <a:pt x="787" y="1398"/>
                  </a:lnTo>
                  <a:lnTo>
                    <a:pt x="791" y="1398"/>
                  </a:lnTo>
                  <a:lnTo>
                    <a:pt x="796" y="1397"/>
                  </a:lnTo>
                  <a:lnTo>
                    <a:pt x="800" y="1397"/>
                  </a:lnTo>
                  <a:lnTo>
                    <a:pt x="805" y="1400"/>
                  </a:lnTo>
                  <a:lnTo>
                    <a:pt x="809" y="1408"/>
                  </a:lnTo>
                  <a:lnTo>
                    <a:pt x="814" y="1401"/>
                  </a:lnTo>
                  <a:lnTo>
                    <a:pt x="819" y="1396"/>
                  </a:lnTo>
                  <a:lnTo>
                    <a:pt x="823" y="1393"/>
                  </a:lnTo>
                  <a:lnTo>
                    <a:pt x="828" y="1391"/>
                  </a:lnTo>
                  <a:lnTo>
                    <a:pt x="832" y="1391"/>
                  </a:lnTo>
                  <a:lnTo>
                    <a:pt x="837" y="1391"/>
                  </a:lnTo>
                  <a:lnTo>
                    <a:pt x="841" y="1392"/>
                  </a:lnTo>
                  <a:lnTo>
                    <a:pt x="846" y="1394"/>
                  </a:lnTo>
                  <a:lnTo>
                    <a:pt x="851" y="1395"/>
                  </a:lnTo>
                  <a:lnTo>
                    <a:pt x="855" y="1396"/>
                  </a:lnTo>
                  <a:lnTo>
                    <a:pt x="860" y="1397"/>
                  </a:lnTo>
                  <a:lnTo>
                    <a:pt x="864" y="1399"/>
                  </a:lnTo>
                  <a:lnTo>
                    <a:pt x="869" y="1400"/>
                  </a:lnTo>
                  <a:lnTo>
                    <a:pt x="873" y="1401"/>
                  </a:lnTo>
                  <a:lnTo>
                    <a:pt x="878" y="1401"/>
                  </a:lnTo>
                  <a:lnTo>
                    <a:pt x="882" y="1401"/>
                  </a:lnTo>
                  <a:lnTo>
                    <a:pt x="887" y="1401"/>
                  </a:lnTo>
                  <a:lnTo>
                    <a:pt x="891" y="1401"/>
                  </a:lnTo>
                  <a:lnTo>
                    <a:pt x="896" y="1401"/>
                  </a:lnTo>
                  <a:lnTo>
                    <a:pt x="901" y="1402"/>
                  </a:lnTo>
                  <a:lnTo>
                    <a:pt x="905" y="1403"/>
                  </a:lnTo>
                  <a:lnTo>
                    <a:pt x="910" y="1403"/>
                  </a:lnTo>
                  <a:lnTo>
                    <a:pt x="914" y="1403"/>
                  </a:lnTo>
                  <a:lnTo>
                    <a:pt x="919" y="1403"/>
                  </a:lnTo>
                  <a:lnTo>
                    <a:pt x="923" y="1403"/>
                  </a:lnTo>
                  <a:lnTo>
                    <a:pt x="928" y="1402"/>
                  </a:lnTo>
                  <a:lnTo>
                    <a:pt x="932" y="1403"/>
                  </a:lnTo>
                  <a:lnTo>
                    <a:pt x="937" y="1403"/>
                  </a:lnTo>
                  <a:lnTo>
                    <a:pt x="941" y="1402"/>
                  </a:lnTo>
                  <a:lnTo>
                    <a:pt x="946" y="1402"/>
                  </a:lnTo>
                  <a:lnTo>
                    <a:pt x="950" y="1402"/>
                  </a:lnTo>
                  <a:lnTo>
                    <a:pt x="955" y="1403"/>
                  </a:lnTo>
                  <a:lnTo>
                    <a:pt x="960" y="1403"/>
                  </a:lnTo>
                  <a:lnTo>
                    <a:pt x="964" y="1403"/>
                  </a:lnTo>
                  <a:lnTo>
                    <a:pt x="969" y="1403"/>
                  </a:lnTo>
                  <a:lnTo>
                    <a:pt x="973" y="1403"/>
                  </a:lnTo>
                  <a:lnTo>
                    <a:pt x="978" y="1403"/>
                  </a:lnTo>
                  <a:lnTo>
                    <a:pt x="982" y="1403"/>
                  </a:lnTo>
                  <a:lnTo>
                    <a:pt x="987" y="1402"/>
                  </a:lnTo>
                  <a:lnTo>
                    <a:pt x="991" y="1401"/>
                  </a:lnTo>
                  <a:lnTo>
                    <a:pt x="996" y="1401"/>
                  </a:lnTo>
                  <a:lnTo>
                    <a:pt x="1000" y="1400"/>
                  </a:lnTo>
                  <a:lnTo>
                    <a:pt x="1005" y="1400"/>
                  </a:lnTo>
                  <a:lnTo>
                    <a:pt x="1010" y="1399"/>
                  </a:lnTo>
                  <a:lnTo>
                    <a:pt x="1014" y="1399"/>
                  </a:lnTo>
                  <a:lnTo>
                    <a:pt x="1019" y="1399"/>
                  </a:lnTo>
                  <a:lnTo>
                    <a:pt x="1023" y="1399"/>
                  </a:lnTo>
                  <a:lnTo>
                    <a:pt x="1028" y="1398"/>
                  </a:lnTo>
                  <a:lnTo>
                    <a:pt x="1032" y="1398"/>
                  </a:lnTo>
                  <a:lnTo>
                    <a:pt x="1037" y="1398"/>
                  </a:lnTo>
                  <a:lnTo>
                    <a:pt x="1041" y="1398"/>
                  </a:lnTo>
                  <a:lnTo>
                    <a:pt x="1046" y="1398"/>
                  </a:lnTo>
                  <a:lnTo>
                    <a:pt x="1050" y="1397"/>
                  </a:lnTo>
                  <a:lnTo>
                    <a:pt x="1055" y="1397"/>
                  </a:lnTo>
                  <a:lnTo>
                    <a:pt x="1060" y="1397"/>
                  </a:lnTo>
                  <a:lnTo>
                    <a:pt x="1064" y="1397"/>
                  </a:lnTo>
                  <a:lnTo>
                    <a:pt x="1069" y="1397"/>
                  </a:lnTo>
                  <a:lnTo>
                    <a:pt x="1073" y="1396"/>
                  </a:lnTo>
                  <a:lnTo>
                    <a:pt x="1078" y="1396"/>
                  </a:lnTo>
                  <a:lnTo>
                    <a:pt x="1082" y="1396"/>
                  </a:lnTo>
                  <a:lnTo>
                    <a:pt x="1087" y="1396"/>
                  </a:lnTo>
                  <a:lnTo>
                    <a:pt x="1092" y="1395"/>
                  </a:lnTo>
                  <a:lnTo>
                    <a:pt x="1096" y="1394"/>
                  </a:lnTo>
                  <a:lnTo>
                    <a:pt x="1101" y="1393"/>
                  </a:lnTo>
                  <a:lnTo>
                    <a:pt x="1105" y="1390"/>
                  </a:lnTo>
                  <a:lnTo>
                    <a:pt x="1110" y="1375"/>
                  </a:lnTo>
                  <a:lnTo>
                    <a:pt x="1112" y="1362"/>
                  </a:lnTo>
                  <a:lnTo>
                    <a:pt x="1114" y="1359"/>
                  </a:lnTo>
                  <a:lnTo>
                    <a:pt x="1117" y="1366"/>
                  </a:lnTo>
                  <a:lnTo>
                    <a:pt x="1119" y="1383"/>
                  </a:lnTo>
                  <a:lnTo>
                    <a:pt x="1123" y="1402"/>
                  </a:lnTo>
                  <a:lnTo>
                    <a:pt x="1128" y="1401"/>
                  </a:lnTo>
                  <a:lnTo>
                    <a:pt x="1133" y="1400"/>
                  </a:lnTo>
                  <a:lnTo>
                    <a:pt x="1137" y="1399"/>
                  </a:lnTo>
                  <a:lnTo>
                    <a:pt x="1142" y="1399"/>
                  </a:lnTo>
                  <a:lnTo>
                    <a:pt x="1146" y="1398"/>
                  </a:lnTo>
                  <a:lnTo>
                    <a:pt x="1151" y="1398"/>
                  </a:lnTo>
                  <a:lnTo>
                    <a:pt x="1155" y="1398"/>
                  </a:lnTo>
                  <a:lnTo>
                    <a:pt x="1160" y="1398"/>
                  </a:lnTo>
                  <a:lnTo>
                    <a:pt x="1164" y="1398"/>
                  </a:lnTo>
                  <a:lnTo>
                    <a:pt x="1169" y="1398"/>
                  </a:lnTo>
                  <a:lnTo>
                    <a:pt x="1173" y="1398"/>
                  </a:lnTo>
                  <a:lnTo>
                    <a:pt x="1178" y="1398"/>
                  </a:lnTo>
                  <a:lnTo>
                    <a:pt x="1182" y="1398"/>
                  </a:lnTo>
                  <a:lnTo>
                    <a:pt x="1187" y="1398"/>
                  </a:lnTo>
                  <a:lnTo>
                    <a:pt x="1192" y="1398"/>
                  </a:lnTo>
                  <a:lnTo>
                    <a:pt x="1196" y="1398"/>
                  </a:lnTo>
                  <a:lnTo>
                    <a:pt x="1201" y="1398"/>
                  </a:lnTo>
                  <a:lnTo>
                    <a:pt x="1205" y="1398"/>
                  </a:lnTo>
                  <a:lnTo>
                    <a:pt x="1210" y="1398"/>
                  </a:lnTo>
                  <a:lnTo>
                    <a:pt x="1214" y="1398"/>
                  </a:lnTo>
                  <a:lnTo>
                    <a:pt x="1219" y="1398"/>
                  </a:lnTo>
                  <a:lnTo>
                    <a:pt x="1223" y="1398"/>
                  </a:lnTo>
                  <a:lnTo>
                    <a:pt x="1228" y="1398"/>
                  </a:lnTo>
                  <a:lnTo>
                    <a:pt x="1232" y="1398"/>
                  </a:lnTo>
                  <a:lnTo>
                    <a:pt x="1237" y="1398"/>
                  </a:lnTo>
                  <a:lnTo>
                    <a:pt x="1242" y="1398"/>
                  </a:lnTo>
                  <a:lnTo>
                    <a:pt x="1246" y="1398"/>
                  </a:lnTo>
                  <a:lnTo>
                    <a:pt x="1251" y="1398"/>
                  </a:lnTo>
                  <a:lnTo>
                    <a:pt x="1255" y="1398"/>
                  </a:lnTo>
                  <a:lnTo>
                    <a:pt x="1260" y="1398"/>
                  </a:lnTo>
                  <a:lnTo>
                    <a:pt x="1264" y="1398"/>
                  </a:lnTo>
                  <a:lnTo>
                    <a:pt x="1269" y="1398"/>
                  </a:lnTo>
                  <a:lnTo>
                    <a:pt x="1273" y="1398"/>
                  </a:lnTo>
                  <a:lnTo>
                    <a:pt x="1278" y="1398"/>
                  </a:lnTo>
                  <a:lnTo>
                    <a:pt x="1282" y="1398"/>
                  </a:lnTo>
                  <a:lnTo>
                    <a:pt x="1287" y="1398"/>
                  </a:lnTo>
                  <a:lnTo>
                    <a:pt x="1291" y="1398"/>
                  </a:lnTo>
                  <a:lnTo>
                    <a:pt x="1296" y="1398"/>
                  </a:lnTo>
                  <a:lnTo>
                    <a:pt x="1301" y="1398"/>
                  </a:lnTo>
                  <a:lnTo>
                    <a:pt x="1305" y="1398"/>
                  </a:lnTo>
                  <a:lnTo>
                    <a:pt x="1310" y="1398"/>
                  </a:lnTo>
                  <a:lnTo>
                    <a:pt x="1314" y="1398"/>
                  </a:lnTo>
                  <a:lnTo>
                    <a:pt x="1319" y="1398"/>
                  </a:lnTo>
                  <a:lnTo>
                    <a:pt x="1323" y="1398"/>
                  </a:lnTo>
                  <a:lnTo>
                    <a:pt x="1328" y="1398"/>
                  </a:lnTo>
                  <a:lnTo>
                    <a:pt x="1333" y="1398"/>
                  </a:lnTo>
                  <a:lnTo>
                    <a:pt x="1337" y="1398"/>
                  </a:lnTo>
                  <a:lnTo>
                    <a:pt x="1342" y="1398"/>
                  </a:lnTo>
                  <a:lnTo>
                    <a:pt x="1346" y="1398"/>
                  </a:lnTo>
                  <a:lnTo>
                    <a:pt x="1351" y="1398"/>
                  </a:lnTo>
                  <a:lnTo>
                    <a:pt x="1355" y="1398"/>
                  </a:lnTo>
                  <a:lnTo>
                    <a:pt x="1360" y="1398"/>
                  </a:lnTo>
                  <a:lnTo>
                    <a:pt x="1365" y="1398"/>
                  </a:lnTo>
                  <a:lnTo>
                    <a:pt x="1369" y="1398"/>
                  </a:lnTo>
                  <a:lnTo>
                    <a:pt x="1374" y="1398"/>
                  </a:lnTo>
                  <a:lnTo>
                    <a:pt x="1378" y="1398"/>
                  </a:lnTo>
                  <a:lnTo>
                    <a:pt x="1383" y="1398"/>
                  </a:lnTo>
                  <a:lnTo>
                    <a:pt x="1387" y="1398"/>
                  </a:lnTo>
                  <a:lnTo>
                    <a:pt x="1392" y="1398"/>
                  </a:lnTo>
                  <a:lnTo>
                    <a:pt x="1396" y="1398"/>
                  </a:lnTo>
                  <a:lnTo>
                    <a:pt x="1401" y="1398"/>
                  </a:lnTo>
                  <a:lnTo>
                    <a:pt x="1405" y="1398"/>
                  </a:lnTo>
                  <a:lnTo>
                    <a:pt x="1410" y="1398"/>
                  </a:lnTo>
                  <a:lnTo>
                    <a:pt x="1414" y="1398"/>
                  </a:lnTo>
                  <a:lnTo>
                    <a:pt x="1419" y="1398"/>
                  </a:lnTo>
                  <a:lnTo>
                    <a:pt x="1424" y="1398"/>
                  </a:lnTo>
                  <a:lnTo>
                    <a:pt x="1428" y="1398"/>
                  </a:lnTo>
                  <a:lnTo>
                    <a:pt x="1433" y="1398"/>
                  </a:lnTo>
                  <a:lnTo>
                    <a:pt x="1437" y="1398"/>
                  </a:lnTo>
                  <a:lnTo>
                    <a:pt x="1442" y="1398"/>
                  </a:lnTo>
                  <a:lnTo>
                    <a:pt x="1446" y="1398"/>
                  </a:lnTo>
                  <a:lnTo>
                    <a:pt x="1451" y="1398"/>
                  </a:lnTo>
                  <a:lnTo>
                    <a:pt x="1455" y="1398"/>
                  </a:lnTo>
                  <a:lnTo>
                    <a:pt x="1460" y="1398"/>
                  </a:lnTo>
                  <a:lnTo>
                    <a:pt x="1464" y="1398"/>
                  </a:lnTo>
                  <a:lnTo>
                    <a:pt x="1469" y="1397"/>
                  </a:lnTo>
                  <a:lnTo>
                    <a:pt x="1474" y="1398"/>
                  </a:lnTo>
                  <a:lnTo>
                    <a:pt x="1478" y="1397"/>
                  </a:lnTo>
                  <a:lnTo>
                    <a:pt x="1483" y="1397"/>
                  </a:lnTo>
                  <a:lnTo>
                    <a:pt x="1487" y="1397"/>
                  </a:lnTo>
                  <a:lnTo>
                    <a:pt x="1492" y="1397"/>
                  </a:lnTo>
                  <a:lnTo>
                    <a:pt x="1496" y="1397"/>
                  </a:lnTo>
                  <a:lnTo>
                    <a:pt x="1501" y="1397"/>
                  </a:lnTo>
                  <a:lnTo>
                    <a:pt x="1505" y="1397"/>
                  </a:lnTo>
                  <a:lnTo>
                    <a:pt x="1510" y="1397"/>
                  </a:lnTo>
                  <a:lnTo>
                    <a:pt x="1514" y="1397"/>
                  </a:lnTo>
                  <a:lnTo>
                    <a:pt x="1519" y="1397"/>
                  </a:lnTo>
                  <a:lnTo>
                    <a:pt x="1523" y="1397"/>
                  </a:lnTo>
                  <a:lnTo>
                    <a:pt x="1528" y="1397"/>
                  </a:lnTo>
                  <a:lnTo>
                    <a:pt x="1533" y="1397"/>
                  </a:lnTo>
                  <a:lnTo>
                    <a:pt x="1537" y="1397"/>
                  </a:lnTo>
                  <a:lnTo>
                    <a:pt x="1542" y="1397"/>
                  </a:lnTo>
                  <a:lnTo>
                    <a:pt x="1546" y="1397"/>
                  </a:lnTo>
                  <a:lnTo>
                    <a:pt x="1551" y="1397"/>
                  </a:lnTo>
                  <a:lnTo>
                    <a:pt x="1555" y="1397"/>
                  </a:lnTo>
                  <a:lnTo>
                    <a:pt x="1560" y="1397"/>
                  </a:lnTo>
                  <a:lnTo>
                    <a:pt x="1564" y="1397"/>
                  </a:lnTo>
                  <a:lnTo>
                    <a:pt x="1569" y="1397"/>
                  </a:lnTo>
                  <a:lnTo>
                    <a:pt x="1574" y="1397"/>
                  </a:lnTo>
                  <a:lnTo>
                    <a:pt x="1578" y="1396"/>
                  </a:lnTo>
                  <a:lnTo>
                    <a:pt x="1583" y="1396"/>
                  </a:lnTo>
                  <a:lnTo>
                    <a:pt x="1587" y="1396"/>
                  </a:lnTo>
                  <a:lnTo>
                    <a:pt x="1592" y="1396"/>
                  </a:lnTo>
                  <a:lnTo>
                    <a:pt x="1596" y="1396"/>
                  </a:lnTo>
                  <a:lnTo>
                    <a:pt x="1601" y="1396"/>
                  </a:lnTo>
                  <a:lnTo>
                    <a:pt x="1606" y="1396"/>
                  </a:lnTo>
                  <a:lnTo>
                    <a:pt x="1610" y="1396"/>
                  </a:lnTo>
                  <a:lnTo>
                    <a:pt x="1615" y="1396"/>
                  </a:lnTo>
                  <a:lnTo>
                    <a:pt x="1619" y="1396"/>
                  </a:lnTo>
                  <a:lnTo>
                    <a:pt x="1624" y="1396"/>
                  </a:lnTo>
                  <a:lnTo>
                    <a:pt x="1628" y="1396"/>
                  </a:lnTo>
                  <a:lnTo>
                    <a:pt x="1633" y="1396"/>
                  </a:lnTo>
                  <a:lnTo>
                    <a:pt x="1637" y="1396"/>
                  </a:lnTo>
                  <a:lnTo>
                    <a:pt x="1642" y="1396"/>
                  </a:lnTo>
                  <a:lnTo>
                    <a:pt x="1646" y="1396"/>
                  </a:lnTo>
                  <a:lnTo>
                    <a:pt x="1651" y="1396"/>
                  </a:lnTo>
                  <a:lnTo>
                    <a:pt x="1656" y="1396"/>
                  </a:lnTo>
                  <a:lnTo>
                    <a:pt x="1660" y="1396"/>
                  </a:lnTo>
                  <a:lnTo>
                    <a:pt x="1665" y="1396"/>
                  </a:lnTo>
                  <a:lnTo>
                    <a:pt x="1669" y="1396"/>
                  </a:lnTo>
                  <a:lnTo>
                    <a:pt x="1674" y="1396"/>
                  </a:lnTo>
                  <a:lnTo>
                    <a:pt x="1678" y="1396"/>
                  </a:lnTo>
                  <a:lnTo>
                    <a:pt x="1683" y="1396"/>
                  </a:lnTo>
                  <a:lnTo>
                    <a:pt x="1687" y="1396"/>
                  </a:lnTo>
                  <a:lnTo>
                    <a:pt x="1692" y="1396"/>
                  </a:lnTo>
                  <a:lnTo>
                    <a:pt x="1696" y="1396"/>
                  </a:lnTo>
                  <a:lnTo>
                    <a:pt x="1701" y="1396"/>
                  </a:lnTo>
                  <a:lnTo>
                    <a:pt x="1706" y="1396"/>
                  </a:lnTo>
                  <a:lnTo>
                    <a:pt x="1710" y="1396"/>
                  </a:lnTo>
                  <a:lnTo>
                    <a:pt x="1715" y="1396"/>
                  </a:lnTo>
                  <a:lnTo>
                    <a:pt x="1719" y="1396"/>
                  </a:lnTo>
                  <a:lnTo>
                    <a:pt x="1724" y="1396"/>
                  </a:lnTo>
                  <a:lnTo>
                    <a:pt x="1728" y="1397"/>
                  </a:lnTo>
                  <a:lnTo>
                    <a:pt x="1733" y="1396"/>
                  </a:lnTo>
                  <a:lnTo>
                    <a:pt x="1737" y="1396"/>
                  </a:lnTo>
                  <a:lnTo>
                    <a:pt x="1742" y="1396"/>
                  </a:lnTo>
                  <a:lnTo>
                    <a:pt x="1746" y="1396"/>
                  </a:lnTo>
                  <a:lnTo>
                    <a:pt x="1751" y="1396"/>
                  </a:lnTo>
                  <a:lnTo>
                    <a:pt x="1755" y="1396"/>
                  </a:lnTo>
                  <a:lnTo>
                    <a:pt x="1760" y="1396"/>
                  </a:lnTo>
                  <a:lnTo>
                    <a:pt x="1765" y="1397"/>
                  </a:lnTo>
                  <a:lnTo>
                    <a:pt x="1769" y="1397"/>
                  </a:lnTo>
                  <a:lnTo>
                    <a:pt x="1774" y="1396"/>
                  </a:lnTo>
                  <a:lnTo>
                    <a:pt x="1778" y="1396"/>
                  </a:lnTo>
                  <a:lnTo>
                    <a:pt x="1783" y="1396"/>
                  </a:lnTo>
                  <a:lnTo>
                    <a:pt x="1787" y="1397"/>
                  </a:lnTo>
                  <a:lnTo>
                    <a:pt x="1792" y="1397"/>
                  </a:lnTo>
                  <a:lnTo>
                    <a:pt x="1796" y="1397"/>
                  </a:lnTo>
                  <a:lnTo>
                    <a:pt x="1801" y="1397"/>
                  </a:lnTo>
                  <a:lnTo>
                    <a:pt x="1805" y="1397"/>
                  </a:lnTo>
                  <a:lnTo>
                    <a:pt x="1810" y="1397"/>
                  </a:lnTo>
                  <a:lnTo>
                    <a:pt x="1815" y="1397"/>
                  </a:lnTo>
                  <a:lnTo>
                    <a:pt x="1819" y="1397"/>
                  </a:lnTo>
                  <a:lnTo>
                    <a:pt x="1824" y="1397"/>
                  </a:lnTo>
                  <a:lnTo>
                    <a:pt x="1828" y="1397"/>
                  </a:lnTo>
                  <a:lnTo>
                    <a:pt x="1833" y="1397"/>
                  </a:lnTo>
                  <a:lnTo>
                    <a:pt x="1837" y="1397"/>
                  </a:lnTo>
                  <a:lnTo>
                    <a:pt x="1842" y="1397"/>
                  </a:lnTo>
                  <a:lnTo>
                    <a:pt x="1847" y="1397"/>
                  </a:lnTo>
                  <a:lnTo>
                    <a:pt x="1851" y="1397"/>
                  </a:lnTo>
                  <a:lnTo>
                    <a:pt x="1856" y="1397"/>
                  </a:lnTo>
                  <a:lnTo>
                    <a:pt x="1860" y="1397"/>
                  </a:lnTo>
                  <a:lnTo>
                    <a:pt x="1865" y="1397"/>
                  </a:lnTo>
                  <a:lnTo>
                    <a:pt x="1869" y="1397"/>
                  </a:lnTo>
                  <a:lnTo>
                    <a:pt x="1874" y="1397"/>
                  </a:lnTo>
                  <a:lnTo>
                    <a:pt x="1878" y="1397"/>
                  </a:lnTo>
                  <a:lnTo>
                    <a:pt x="1883" y="1397"/>
                  </a:lnTo>
                  <a:lnTo>
                    <a:pt x="1888" y="1397"/>
                  </a:lnTo>
                  <a:lnTo>
                    <a:pt x="1892" y="1397"/>
                  </a:lnTo>
                  <a:lnTo>
                    <a:pt x="1897" y="1397"/>
                  </a:lnTo>
                  <a:lnTo>
                    <a:pt x="1901" y="1397"/>
                  </a:lnTo>
                  <a:lnTo>
                    <a:pt x="1906" y="1397"/>
                  </a:lnTo>
                  <a:lnTo>
                    <a:pt x="1910" y="1397"/>
                  </a:lnTo>
                  <a:lnTo>
                    <a:pt x="1915" y="1397"/>
                  </a:lnTo>
                  <a:lnTo>
                    <a:pt x="1919" y="1397"/>
                  </a:lnTo>
                  <a:lnTo>
                    <a:pt x="1924" y="1397"/>
                  </a:lnTo>
                  <a:lnTo>
                    <a:pt x="1928" y="1397"/>
                  </a:lnTo>
                  <a:lnTo>
                    <a:pt x="1933" y="1397"/>
                  </a:lnTo>
                  <a:lnTo>
                    <a:pt x="1938" y="1397"/>
                  </a:lnTo>
                  <a:lnTo>
                    <a:pt x="1942" y="1397"/>
                  </a:lnTo>
                  <a:lnTo>
                    <a:pt x="1947" y="1397"/>
                  </a:lnTo>
                  <a:lnTo>
                    <a:pt x="1951" y="1397"/>
                  </a:lnTo>
                  <a:lnTo>
                    <a:pt x="1956" y="1397"/>
                  </a:lnTo>
                  <a:lnTo>
                    <a:pt x="1960" y="1397"/>
                  </a:lnTo>
                  <a:lnTo>
                    <a:pt x="1965" y="1397"/>
                  </a:lnTo>
                  <a:lnTo>
                    <a:pt x="1969" y="1397"/>
                  </a:lnTo>
                  <a:lnTo>
                    <a:pt x="1974" y="1397"/>
                  </a:lnTo>
                  <a:lnTo>
                    <a:pt x="1978" y="1397"/>
                  </a:lnTo>
                  <a:lnTo>
                    <a:pt x="1983" y="1397"/>
                  </a:lnTo>
                  <a:lnTo>
                    <a:pt x="1987" y="1397"/>
                  </a:lnTo>
                  <a:lnTo>
                    <a:pt x="1992" y="1397"/>
                  </a:lnTo>
                  <a:lnTo>
                    <a:pt x="1997" y="1397"/>
                  </a:lnTo>
                  <a:lnTo>
                    <a:pt x="2001" y="1397"/>
                  </a:lnTo>
                  <a:lnTo>
                    <a:pt x="2006" y="1398"/>
                  </a:lnTo>
                  <a:lnTo>
                    <a:pt x="2010" y="1397"/>
                  </a:lnTo>
                  <a:lnTo>
                    <a:pt x="2015" y="1398"/>
                  </a:lnTo>
                  <a:lnTo>
                    <a:pt x="2019" y="1398"/>
                  </a:lnTo>
                  <a:lnTo>
                    <a:pt x="2024" y="1397"/>
                  </a:lnTo>
                  <a:lnTo>
                    <a:pt x="2028" y="1398"/>
                  </a:lnTo>
                  <a:lnTo>
                    <a:pt x="2033" y="1397"/>
                  </a:lnTo>
                  <a:lnTo>
                    <a:pt x="2037" y="1398"/>
                  </a:lnTo>
                  <a:lnTo>
                    <a:pt x="2042" y="1398"/>
                  </a:lnTo>
                  <a:lnTo>
                    <a:pt x="2047" y="1398"/>
                  </a:lnTo>
                  <a:lnTo>
                    <a:pt x="2051" y="1398"/>
                  </a:lnTo>
                  <a:lnTo>
                    <a:pt x="2056" y="1398"/>
                  </a:lnTo>
                  <a:lnTo>
                    <a:pt x="2060" y="1398"/>
                  </a:lnTo>
                  <a:lnTo>
                    <a:pt x="2065" y="1398"/>
                  </a:lnTo>
                  <a:lnTo>
                    <a:pt x="2069" y="1398"/>
                  </a:lnTo>
                  <a:lnTo>
                    <a:pt x="2074" y="1398"/>
                  </a:lnTo>
                  <a:lnTo>
                    <a:pt x="2078" y="1398"/>
                  </a:lnTo>
                  <a:lnTo>
                    <a:pt x="2083" y="1398"/>
                  </a:lnTo>
                  <a:lnTo>
                    <a:pt x="2088" y="1398"/>
                  </a:lnTo>
                  <a:lnTo>
                    <a:pt x="2092" y="1398"/>
                  </a:lnTo>
                  <a:lnTo>
                    <a:pt x="2097" y="1398"/>
                  </a:lnTo>
                  <a:lnTo>
                    <a:pt x="2101" y="1398"/>
                  </a:lnTo>
                  <a:lnTo>
                    <a:pt x="2106" y="1398"/>
                  </a:lnTo>
                  <a:lnTo>
                    <a:pt x="2110" y="1398"/>
                  </a:lnTo>
                  <a:lnTo>
                    <a:pt x="2115" y="1398"/>
                  </a:lnTo>
                  <a:lnTo>
                    <a:pt x="2120" y="1398"/>
                  </a:lnTo>
                  <a:lnTo>
                    <a:pt x="2124" y="1398"/>
                  </a:lnTo>
                  <a:lnTo>
                    <a:pt x="2129" y="1398"/>
                  </a:lnTo>
                  <a:lnTo>
                    <a:pt x="2133" y="1398"/>
                  </a:lnTo>
                  <a:lnTo>
                    <a:pt x="2138" y="1398"/>
                  </a:lnTo>
                  <a:lnTo>
                    <a:pt x="2142" y="1398"/>
                  </a:lnTo>
                  <a:lnTo>
                    <a:pt x="2147" y="1398"/>
                  </a:lnTo>
                  <a:lnTo>
                    <a:pt x="2151" y="1398"/>
                  </a:lnTo>
                  <a:lnTo>
                    <a:pt x="2156" y="1398"/>
                  </a:lnTo>
                  <a:lnTo>
                    <a:pt x="2160" y="1398"/>
                  </a:lnTo>
                  <a:lnTo>
                    <a:pt x="2165" y="1398"/>
                  </a:lnTo>
                  <a:lnTo>
                    <a:pt x="2170" y="1398"/>
                  </a:lnTo>
                  <a:lnTo>
                    <a:pt x="2174" y="1398"/>
                  </a:lnTo>
                  <a:lnTo>
                    <a:pt x="2179" y="1398"/>
                  </a:lnTo>
                  <a:lnTo>
                    <a:pt x="2183" y="1398"/>
                  </a:lnTo>
                  <a:lnTo>
                    <a:pt x="2188" y="1398"/>
                  </a:lnTo>
                  <a:lnTo>
                    <a:pt x="2192" y="1398"/>
                  </a:lnTo>
                  <a:lnTo>
                    <a:pt x="2197" y="1398"/>
                  </a:lnTo>
                  <a:lnTo>
                    <a:pt x="2201" y="1398"/>
                  </a:lnTo>
                  <a:lnTo>
                    <a:pt x="2206" y="1398"/>
                  </a:lnTo>
                  <a:lnTo>
                    <a:pt x="2210" y="1398"/>
                  </a:lnTo>
                  <a:lnTo>
                    <a:pt x="2215" y="1398"/>
                  </a:lnTo>
                  <a:lnTo>
                    <a:pt x="2220" y="1398"/>
                  </a:lnTo>
                  <a:lnTo>
                    <a:pt x="2224" y="1398"/>
                  </a:lnTo>
                  <a:lnTo>
                    <a:pt x="2229" y="1398"/>
                  </a:lnTo>
                  <a:lnTo>
                    <a:pt x="2233" y="1398"/>
                  </a:lnTo>
                  <a:lnTo>
                    <a:pt x="2238" y="1398"/>
                  </a:lnTo>
                  <a:lnTo>
                    <a:pt x="2242" y="1398"/>
                  </a:lnTo>
                  <a:lnTo>
                    <a:pt x="2247" y="1398"/>
                  </a:lnTo>
                  <a:lnTo>
                    <a:pt x="2251" y="1399"/>
                  </a:lnTo>
                  <a:lnTo>
                    <a:pt x="2256" y="1398"/>
                  </a:lnTo>
                  <a:lnTo>
                    <a:pt x="2260" y="1399"/>
                  </a:lnTo>
                  <a:lnTo>
                    <a:pt x="2265" y="1398"/>
                  </a:lnTo>
                  <a:lnTo>
                    <a:pt x="2269" y="1399"/>
                  </a:lnTo>
                  <a:lnTo>
                    <a:pt x="2274" y="1398"/>
                  </a:lnTo>
                  <a:lnTo>
                    <a:pt x="2279" y="1398"/>
                  </a:lnTo>
                  <a:lnTo>
                    <a:pt x="2283" y="1398"/>
                  </a:lnTo>
                  <a:lnTo>
                    <a:pt x="2288" y="1398"/>
                  </a:lnTo>
                  <a:lnTo>
                    <a:pt x="2292" y="1398"/>
                  </a:lnTo>
                  <a:lnTo>
                    <a:pt x="2297" y="1398"/>
                  </a:lnTo>
                  <a:lnTo>
                    <a:pt x="2301" y="1398"/>
                  </a:lnTo>
                  <a:lnTo>
                    <a:pt x="2306" y="1398"/>
                  </a:lnTo>
                  <a:lnTo>
                    <a:pt x="2310" y="1398"/>
                  </a:lnTo>
                  <a:lnTo>
                    <a:pt x="2315" y="1398"/>
                  </a:lnTo>
                  <a:lnTo>
                    <a:pt x="2319" y="1398"/>
                  </a:lnTo>
                  <a:lnTo>
                    <a:pt x="2324" y="1398"/>
                  </a:lnTo>
                  <a:lnTo>
                    <a:pt x="2329" y="1397"/>
                  </a:lnTo>
                  <a:lnTo>
                    <a:pt x="2333" y="1397"/>
                  </a:lnTo>
                  <a:lnTo>
                    <a:pt x="2338" y="1397"/>
                  </a:lnTo>
                  <a:lnTo>
                    <a:pt x="2342" y="1397"/>
                  </a:lnTo>
                  <a:lnTo>
                    <a:pt x="2347" y="1397"/>
                  </a:lnTo>
                  <a:lnTo>
                    <a:pt x="2351" y="1397"/>
                  </a:lnTo>
                  <a:lnTo>
                    <a:pt x="2356" y="1397"/>
                  </a:lnTo>
                  <a:lnTo>
                    <a:pt x="2361" y="1397"/>
                  </a:lnTo>
                  <a:lnTo>
                    <a:pt x="2365" y="1398"/>
                  </a:lnTo>
                  <a:lnTo>
                    <a:pt x="2370" y="1398"/>
                  </a:lnTo>
                  <a:lnTo>
                    <a:pt x="2374" y="1398"/>
                  </a:lnTo>
                  <a:lnTo>
                    <a:pt x="2379" y="1398"/>
                  </a:lnTo>
                  <a:lnTo>
                    <a:pt x="2383" y="1398"/>
                  </a:lnTo>
                  <a:lnTo>
                    <a:pt x="2388" y="1398"/>
                  </a:lnTo>
                  <a:lnTo>
                    <a:pt x="2392" y="1398"/>
                  </a:lnTo>
                  <a:lnTo>
                    <a:pt x="2397" y="1397"/>
                  </a:lnTo>
                  <a:lnTo>
                    <a:pt x="2402" y="1397"/>
                  </a:lnTo>
                  <a:lnTo>
                    <a:pt x="2406" y="1397"/>
                  </a:lnTo>
                  <a:lnTo>
                    <a:pt x="2411" y="1397"/>
                  </a:lnTo>
                  <a:lnTo>
                    <a:pt x="2415" y="1397"/>
                  </a:lnTo>
                  <a:lnTo>
                    <a:pt x="2420" y="1398"/>
                  </a:lnTo>
                  <a:lnTo>
                    <a:pt x="2424" y="1398"/>
                  </a:lnTo>
                  <a:lnTo>
                    <a:pt x="2429" y="1398"/>
                  </a:lnTo>
                  <a:lnTo>
                    <a:pt x="2433" y="1398"/>
                  </a:lnTo>
                  <a:lnTo>
                    <a:pt x="2438" y="1398"/>
                  </a:lnTo>
                  <a:lnTo>
                    <a:pt x="2442" y="1398"/>
                  </a:lnTo>
                  <a:lnTo>
                    <a:pt x="2447" y="1398"/>
                  </a:lnTo>
                  <a:lnTo>
                    <a:pt x="2452" y="1399"/>
                  </a:lnTo>
                  <a:lnTo>
                    <a:pt x="2456" y="1399"/>
                  </a:lnTo>
                  <a:lnTo>
                    <a:pt x="2461" y="1399"/>
                  </a:lnTo>
                  <a:lnTo>
                    <a:pt x="2465" y="1398"/>
                  </a:lnTo>
                  <a:lnTo>
                    <a:pt x="2470" y="1399"/>
                  </a:lnTo>
                  <a:lnTo>
                    <a:pt x="2474" y="1399"/>
                  </a:lnTo>
                  <a:lnTo>
                    <a:pt x="2479" y="1399"/>
                  </a:lnTo>
                  <a:lnTo>
                    <a:pt x="2483" y="1399"/>
                  </a:lnTo>
                  <a:lnTo>
                    <a:pt x="2488" y="1399"/>
                  </a:lnTo>
                  <a:lnTo>
                    <a:pt x="2492" y="1399"/>
                  </a:lnTo>
                  <a:lnTo>
                    <a:pt x="2497" y="1399"/>
                  </a:lnTo>
                  <a:lnTo>
                    <a:pt x="2501" y="1399"/>
                  </a:lnTo>
                  <a:lnTo>
                    <a:pt x="2506" y="1399"/>
                  </a:lnTo>
                  <a:lnTo>
                    <a:pt x="2511" y="1399"/>
                  </a:lnTo>
                  <a:lnTo>
                    <a:pt x="2515" y="1399"/>
                  </a:lnTo>
                  <a:lnTo>
                    <a:pt x="2520" y="1399"/>
                  </a:lnTo>
                  <a:lnTo>
                    <a:pt x="2524" y="1399"/>
                  </a:lnTo>
                  <a:lnTo>
                    <a:pt x="2529" y="1399"/>
                  </a:lnTo>
                  <a:lnTo>
                    <a:pt x="2533" y="1399"/>
                  </a:lnTo>
                  <a:lnTo>
                    <a:pt x="2538" y="1399"/>
                  </a:lnTo>
                  <a:lnTo>
                    <a:pt x="2542" y="1399"/>
                  </a:lnTo>
                  <a:lnTo>
                    <a:pt x="2547" y="1399"/>
                  </a:lnTo>
                  <a:lnTo>
                    <a:pt x="2551" y="1399"/>
                  </a:lnTo>
                  <a:lnTo>
                    <a:pt x="2556" y="1399"/>
                  </a:lnTo>
                  <a:lnTo>
                    <a:pt x="2561" y="1399"/>
                  </a:lnTo>
                  <a:lnTo>
                    <a:pt x="2565" y="1399"/>
                  </a:lnTo>
                  <a:lnTo>
                    <a:pt x="2570" y="1399"/>
                  </a:lnTo>
                  <a:lnTo>
                    <a:pt x="2574" y="1399"/>
                  </a:lnTo>
                  <a:lnTo>
                    <a:pt x="2579" y="1399"/>
                  </a:lnTo>
                  <a:lnTo>
                    <a:pt x="2583" y="1399"/>
                  </a:lnTo>
                  <a:lnTo>
                    <a:pt x="2588" y="1399"/>
                  </a:lnTo>
                  <a:lnTo>
                    <a:pt x="2592" y="1399"/>
                  </a:lnTo>
                  <a:lnTo>
                    <a:pt x="2597" y="1399"/>
                  </a:lnTo>
                  <a:lnTo>
                    <a:pt x="2602" y="1399"/>
                  </a:lnTo>
                  <a:lnTo>
                    <a:pt x="2606" y="1399"/>
                  </a:lnTo>
                  <a:lnTo>
                    <a:pt x="2611" y="1399"/>
                  </a:lnTo>
                  <a:lnTo>
                    <a:pt x="2615" y="1399"/>
                  </a:lnTo>
                  <a:lnTo>
                    <a:pt x="2620" y="1399"/>
                  </a:lnTo>
                  <a:lnTo>
                    <a:pt x="2624" y="1399"/>
                  </a:lnTo>
                  <a:lnTo>
                    <a:pt x="2629" y="1399"/>
                  </a:lnTo>
                  <a:lnTo>
                    <a:pt x="2634" y="1399"/>
                  </a:lnTo>
                  <a:lnTo>
                    <a:pt x="2638" y="1399"/>
                  </a:lnTo>
                  <a:lnTo>
                    <a:pt x="2643" y="1399"/>
                  </a:lnTo>
                  <a:lnTo>
                    <a:pt x="2647" y="1399"/>
                  </a:lnTo>
                  <a:lnTo>
                    <a:pt x="2652" y="1399"/>
                  </a:lnTo>
                  <a:lnTo>
                    <a:pt x="2656" y="1399"/>
                  </a:lnTo>
                  <a:lnTo>
                    <a:pt x="2661" y="1399"/>
                  </a:lnTo>
                  <a:lnTo>
                    <a:pt x="2665" y="1399"/>
                  </a:lnTo>
                  <a:lnTo>
                    <a:pt x="2670" y="1399"/>
                  </a:lnTo>
                  <a:lnTo>
                    <a:pt x="2674" y="1399"/>
                  </a:lnTo>
                  <a:lnTo>
                    <a:pt x="2679" y="1399"/>
                  </a:lnTo>
                  <a:lnTo>
                    <a:pt x="2684" y="1399"/>
                  </a:lnTo>
                  <a:lnTo>
                    <a:pt x="2688" y="1399"/>
                  </a:lnTo>
                  <a:lnTo>
                    <a:pt x="2693" y="1399"/>
                  </a:lnTo>
                  <a:lnTo>
                    <a:pt x="2697" y="1399"/>
                  </a:lnTo>
                  <a:lnTo>
                    <a:pt x="2702" y="1399"/>
                  </a:lnTo>
                  <a:lnTo>
                    <a:pt x="2706" y="1399"/>
                  </a:lnTo>
                  <a:lnTo>
                    <a:pt x="2711" y="1399"/>
                  </a:lnTo>
                  <a:lnTo>
                    <a:pt x="2715" y="1399"/>
                  </a:lnTo>
                  <a:lnTo>
                    <a:pt x="2720" y="1399"/>
                  </a:lnTo>
                  <a:lnTo>
                    <a:pt x="2724" y="1399"/>
                  </a:lnTo>
                  <a:lnTo>
                    <a:pt x="2729" y="1399"/>
                  </a:lnTo>
                  <a:lnTo>
                    <a:pt x="2733" y="1399"/>
                  </a:lnTo>
                  <a:lnTo>
                    <a:pt x="2738" y="1399"/>
                  </a:lnTo>
                  <a:lnTo>
                    <a:pt x="2743" y="1399"/>
                  </a:lnTo>
                  <a:lnTo>
                    <a:pt x="2747" y="1399"/>
                  </a:lnTo>
                  <a:lnTo>
                    <a:pt x="2752" y="1399"/>
                  </a:lnTo>
                  <a:lnTo>
                    <a:pt x="2756" y="1399"/>
                  </a:lnTo>
                  <a:lnTo>
                    <a:pt x="2761" y="1399"/>
                  </a:lnTo>
                  <a:lnTo>
                    <a:pt x="2765" y="1399"/>
                  </a:lnTo>
                  <a:lnTo>
                    <a:pt x="2770" y="1399"/>
                  </a:lnTo>
                  <a:lnTo>
                    <a:pt x="2774" y="1399"/>
                  </a:lnTo>
                  <a:lnTo>
                    <a:pt x="2779" y="1399"/>
                  </a:lnTo>
                  <a:lnTo>
                    <a:pt x="2783" y="1399"/>
                  </a:lnTo>
                  <a:lnTo>
                    <a:pt x="2788" y="1399"/>
                  </a:lnTo>
                  <a:lnTo>
                    <a:pt x="2793" y="1399"/>
                  </a:lnTo>
                  <a:lnTo>
                    <a:pt x="2797" y="1399"/>
                  </a:lnTo>
                  <a:lnTo>
                    <a:pt x="2802" y="1399"/>
                  </a:lnTo>
                  <a:lnTo>
                    <a:pt x="2806" y="1399"/>
                  </a:lnTo>
                  <a:lnTo>
                    <a:pt x="2811" y="1398"/>
                  </a:lnTo>
                  <a:lnTo>
                    <a:pt x="2815" y="1399"/>
                  </a:lnTo>
                  <a:lnTo>
                    <a:pt x="2820" y="1399"/>
                  </a:lnTo>
                  <a:lnTo>
                    <a:pt x="2824" y="1399"/>
                  </a:lnTo>
                  <a:lnTo>
                    <a:pt x="2829" y="1399"/>
                  </a:lnTo>
                  <a:lnTo>
                    <a:pt x="2833" y="1398"/>
                  </a:lnTo>
                  <a:lnTo>
                    <a:pt x="2838" y="1399"/>
                  </a:lnTo>
                  <a:lnTo>
                    <a:pt x="2843" y="1399"/>
                  </a:lnTo>
                  <a:lnTo>
                    <a:pt x="2847" y="1398"/>
                  </a:lnTo>
                  <a:lnTo>
                    <a:pt x="2852" y="1399"/>
                  </a:lnTo>
                  <a:lnTo>
                    <a:pt x="2856" y="1398"/>
                  </a:lnTo>
                  <a:lnTo>
                    <a:pt x="2861" y="1399"/>
                  </a:lnTo>
                  <a:lnTo>
                    <a:pt x="2865" y="1399"/>
                  </a:lnTo>
                  <a:lnTo>
                    <a:pt x="2870" y="1398"/>
                  </a:lnTo>
                  <a:lnTo>
                    <a:pt x="2875" y="1399"/>
                  </a:lnTo>
                  <a:lnTo>
                    <a:pt x="2879" y="1399"/>
                  </a:lnTo>
                  <a:lnTo>
                    <a:pt x="2884" y="1399"/>
                  </a:lnTo>
                  <a:lnTo>
                    <a:pt x="2888" y="1399"/>
                  </a:lnTo>
                  <a:lnTo>
                    <a:pt x="2893" y="1399"/>
                  </a:lnTo>
                  <a:lnTo>
                    <a:pt x="2897" y="1399"/>
                  </a:lnTo>
                  <a:lnTo>
                    <a:pt x="2902" y="1399"/>
                  </a:lnTo>
                  <a:lnTo>
                    <a:pt x="2906" y="1399"/>
                  </a:lnTo>
                  <a:lnTo>
                    <a:pt x="2911" y="1399"/>
                  </a:lnTo>
                  <a:lnTo>
                    <a:pt x="2916" y="1399"/>
                  </a:lnTo>
                  <a:lnTo>
                    <a:pt x="2920" y="1399"/>
                  </a:lnTo>
                  <a:lnTo>
                    <a:pt x="2925" y="1399"/>
                  </a:lnTo>
                  <a:lnTo>
                    <a:pt x="2929" y="1399"/>
                  </a:lnTo>
                  <a:lnTo>
                    <a:pt x="2934" y="1399"/>
                  </a:lnTo>
                  <a:lnTo>
                    <a:pt x="2938" y="1399"/>
                  </a:lnTo>
                  <a:lnTo>
                    <a:pt x="2943" y="1399"/>
                  </a:lnTo>
                  <a:lnTo>
                    <a:pt x="2947" y="1399"/>
                  </a:lnTo>
                  <a:lnTo>
                    <a:pt x="2952" y="1399"/>
                  </a:lnTo>
                  <a:lnTo>
                    <a:pt x="2956" y="1398"/>
                  </a:lnTo>
                  <a:lnTo>
                    <a:pt x="2961" y="1398"/>
                  </a:lnTo>
                  <a:lnTo>
                    <a:pt x="2965" y="1399"/>
                  </a:lnTo>
                  <a:lnTo>
                    <a:pt x="2970" y="1399"/>
                  </a:lnTo>
                  <a:lnTo>
                    <a:pt x="2975" y="1399"/>
                  </a:lnTo>
                  <a:lnTo>
                    <a:pt x="2979" y="1398"/>
                  </a:lnTo>
                  <a:lnTo>
                    <a:pt x="2984" y="1398"/>
                  </a:lnTo>
                  <a:lnTo>
                    <a:pt x="2988" y="1398"/>
                  </a:lnTo>
                  <a:lnTo>
                    <a:pt x="2993" y="1398"/>
                  </a:lnTo>
                  <a:lnTo>
                    <a:pt x="2997" y="1399"/>
                  </a:lnTo>
                  <a:lnTo>
                    <a:pt x="3002" y="1398"/>
                  </a:lnTo>
                  <a:lnTo>
                    <a:pt x="3006" y="1399"/>
                  </a:lnTo>
                  <a:lnTo>
                    <a:pt x="3011" y="1399"/>
                  </a:lnTo>
                  <a:lnTo>
                    <a:pt x="3015" y="1399"/>
                  </a:lnTo>
                  <a:lnTo>
                    <a:pt x="3020" y="1399"/>
                  </a:lnTo>
                  <a:lnTo>
                    <a:pt x="3025" y="1399"/>
                  </a:lnTo>
                  <a:lnTo>
                    <a:pt x="3029" y="1399"/>
                  </a:lnTo>
                  <a:lnTo>
                    <a:pt x="3034" y="1398"/>
                  </a:lnTo>
                  <a:lnTo>
                    <a:pt x="3038" y="1399"/>
                  </a:lnTo>
                  <a:lnTo>
                    <a:pt x="3043" y="1399"/>
                  </a:lnTo>
                  <a:lnTo>
                    <a:pt x="3047" y="1399"/>
                  </a:lnTo>
                  <a:lnTo>
                    <a:pt x="3052" y="1399"/>
                  </a:lnTo>
                  <a:lnTo>
                    <a:pt x="3056" y="1399"/>
                  </a:lnTo>
                  <a:lnTo>
                    <a:pt x="3061" y="1399"/>
                  </a:lnTo>
                  <a:lnTo>
                    <a:pt x="3065" y="1399"/>
                  </a:lnTo>
                  <a:lnTo>
                    <a:pt x="3070" y="1399"/>
                  </a:lnTo>
                  <a:lnTo>
                    <a:pt x="3074" y="1399"/>
                  </a:lnTo>
                  <a:lnTo>
                    <a:pt x="3079" y="1399"/>
                  </a:lnTo>
                  <a:lnTo>
                    <a:pt x="3084" y="1399"/>
                  </a:lnTo>
                  <a:lnTo>
                    <a:pt x="3088" y="1399"/>
                  </a:lnTo>
                  <a:lnTo>
                    <a:pt x="3093" y="1399"/>
                  </a:lnTo>
                  <a:lnTo>
                    <a:pt x="3097" y="1399"/>
                  </a:lnTo>
                  <a:lnTo>
                    <a:pt x="3102" y="1399"/>
                  </a:lnTo>
                  <a:lnTo>
                    <a:pt x="3106" y="1399"/>
                  </a:lnTo>
                  <a:lnTo>
                    <a:pt x="3111" y="1399"/>
                  </a:lnTo>
                  <a:lnTo>
                    <a:pt x="3116" y="1399"/>
                  </a:lnTo>
                  <a:lnTo>
                    <a:pt x="3120" y="1399"/>
                  </a:lnTo>
                  <a:lnTo>
                    <a:pt x="3125" y="1399"/>
                  </a:lnTo>
                  <a:lnTo>
                    <a:pt x="3129" y="1399"/>
                  </a:lnTo>
                  <a:lnTo>
                    <a:pt x="3134" y="1399"/>
                  </a:lnTo>
                  <a:lnTo>
                    <a:pt x="3138" y="1399"/>
                  </a:lnTo>
                  <a:lnTo>
                    <a:pt x="3143" y="1399"/>
                  </a:lnTo>
                  <a:lnTo>
                    <a:pt x="3148" y="1399"/>
                  </a:lnTo>
                  <a:lnTo>
                    <a:pt x="3152" y="1399"/>
                  </a:lnTo>
                  <a:lnTo>
                    <a:pt x="3157" y="1399"/>
                  </a:lnTo>
                  <a:lnTo>
                    <a:pt x="3161" y="1399"/>
                  </a:lnTo>
                  <a:lnTo>
                    <a:pt x="3166" y="1399"/>
                  </a:lnTo>
                  <a:lnTo>
                    <a:pt x="3170" y="1399"/>
                  </a:lnTo>
                  <a:lnTo>
                    <a:pt x="3175" y="1399"/>
                  </a:lnTo>
                  <a:lnTo>
                    <a:pt x="3179" y="1399"/>
                  </a:lnTo>
                  <a:lnTo>
                    <a:pt x="3184" y="1399"/>
                  </a:lnTo>
                  <a:lnTo>
                    <a:pt x="3188" y="1399"/>
                  </a:lnTo>
                  <a:lnTo>
                    <a:pt x="3193" y="1399"/>
                  </a:lnTo>
                  <a:lnTo>
                    <a:pt x="3197" y="1399"/>
                  </a:lnTo>
                  <a:lnTo>
                    <a:pt x="3202" y="1399"/>
                  </a:lnTo>
                  <a:lnTo>
                    <a:pt x="3207" y="1399"/>
                  </a:lnTo>
                  <a:lnTo>
                    <a:pt x="3211" y="1399"/>
                  </a:lnTo>
                  <a:lnTo>
                    <a:pt x="3216" y="1399"/>
                  </a:lnTo>
                  <a:lnTo>
                    <a:pt x="3220" y="1399"/>
                  </a:lnTo>
                  <a:lnTo>
                    <a:pt x="3225" y="1399"/>
                  </a:lnTo>
                  <a:lnTo>
                    <a:pt x="3229" y="1399"/>
                  </a:lnTo>
                  <a:lnTo>
                    <a:pt x="3234" y="1399"/>
                  </a:lnTo>
                  <a:lnTo>
                    <a:pt x="3238" y="1399"/>
                  </a:lnTo>
                  <a:lnTo>
                    <a:pt x="3243" y="1399"/>
                  </a:lnTo>
                  <a:lnTo>
                    <a:pt x="3247" y="1399"/>
                  </a:lnTo>
                  <a:lnTo>
                    <a:pt x="3252" y="1399"/>
                  </a:lnTo>
                  <a:lnTo>
                    <a:pt x="3257" y="1399"/>
                  </a:lnTo>
                  <a:lnTo>
                    <a:pt x="3261" y="1399"/>
                  </a:lnTo>
                  <a:lnTo>
                    <a:pt x="3266" y="1399"/>
                  </a:lnTo>
                  <a:lnTo>
                    <a:pt x="3270" y="1398"/>
                  </a:lnTo>
                  <a:lnTo>
                    <a:pt x="3275" y="1398"/>
                  </a:lnTo>
                  <a:lnTo>
                    <a:pt x="3279" y="1398"/>
                  </a:lnTo>
                  <a:lnTo>
                    <a:pt x="3284" y="1398"/>
                  </a:lnTo>
                  <a:lnTo>
                    <a:pt x="3288" y="1398"/>
                  </a:lnTo>
                  <a:lnTo>
                    <a:pt x="3293" y="1398"/>
                  </a:lnTo>
                  <a:lnTo>
                    <a:pt x="3297" y="1398"/>
                  </a:lnTo>
                  <a:lnTo>
                    <a:pt x="3302" y="1398"/>
                  </a:lnTo>
                  <a:lnTo>
                    <a:pt x="3306" y="1398"/>
                  </a:lnTo>
                  <a:lnTo>
                    <a:pt x="3311" y="1398"/>
                  </a:lnTo>
                  <a:lnTo>
                    <a:pt x="3316" y="1398"/>
                  </a:lnTo>
                  <a:lnTo>
                    <a:pt x="3320" y="1398"/>
                  </a:lnTo>
                  <a:lnTo>
                    <a:pt x="3325" y="1398"/>
                  </a:lnTo>
                  <a:lnTo>
                    <a:pt x="3329" y="1398"/>
                  </a:lnTo>
                  <a:lnTo>
                    <a:pt x="3334" y="1398"/>
                  </a:lnTo>
                  <a:lnTo>
                    <a:pt x="3338" y="1398"/>
                  </a:lnTo>
                  <a:lnTo>
                    <a:pt x="3343" y="1397"/>
                  </a:lnTo>
                  <a:lnTo>
                    <a:pt x="3347" y="1398"/>
                  </a:lnTo>
                  <a:lnTo>
                    <a:pt x="3352" y="1398"/>
                  </a:lnTo>
                  <a:lnTo>
                    <a:pt x="3357" y="1398"/>
                  </a:lnTo>
                  <a:lnTo>
                    <a:pt x="3361" y="1398"/>
                  </a:lnTo>
                  <a:lnTo>
                    <a:pt x="3366" y="1398"/>
                  </a:lnTo>
                  <a:lnTo>
                    <a:pt x="3370" y="1397"/>
                  </a:lnTo>
                  <a:lnTo>
                    <a:pt x="3375" y="1398"/>
                  </a:lnTo>
                  <a:lnTo>
                    <a:pt x="3379" y="1398"/>
                  </a:lnTo>
                  <a:lnTo>
                    <a:pt x="3384" y="1398"/>
                  </a:lnTo>
                  <a:lnTo>
                    <a:pt x="3389" y="1398"/>
                  </a:lnTo>
                  <a:lnTo>
                    <a:pt x="3393" y="1398"/>
                  </a:lnTo>
                  <a:lnTo>
                    <a:pt x="3398" y="1397"/>
                  </a:lnTo>
                  <a:lnTo>
                    <a:pt x="3402" y="1397"/>
                  </a:lnTo>
                  <a:lnTo>
                    <a:pt x="3407" y="1397"/>
                  </a:lnTo>
                  <a:lnTo>
                    <a:pt x="3411" y="1397"/>
                  </a:lnTo>
                  <a:lnTo>
                    <a:pt x="3416" y="1397"/>
                  </a:lnTo>
                  <a:lnTo>
                    <a:pt x="3420" y="1396"/>
                  </a:lnTo>
                  <a:lnTo>
                    <a:pt x="3425" y="1396"/>
                  </a:lnTo>
                  <a:lnTo>
                    <a:pt x="3430" y="1396"/>
                  </a:lnTo>
                  <a:lnTo>
                    <a:pt x="3434" y="1396"/>
                  </a:lnTo>
                  <a:lnTo>
                    <a:pt x="3439" y="1396"/>
                  </a:lnTo>
                  <a:lnTo>
                    <a:pt x="3443" y="1397"/>
                  </a:lnTo>
                  <a:lnTo>
                    <a:pt x="3448" y="1397"/>
                  </a:lnTo>
                  <a:lnTo>
                    <a:pt x="3452" y="1398"/>
                  </a:lnTo>
                  <a:lnTo>
                    <a:pt x="3457" y="1398"/>
                  </a:lnTo>
                  <a:lnTo>
                    <a:pt x="3461" y="1398"/>
                  </a:lnTo>
                  <a:lnTo>
                    <a:pt x="3466" y="1398"/>
                  </a:lnTo>
                  <a:lnTo>
                    <a:pt x="3470" y="1398"/>
                  </a:lnTo>
                  <a:lnTo>
                    <a:pt x="3475" y="1398"/>
                  </a:lnTo>
                  <a:lnTo>
                    <a:pt x="3479" y="1398"/>
                  </a:lnTo>
                  <a:lnTo>
                    <a:pt x="3484" y="1398"/>
                  </a:lnTo>
                  <a:lnTo>
                    <a:pt x="3489" y="1398"/>
                  </a:lnTo>
                  <a:lnTo>
                    <a:pt x="3493" y="1398"/>
                  </a:lnTo>
                  <a:lnTo>
                    <a:pt x="3498" y="1398"/>
                  </a:lnTo>
                  <a:lnTo>
                    <a:pt x="3502" y="1398"/>
                  </a:lnTo>
                  <a:lnTo>
                    <a:pt x="3507" y="1398"/>
                  </a:lnTo>
                  <a:lnTo>
                    <a:pt x="3511" y="1398"/>
                  </a:lnTo>
                  <a:lnTo>
                    <a:pt x="3516" y="1398"/>
                  </a:lnTo>
                  <a:lnTo>
                    <a:pt x="3520" y="1398"/>
                  </a:lnTo>
                  <a:lnTo>
                    <a:pt x="3525" y="1398"/>
                  </a:lnTo>
                  <a:lnTo>
                    <a:pt x="3529" y="1398"/>
                  </a:lnTo>
                  <a:lnTo>
                    <a:pt x="3534" y="1399"/>
                  </a:lnTo>
                  <a:lnTo>
                    <a:pt x="3539" y="1398"/>
                  </a:lnTo>
                  <a:lnTo>
                    <a:pt x="3543" y="1399"/>
                  </a:lnTo>
                  <a:lnTo>
                    <a:pt x="3548" y="1399"/>
                  </a:lnTo>
                  <a:lnTo>
                    <a:pt x="3552" y="1398"/>
                  </a:lnTo>
                  <a:lnTo>
                    <a:pt x="3557" y="1398"/>
                  </a:lnTo>
                  <a:lnTo>
                    <a:pt x="3561" y="1398"/>
                  </a:lnTo>
                  <a:lnTo>
                    <a:pt x="3566" y="1398"/>
                  </a:lnTo>
                  <a:lnTo>
                    <a:pt x="3570" y="1398"/>
                  </a:lnTo>
                  <a:lnTo>
                    <a:pt x="3575" y="1398"/>
                  </a:lnTo>
                  <a:lnTo>
                    <a:pt x="3579" y="1398"/>
                  </a:lnTo>
                  <a:lnTo>
                    <a:pt x="3584" y="1398"/>
                  </a:lnTo>
                  <a:lnTo>
                    <a:pt x="3588" y="1398"/>
                  </a:lnTo>
                  <a:lnTo>
                    <a:pt x="3593" y="1398"/>
                  </a:lnTo>
                  <a:lnTo>
                    <a:pt x="3598" y="1398"/>
                  </a:lnTo>
                  <a:lnTo>
                    <a:pt x="3602" y="1398"/>
                  </a:lnTo>
                  <a:lnTo>
                    <a:pt x="3607" y="1398"/>
                  </a:lnTo>
                  <a:lnTo>
                    <a:pt x="3611" y="1398"/>
                  </a:lnTo>
                  <a:lnTo>
                    <a:pt x="3616" y="1398"/>
                  </a:lnTo>
                  <a:lnTo>
                    <a:pt x="3620" y="1398"/>
                  </a:lnTo>
                  <a:lnTo>
                    <a:pt x="3625" y="1398"/>
                  </a:lnTo>
                  <a:lnTo>
                    <a:pt x="3630" y="1398"/>
                  </a:lnTo>
                  <a:lnTo>
                    <a:pt x="3634" y="1398"/>
                  </a:lnTo>
                  <a:lnTo>
                    <a:pt x="3639" y="1398"/>
                  </a:lnTo>
                  <a:lnTo>
                    <a:pt x="3643" y="1398"/>
                  </a:lnTo>
                  <a:lnTo>
                    <a:pt x="3648" y="1398"/>
                  </a:lnTo>
                  <a:lnTo>
                    <a:pt x="3652" y="1398"/>
                  </a:lnTo>
                  <a:lnTo>
                    <a:pt x="3657" y="1398"/>
                  </a:lnTo>
                  <a:lnTo>
                    <a:pt x="3662" y="1398"/>
                  </a:lnTo>
                  <a:lnTo>
                    <a:pt x="3666" y="1398"/>
                  </a:lnTo>
                  <a:lnTo>
                    <a:pt x="3671" y="1398"/>
                  </a:lnTo>
                  <a:lnTo>
                    <a:pt x="3675" y="1398"/>
                  </a:lnTo>
                  <a:lnTo>
                    <a:pt x="3680" y="1398"/>
                  </a:lnTo>
                  <a:lnTo>
                    <a:pt x="3684" y="1398"/>
                  </a:lnTo>
                  <a:lnTo>
                    <a:pt x="3689" y="1398"/>
                  </a:lnTo>
                  <a:lnTo>
                    <a:pt x="3693" y="1398"/>
                  </a:lnTo>
                  <a:lnTo>
                    <a:pt x="3698" y="1398"/>
                  </a:lnTo>
                  <a:lnTo>
                    <a:pt x="3702" y="1398"/>
                  </a:lnTo>
                  <a:lnTo>
                    <a:pt x="3707" y="1398"/>
                  </a:lnTo>
                  <a:lnTo>
                    <a:pt x="3711" y="1399"/>
                  </a:lnTo>
                  <a:lnTo>
                    <a:pt x="3716" y="1398"/>
                  </a:lnTo>
                  <a:lnTo>
                    <a:pt x="3721" y="1398"/>
                  </a:lnTo>
                  <a:lnTo>
                    <a:pt x="3725" y="1398"/>
                  </a:lnTo>
                  <a:lnTo>
                    <a:pt x="3730" y="1398"/>
                  </a:lnTo>
                  <a:lnTo>
                    <a:pt x="3734" y="1398"/>
                  </a:lnTo>
                  <a:lnTo>
                    <a:pt x="3739" y="1398"/>
                  </a:lnTo>
                  <a:lnTo>
                    <a:pt x="3743" y="1398"/>
                  </a:lnTo>
                  <a:lnTo>
                    <a:pt x="3748" y="1398"/>
                  </a:lnTo>
                  <a:lnTo>
                    <a:pt x="3752" y="1398"/>
                  </a:lnTo>
                  <a:lnTo>
                    <a:pt x="3757" y="1398"/>
                  </a:lnTo>
                  <a:lnTo>
                    <a:pt x="3761" y="1398"/>
                  </a:lnTo>
                  <a:lnTo>
                    <a:pt x="3766" y="1398"/>
                  </a:lnTo>
                  <a:lnTo>
                    <a:pt x="3771" y="1398"/>
                  </a:lnTo>
                  <a:lnTo>
                    <a:pt x="3775" y="1398"/>
                  </a:lnTo>
                  <a:lnTo>
                    <a:pt x="3780" y="1398"/>
                  </a:lnTo>
                  <a:lnTo>
                    <a:pt x="3784" y="1398"/>
                  </a:lnTo>
                  <a:lnTo>
                    <a:pt x="3789" y="1398"/>
                  </a:lnTo>
                  <a:lnTo>
                    <a:pt x="3793" y="1398"/>
                  </a:lnTo>
                  <a:lnTo>
                    <a:pt x="3798" y="1398"/>
                  </a:lnTo>
                  <a:lnTo>
                    <a:pt x="3802" y="1397"/>
                  </a:lnTo>
                  <a:lnTo>
                    <a:pt x="3807" y="1398"/>
                  </a:lnTo>
                  <a:lnTo>
                    <a:pt x="3811" y="1397"/>
                  </a:lnTo>
                  <a:lnTo>
                    <a:pt x="3816" y="1397"/>
                  </a:lnTo>
                  <a:lnTo>
                    <a:pt x="3820" y="1397"/>
                  </a:lnTo>
                  <a:lnTo>
                    <a:pt x="3825" y="1397"/>
                  </a:lnTo>
                  <a:lnTo>
                    <a:pt x="3830" y="1398"/>
                  </a:lnTo>
                  <a:lnTo>
                    <a:pt x="3834" y="1398"/>
                  </a:lnTo>
                  <a:lnTo>
                    <a:pt x="3839" y="1398"/>
                  </a:lnTo>
                  <a:lnTo>
                    <a:pt x="3843" y="1398"/>
                  </a:lnTo>
                  <a:lnTo>
                    <a:pt x="3848" y="1398"/>
                  </a:lnTo>
                  <a:lnTo>
                    <a:pt x="3852" y="1398"/>
                  </a:lnTo>
                  <a:lnTo>
                    <a:pt x="3857" y="1398"/>
                  </a:lnTo>
                  <a:lnTo>
                    <a:pt x="3861" y="1398"/>
                  </a:lnTo>
                  <a:lnTo>
                    <a:pt x="3866" y="1398"/>
                  </a:lnTo>
                  <a:lnTo>
                    <a:pt x="3871" y="1398"/>
                  </a:lnTo>
                  <a:lnTo>
                    <a:pt x="3875" y="1398"/>
                  </a:lnTo>
                  <a:lnTo>
                    <a:pt x="3880" y="1398"/>
                  </a:lnTo>
                  <a:lnTo>
                    <a:pt x="3884" y="1398"/>
                  </a:lnTo>
                  <a:lnTo>
                    <a:pt x="3889" y="1398"/>
                  </a:lnTo>
                  <a:lnTo>
                    <a:pt x="3893" y="1398"/>
                  </a:lnTo>
                  <a:lnTo>
                    <a:pt x="3898" y="1398"/>
                  </a:lnTo>
                  <a:lnTo>
                    <a:pt x="3903" y="1398"/>
                  </a:lnTo>
                  <a:lnTo>
                    <a:pt x="3907" y="1398"/>
                  </a:lnTo>
                  <a:lnTo>
                    <a:pt x="3912" y="1398"/>
                  </a:lnTo>
                  <a:lnTo>
                    <a:pt x="3916" y="1398"/>
                  </a:lnTo>
                  <a:lnTo>
                    <a:pt x="3921" y="1398"/>
                  </a:lnTo>
                  <a:lnTo>
                    <a:pt x="3925" y="1398"/>
                  </a:lnTo>
                  <a:lnTo>
                    <a:pt x="3930" y="1398"/>
                  </a:lnTo>
                  <a:lnTo>
                    <a:pt x="3934" y="1398"/>
                  </a:lnTo>
                  <a:lnTo>
                    <a:pt x="3939" y="1398"/>
                  </a:lnTo>
                  <a:lnTo>
                    <a:pt x="3943" y="1398"/>
                  </a:lnTo>
                  <a:lnTo>
                    <a:pt x="3948" y="1398"/>
                  </a:lnTo>
                  <a:lnTo>
                    <a:pt x="3953" y="1398"/>
                  </a:lnTo>
                  <a:lnTo>
                    <a:pt x="3957" y="1398"/>
                  </a:lnTo>
                  <a:lnTo>
                    <a:pt x="3962" y="1398"/>
                  </a:lnTo>
                  <a:lnTo>
                    <a:pt x="3966" y="1398"/>
                  </a:lnTo>
                  <a:lnTo>
                    <a:pt x="3971" y="1398"/>
                  </a:lnTo>
                  <a:lnTo>
                    <a:pt x="3975" y="1398"/>
                  </a:lnTo>
                  <a:lnTo>
                    <a:pt x="3980" y="1398"/>
                  </a:lnTo>
                  <a:lnTo>
                    <a:pt x="3984" y="1398"/>
                  </a:lnTo>
                  <a:lnTo>
                    <a:pt x="3989" y="1398"/>
                  </a:lnTo>
                  <a:lnTo>
                    <a:pt x="3993" y="1398"/>
                  </a:lnTo>
                  <a:lnTo>
                    <a:pt x="3998" y="1398"/>
                  </a:lnTo>
                  <a:lnTo>
                    <a:pt x="4003" y="1398"/>
                  </a:lnTo>
                  <a:lnTo>
                    <a:pt x="4007" y="1398"/>
                  </a:lnTo>
                  <a:lnTo>
                    <a:pt x="4012" y="1398"/>
                  </a:lnTo>
                  <a:lnTo>
                    <a:pt x="4016" y="1398"/>
                  </a:lnTo>
                  <a:lnTo>
                    <a:pt x="4021" y="1398"/>
                  </a:lnTo>
                  <a:lnTo>
                    <a:pt x="4025" y="1398"/>
                  </a:lnTo>
                  <a:lnTo>
                    <a:pt x="4030" y="1398"/>
                  </a:lnTo>
                  <a:lnTo>
                    <a:pt x="4034" y="1398"/>
                  </a:lnTo>
                  <a:lnTo>
                    <a:pt x="4039" y="1398"/>
                  </a:lnTo>
                  <a:lnTo>
                    <a:pt x="4043" y="1398"/>
                  </a:lnTo>
                  <a:lnTo>
                    <a:pt x="4048" y="1398"/>
                  </a:lnTo>
                  <a:lnTo>
                    <a:pt x="4052" y="1398"/>
                  </a:lnTo>
                  <a:lnTo>
                    <a:pt x="4057" y="1398"/>
                  </a:lnTo>
                  <a:lnTo>
                    <a:pt x="4062" y="1398"/>
                  </a:lnTo>
                  <a:lnTo>
                    <a:pt x="4066" y="1398"/>
                  </a:lnTo>
                  <a:lnTo>
                    <a:pt x="4071" y="1398"/>
                  </a:lnTo>
                  <a:lnTo>
                    <a:pt x="4075" y="1398"/>
                  </a:lnTo>
                  <a:lnTo>
                    <a:pt x="4080" y="1398"/>
                  </a:lnTo>
                  <a:lnTo>
                    <a:pt x="4084" y="1398"/>
                  </a:lnTo>
                  <a:lnTo>
                    <a:pt x="4089" y="1398"/>
                  </a:lnTo>
                  <a:lnTo>
                    <a:pt x="4093" y="1398"/>
                  </a:lnTo>
                  <a:lnTo>
                    <a:pt x="4098" y="1398"/>
                  </a:lnTo>
                  <a:lnTo>
                    <a:pt x="4102" y="1398"/>
                  </a:lnTo>
                  <a:lnTo>
                    <a:pt x="4107" y="1398"/>
                  </a:lnTo>
                  <a:lnTo>
                    <a:pt x="4112" y="1398"/>
                  </a:lnTo>
                  <a:lnTo>
                    <a:pt x="4116" y="1398"/>
                  </a:lnTo>
                  <a:lnTo>
                    <a:pt x="4121" y="1398"/>
                  </a:lnTo>
                  <a:lnTo>
                    <a:pt x="4125" y="1398"/>
                  </a:lnTo>
                  <a:lnTo>
                    <a:pt x="4130" y="1398"/>
                  </a:lnTo>
                  <a:lnTo>
                    <a:pt x="4134" y="1398"/>
                  </a:lnTo>
                  <a:lnTo>
                    <a:pt x="4139" y="1398"/>
                  </a:lnTo>
                  <a:lnTo>
                    <a:pt x="4144" y="1398"/>
                  </a:lnTo>
                  <a:lnTo>
                    <a:pt x="4148" y="1398"/>
                  </a:lnTo>
                  <a:lnTo>
                    <a:pt x="4153" y="1398"/>
                  </a:lnTo>
                  <a:lnTo>
                    <a:pt x="4157" y="1398"/>
                  </a:lnTo>
                  <a:lnTo>
                    <a:pt x="4162" y="1398"/>
                  </a:lnTo>
                  <a:lnTo>
                    <a:pt x="4166" y="1398"/>
                  </a:lnTo>
                  <a:lnTo>
                    <a:pt x="4171" y="1398"/>
                  </a:lnTo>
                  <a:lnTo>
                    <a:pt x="4175" y="1398"/>
                  </a:lnTo>
                  <a:lnTo>
                    <a:pt x="4180" y="1398"/>
                  </a:lnTo>
                  <a:lnTo>
                    <a:pt x="4185" y="1398"/>
                  </a:lnTo>
                  <a:lnTo>
                    <a:pt x="4189" y="1397"/>
                  </a:lnTo>
                  <a:lnTo>
                    <a:pt x="4194" y="1397"/>
                  </a:lnTo>
                  <a:lnTo>
                    <a:pt x="4198" y="1397"/>
                  </a:lnTo>
                  <a:lnTo>
                    <a:pt x="4203" y="1397"/>
                  </a:lnTo>
                  <a:lnTo>
                    <a:pt x="4207" y="1397"/>
                  </a:lnTo>
                  <a:lnTo>
                    <a:pt x="4212" y="1397"/>
                  </a:lnTo>
                  <a:lnTo>
                    <a:pt x="4216" y="1397"/>
                  </a:lnTo>
                  <a:lnTo>
                    <a:pt x="4221" y="1397"/>
                  </a:lnTo>
                  <a:lnTo>
                    <a:pt x="4225" y="1397"/>
                  </a:lnTo>
                  <a:lnTo>
                    <a:pt x="4230" y="1398"/>
                  </a:lnTo>
                  <a:lnTo>
                    <a:pt x="4235" y="1397"/>
                  </a:lnTo>
                  <a:lnTo>
                    <a:pt x="4239" y="1398"/>
                  </a:lnTo>
                  <a:lnTo>
                    <a:pt x="4244" y="1398"/>
                  </a:lnTo>
                  <a:lnTo>
                    <a:pt x="4248" y="1398"/>
                  </a:lnTo>
                  <a:lnTo>
                    <a:pt x="4253" y="1398"/>
                  </a:lnTo>
                  <a:lnTo>
                    <a:pt x="4257" y="1398"/>
                  </a:lnTo>
                  <a:lnTo>
                    <a:pt x="4262" y="1397"/>
                  </a:lnTo>
                  <a:lnTo>
                    <a:pt x="4266" y="1397"/>
                  </a:lnTo>
                  <a:lnTo>
                    <a:pt x="4271" y="1397"/>
                  </a:lnTo>
                  <a:lnTo>
                    <a:pt x="4275" y="1397"/>
                  </a:lnTo>
                  <a:lnTo>
                    <a:pt x="4280" y="1397"/>
                  </a:lnTo>
                  <a:lnTo>
                    <a:pt x="4284" y="1396"/>
                  </a:lnTo>
                  <a:lnTo>
                    <a:pt x="4289" y="1396"/>
                  </a:lnTo>
                  <a:lnTo>
                    <a:pt x="4294" y="1396"/>
                  </a:lnTo>
                  <a:lnTo>
                    <a:pt x="4298" y="1396"/>
                  </a:lnTo>
                  <a:lnTo>
                    <a:pt x="4303" y="1396"/>
                  </a:lnTo>
                  <a:lnTo>
                    <a:pt x="4307" y="1396"/>
                  </a:lnTo>
                  <a:lnTo>
                    <a:pt x="4312" y="1397"/>
                  </a:lnTo>
                  <a:lnTo>
                    <a:pt x="4316" y="1397"/>
                  </a:lnTo>
                  <a:lnTo>
                    <a:pt x="4321" y="1397"/>
                  </a:lnTo>
                  <a:lnTo>
                    <a:pt x="4325" y="1397"/>
                  </a:lnTo>
                  <a:lnTo>
                    <a:pt x="4330" y="1398"/>
                  </a:lnTo>
                  <a:lnTo>
                    <a:pt x="4334" y="1398"/>
                  </a:lnTo>
                  <a:lnTo>
                    <a:pt x="4339" y="1397"/>
                  </a:lnTo>
                  <a:lnTo>
                    <a:pt x="4344" y="1397"/>
                  </a:lnTo>
                  <a:lnTo>
                    <a:pt x="4348" y="1398"/>
                  </a:lnTo>
                  <a:lnTo>
                    <a:pt x="4353" y="1397"/>
                  </a:lnTo>
                  <a:lnTo>
                    <a:pt x="4357" y="1398"/>
                  </a:lnTo>
                  <a:lnTo>
                    <a:pt x="4362" y="1397"/>
                  </a:lnTo>
                  <a:lnTo>
                    <a:pt x="4366" y="1397"/>
                  </a:lnTo>
                  <a:lnTo>
                    <a:pt x="4371" y="1397"/>
                  </a:lnTo>
                  <a:lnTo>
                    <a:pt x="4375" y="1398"/>
                  </a:lnTo>
                  <a:lnTo>
                    <a:pt x="4380" y="1397"/>
                  </a:lnTo>
                  <a:lnTo>
                    <a:pt x="4385" y="1397"/>
                  </a:lnTo>
                  <a:lnTo>
                    <a:pt x="4389" y="1397"/>
                  </a:lnTo>
                  <a:lnTo>
                    <a:pt x="4394" y="1397"/>
                  </a:lnTo>
                  <a:lnTo>
                    <a:pt x="4398" y="1397"/>
                  </a:lnTo>
                  <a:lnTo>
                    <a:pt x="4403" y="1397"/>
                  </a:lnTo>
                  <a:lnTo>
                    <a:pt x="4407" y="1397"/>
                  </a:lnTo>
                  <a:lnTo>
                    <a:pt x="4412" y="1397"/>
                  </a:lnTo>
                  <a:lnTo>
                    <a:pt x="4417" y="1397"/>
                  </a:lnTo>
                  <a:lnTo>
                    <a:pt x="4421" y="1397"/>
                  </a:lnTo>
                  <a:lnTo>
                    <a:pt x="4426" y="1397"/>
                  </a:lnTo>
                  <a:lnTo>
                    <a:pt x="4430" y="1397"/>
                  </a:lnTo>
                  <a:lnTo>
                    <a:pt x="4435" y="1397"/>
                  </a:lnTo>
                  <a:lnTo>
                    <a:pt x="4439" y="1397"/>
                  </a:lnTo>
                  <a:lnTo>
                    <a:pt x="4444" y="1397"/>
                  </a:lnTo>
                  <a:lnTo>
                    <a:pt x="4448" y="1397"/>
                  </a:lnTo>
                  <a:lnTo>
                    <a:pt x="4453" y="1397"/>
                  </a:lnTo>
                  <a:lnTo>
                    <a:pt x="4457" y="1397"/>
                  </a:lnTo>
                  <a:lnTo>
                    <a:pt x="4462" y="1397"/>
                  </a:lnTo>
                  <a:lnTo>
                    <a:pt x="4467" y="1397"/>
                  </a:lnTo>
                  <a:lnTo>
                    <a:pt x="4471" y="1397"/>
                  </a:lnTo>
                  <a:lnTo>
                    <a:pt x="4476" y="1397"/>
                  </a:lnTo>
                  <a:lnTo>
                    <a:pt x="4480" y="1397"/>
                  </a:lnTo>
                  <a:lnTo>
                    <a:pt x="4485" y="1397"/>
                  </a:lnTo>
                  <a:lnTo>
                    <a:pt x="4489" y="1397"/>
                  </a:lnTo>
                  <a:lnTo>
                    <a:pt x="4494" y="1397"/>
                  </a:lnTo>
                  <a:lnTo>
                    <a:pt x="4498" y="1397"/>
                  </a:lnTo>
                  <a:lnTo>
                    <a:pt x="4503" y="1397"/>
                  </a:lnTo>
                  <a:lnTo>
                    <a:pt x="4507" y="1397"/>
                  </a:lnTo>
                  <a:lnTo>
                    <a:pt x="4512" y="1397"/>
                  </a:lnTo>
                  <a:lnTo>
                    <a:pt x="4516" y="1397"/>
                  </a:lnTo>
                  <a:lnTo>
                    <a:pt x="4521" y="1397"/>
                  </a:lnTo>
                  <a:lnTo>
                    <a:pt x="4526" y="1397"/>
                  </a:lnTo>
                  <a:lnTo>
                    <a:pt x="4530" y="1397"/>
                  </a:lnTo>
                  <a:lnTo>
                    <a:pt x="4535" y="1397"/>
                  </a:lnTo>
                  <a:lnTo>
                    <a:pt x="4539" y="1397"/>
                  </a:lnTo>
                  <a:lnTo>
                    <a:pt x="4544" y="1397"/>
                  </a:lnTo>
                  <a:lnTo>
                    <a:pt x="4548" y="1397"/>
                  </a:lnTo>
                  <a:lnTo>
                    <a:pt x="4553" y="1397"/>
                  </a:lnTo>
                  <a:lnTo>
                    <a:pt x="4557" y="1397"/>
                  </a:lnTo>
                  <a:lnTo>
                    <a:pt x="4562" y="1397"/>
                  </a:lnTo>
                  <a:lnTo>
                    <a:pt x="4566" y="1397"/>
                  </a:lnTo>
                  <a:lnTo>
                    <a:pt x="4571" y="1397"/>
                  </a:lnTo>
                  <a:lnTo>
                    <a:pt x="4576" y="1397"/>
                  </a:lnTo>
                  <a:lnTo>
                    <a:pt x="4580" y="1397"/>
                  </a:lnTo>
                  <a:lnTo>
                    <a:pt x="4585" y="1397"/>
                  </a:lnTo>
                  <a:lnTo>
                    <a:pt x="4589" y="1397"/>
                  </a:lnTo>
                  <a:lnTo>
                    <a:pt x="4594" y="1397"/>
                  </a:lnTo>
                  <a:lnTo>
                    <a:pt x="4598" y="1397"/>
                  </a:lnTo>
                  <a:lnTo>
                    <a:pt x="4603" y="1397"/>
                  </a:lnTo>
                  <a:lnTo>
                    <a:pt x="4607" y="1397"/>
                  </a:lnTo>
                  <a:lnTo>
                    <a:pt x="4612" y="1397"/>
                  </a:lnTo>
                  <a:lnTo>
                    <a:pt x="4616" y="1397"/>
                  </a:lnTo>
                  <a:lnTo>
                    <a:pt x="4621" y="1397"/>
                  </a:lnTo>
                  <a:lnTo>
                    <a:pt x="4626" y="1397"/>
                  </a:lnTo>
                  <a:lnTo>
                    <a:pt x="4630" y="1397"/>
                  </a:lnTo>
                  <a:lnTo>
                    <a:pt x="4635" y="1397"/>
                  </a:lnTo>
                  <a:lnTo>
                    <a:pt x="4639" y="1397"/>
                  </a:lnTo>
                  <a:lnTo>
                    <a:pt x="4644" y="1397"/>
                  </a:lnTo>
                  <a:lnTo>
                    <a:pt x="4648" y="1397"/>
                  </a:lnTo>
                  <a:lnTo>
                    <a:pt x="4653" y="1397"/>
                  </a:lnTo>
                  <a:lnTo>
                    <a:pt x="4658" y="1397"/>
                  </a:lnTo>
                  <a:lnTo>
                    <a:pt x="4662" y="1397"/>
                  </a:lnTo>
                  <a:lnTo>
                    <a:pt x="4667" y="1397"/>
                  </a:lnTo>
                  <a:lnTo>
                    <a:pt x="4671" y="1396"/>
                  </a:lnTo>
                  <a:lnTo>
                    <a:pt x="4676" y="1396"/>
                  </a:lnTo>
                  <a:lnTo>
                    <a:pt x="4680" y="1396"/>
                  </a:lnTo>
                  <a:lnTo>
                    <a:pt x="4685" y="1396"/>
                  </a:lnTo>
                  <a:lnTo>
                    <a:pt x="4689" y="1396"/>
                  </a:lnTo>
                  <a:lnTo>
                    <a:pt x="4694" y="1396"/>
                  </a:lnTo>
                  <a:lnTo>
                    <a:pt x="4699" y="1396"/>
                  </a:lnTo>
                  <a:lnTo>
                    <a:pt x="4703" y="1396"/>
                  </a:lnTo>
                  <a:lnTo>
                    <a:pt x="4708" y="1396"/>
                  </a:lnTo>
                  <a:lnTo>
                    <a:pt x="4712" y="1396"/>
                  </a:lnTo>
                  <a:lnTo>
                    <a:pt x="4717" y="1396"/>
                  </a:lnTo>
                  <a:lnTo>
                    <a:pt x="4721" y="1396"/>
                  </a:lnTo>
                  <a:lnTo>
                    <a:pt x="4726" y="1396"/>
                  </a:lnTo>
                  <a:lnTo>
                    <a:pt x="4730" y="1396"/>
                  </a:lnTo>
                  <a:lnTo>
                    <a:pt x="4735" y="1396"/>
                  </a:lnTo>
                  <a:lnTo>
                    <a:pt x="4739" y="1396"/>
                  </a:lnTo>
                  <a:lnTo>
                    <a:pt x="4744" y="1396"/>
                  </a:lnTo>
                  <a:lnTo>
                    <a:pt x="4749" y="1396"/>
                  </a:lnTo>
                  <a:lnTo>
                    <a:pt x="4753" y="1396"/>
                  </a:lnTo>
                  <a:lnTo>
                    <a:pt x="4758" y="1396"/>
                  </a:lnTo>
                  <a:lnTo>
                    <a:pt x="4762" y="1395"/>
                  </a:lnTo>
                  <a:lnTo>
                    <a:pt x="4767" y="1395"/>
                  </a:lnTo>
                  <a:lnTo>
                    <a:pt x="4771" y="1395"/>
                  </a:lnTo>
                  <a:lnTo>
                    <a:pt x="4776" y="1395"/>
                  </a:lnTo>
                  <a:lnTo>
                    <a:pt x="4780" y="1396"/>
                  </a:lnTo>
                  <a:lnTo>
                    <a:pt x="4785" y="1396"/>
                  </a:lnTo>
                  <a:lnTo>
                    <a:pt x="4789" y="1396"/>
                  </a:lnTo>
                  <a:lnTo>
                    <a:pt x="4794" y="1396"/>
                  </a:lnTo>
                  <a:lnTo>
                    <a:pt x="4798" y="1396"/>
                  </a:lnTo>
                  <a:lnTo>
                    <a:pt x="4803" y="1396"/>
                  </a:lnTo>
                  <a:lnTo>
                    <a:pt x="4808" y="1396"/>
                  </a:lnTo>
                  <a:lnTo>
                    <a:pt x="4812" y="1396"/>
                  </a:lnTo>
                  <a:lnTo>
                    <a:pt x="4817" y="1396"/>
                  </a:lnTo>
                  <a:lnTo>
                    <a:pt x="4821" y="1396"/>
                  </a:lnTo>
                  <a:lnTo>
                    <a:pt x="4826" y="1396"/>
                  </a:lnTo>
                  <a:lnTo>
                    <a:pt x="4830" y="1395"/>
                  </a:lnTo>
                  <a:lnTo>
                    <a:pt x="4835" y="1396"/>
                  </a:lnTo>
                  <a:lnTo>
                    <a:pt x="4839" y="1395"/>
                  </a:lnTo>
                  <a:lnTo>
                    <a:pt x="4844" y="1395"/>
                  </a:lnTo>
                  <a:lnTo>
                    <a:pt x="4848" y="1395"/>
                  </a:lnTo>
                  <a:lnTo>
                    <a:pt x="4853" y="1395"/>
                  </a:lnTo>
                  <a:lnTo>
                    <a:pt x="4858" y="1395"/>
                  </a:lnTo>
                  <a:lnTo>
                    <a:pt x="4862" y="1395"/>
                  </a:lnTo>
                  <a:lnTo>
                    <a:pt x="4867" y="1395"/>
                  </a:lnTo>
                  <a:lnTo>
                    <a:pt x="4871" y="1395"/>
                  </a:lnTo>
                  <a:lnTo>
                    <a:pt x="4876" y="1395"/>
                  </a:lnTo>
                  <a:lnTo>
                    <a:pt x="4880" y="1395"/>
                  </a:lnTo>
                  <a:lnTo>
                    <a:pt x="4885" y="1395"/>
                  </a:lnTo>
                  <a:lnTo>
                    <a:pt x="4889" y="1395"/>
                  </a:lnTo>
                  <a:lnTo>
                    <a:pt x="4894" y="1395"/>
                  </a:lnTo>
                  <a:lnTo>
                    <a:pt x="4899" y="1395"/>
                  </a:lnTo>
                  <a:lnTo>
                    <a:pt x="4903" y="1395"/>
                  </a:lnTo>
                  <a:lnTo>
                    <a:pt x="4908" y="1395"/>
                  </a:lnTo>
                  <a:lnTo>
                    <a:pt x="4912" y="1395"/>
                  </a:lnTo>
                  <a:lnTo>
                    <a:pt x="4917" y="1395"/>
                  </a:lnTo>
                  <a:lnTo>
                    <a:pt x="4921" y="1395"/>
                  </a:lnTo>
                  <a:lnTo>
                    <a:pt x="4926" y="1395"/>
                  </a:lnTo>
                  <a:lnTo>
                    <a:pt x="4931" y="1394"/>
                  </a:lnTo>
                  <a:lnTo>
                    <a:pt x="4935" y="1394"/>
                  </a:lnTo>
                  <a:lnTo>
                    <a:pt x="4940" y="1394"/>
                  </a:lnTo>
                  <a:lnTo>
                    <a:pt x="4944" y="1394"/>
                  </a:lnTo>
                  <a:lnTo>
                    <a:pt x="4949" y="1394"/>
                  </a:lnTo>
                  <a:lnTo>
                    <a:pt x="4953" y="1394"/>
                  </a:lnTo>
                  <a:lnTo>
                    <a:pt x="4958" y="1393"/>
                  </a:lnTo>
                  <a:lnTo>
                    <a:pt x="4962" y="1392"/>
                  </a:lnTo>
                  <a:lnTo>
                    <a:pt x="4967" y="1389"/>
                  </a:lnTo>
                  <a:lnTo>
                    <a:pt x="4971" y="1384"/>
                  </a:lnTo>
                  <a:lnTo>
                    <a:pt x="4976" y="1371"/>
                  </a:lnTo>
                  <a:lnTo>
                    <a:pt x="4981" y="1345"/>
                  </a:lnTo>
                  <a:lnTo>
                    <a:pt x="4985" y="1300"/>
                  </a:lnTo>
                  <a:lnTo>
                    <a:pt x="4990" y="1225"/>
                  </a:lnTo>
                  <a:lnTo>
                    <a:pt x="4992" y="1174"/>
                  </a:lnTo>
                  <a:lnTo>
                    <a:pt x="4994" y="1114"/>
                  </a:lnTo>
                  <a:lnTo>
                    <a:pt x="4996" y="1043"/>
                  </a:lnTo>
                  <a:lnTo>
                    <a:pt x="4999" y="963"/>
                  </a:lnTo>
                  <a:lnTo>
                    <a:pt x="5001" y="873"/>
                  </a:lnTo>
                  <a:lnTo>
                    <a:pt x="5003" y="771"/>
                  </a:lnTo>
                  <a:lnTo>
                    <a:pt x="5005" y="657"/>
                  </a:lnTo>
                  <a:lnTo>
                    <a:pt x="5008" y="528"/>
                  </a:lnTo>
                  <a:lnTo>
                    <a:pt x="5012" y="240"/>
                  </a:lnTo>
                  <a:lnTo>
                    <a:pt x="5015" y="110"/>
                  </a:lnTo>
                  <a:lnTo>
                    <a:pt x="5017" y="21"/>
                  </a:lnTo>
                  <a:lnTo>
                    <a:pt x="5019" y="0"/>
                  </a:lnTo>
                  <a:lnTo>
                    <a:pt x="5021" y="61"/>
                  </a:lnTo>
                  <a:lnTo>
                    <a:pt x="5024" y="201"/>
                  </a:lnTo>
                  <a:lnTo>
                    <a:pt x="5026" y="398"/>
                  </a:lnTo>
                  <a:lnTo>
                    <a:pt x="5030" y="829"/>
                  </a:lnTo>
                  <a:lnTo>
                    <a:pt x="5033" y="1009"/>
                  </a:lnTo>
                  <a:lnTo>
                    <a:pt x="5035" y="1146"/>
                  </a:lnTo>
                  <a:lnTo>
                    <a:pt x="5037" y="1241"/>
                  </a:lnTo>
                  <a:lnTo>
                    <a:pt x="5040" y="1303"/>
                  </a:lnTo>
                  <a:lnTo>
                    <a:pt x="5042" y="1340"/>
                  </a:lnTo>
                  <a:lnTo>
                    <a:pt x="5044" y="1362"/>
                  </a:lnTo>
                  <a:lnTo>
                    <a:pt x="5049" y="1381"/>
                  </a:lnTo>
                  <a:lnTo>
                    <a:pt x="5053" y="1388"/>
                  </a:lnTo>
                  <a:lnTo>
                    <a:pt x="5058" y="1390"/>
                  </a:lnTo>
                  <a:lnTo>
                    <a:pt x="5062" y="1391"/>
                  </a:lnTo>
                  <a:lnTo>
                    <a:pt x="5067" y="1391"/>
                  </a:lnTo>
                  <a:lnTo>
                    <a:pt x="5071" y="1391"/>
                  </a:lnTo>
                  <a:lnTo>
                    <a:pt x="5076" y="1391"/>
                  </a:lnTo>
                  <a:lnTo>
                    <a:pt x="5080" y="1391"/>
                  </a:lnTo>
                  <a:lnTo>
                    <a:pt x="5085" y="1391"/>
                  </a:lnTo>
                  <a:lnTo>
                    <a:pt x="5090" y="1391"/>
                  </a:lnTo>
                  <a:lnTo>
                    <a:pt x="5094" y="1392"/>
                  </a:lnTo>
                  <a:lnTo>
                    <a:pt x="5099" y="1392"/>
                  </a:lnTo>
                  <a:lnTo>
                    <a:pt x="5103" y="1391"/>
                  </a:lnTo>
                  <a:lnTo>
                    <a:pt x="5108" y="1391"/>
                  </a:lnTo>
                  <a:lnTo>
                    <a:pt x="5112" y="1391"/>
                  </a:lnTo>
                  <a:lnTo>
                    <a:pt x="5117" y="1391"/>
                  </a:lnTo>
                  <a:lnTo>
                    <a:pt x="5121" y="1392"/>
                  </a:lnTo>
                  <a:lnTo>
                    <a:pt x="5126" y="1391"/>
                  </a:lnTo>
                  <a:lnTo>
                    <a:pt x="5130" y="1391"/>
                  </a:lnTo>
                  <a:lnTo>
                    <a:pt x="5135" y="1392"/>
                  </a:lnTo>
                  <a:lnTo>
                    <a:pt x="5140" y="1391"/>
                  </a:lnTo>
                  <a:lnTo>
                    <a:pt x="5144" y="1391"/>
                  </a:lnTo>
                  <a:lnTo>
                    <a:pt x="5149" y="1391"/>
                  </a:lnTo>
                  <a:lnTo>
                    <a:pt x="5153" y="1391"/>
                  </a:lnTo>
                  <a:lnTo>
                    <a:pt x="5158" y="1391"/>
                  </a:lnTo>
                  <a:lnTo>
                    <a:pt x="5162" y="1391"/>
                  </a:lnTo>
                  <a:lnTo>
                    <a:pt x="5167" y="1391"/>
                  </a:lnTo>
                  <a:lnTo>
                    <a:pt x="5172" y="1391"/>
                  </a:lnTo>
                  <a:lnTo>
                    <a:pt x="5176" y="1391"/>
                  </a:lnTo>
                  <a:lnTo>
                    <a:pt x="5181" y="1391"/>
                  </a:lnTo>
                  <a:lnTo>
                    <a:pt x="5185" y="1390"/>
                  </a:lnTo>
                  <a:lnTo>
                    <a:pt x="5190" y="1390"/>
                  </a:lnTo>
                  <a:lnTo>
                    <a:pt x="5194" y="1390"/>
                  </a:lnTo>
                  <a:lnTo>
                    <a:pt x="5199" y="1390"/>
                  </a:lnTo>
                  <a:lnTo>
                    <a:pt x="5203" y="1390"/>
                  </a:lnTo>
                  <a:lnTo>
                    <a:pt x="5208" y="1390"/>
                  </a:lnTo>
                  <a:lnTo>
                    <a:pt x="5213" y="1389"/>
                  </a:lnTo>
                  <a:lnTo>
                    <a:pt x="5217" y="1389"/>
                  </a:lnTo>
                  <a:lnTo>
                    <a:pt x="5222" y="1389"/>
                  </a:lnTo>
                  <a:lnTo>
                    <a:pt x="5226" y="1389"/>
                  </a:lnTo>
                  <a:lnTo>
                    <a:pt x="5231" y="1389"/>
                  </a:lnTo>
                  <a:lnTo>
                    <a:pt x="5235" y="1389"/>
                  </a:lnTo>
                  <a:lnTo>
                    <a:pt x="5240" y="1389"/>
                  </a:lnTo>
                  <a:lnTo>
                    <a:pt x="5244" y="1388"/>
                  </a:lnTo>
                  <a:lnTo>
                    <a:pt x="5249" y="1388"/>
                  </a:lnTo>
                  <a:lnTo>
                    <a:pt x="5253" y="1388"/>
                  </a:lnTo>
                  <a:lnTo>
                    <a:pt x="5258" y="1388"/>
                  </a:lnTo>
                  <a:lnTo>
                    <a:pt x="5262" y="1388"/>
                  </a:lnTo>
                  <a:lnTo>
                    <a:pt x="5267" y="1388"/>
                  </a:lnTo>
                  <a:lnTo>
                    <a:pt x="5272" y="1387"/>
                  </a:lnTo>
                  <a:lnTo>
                    <a:pt x="5276" y="1387"/>
                  </a:lnTo>
                  <a:lnTo>
                    <a:pt x="5281" y="1386"/>
                  </a:lnTo>
                  <a:lnTo>
                    <a:pt x="5285" y="1386"/>
                  </a:lnTo>
                  <a:lnTo>
                    <a:pt x="5290" y="1386"/>
                  </a:lnTo>
                  <a:lnTo>
                    <a:pt x="5294" y="1385"/>
                  </a:lnTo>
                  <a:lnTo>
                    <a:pt x="5299" y="1385"/>
                  </a:lnTo>
                  <a:lnTo>
                    <a:pt x="5303" y="1386"/>
                  </a:lnTo>
                  <a:lnTo>
                    <a:pt x="5308" y="1386"/>
                  </a:lnTo>
                  <a:lnTo>
                    <a:pt x="5312" y="1387"/>
                  </a:lnTo>
                  <a:lnTo>
                    <a:pt x="5317" y="1387"/>
                  </a:lnTo>
                  <a:lnTo>
                    <a:pt x="5322" y="1388"/>
                  </a:lnTo>
                  <a:lnTo>
                    <a:pt x="5326" y="1388"/>
                  </a:lnTo>
                  <a:lnTo>
                    <a:pt x="5331" y="1388"/>
                  </a:lnTo>
                  <a:lnTo>
                    <a:pt x="5335" y="1388"/>
                  </a:lnTo>
                  <a:lnTo>
                    <a:pt x="5340" y="1388"/>
                  </a:lnTo>
                  <a:lnTo>
                    <a:pt x="5344" y="1388"/>
                  </a:lnTo>
                  <a:lnTo>
                    <a:pt x="5349" y="1388"/>
                  </a:lnTo>
                  <a:lnTo>
                    <a:pt x="5353" y="1388"/>
                  </a:lnTo>
                  <a:lnTo>
                    <a:pt x="5358" y="1388"/>
                  </a:lnTo>
                  <a:lnTo>
                    <a:pt x="5362" y="1388"/>
                  </a:lnTo>
                  <a:lnTo>
                    <a:pt x="5367" y="1388"/>
                  </a:lnTo>
                  <a:lnTo>
                    <a:pt x="5372" y="1388"/>
                  </a:lnTo>
                  <a:lnTo>
                    <a:pt x="5376" y="1388"/>
                  </a:lnTo>
                  <a:lnTo>
                    <a:pt x="5381" y="1388"/>
                  </a:lnTo>
                  <a:lnTo>
                    <a:pt x="5385" y="1388"/>
                  </a:lnTo>
                  <a:lnTo>
                    <a:pt x="5390" y="1388"/>
                  </a:lnTo>
                  <a:lnTo>
                    <a:pt x="5394" y="1388"/>
                  </a:lnTo>
                  <a:lnTo>
                    <a:pt x="5399" y="1388"/>
                  </a:lnTo>
                  <a:lnTo>
                    <a:pt x="5403" y="1388"/>
                  </a:lnTo>
                  <a:lnTo>
                    <a:pt x="5408" y="1388"/>
                  </a:lnTo>
                  <a:lnTo>
                    <a:pt x="5413" y="1388"/>
                  </a:lnTo>
                  <a:lnTo>
                    <a:pt x="5417" y="1388"/>
                  </a:lnTo>
                  <a:lnTo>
                    <a:pt x="5422" y="1389"/>
                  </a:lnTo>
                  <a:lnTo>
                    <a:pt x="5426" y="1389"/>
                  </a:lnTo>
                  <a:lnTo>
                    <a:pt x="5431" y="1389"/>
                  </a:lnTo>
                  <a:lnTo>
                    <a:pt x="5435" y="1390"/>
                  </a:lnTo>
                  <a:lnTo>
                    <a:pt x="5440" y="1390"/>
                  </a:lnTo>
                  <a:lnTo>
                    <a:pt x="5445" y="1391"/>
                  </a:lnTo>
                  <a:lnTo>
                    <a:pt x="5449" y="1391"/>
                  </a:lnTo>
                  <a:lnTo>
                    <a:pt x="5454" y="1392"/>
                  </a:lnTo>
                  <a:lnTo>
                    <a:pt x="5458" y="1392"/>
                  </a:lnTo>
                  <a:lnTo>
                    <a:pt x="5463" y="1393"/>
                  </a:lnTo>
                  <a:lnTo>
                    <a:pt x="5467" y="1393"/>
                  </a:lnTo>
                  <a:lnTo>
                    <a:pt x="5472" y="1394"/>
                  </a:lnTo>
                  <a:lnTo>
                    <a:pt x="5476" y="1394"/>
                  </a:lnTo>
                  <a:lnTo>
                    <a:pt x="5481" y="1394"/>
                  </a:lnTo>
                  <a:lnTo>
                    <a:pt x="5485" y="1395"/>
                  </a:lnTo>
                  <a:lnTo>
                    <a:pt x="5490" y="1395"/>
                  </a:lnTo>
                  <a:lnTo>
                    <a:pt x="5494" y="1395"/>
                  </a:lnTo>
                  <a:lnTo>
                    <a:pt x="5499" y="1396"/>
                  </a:lnTo>
                  <a:lnTo>
                    <a:pt x="5504" y="1396"/>
                  </a:lnTo>
                  <a:lnTo>
                    <a:pt x="5508" y="1396"/>
                  </a:lnTo>
                  <a:lnTo>
                    <a:pt x="5513" y="1396"/>
                  </a:lnTo>
                  <a:lnTo>
                    <a:pt x="5517" y="1397"/>
                  </a:lnTo>
                  <a:lnTo>
                    <a:pt x="5522" y="1397"/>
                  </a:lnTo>
                  <a:lnTo>
                    <a:pt x="5526" y="1397"/>
                  </a:lnTo>
                  <a:lnTo>
                    <a:pt x="5531" y="1397"/>
                  </a:lnTo>
                  <a:lnTo>
                    <a:pt x="5535" y="1397"/>
                  </a:lnTo>
                  <a:lnTo>
                    <a:pt x="5540" y="1397"/>
                  </a:lnTo>
                  <a:lnTo>
                    <a:pt x="5544" y="1397"/>
                  </a:lnTo>
                  <a:lnTo>
                    <a:pt x="5549" y="1397"/>
                  </a:lnTo>
                  <a:lnTo>
                    <a:pt x="5554" y="1398"/>
                  </a:lnTo>
                  <a:lnTo>
                    <a:pt x="5558" y="1398"/>
                  </a:lnTo>
                  <a:lnTo>
                    <a:pt x="5563" y="1398"/>
                  </a:lnTo>
                  <a:lnTo>
                    <a:pt x="5567" y="1398"/>
                  </a:lnTo>
                  <a:lnTo>
                    <a:pt x="5572" y="1398"/>
                  </a:lnTo>
                  <a:lnTo>
                    <a:pt x="5576" y="1398"/>
                  </a:lnTo>
                  <a:lnTo>
                    <a:pt x="5581" y="1398"/>
                  </a:lnTo>
                  <a:lnTo>
                    <a:pt x="5585" y="1398"/>
                  </a:lnTo>
                  <a:lnTo>
                    <a:pt x="5590" y="1399"/>
                  </a:lnTo>
                  <a:lnTo>
                    <a:pt x="5594" y="1399"/>
                  </a:lnTo>
                  <a:lnTo>
                    <a:pt x="5599" y="1399"/>
                  </a:lnTo>
                  <a:lnTo>
                    <a:pt x="5603" y="1399"/>
                  </a:lnTo>
                  <a:lnTo>
                    <a:pt x="5608" y="1399"/>
                  </a:lnTo>
                  <a:lnTo>
                    <a:pt x="5613" y="1399"/>
                  </a:lnTo>
                  <a:lnTo>
                    <a:pt x="5617" y="1399"/>
                  </a:lnTo>
                  <a:lnTo>
                    <a:pt x="5622" y="1399"/>
                  </a:lnTo>
                  <a:lnTo>
                    <a:pt x="5626" y="1399"/>
                  </a:lnTo>
                  <a:lnTo>
                    <a:pt x="5631" y="1399"/>
                  </a:lnTo>
                  <a:lnTo>
                    <a:pt x="5635" y="1399"/>
                  </a:lnTo>
                  <a:lnTo>
                    <a:pt x="5640" y="1399"/>
                  </a:lnTo>
                  <a:lnTo>
                    <a:pt x="5644" y="1399"/>
                  </a:lnTo>
                  <a:lnTo>
                    <a:pt x="5649" y="1399"/>
                  </a:lnTo>
                  <a:lnTo>
                    <a:pt x="5654" y="1399"/>
                  </a:lnTo>
                  <a:lnTo>
                    <a:pt x="5658" y="1399"/>
                  </a:lnTo>
                  <a:lnTo>
                    <a:pt x="5663" y="1399"/>
                  </a:lnTo>
                  <a:lnTo>
                    <a:pt x="5667" y="1399"/>
                  </a:lnTo>
                  <a:lnTo>
                    <a:pt x="5672" y="1399"/>
                  </a:lnTo>
                  <a:lnTo>
                    <a:pt x="5676" y="1399"/>
                  </a:lnTo>
                  <a:lnTo>
                    <a:pt x="5681" y="1399"/>
                  </a:lnTo>
                  <a:lnTo>
                    <a:pt x="5686" y="1399"/>
                  </a:lnTo>
                  <a:lnTo>
                    <a:pt x="5690" y="1399"/>
                  </a:lnTo>
                  <a:lnTo>
                    <a:pt x="5695" y="1399"/>
                  </a:lnTo>
                  <a:lnTo>
                    <a:pt x="5699" y="1399"/>
                  </a:lnTo>
                  <a:lnTo>
                    <a:pt x="5704" y="1399"/>
                  </a:lnTo>
                  <a:lnTo>
                    <a:pt x="5708" y="1399"/>
                  </a:lnTo>
                  <a:lnTo>
                    <a:pt x="5713" y="1399"/>
                  </a:lnTo>
                  <a:lnTo>
                    <a:pt x="5717" y="1399"/>
                  </a:lnTo>
                  <a:lnTo>
                    <a:pt x="5722" y="1399"/>
                  </a:lnTo>
                  <a:lnTo>
                    <a:pt x="5726" y="1399"/>
                  </a:lnTo>
                  <a:lnTo>
                    <a:pt x="5731" y="1399"/>
                  </a:lnTo>
                  <a:lnTo>
                    <a:pt x="5736" y="1399"/>
                  </a:lnTo>
                  <a:lnTo>
                    <a:pt x="5740" y="1399"/>
                  </a:lnTo>
                  <a:lnTo>
                    <a:pt x="5745" y="1399"/>
                  </a:lnTo>
                  <a:lnTo>
                    <a:pt x="5749" y="1399"/>
                  </a:lnTo>
                  <a:lnTo>
                    <a:pt x="5754" y="1399"/>
                  </a:lnTo>
                  <a:lnTo>
                    <a:pt x="5758" y="1399"/>
                  </a:lnTo>
                  <a:lnTo>
                    <a:pt x="5763" y="1399"/>
                  </a:lnTo>
                  <a:lnTo>
                    <a:pt x="5767" y="1399"/>
                  </a:lnTo>
                  <a:lnTo>
                    <a:pt x="5772" y="1399"/>
                  </a:lnTo>
                  <a:lnTo>
                    <a:pt x="5776" y="1399"/>
                  </a:lnTo>
                  <a:lnTo>
                    <a:pt x="5781" y="1399"/>
                  </a:lnTo>
                  <a:lnTo>
                    <a:pt x="5786" y="1399"/>
                  </a:lnTo>
                  <a:lnTo>
                    <a:pt x="5790" y="1399"/>
                  </a:lnTo>
                  <a:lnTo>
                    <a:pt x="5795" y="1399"/>
                  </a:lnTo>
                  <a:lnTo>
                    <a:pt x="5799" y="1399"/>
                  </a:lnTo>
                  <a:lnTo>
                    <a:pt x="5804" y="1399"/>
                  </a:lnTo>
                  <a:lnTo>
                    <a:pt x="5808" y="1399"/>
                  </a:lnTo>
                  <a:lnTo>
                    <a:pt x="5813" y="1400"/>
                  </a:lnTo>
                  <a:lnTo>
                    <a:pt x="5817" y="1399"/>
                  </a:lnTo>
                  <a:lnTo>
                    <a:pt x="5822" y="1399"/>
                  </a:lnTo>
                  <a:lnTo>
                    <a:pt x="5826" y="1399"/>
                  </a:lnTo>
                  <a:lnTo>
                    <a:pt x="5831" y="1400"/>
                  </a:lnTo>
                  <a:lnTo>
                    <a:pt x="5835" y="1399"/>
                  </a:lnTo>
                  <a:lnTo>
                    <a:pt x="5840" y="1400"/>
                  </a:lnTo>
                  <a:lnTo>
                    <a:pt x="5845" y="1399"/>
                  </a:lnTo>
                  <a:lnTo>
                    <a:pt x="5849" y="1399"/>
                  </a:lnTo>
                  <a:lnTo>
                    <a:pt x="5854" y="1399"/>
                  </a:lnTo>
                  <a:lnTo>
                    <a:pt x="5858" y="1399"/>
                  </a:lnTo>
                  <a:lnTo>
                    <a:pt x="5863" y="1399"/>
                  </a:lnTo>
                  <a:lnTo>
                    <a:pt x="5867" y="1400"/>
                  </a:lnTo>
                  <a:lnTo>
                    <a:pt x="5872" y="1399"/>
                  </a:lnTo>
                  <a:lnTo>
                    <a:pt x="5876" y="1400"/>
                  </a:lnTo>
                  <a:lnTo>
                    <a:pt x="5881" y="1399"/>
                  </a:lnTo>
                  <a:lnTo>
                    <a:pt x="5885" y="1400"/>
                  </a:lnTo>
                  <a:lnTo>
                    <a:pt x="5890" y="1400"/>
                  </a:lnTo>
                  <a:lnTo>
                    <a:pt x="5895" y="1400"/>
                  </a:lnTo>
                  <a:lnTo>
                    <a:pt x="5899" y="1400"/>
                  </a:lnTo>
                  <a:lnTo>
                    <a:pt x="5904" y="1399"/>
                  </a:lnTo>
                  <a:lnTo>
                    <a:pt x="5908" y="1400"/>
                  </a:lnTo>
                  <a:lnTo>
                    <a:pt x="5913" y="1400"/>
                  </a:lnTo>
                  <a:lnTo>
                    <a:pt x="5917" y="1400"/>
                  </a:lnTo>
                  <a:lnTo>
                    <a:pt x="5922" y="1399"/>
                  </a:lnTo>
                  <a:lnTo>
                    <a:pt x="5927" y="1399"/>
                  </a:lnTo>
                  <a:lnTo>
                    <a:pt x="5931" y="1400"/>
                  </a:lnTo>
                  <a:lnTo>
                    <a:pt x="5936" y="1399"/>
                  </a:lnTo>
                  <a:lnTo>
                    <a:pt x="5940" y="1400"/>
                  </a:lnTo>
                  <a:lnTo>
                    <a:pt x="5945" y="1400"/>
                  </a:lnTo>
                  <a:lnTo>
                    <a:pt x="5949" y="1400"/>
                  </a:lnTo>
                  <a:lnTo>
                    <a:pt x="5954" y="1400"/>
                  </a:lnTo>
                  <a:lnTo>
                    <a:pt x="5958" y="1399"/>
                  </a:lnTo>
                  <a:lnTo>
                    <a:pt x="5963" y="1400"/>
                  </a:lnTo>
                  <a:lnTo>
                    <a:pt x="5968" y="1400"/>
                  </a:lnTo>
                  <a:lnTo>
                    <a:pt x="5972" y="1400"/>
                  </a:lnTo>
                  <a:lnTo>
                    <a:pt x="5977" y="1400"/>
                  </a:lnTo>
                  <a:lnTo>
                    <a:pt x="5981" y="1400"/>
                  </a:lnTo>
                  <a:lnTo>
                    <a:pt x="5986" y="1400"/>
                  </a:lnTo>
                  <a:lnTo>
                    <a:pt x="5990" y="1400"/>
                  </a:lnTo>
                  <a:lnTo>
                    <a:pt x="5995" y="1400"/>
                  </a:lnTo>
                  <a:lnTo>
                    <a:pt x="5999" y="1400"/>
                  </a:lnTo>
                  <a:lnTo>
                    <a:pt x="6004" y="1400"/>
                  </a:lnTo>
                  <a:lnTo>
                    <a:pt x="6008" y="1400"/>
                  </a:lnTo>
                  <a:lnTo>
                    <a:pt x="6013" y="1400"/>
                  </a:lnTo>
                  <a:lnTo>
                    <a:pt x="6018" y="1400"/>
                  </a:lnTo>
                  <a:lnTo>
                    <a:pt x="6022" y="1400"/>
                  </a:lnTo>
                  <a:lnTo>
                    <a:pt x="6027" y="1400"/>
                  </a:lnTo>
                  <a:lnTo>
                    <a:pt x="6031" y="1400"/>
                  </a:lnTo>
                  <a:lnTo>
                    <a:pt x="6036" y="1400"/>
                  </a:lnTo>
                  <a:lnTo>
                    <a:pt x="6040" y="1400"/>
                  </a:lnTo>
                  <a:lnTo>
                    <a:pt x="6045" y="1400"/>
                  </a:lnTo>
                  <a:lnTo>
                    <a:pt x="6049" y="1400"/>
                  </a:lnTo>
                  <a:lnTo>
                    <a:pt x="6054" y="1400"/>
                  </a:lnTo>
                  <a:lnTo>
                    <a:pt x="6058" y="1400"/>
                  </a:lnTo>
                  <a:lnTo>
                    <a:pt x="6063" y="1400"/>
                  </a:lnTo>
                  <a:lnTo>
                    <a:pt x="6068" y="1399"/>
                  </a:lnTo>
                  <a:lnTo>
                    <a:pt x="6072" y="1400"/>
                  </a:lnTo>
                  <a:lnTo>
                    <a:pt x="6077" y="1400"/>
                  </a:lnTo>
                  <a:lnTo>
                    <a:pt x="6081" y="1400"/>
                  </a:lnTo>
                  <a:lnTo>
                    <a:pt x="6086" y="1400"/>
                  </a:lnTo>
                  <a:lnTo>
                    <a:pt x="6090" y="1400"/>
                  </a:lnTo>
                  <a:lnTo>
                    <a:pt x="6095" y="1400"/>
                  </a:lnTo>
                  <a:lnTo>
                    <a:pt x="6099" y="1400"/>
                  </a:lnTo>
                  <a:lnTo>
                    <a:pt x="6104" y="1400"/>
                  </a:lnTo>
                  <a:lnTo>
                    <a:pt x="6108" y="1399"/>
                  </a:lnTo>
                  <a:lnTo>
                    <a:pt x="6113" y="1400"/>
                  </a:lnTo>
                  <a:lnTo>
                    <a:pt x="6117" y="1400"/>
                  </a:lnTo>
                  <a:lnTo>
                    <a:pt x="6122" y="1400"/>
                  </a:lnTo>
                  <a:lnTo>
                    <a:pt x="6127" y="1400"/>
                  </a:lnTo>
                  <a:lnTo>
                    <a:pt x="6131" y="1400"/>
                  </a:lnTo>
                  <a:lnTo>
                    <a:pt x="6136" y="1400"/>
                  </a:lnTo>
                  <a:lnTo>
                    <a:pt x="6140" y="1400"/>
                  </a:lnTo>
                  <a:lnTo>
                    <a:pt x="6145" y="1400"/>
                  </a:lnTo>
                  <a:lnTo>
                    <a:pt x="6149" y="1399"/>
                  </a:lnTo>
                  <a:lnTo>
                    <a:pt x="6154" y="1400"/>
                  </a:lnTo>
                  <a:lnTo>
                    <a:pt x="6159" y="1399"/>
                  </a:lnTo>
                  <a:lnTo>
                    <a:pt x="6163" y="1399"/>
                  </a:lnTo>
                  <a:lnTo>
                    <a:pt x="6168" y="1400"/>
                  </a:lnTo>
                  <a:lnTo>
                    <a:pt x="6172" y="1400"/>
                  </a:lnTo>
                  <a:lnTo>
                    <a:pt x="6177" y="1400"/>
                  </a:lnTo>
                  <a:lnTo>
                    <a:pt x="6181" y="1400"/>
                  </a:lnTo>
                  <a:lnTo>
                    <a:pt x="6186" y="1400"/>
                  </a:lnTo>
                  <a:lnTo>
                    <a:pt x="6190" y="1400"/>
                  </a:lnTo>
                  <a:lnTo>
                    <a:pt x="6195" y="1400"/>
                  </a:lnTo>
                  <a:lnTo>
                    <a:pt x="6200" y="1399"/>
                  </a:lnTo>
                  <a:lnTo>
                    <a:pt x="6204" y="1400"/>
                  </a:lnTo>
                  <a:lnTo>
                    <a:pt x="6209" y="1400"/>
                  </a:lnTo>
                  <a:lnTo>
                    <a:pt x="6213" y="1400"/>
                  </a:lnTo>
                  <a:lnTo>
                    <a:pt x="6218" y="1400"/>
                  </a:lnTo>
                  <a:lnTo>
                    <a:pt x="6222" y="1400"/>
                  </a:lnTo>
                  <a:lnTo>
                    <a:pt x="6227" y="1400"/>
                  </a:lnTo>
                  <a:lnTo>
                    <a:pt x="6231" y="1399"/>
                  </a:lnTo>
                  <a:lnTo>
                    <a:pt x="6236" y="1400"/>
                  </a:lnTo>
                  <a:lnTo>
                    <a:pt x="6240" y="1400"/>
                  </a:lnTo>
                  <a:lnTo>
                    <a:pt x="6245" y="1400"/>
                  </a:lnTo>
                  <a:lnTo>
                    <a:pt x="6250" y="1400"/>
                  </a:lnTo>
                  <a:lnTo>
                    <a:pt x="6254" y="1400"/>
                  </a:lnTo>
                  <a:lnTo>
                    <a:pt x="6259" y="1400"/>
                  </a:lnTo>
                  <a:lnTo>
                    <a:pt x="6263" y="1400"/>
                  </a:lnTo>
                  <a:lnTo>
                    <a:pt x="6268" y="1400"/>
                  </a:lnTo>
                  <a:lnTo>
                    <a:pt x="6272" y="1400"/>
                  </a:lnTo>
                  <a:lnTo>
                    <a:pt x="6277" y="1400"/>
                  </a:lnTo>
                  <a:lnTo>
                    <a:pt x="6281" y="1400"/>
                  </a:lnTo>
                  <a:lnTo>
                    <a:pt x="6286" y="1400"/>
                  </a:lnTo>
                  <a:lnTo>
                    <a:pt x="6290" y="1400"/>
                  </a:lnTo>
                  <a:lnTo>
                    <a:pt x="6295" y="1400"/>
                  </a:lnTo>
                  <a:lnTo>
                    <a:pt x="6300" y="1400"/>
                  </a:lnTo>
                  <a:lnTo>
                    <a:pt x="6304" y="1400"/>
                  </a:lnTo>
                  <a:lnTo>
                    <a:pt x="6309" y="1400"/>
                  </a:lnTo>
                  <a:lnTo>
                    <a:pt x="6313" y="1400"/>
                  </a:lnTo>
                  <a:lnTo>
                    <a:pt x="6318" y="1400"/>
                  </a:lnTo>
                  <a:lnTo>
                    <a:pt x="6322" y="1400"/>
                  </a:lnTo>
                  <a:lnTo>
                    <a:pt x="6327" y="1400"/>
                  </a:lnTo>
                  <a:lnTo>
                    <a:pt x="6331" y="1400"/>
                  </a:lnTo>
                  <a:lnTo>
                    <a:pt x="6336" y="1400"/>
                  </a:lnTo>
                  <a:lnTo>
                    <a:pt x="6340" y="1400"/>
                  </a:lnTo>
                  <a:lnTo>
                    <a:pt x="6345" y="1400"/>
                  </a:lnTo>
                  <a:lnTo>
                    <a:pt x="6349" y="1400"/>
                  </a:lnTo>
                  <a:lnTo>
                    <a:pt x="6354" y="1400"/>
                  </a:lnTo>
                  <a:lnTo>
                    <a:pt x="6359" y="1400"/>
                  </a:lnTo>
                  <a:lnTo>
                    <a:pt x="6363" y="1400"/>
                  </a:lnTo>
                  <a:lnTo>
                    <a:pt x="6368" y="1400"/>
                  </a:lnTo>
                  <a:lnTo>
                    <a:pt x="6372" y="1400"/>
                  </a:lnTo>
                  <a:lnTo>
                    <a:pt x="6377" y="1400"/>
                  </a:lnTo>
                  <a:lnTo>
                    <a:pt x="6381" y="1400"/>
                  </a:lnTo>
                  <a:lnTo>
                    <a:pt x="6386" y="1400"/>
                  </a:lnTo>
                  <a:lnTo>
                    <a:pt x="6390" y="1400"/>
                  </a:lnTo>
                  <a:lnTo>
                    <a:pt x="6395" y="1400"/>
                  </a:lnTo>
                  <a:lnTo>
                    <a:pt x="6399" y="1400"/>
                  </a:lnTo>
                  <a:lnTo>
                    <a:pt x="6404" y="1400"/>
                  </a:lnTo>
                  <a:lnTo>
                    <a:pt x="6409" y="1400"/>
                  </a:lnTo>
                  <a:lnTo>
                    <a:pt x="6413" y="1400"/>
                  </a:lnTo>
                  <a:lnTo>
                    <a:pt x="6418" y="1400"/>
                  </a:lnTo>
                  <a:lnTo>
                    <a:pt x="6422" y="1400"/>
                  </a:lnTo>
                  <a:lnTo>
                    <a:pt x="6427" y="1400"/>
                  </a:lnTo>
                  <a:lnTo>
                    <a:pt x="6431" y="1400"/>
                  </a:lnTo>
                  <a:lnTo>
                    <a:pt x="6436" y="1400"/>
                  </a:lnTo>
                  <a:lnTo>
                    <a:pt x="6441" y="1400"/>
                  </a:lnTo>
                  <a:lnTo>
                    <a:pt x="6445" y="1400"/>
                  </a:lnTo>
                  <a:lnTo>
                    <a:pt x="6450" y="1400"/>
                  </a:lnTo>
                  <a:lnTo>
                    <a:pt x="6454" y="1400"/>
                  </a:lnTo>
                  <a:lnTo>
                    <a:pt x="6459" y="1400"/>
                  </a:lnTo>
                  <a:lnTo>
                    <a:pt x="6463" y="1400"/>
                  </a:lnTo>
                  <a:lnTo>
                    <a:pt x="6468" y="1400"/>
                  </a:lnTo>
                  <a:lnTo>
                    <a:pt x="6472" y="1400"/>
                  </a:lnTo>
                  <a:lnTo>
                    <a:pt x="6477" y="1400"/>
                  </a:lnTo>
                  <a:lnTo>
                    <a:pt x="6482" y="1400"/>
                  </a:lnTo>
                  <a:lnTo>
                    <a:pt x="6486" y="1400"/>
                  </a:lnTo>
                  <a:lnTo>
                    <a:pt x="6491" y="1400"/>
                  </a:lnTo>
                  <a:lnTo>
                    <a:pt x="6495" y="1400"/>
                  </a:lnTo>
                  <a:lnTo>
                    <a:pt x="6500" y="1400"/>
                  </a:lnTo>
                  <a:lnTo>
                    <a:pt x="6504" y="1400"/>
                  </a:lnTo>
                  <a:lnTo>
                    <a:pt x="6509" y="1400"/>
                  </a:lnTo>
                  <a:lnTo>
                    <a:pt x="6513" y="1400"/>
                  </a:lnTo>
                  <a:lnTo>
                    <a:pt x="6518" y="1400"/>
                  </a:lnTo>
                  <a:lnTo>
                    <a:pt x="6522" y="1400"/>
                  </a:lnTo>
                  <a:lnTo>
                    <a:pt x="6527" y="1400"/>
                  </a:lnTo>
                  <a:lnTo>
                    <a:pt x="6532" y="1400"/>
                  </a:lnTo>
                  <a:lnTo>
                    <a:pt x="6536" y="1400"/>
                  </a:lnTo>
                  <a:lnTo>
                    <a:pt x="6541" y="1400"/>
                  </a:lnTo>
                  <a:lnTo>
                    <a:pt x="6545" y="1400"/>
                  </a:lnTo>
                  <a:lnTo>
                    <a:pt x="6550" y="1400"/>
                  </a:lnTo>
                  <a:lnTo>
                    <a:pt x="6554" y="1400"/>
                  </a:lnTo>
                  <a:lnTo>
                    <a:pt x="6559" y="1400"/>
                  </a:lnTo>
                  <a:lnTo>
                    <a:pt x="6563" y="1400"/>
                  </a:lnTo>
                  <a:lnTo>
                    <a:pt x="6568" y="1400"/>
                  </a:lnTo>
                  <a:lnTo>
                    <a:pt x="6572" y="1400"/>
                  </a:lnTo>
                  <a:lnTo>
                    <a:pt x="6577" y="1400"/>
                  </a:lnTo>
                  <a:lnTo>
                    <a:pt x="6581" y="1400"/>
                  </a:lnTo>
                  <a:lnTo>
                    <a:pt x="6586" y="1400"/>
                  </a:lnTo>
                  <a:lnTo>
                    <a:pt x="6591" y="1400"/>
                  </a:lnTo>
                  <a:lnTo>
                    <a:pt x="6595" y="1400"/>
                  </a:lnTo>
                  <a:lnTo>
                    <a:pt x="6600" y="1400"/>
                  </a:lnTo>
                  <a:lnTo>
                    <a:pt x="6604" y="1400"/>
                  </a:lnTo>
                  <a:lnTo>
                    <a:pt x="6609" y="1400"/>
                  </a:lnTo>
                  <a:lnTo>
                    <a:pt x="6613" y="1399"/>
                  </a:lnTo>
                  <a:lnTo>
                    <a:pt x="6618" y="1400"/>
                  </a:lnTo>
                  <a:lnTo>
                    <a:pt x="6622" y="1400"/>
                  </a:lnTo>
                  <a:lnTo>
                    <a:pt x="6627" y="1400"/>
                  </a:lnTo>
                  <a:lnTo>
                    <a:pt x="6631" y="1399"/>
                  </a:lnTo>
                  <a:lnTo>
                    <a:pt x="6636" y="1399"/>
                  </a:lnTo>
                  <a:lnTo>
                    <a:pt x="6641" y="1400"/>
                  </a:lnTo>
                  <a:lnTo>
                    <a:pt x="6645" y="1399"/>
                  </a:lnTo>
                  <a:lnTo>
                    <a:pt x="6650" y="1399"/>
                  </a:lnTo>
                  <a:lnTo>
                    <a:pt x="6654" y="1399"/>
                  </a:lnTo>
                  <a:lnTo>
                    <a:pt x="6659" y="1399"/>
                  </a:lnTo>
                  <a:lnTo>
                    <a:pt x="6663" y="1399"/>
                  </a:lnTo>
                  <a:lnTo>
                    <a:pt x="6668" y="1399"/>
                  </a:lnTo>
                  <a:lnTo>
                    <a:pt x="6672" y="1399"/>
                  </a:lnTo>
                  <a:lnTo>
                    <a:pt x="6677" y="1399"/>
                  </a:lnTo>
                  <a:lnTo>
                    <a:pt x="6682" y="1399"/>
                  </a:lnTo>
                  <a:lnTo>
                    <a:pt x="6686" y="1399"/>
                  </a:lnTo>
                  <a:lnTo>
                    <a:pt x="6691" y="1399"/>
                  </a:lnTo>
                  <a:lnTo>
                    <a:pt x="6695" y="1399"/>
                  </a:lnTo>
                  <a:lnTo>
                    <a:pt x="6700" y="1399"/>
                  </a:lnTo>
                  <a:lnTo>
                    <a:pt x="6704" y="1399"/>
                  </a:lnTo>
                  <a:lnTo>
                    <a:pt x="6709" y="1399"/>
                  </a:lnTo>
                  <a:lnTo>
                    <a:pt x="6714" y="1399"/>
                  </a:lnTo>
                  <a:lnTo>
                    <a:pt x="6718" y="1399"/>
                  </a:lnTo>
                  <a:lnTo>
                    <a:pt x="6723" y="1399"/>
                  </a:lnTo>
                  <a:lnTo>
                    <a:pt x="6727" y="1399"/>
                  </a:lnTo>
                  <a:lnTo>
                    <a:pt x="6732" y="1399"/>
                  </a:lnTo>
                  <a:lnTo>
                    <a:pt x="6736" y="1399"/>
                  </a:lnTo>
                  <a:lnTo>
                    <a:pt x="6741" y="1399"/>
                  </a:lnTo>
                  <a:lnTo>
                    <a:pt x="6745" y="1399"/>
                  </a:lnTo>
                  <a:lnTo>
                    <a:pt x="6750" y="1399"/>
                  </a:lnTo>
                  <a:lnTo>
                    <a:pt x="6754" y="1399"/>
                  </a:lnTo>
                  <a:lnTo>
                    <a:pt x="6759" y="1399"/>
                  </a:lnTo>
                  <a:lnTo>
                    <a:pt x="6764" y="1399"/>
                  </a:lnTo>
                  <a:lnTo>
                    <a:pt x="6768" y="1399"/>
                  </a:lnTo>
                  <a:lnTo>
                    <a:pt x="6773" y="1399"/>
                  </a:lnTo>
                  <a:lnTo>
                    <a:pt x="6777" y="1399"/>
                  </a:lnTo>
                  <a:lnTo>
                    <a:pt x="6782" y="1399"/>
                  </a:lnTo>
                  <a:lnTo>
                    <a:pt x="6786" y="1399"/>
                  </a:lnTo>
                  <a:lnTo>
                    <a:pt x="6791" y="1399"/>
                  </a:lnTo>
                  <a:lnTo>
                    <a:pt x="6795" y="1399"/>
                  </a:lnTo>
                  <a:lnTo>
                    <a:pt x="6800" y="1399"/>
                  </a:lnTo>
                  <a:lnTo>
                    <a:pt x="6804" y="1399"/>
                  </a:lnTo>
                  <a:lnTo>
                    <a:pt x="6809" y="1399"/>
                  </a:lnTo>
                  <a:lnTo>
                    <a:pt x="6813" y="1399"/>
                  </a:lnTo>
                  <a:lnTo>
                    <a:pt x="6818" y="1399"/>
                  </a:lnTo>
                  <a:lnTo>
                    <a:pt x="6823" y="1399"/>
                  </a:lnTo>
                </a:path>
              </a:pathLst>
            </a:custGeom>
            <a:noFill/>
            <a:ln w="19050"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81213" tIns="40607" rIns="81213" bIns="40607" numCol="1" anchor="t" anchorCtr="0" compatLnSpc="1">
              <a:prstTxWarp prst="textNoShape">
                <a:avLst/>
              </a:prstTxWarp>
            </a:bodyPr>
            <a:lstStyle/>
            <a:p>
              <a:endParaRPr lang="en-US" sz="700" b="1" dirty="0"/>
            </a:p>
          </p:txBody>
        </p:sp>
        <p:sp>
          <p:nvSpPr>
            <p:cNvPr id="9" name="Rectangle 208">
              <a:extLst>
                <a:ext uri="{FF2B5EF4-FFF2-40B4-BE49-F238E27FC236}">
                  <a16:creationId xmlns:a16="http://schemas.microsoft.com/office/drawing/2014/main" id="{25F25D73-1B96-4F4E-CCB2-FAC56C6F0929}"/>
                </a:ext>
              </a:extLst>
            </p:cNvPr>
            <p:cNvSpPr>
              <a:spLocks noChangeArrowheads="1"/>
            </p:cNvSpPr>
            <p:nvPr/>
          </p:nvSpPr>
          <p:spPr bwMode="auto">
            <a:xfrm>
              <a:off x="8798151" y="4627153"/>
              <a:ext cx="140968" cy="947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min</a:t>
              </a:r>
              <a:endParaRPr lang="en-US" altLang="en-US" sz="700" b="1"/>
            </a:p>
          </p:txBody>
        </p:sp>
        <p:sp>
          <p:nvSpPr>
            <p:cNvPr id="10" name="Rectangle 209">
              <a:extLst>
                <a:ext uri="{FF2B5EF4-FFF2-40B4-BE49-F238E27FC236}">
                  <a16:creationId xmlns:a16="http://schemas.microsoft.com/office/drawing/2014/main" id="{FD27A4ED-9235-E5EA-A389-7E2905D19C02}"/>
                </a:ext>
              </a:extLst>
            </p:cNvPr>
            <p:cNvSpPr>
              <a:spLocks noChangeArrowheads="1"/>
            </p:cNvSpPr>
            <p:nvPr/>
          </p:nvSpPr>
          <p:spPr bwMode="auto">
            <a:xfrm>
              <a:off x="1929649" y="2883067"/>
              <a:ext cx="183259" cy="947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812129"/>
              <a:r>
                <a:rPr lang="en-US" altLang="en-US" sz="700" b="1">
                  <a:solidFill>
                    <a:srgbClr val="000000"/>
                  </a:solidFill>
                </a:rPr>
                <a:t>mAU</a:t>
              </a:r>
              <a:endParaRPr lang="en-US" altLang="en-US" sz="700" b="1"/>
            </a:p>
          </p:txBody>
        </p:sp>
        <p:sp>
          <p:nvSpPr>
            <p:cNvPr id="11" name="Rectangle 210">
              <a:extLst>
                <a:ext uri="{FF2B5EF4-FFF2-40B4-BE49-F238E27FC236}">
                  <a16:creationId xmlns:a16="http://schemas.microsoft.com/office/drawing/2014/main" id="{F62FC19C-9C2F-37E3-E4B5-ABF90420A767}"/>
                </a:ext>
              </a:extLst>
            </p:cNvPr>
            <p:cNvSpPr>
              <a:spLocks noChangeArrowheads="1"/>
            </p:cNvSpPr>
            <p:nvPr/>
          </p:nvSpPr>
          <p:spPr bwMode="auto">
            <a:xfrm>
              <a:off x="1907079" y="2883245"/>
              <a:ext cx="6999820" cy="1829449"/>
            </a:xfrm>
            <a:prstGeom prst="rect">
              <a:avLst/>
            </a:prstGeom>
            <a:noFill/>
            <a:ln w="190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81213" tIns="40607" rIns="81213" bIns="40607" numCol="1" anchor="t" anchorCtr="0" compatLnSpc="1">
              <a:prstTxWarp prst="textNoShape">
                <a:avLst/>
              </a:prstTxWarp>
            </a:bodyPr>
            <a:lstStyle/>
            <a:p>
              <a:endParaRPr lang="en-US" sz="700" b="1"/>
            </a:p>
          </p:txBody>
        </p:sp>
        <p:pic>
          <p:nvPicPr>
            <p:cNvPr id="12" name="Picture 214">
              <a:extLst>
                <a:ext uri="{FF2B5EF4-FFF2-40B4-BE49-F238E27FC236}">
                  <a16:creationId xmlns:a16="http://schemas.microsoft.com/office/drawing/2014/main" id="{6825380D-26AA-3F00-1279-84CC1AEF00E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07079" y="2812080"/>
              <a:ext cx="58477" cy="47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14" name="Picture 389" descr="trans-Anethole 99 4180-23-8">
              <a:extLst>
                <a:ext uri="{FF2B5EF4-FFF2-40B4-BE49-F238E27FC236}">
                  <a16:creationId xmlns:a16="http://schemas.microsoft.com/office/drawing/2014/main" id="{1C71B48F-4CAD-7568-9CDC-16273D061A4B}"/>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247627" y="3060076"/>
              <a:ext cx="1412076" cy="465861"/>
            </a:xfrm>
            <a:prstGeom prst="rect">
              <a:avLst/>
            </a:prstGeom>
            <a:noFill/>
            <a:extLst>
              <a:ext uri="{909E8E84-426E-40DD-AFC4-6F175D3DCCD1}">
                <a14:hiddenFill xmlns:a14="http://schemas.microsoft.com/office/drawing/2010/main">
                  <a:solidFill>
                    <a:srgbClr val="FFFFFF"/>
                  </a:solidFill>
                </a14:hiddenFill>
              </a:ext>
            </a:extLst>
          </p:spPr>
        </p:pic>
        <p:sp>
          <p:nvSpPr>
            <p:cNvPr id="415" name="TextBox 414">
              <a:extLst>
                <a:ext uri="{FF2B5EF4-FFF2-40B4-BE49-F238E27FC236}">
                  <a16:creationId xmlns:a16="http://schemas.microsoft.com/office/drawing/2014/main" id="{CDAFA6E0-2714-C451-79F8-43202FDE9615}"/>
                </a:ext>
              </a:extLst>
            </p:cNvPr>
            <p:cNvSpPr txBox="1"/>
            <p:nvPr/>
          </p:nvSpPr>
          <p:spPr>
            <a:xfrm>
              <a:off x="7340967" y="3506271"/>
              <a:ext cx="1230938" cy="230061"/>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nethole standard</a:t>
              </a:r>
            </a:p>
          </p:txBody>
        </p:sp>
        <p:sp>
          <p:nvSpPr>
            <p:cNvPr id="416" name="Arrow: Down 1544">
              <a:extLst>
                <a:ext uri="{FF2B5EF4-FFF2-40B4-BE49-F238E27FC236}">
                  <a16:creationId xmlns:a16="http://schemas.microsoft.com/office/drawing/2014/main" id="{C371568E-CB3E-C502-384F-30B2CCBECC1C}"/>
                </a:ext>
              </a:extLst>
            </p:cNvPr>
            <p:cNvSpPr/>
            <p:nvPr/>
          </p:nvSpPr>
          <p:spPr>
            <a:xfrm rot="5400000">
              <a:off x="7128230" y="3219785"/>
              <a:ext cx="67156" cy="148919"/>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sz="2000">
                <a:ln w="0">
                  <a:solidFill>
                    <a:sysClr val="windowText" lastClr="000000"/>
                  </a:solidFill>
                </a:ln>
                <a:solidFill>
                  <a:schemeClr val="tx1"/>
                </a:solidFill>
                <a:effectLst>
                  <a:outerShdw blurRad="38100" dist="19050" dir="2700000" algn="tl" rotWithShape="0">
                    <a:schemeClr val="dk1">
                      <a:alpha val="40000"/>
                    </a:schemeClr>
                  </a:outerShdw>
                </a:effectLst>
              </a:endParaRPr>
            </a:p>
          </p:txBody>
        </p:sp>
        <p:sp>
          <p:nvSpPr>
            <p:cNvPr id="421" name="TextBox 420">
              <a:extLst>
                <a:ext uri="{FF2B5EF4-FFF2-40B4-BE49-F238E27FC236}">
                  <a16:creationId xmlns:a16="http://schemas.microsoft.com/office/drawing/2014/main" id="{210C56CA-8B57-EFFB-14F4-347EED3F81EC}"/>
                </a:ext>
              </a:extLst>
            </p:cNvPr>
            <p:cNvSpPr txBox="1"/>
            <p:nvPr/>
          </p:nvSpPr>
          <p:spPr>
            <a:xfrm>
              <a:off x="3251223" y="3004721"/>
              <a:ext cx="1560805" cy="270660"/>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nethole Standard</a:t>
              </a:r>
            </a:p>
          </p:txBody>
        </p:sp>
      </p:grpSp>
      <p:sp>
        <p:nvSpPr>
          <p:cNvPr id="422" name="TextBox 421">
            <a:extLst>
              <a:ext uri="{FF2B5EF4-FFF2-40B4-BE49-F238E27FC236}">
                <a16:creationId xmlns:a16="http://schemas.microsoft.com/office/drawing/2014/main" id="{01BF9F5D-D56F-AD78-4FF5-A02CCCFB2A46}"/>
              </a:ext>
            </a:extLst>
          </p:cNvPr>
          <p:cNvSpPr txBox="1"/>
          <p:nvPr/>
        </p:nvSpPr>
        <p:spPr>
          <a:xfrm>
            <a:off x="1338433" y="370933"/>
            <a:ext cx="499363" cy="523220"/>
          </a:xfrm>
          <a:prstGeom prst="rect">
            <a:avLst/>
          </a:prstGeom>
          <a:noFill/>
        </p:spPr>
        <p:txBody>
          <a:bodyPr wrap="square">
            <a:spAutoFit/>
          </a:bodyPr>
          <a:lstStyle/>
          <a:p>
            <a:r>
              <a:rPr lang="en-US" altLang="ko-KR" sz="2800" b="1" dirty="0"/>
              <a:t>A</a:t>
            </a:r>
            <a:endParaRPr lang="ko-KR" altLang="en-US" sz="2800" dirty="0"/>
          </a:p>
        </p:txBody>
      </p:sp>
      <p:sp>
        <p:nvSpPr>
          <p:cNvPr id="423" name="TextBox 422">
            <a:extLst>
              <a:ext uri="{FF2B5EF4-FFF2-40B4-BE49-F238E27FC236}">
                <a16:creationId xmlns:a16="http://schemas.microsoft.com/office/drawing/2014/main" id="{5FCD125B-EDFB-4D68-5100-46C1433CA7B6}"/>
              </a:ext>
            </a:extLst>
          </p:cNvPr>
          <p:cNvSpPr txBox="1"/>
          <p:nvPr/>
        </p:nvSpPr>
        <p:spPr>
          <a:xfrm>
            <a:off x="1329807" y="2699026"/>
            <a:ext cx="499363" cy="523220"/>
          </a:xfrm>
          <a:prstGeom prst="rect">
            <a:avLst/>
          </a:prstGeom>
          <a:noFill/>
        </p:spPr>
        <p:txBody>
          <a:bodyPr wrap="square">
            <a:spAutoFit/>
          </a:bodyPr>
          <a:lstStyle/>
          <a:p>
            <a:r>
              <a:rPr lang="en-US" altLang="ko-KR" sz="2800" b="1" dirty="0"/>
              <a:t>B</a:t>
            </a:r>
            <a:endParaRPr lang="ko-KR" altLang="en-US" sz="2800" dirty="0"/>
          </a:p>
        </p:txBody>
      </p:sp>
      <p:sp>
        <p:nvSpPr>
          <p:cNvPr id="424" name="직사각형 423">
            <a:extLst>
              <a:ext uri="{FF2B5EF4-FFF2-40B4-BE49-F238E27FC236}">
                <a16:creationId xmlns:a16="http://schemas.microsoft.com/office/drawing/2014/main" id="{17690900-7771-4CB3-83D8-6B64279AD93B}"/>
              </a:ext>
            </a:extLst>
          </p:cNvPr>
          <p:cNvSpPr/>
          <p:nvPr/>
        </p:nvSpPr>
        <p:spPr>
          <a:xfrm>
            <a:off x="469365" y="4942542"/>
            <a:ext cx="10615014" cy="1664879"/>
          </a:xfrm>
          <a:prstGeom prst="rect">
            <a:avLst/>
          </a:prstGeom>
        </p:spPr>
        <p:txBody>
          <a:bodyPr wrap="square">
            <a:spAutoFit/>
          </a:bodyPr>
          <a:lstStyle/>
          <a:p>
            <a:pPr algn="just" latinLnBrk="1">
              <a:lnSpc>
                <a:spcPct val="107000"/>
              </a:lnSpc>
              <a:spcAft>
                <a:spcPts val="800"/>
              </a:spcAft>
            </a:pPr>
            <a:r>
              <a:rPr lang="en-US" altLang="ko-KR" sz="1200" kern="100" dirty="0">
                <a:latin typeface="Palatino Linotype" panose="02040502050505030304" pitchFamily="18" charset="0"/>
                <a:cs typeface="Times New Roman" panose="02020603050405020304" pitchFamily="18" charset="0"/>
              </a:rPr>
              <a:t>Supplementary Figure 3. Identification of the ‘anethole peak’ by ,ultra-high-performance liquid chromatography (U-HPLC). A 20 </a:t>
            </a:r>
            <a:r>
              <a:rPr lang="en-US" altLang="ko-KR" sz="1200" kern="100" dirty="0" err="1">
                <a:latin typeface="Palatino Linotype" panose="02040502050505030304" pitchFamily="18" charset="0"/>
                <a:cs typeface="Times New Roman" panose="02020603050405020304" pitchFamily="18" charset="0"/>
              </a:rPr>
              <a:t>μL</a:t>
            </a:r>
            <a:r>
              <a:rPr lang="en-US" altLang="ko-KR" sz="1200" kern="100" dirty="0">
                <a:latin typeface="Palatino Linotype" panose="02040502050505030304" pitchFamily="18" charset="0"/>
                <a:cs typeface="Times New Roman" panose="02020603050405020304" pitchFamily="18" charset="0"/>
              </a:rPr>
              <a:t> sample of the extract and an anethole standard, dissolved in HPLC-grade methanol and filtered through a 0.2 </a:t>
            </a:r>
            <a:r>
              <a:rPr lang="en-US" altLang="ko-KR" sz="1200" kern="100" dirty="0" err="1">
                <a:latin typeface="Palatino Linotype" panose="02040502050505030304" pitchFamily="18" charset="0"/>
                <a:cs typeface="Times New Roman" panose="02020603050405020304" pitchFamily="18" charset="0"/>
              </a:rPr>
              <a:t>μm</a:t>
            </a:r>
            <a:r>
              <a:rPr lang="en-US" altLang="ko-KR" sz="1200" kern="100" dirty="0">
                <a:latin typeface="Palatino Linotype" panose="02040502050505030304" pitchFamily="18" charset="0"/>
                <a:cs typeface="Times New Roman" panose="02020603050405020304" pitchFamily="18" charset="0"/>
              </a:rPr>
              <a:t> Whatman filter, was injected into an U-HPLC instrument equipped with a photodiode array detector. The sample was separated on a </a:t>
            </a:r>
            <a:r>
              <a:rPr lang="en-US" altLang="ko-KR" sz="1200" kern="100" dirty="0" err="1">
                <a:latin typeface="Palatino Linotype" panose="02040502050505030304" pitchFamily="18" charset="0"/>
                <a:cs typeface="Times New Roman" panose="02020603050405020304" pitchFamily="18" charset="0"/>
              </a:rPr>
              <a:t>Mightysil</a:t>
            </a:r>
            <a:r>
              <a:rPr lang="en-US" altLang="ko-KR" sz="1200" kern="100" dirty="0">
                <a:latin typeface="Palatino Linotype" panose="02040502050505030304" pitchFamily="18" charset="0"/>
                <a:cs typeface="Times New Roman" panose="02020603050405020304" pitchFamily="18" charset="0"/>
              </a:rPr>
              <a:t> reverse-phase C18 column (4.6 mm × 250 mm, 5 </a:t>
            </a:r>
            <a:r>
              <a:rPr lang="en-US" altLang="ko-KR" sz="1200" kern="100" dirty="0" err="1">
                <a:latin typeface="Palatino Linotype" panose="02040502050505030304" pitchFamily="18" charset="0"/>
                <a:cs typeface="Times New Roman" panose="02020603050405020304" pitchFamily="18" charset="0"/>
              </a:rPr>
              <a:t>μm</a:t>
            </a:r>
            <a:r>
              <a:rPr lang="en-US" altLang="ko-KR" sz="1200" kern="100" dirty="0">
                <a:latin typeface="Palatino Linotype" panose="02040502050505030304" pitchFamily="18" charset="0"/>
                <a:cs typeface="Times New Roman" panose="02020603050405020304" pitchFamily="18" charset="0"/>
              </a:rPr>
              <a:t>) using gradient elution with acetonitrile and water at a flow rate of 1 mL/min. The gradient program was as follows: 10% acetonitrile for 0-1 minutes, 50% acetonitrile for 1-8 minutes, 70% acetonitrile for 8-14 minutes, 95% acetonitrile for 14-16 minutes, and 10% acetonitrile for 16-25 minutes. The absorbance of the substrates was monitored at 260 nm, and the relative area (%) of anethole was determined from the peaks observed in the chromatogram. A retention time of 18.4 minutes was observed for both the anethole standard and the corresponding peak in the FVSE extract, confirming the presence of anethole in the sample. The relative area (%) of anethole in the extract was determined to be 10.67%.</a:t>
            </a:r>
          </a:p>
        </p:txBody>
      </p:sp>
    </p:spTree>
    <p:extLst>
      <p:ext uri="{BB962C8B-B14F-4D97-AF65-F5344CB8AC3E}">
        <p14:creationId xmlns:p14="http://schemas.microsoft.com/office/powerpoint/2010/main" val="3903322358"/>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3</TotalTime>
  <Words>289</Words>
  <Application>Microsoft Office PowerPoint</Application>
  <PresentationFormat>와이드스크린</PresentationFormat>
  <Paragraphs>75</Paragraphs>
  <Slides>1</Slides>
  <Notes>0</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맑은 고딕</vt:lpstr>
      <vt:lpstr>Arial</vt:lpstr>
      <vt:lpstr>Calibri</vt:lpstr>
      <vt:lpstr>Calibri Light</vt:lpstr>
      <vt:lpstr>Palatino Linotype</vt:lpstr>
      <vt:lpstr>Times New Roman</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MoonIS</cp:lastModifiedBy>
  <cp:revision>10</cp:revision>
  <dcterms:created xsi:type="dcterms:W3CDTF">2024-09-13T03:11:34Z</dcterms:created>
  <dcterms:modified xsi:type="dcterms:W3CDTF">2024-09-25T02:16:13Z</dcterms:modified>
</cp:coreProperties>
</file>